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64" r:id="rId2"/>
    <p:sldId id="263" r:id="rId3"/>
  </p:sldIdLst>
  <p:sldSz cx="9144000" cy="6858000" type="screen4x3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10" d="100"/>
          <a:sy n="110" d="100"/>
        </p:scale>
        <p:origin x="-1608" y="-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encabezado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F97742A-9698-45D7-9793-B270046B01BA}" type="datetimeFigureOut">
              <a:rPr lang="es-ES" smtClean="0"/>
              <a:pPr/>
              <a:t>02/03/2018</a:t>
            </a:fld>
            <a:endParaRPr lang="es-ES"/>
          </a:p>
        </p:txBody>
      </p:sp>
      <p:sp>
        <p:nvSpPr>
          <p:cNvPr id="4" name="3 Marcador de imagen de diapositiva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4 Marcador de notas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5103F4B-807D-4C94-BD4A-BEB1E953B5FD}" type="slidenum">
              <a:rPr lang="es-ES" smtClean="0"/>
              <a:pPr/>
              <a:t>‹Nº›</a:t>
            </a:fld>
            <a:endParaRPr lang="es-E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190B16-0057-4673-806D-728CC8ECBD5A}" type="datetimeFigureOut">
              <a:rPr lang="es-ES" smtClean="0"/>
              <a:pPr/>
              <a:t>02/03/2018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6A7197-F20C-492B-A050-52AF04DE8480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190B16-0057-4673-806D-728CC8ECBD5A}" type="datetimeFigureOut">
              <a:rPr lang="es-ES" smtClean="0"/>
              <a:pPr/>
              <a:t>02/03/2018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6A7197-F20C-492B-A050-52AF04DE8480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190B16-0057-4673-806D-728CC8ECBD5A}" type="datetimeFigureOut">
              <a:rPr lang="es-ES" smtClean="0"/>
              <a:pPr/>
              <a:t>02/03/2018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6A7197-F20C-492B-A050-52AF04DE8480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190B16-0057-4673-806D-728CC8ECBD5A}" type="datetimeFigureOut">
              <a:rPr lang="es-ES" smtClean="0"/>
              <a:pPr/>
              <a:t>02/03/2018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6A7197-F20C-492B-A050-52AF04DE8480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190B16-0057-4673-806D-728CC8ECBD5A}" type="datetimeFigureOut">
              <a:rPr lang="es-ES" smtClean="0"/>
              <a:pPr/>
              <a:t>02/03/2018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6A7197-F20C-492B-A050-52AF04DE8480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190B16-0057-4673-806D-728CC8ECBD5A}" type="datetimeFigureOut">
              <a:rPr lang="es-ES" smtClean="0"/>
              <a:pPr/>
              <a:t>02/03/2018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6A7197-F20C-492B-A050-52AF04DE8480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190B16-0057-4673-806D-728CC8ECBD5A}" type="datetimeFigureOut">
              <a:rPr lang="es-ES" smtClean="0"/>
              <a:pPr/>
              <a:t>02/03/2018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6A7197-F20C-492B-A050-52AF04DE8480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190B16-0057-4673-806D-728CC8ECBD5A}" type="datetimeFigureOut">
              <a:rPr lang="es-ES" smtClean="0"/>
              <a:pPr/>
              <a:t>02/03/2018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6A7197-F20C-492B-A050-52AF04DE8480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190B16-0057-4673-806D-728CC8ECBD5A}" type="datetimeFigureOut">
              <a:rPr lang="es-ES" smtClean="0"/>
              <a:pPr/>
              <a:t>02/03/2018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6A7197-F20C-492B-A050-52AF04DE8480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190B16-0057-4673-806D-728CC8ECBD5A}" type="datetimeFigureOut">
              <a:rPr lang="es-ES" smtClean="0"/>
              <a:pPr/>
              <a:t>02/03/2018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6A7197-F20C-492B-A050-52AF04DE8480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190B16-0057-4673-806D-728CC8ECBD5A}" type="datetimeFigureOut">
              <a:rPr lang="es-ES" smtClean="0"/>
              <a:pPr/>
              <a:t>02/03/2018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6A7197-F20C-492B-A050-52AF04DE8480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190B16-0057-4673-806D-728CC8ECBD5A}" type="datetimeFigureOut">
              <a:rPr lang="es-ES" smtClean="0"/>
              <a:pPr/>
              <a:t>02/03/2018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6A7197-F20C-492B-A050-52AF04DE8480}" type="slidenum">
              <a:rPr lang="es-ES" smtClean="0"/>
              <a:pPr/>
              <a:t>‹Nº›</a:t>
            </a:fld>
            <a:endParaRPr lang="es-E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Freeform 16"/>
          <p:cNvSpPr>
            <a:spLocks noEditPoints="1"/>
          </p:cNvSpPr>
          <p:nvPr/>
        </p:nvSpPr>
        <p:spPr bwMode="auto">
          <a:xfrm>
            <a:off x="6540773" y="2141482"/>
            <a:ext cx="838200" cy="571500"/>
          </a:xfrm>
          <a:custGeom>
            <a:avLst/>
            <a:gdLst/>
            <a:ahLst/>
            <a:cxnLst>
              <a:cxn ang="0">
                <a:pos x="1" y="112"/>
              </a:cxn>
              <a:cxn ang="0">
                <a:pos x="12" y="67"/>
              </a:cxn>
              <a:cxn ang="0">
                <a:pos x="38" y="32"/>
              </a:cxn>
              <a:cxn ang="0">
                <a:pos x="76" y="8"/>
              </a:cxn>
              <a:cxn ang="0">
                <a:pos x="116" y="0"/>
              </a:cxn>
              <a:cxn ang="0">
                <a:pos x="1298" y="1"/>
              </a:cxn>
              <a:cxn ang="0">
                <a:pos x="1343" y="12"/>
              </a:cxn>
              <a:cxn ang="0">
                <a:pos x="1379" y="38"/>
              </a:cxn>
              <a:cxn ang="0">
                <a:pos x="1401" y="76"/>
              </a:cxn>
              <a:cxn ang="0">
                <a:pos x="1408" y="116"/>
              </a:cxn>
              <a:cxn ang="0">
                <a:pos x="1408" y="850"/>
              </a:cxn>
              <a:cxn ang="0">
                <a:pos x="1398" y="895"/>
              </a:cxn>
              <a:cxn ang="0">
                <a:pos x="1372" y="931"/>
              </a:cxn>
              <a:cxn ang="0">
                <a:pos x="1334" y="953"/>
              </a:cxn>
              <a:cxn ang="0">
                <a:pos x="1293" y="960"/>
              </a:cxn>
              <a:cxn ang="0">
                <a:pos x="112" y="960"/>
              </a:cxn>
              <a:cxn ang="0">
                <a:pos x="67" y="950"/>
              </a:cxn>
              <a:cxn ang="0">
                <a:pos x="32" y="924"/>
              </a:cxn>
              <a:cxn ang="0">
                <a:pos x="8" y="886"/>
              </a:cxn>
              <a:cxn ang="0">
                <a:pos x="0" y="845"/>
              </a:cxn>
              <a:cxn ang="0">
                <a:pos x="48" y="845"/>
              </a:cxn>
              <a:cxn ang="0">
                <a:pos x="55" y="877"/>
              </a:cxn>
              <a:cxn ang="0">
                <a:pos x="71" y="897"/>
              </a:cxn>
              <a:cxn ang="0">
                <a:pos x="94" y="909"/>
              </a:cxn>
              <a:cxn ang="0">
                <a:pos x="121" y="913"/>
              </a:cxn>
              <a:cxn ang="0">
                <a:pos x="1293" y="912"/>
              </a:cxn>
              <a:cxn ang="0">
                <a:pos x="1325" y="906"/>
              </a:cxn>
              <a:cxn ang="0">
                <a:pos x="1345" y="890"/>
              </a:cxn>
              <a:cxn ang="0">
                <a:pos x="1357" y="868"/>
              </a:cxn>
              <a:cxn ang="0">
                <a:pos x="1361" y="841"/>
              </a:cxn>
              <a:cxn ang="0">
                <a:pos x="1360" y="116"/>
              </a:cxn>
              <a:cxn ang="0">
                <a:pos x="1354" y="85"/>
              </a:cxn>
              <a:cxn ang="0">
                <a:pos x="1338" y="65"/>
              </a:cxn>
              <a:cxn ang="0">
                <a:pos x="1316" y="51"/>
              </a:cxn>
              <a:cxn ang="0">
                <a:pos x="1289" y="48"/>
              </a:cxn>
              <a:cxn ang="0">
                <a:pos x="116" y="48"/>
              </a:cxn>
              <a:cxn ang="0">
                <a:pos x="85" y="55"/>
              </a:cxn>
              <a:cxn ang="0">
                <a:pos x="65" y="71"/>
              </a:cxn>
              <a:cxn ang="0">
                <a:pos x="51" y="94"/>
              </a:cxn>
              <a:cxn ang="0">
                <a:pos x="48" y="121"/>
              </a:cxn>
              <a:cxn ang="0">
                <a:pos x="48" y="845"/>
              </a:cxn>
            </a:cxnLst>
            <a:rect l="0" t="0" r="r" b="b"/>
            <a:pathLst>
              <a:path w="1408" h="960">
                <a:moveTo>
                  <a:pt x="0" y="116"/>
                </a:moveTo>
                <a:cubicBezTo>
                  <a:pt x="0" y="115"/>
                  <a:pt x="1" y="113"/>
                  <a:pt x="1" y="112"/>
                </a:cubicBezTo>
                <a:lnTo>
                  <a:pt x="8" y="76"/>
                </a:lnTo>
                <a:cubicBezTo>
                  <a:pt x="9" y="73"/>
                  <a:pt x="10" y="70"/>
                  <a:pt x="12" y="67"/>
                </a:cubicBezTo>
                <a:lnTo>
                  <a:pt x="32" y="38"/>
                </a:lnTo>
                <a:cubicBezTo>
                  <a:pt x="33" y="35"/>
                  <a:pt x="35" y="33"/>
                  <a:pt x="38" y="32"/>
                </a:cubicBezTo>
                <a:lnTo>
                  <a:pt x="67" y="12"/>
                </a:lnTo>
                <a:cubicBezTo>
                  <a:pt x="70" y="10"/>
                  <a:pt x="73" y="9"/>
                  <a:pt x="76" y="8"/>
                </a:cubicBezTo>
                <a:lnTo>
                  <a:pt x="112" y="1"/>
                </a:lnTo>
                <a:cubicBezTo>
                  <a:pt x="113" y="1"/>
                  <a:pt x="115" y="0"/>
                  <a:pt x="116" y="0"/>
                </a:cubicBezTo>
                <a:lnTo>
                  <a:pt x="1293" y="0"/>
                </a:lnTo>
                <a:cubicBezTo>
                  <a:pt x="1295" y="0"/>
                  <a:pt x="1297" y="1"/>
                  <a:pt x="1298" y="1"/>
                </a:cubicBezTo>
                <a:lnTo>
                  <a:pt x="1334" y="8"/>
                </a:lnTo>
                <a:cubicBezTo>
                  <a:pt x="1337" y="9"/>
                  <a:pt x="1340" y="10"/>
                  <a:pt x="1343" y="12"/>
                </a:cubicBezTo>
                <a:lnTo>
                  <a:pt x="1372" y="32"/>
                </a:lnTo>
                <a:cubicBezTo>
                  <a:pt x="1375" y="33"/>
                  <a:pt x="1377" y="36"/>
                  <a:pt x="1379" y="38"/>
                </a:cubicBezTo>
                <a:lnTo>
                  <a:pt x="1398" y="67"/>
                </a:lnTo>
                <a:cubicBezTo>
                  <a:pt x="1399" y="70"/>
                  <a:pt x="1400" y="73"/>
                  <a:pt x="1401" y="76"/>
                </a:cubicBezTo>
                <a:lnTo>
                  <a:pt x="1408" y="112"/>
                </a:lnTo>
                <a:cubicBezTo>
                  <a:pt x="1408" y="113"/>
                  <a:pt x="1408" y="115"/>
                  <a:pt x="1408" y="116"/>
                </a:cubicBezTo>
                <a:lnTo>
                  <a:pt x="1408" y="845"/>
                </a:lnTo>
                <a:cubicBezTo>
                  <a:pt x="1408" y="847"/>
                  <a:pt x="1408" y="849"/>
                  <a:pt x="1408" y="850"/>
                </a:cubicBezTo>
                <a:lnTo>
                  <a:pt x="1401" y="886"/>
                </a:lnTo>
                <a:cubicBezTo>
                  <a:pt x="1400" y="889"/>
                  <a:pt x="1399" y="892"/>
                  <a:pt x="1398" y="895"/>
                </a:cubicBezTo>
                <a:lnTo>
                  <a:pt x="1379" y="924"/>
                </a:lnTo>
                <a:cubicBezTo>
                  <a:pt x="1377" y="926"/>
                  <a:pt x="1374" y="929"/>
                  <a:pt x="1372" y="931"/>
                </a:cubicBezTo>
                <a:lnTo>
                  <a:pt x="1343" y="950"/>
                </a:lnTo>
                <a:cubicBezTo>
                  <a:pt x="1340" y="951"/>
                  <a:pt x="1337" y="952"/>
                  <a:pt x="1334" y="953"/>
                </a:cubicBezTo>
                <a:lnTo>
                  <a:pt x="1298" y="960"/>
                </a:lnTo>
                <a:cubicBezTo>
                  <a:pt x="1297" y="960"/>
                  <a:pt x="1295" y="960"/>
                  <a:pt x="1293" y="960"/>
                </a:cubicBezTo>
                <a:lnTo>
                  <a:pt x="116" y="960"/>
                </a:lnTo>
                <a:cubicBezTo>
                  <a:pt x="115" y="960"/>
                  <a:pt x="113" y="960"/>
                  <a:pt x="112" y="960"/>
                </a:cubicBezTo>
                <a:lnTo>
                  <a:pt x="76" y="953"/>
                </a:lnTo>
                <a:cubicBezTo>
                  <a:pt x="73" y="952"/>
                  <a:pt x="70" y="951"/>
                  <a:pt x="67" y="950"/>
                </a:cubicBezTo>
                <a:lnTo>
                  <a:pt x="38" y="931"/>
                </a:lnTo>
                <a:cubicBezTo>
                  <a:pt x="36" y="929"/>
                  <a:pt x="33" y="927"/>
                  <a:pt x="32" y="924"/>
                </a:cubicBezTo>
                <a:lnTo>
                  <a:pt x="12" y="895"/>
                </a:lnTo>
                <a:cubicBezTo>
                  <a:pt x="10" y="892"/>
                  <a:pt x="9" y="889"/>
                  <a:pt x="8" y="886"/>
                </a:cubicBezTo>
                <a:lnTo>
                  <a:pt x="1" y="850"/>
                </a:lnTo>
                <a:cubicBezTo>
                  <a:pt x="1" y="849"/>
                  <a:pt x="0" y="847"/>
                  <a:pt x="0" y="845"/>
                </a:cubicBezTo>
                <a:lnTo>
                  <a:pt x="0" y="116"/>
                </a:lnTo>
                <a:close/>
                <a:moveTo>
                  <a:pt x="48" y="845"/>
                </a:moveTo>
                <a:lnTo>
                  <a:pt x="48" y="841"/>
                </a:lnTo>
                <a:lnTo>
                  <a:pt x="55" y="877"/>
                </a:lnTo>
                <a:lnTo>
                  <a:pt x="51" y="868"/>
                </a:lnTo>
                <a:lnTo>
                  <a:pt x="71" y="897"/>
                </a:lnTo>
                <a:lnTo>
                  <a:pt x="65" y="890"/>
                </a:lnTo>
                <a:lnTo>
                  <a:pt x="94" y="909"/>
                </a:lnTo>
                <a:lnTo>
                  <a:pt x="85" y="906"/>
                </a:lnTo>
                <a:lnTo>
                  <a:pt x="121" y="913"/>
                </a:lnTo>
                <a:lnTo>
                  <a:pt x="116" y="912"/>
                </a:lnTo>
                <a:lnTo>
                  <a:pt x="1293" y="912"/>
                </a:lnTo>
                <a:lnTo>
                  <a:pt x="1289" y="913"/>
                </a:lnTo>
                <a:lnTo>
                  <a:pt x="1325" y="906"/>
                </a:lnTo>
                <a:lnTo>
                  <a:pt x="1316" y="909"/>
                </a:lnTo>
                <a:lnTo>
                  <a:pt x="1345" y="890"/>
                </a:lnTo>
                <a:lnTo>
                  <a:pt x="1338" y="897"/>
                </a:lnTo>
                <a:lnTo>
                  <a:pt x="1357" y="868"/>
                </a:lnTo>
                <a:lnTo>
                  <a:pt x="1354" y="877"/>
                </a:lnTo>
                <a:lnTo>
                  <a:pt x="1361" y="841"/>
                </a:lnTo>
                <a:lnTo>
                  <a:pt x="1360" y="845"/>
                </a:lnTo>
                <a:lnTo>
                  <a:pt x="1360" y="116"/>
                </a:lnTo>
                <a:lnTo>
                  <a:pt x="1361" y="121"/>
                </a:lnTo>
                <a:lnTo>
                  <a:pt x="1354" y="85"/>
                </a:lnTo>
                <a:lnTo>
                  <a:pt x="1357" y="94"/>
                </a:lnTo>
                <a:lnTo>
                  <a:pt x="1338" y="65"/>
                </a:lnTo>
                <a:lnTo>
                  <a:pt x="1345" y="71"/>
                </a:lnTo>
                <a:lnTo>
                  <a:pt x="1316" y="51"/>
                </a:lnTo>
                <a:lnTo>
                  <a:pt x="1325" y="55"/>
                </a:lnTo>
                <a:lnTo>
                  <a:pt x="1289" y="48"/>
                </a:lnTo>
                <a:lnTo>
                  <a:pt x="1293" y="48"/>
                </a:lnTo>
                <a:lnTo>
                  <a:pt x="116" y="48"/>
                </a:lnTo>
                <a:lnTo>
                  <a:pt x="121" y="48"/>
                </a:lnTo>
                <a:lnTo>
                  <a:pt x="85" y="55"/>
                </a:lnTo>
                <a:lnTo>
                  <a:pt x="94" y="51"/>
                </a:lnTo>
                <a:lnTo>
                  <a:pt x="65" y="71"/>
                </a:lnTo>
                <a:lnTo>
                  <a:pt x="71" y="65"/>
                </a:lnTo>
                <a:lnTo>
                  <a:pt x="51" y="94"/>
                </a:lnTo>
                <a:lnTo>
                  <a:pt x="55" y="85"/>
                </a:lnTo>
                <a:lnTo>
                  <a:pt x="48" y="121"/>
                </a:lnTo>
                <a:lnTo>
                  <a:pt x="48" y="116"/>
                </a:lnTo>
                <a:lnTo>
                  <a:pt x="48" y="845"/>
                </a:lnTo>
                <a:close/>
              </a:path>
            </a:pathLst>
          </a:custGeom>
          <a:solidFill>
            <a:srgbClr val="1B4171"/>
          </a:solidFill>
          <a:ln w="0" cap="flat">
            <a:solidFill>
              <a:srgbClr val="1B417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 sz="1100" b="1"/>
          </a:p>
        </p:txBody>
      </p:sp>
      <p:sp>
        <p:nvSpPr>
          <p:cNvPr id="20" name="Freeform 20"/>
          <p:cNvSpPr>
            <a:spLocks/>
          </p:cNvSpPr>
          <p:nvPr/>
        </p:nvSpPr>
        <p:spPr bwMode="auto">
          <a:xfrm>
            <a:off x="6244555" y="2698694"/>
            <a:ext cx="728018" cy="447675"/>
          </a:xfrm>
          <a:custGeom>
            <a:avLst/>
            <a:gdLst/>
            <a:ahLst/>
            <a:cxnLst>
              <a:cxn ang="0">
                <a:pos x="2710" y="0"/>
              </a:cxn>
              <a:cxn ang="0">
                <a:pos x="2710" y="376"/>
              </a:cxn>
              <a:cxn ang="0">
                <a:pos x="2686" y="400"/>
              </a:cxn>
              <a:cxn ang="0">
                <a:pos x="24" y="400"/>
              </a:cxn>
              <a:cxn ang="0">
                <a:pos x="48" y="376"/>
              </a:cxn>
              <a:cxn ang="0">
                <a:pos x="48" y="752"/>
              </a:cxn>
              <a:cxn ang="0">
                <a:pos x="0" y="752"/>
              </a:cxn>
              <a:cxn ang="0">
                <a:pos x="0" y="376"/>
              </a:cxn>
              <a:cxn ang="0">
                <a:pos x="24" y="352"/>
              </a:cxn>
              <a:cxn ang="0">
                <a:pos x="2686" y="352"/>
              </a:cxn>
              <a:cxn ang="0">
                <a:pos x="2662" y="376"/>
              </a:cxn>
              <a:cxn ang="0">
                <a:pos x="2662" y="0"/>
              </a:cxn>
              <a:cxn ang="0">
                <a:pos x="2710" y="0"/>
              </a:cxn>
            </a:cxnLst>
            <a:rect l="0" t="0" r="r" b="b"/>
            <a:pathLst>
              <a:path w="2710" h="752">
                <a:moveTo>
                  <a:pt x="2710" y="0"/>
                </a:moveTo>
                <a:lnTo>
                  <a:pt x="2710" y="376"/>
                </a:lnTo>
                <a:cubicBezTo>
                  <a:pt x="2710" y="390"/>
                  <a:pt x="2699" y="400"/>
                  <a:pt x="2686" y="400"/>
                </a:cubicBezTo>
                <a:lnTo>
                  <a:pt x="24" y="400"/>
                </a:lnTo>
                <a:lnTo>
                  <a:pt x="48" y="376"/>
                </a:lnTo>
                <a:lnTo>
                  <a:pt x="48" y="752"/>
                </a:lnTo>
                <a:lnTo>
                  <a:pt x="0" y="752"/>
                </a:lnTo>
                <a:lnTo>
                  <a:pt x="0" y="376"/>
                </a:lnTo>
                <a:cubicBezTo>
                  <a:pt x="0" y="363"/>
                  <a:pt x="11" y="352"/>
                  <a:pt x="24" y="352"/>
                </a:cubicBezTo>
                <a:lnTo>
                  <a:pt x="2686" y="352"/>
                </a:lnTo>
                <a:lnTo>
                  <a:pt x="2662" y="376"/>
                </a:lnTo>
                <a:lnTo>
                  <a:pt x="2662" y="0"/>
                </a:lnTo>
                <a:lnTo>
                  <a:pt x="2710" y="0"/>
                </a:lnTo>
                <a:close/>
              </a:path>
            </a:pathLst>
          </a:custGeom>
          <a:solidFill>
            <a:srgbClr val="1B4171"/>
          </a:solidFill>
          <a:ln w="0" cap="flat">
            <a:solidFill>
              <a:srgbClr val="1B417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 sz="1100" b="1"/>
          </a:p>
        </p:txBody>
      </p:sp>
      <p:sp>
        <p:nvSpPr>
          <p:cNvPr id="21" name="Freeform 22"/>
          <p:cNvSpPr>
            <a:spLocks noEditPoints="1"/>
          </p:cNvSpPr>
          <p:nvPr/>
        </p:nvSpPr>
        <p:spPr bwMode="auto">
          <a:xfrm>
            <a:off x="5838403" y="3132082"/>
            <a:ext cx="838200" cy="571500"/>
          </a:xfrm>
          <a:custGeom>
            <a:avLst/>
            <a:gdLst/>
            <a:ahLst/>
            <a:cxnLst>
              <a:cxn ang="0">
                <a:pos x="1" y="112"/>
              </a:cxn>
              <a:cxn ang="0">
                <a:pos x="12" y="67"/>
              </a:cxn>
              <a:cxn ang="0">
                <a:pos x="38" y="32"/>
              </a:cxn>
              <a:cxn ang="0">
                <a:pos x="76" y="8"/>
              </a:cxn>
              <a:cxn ang="0">
                <a:pos x="116" y="0"/>
              </a:cxn>
              <a:cxn ang="0">
                <a:pos x="1298" y="1"/>
              </a:cxn>
              <a:cxn ang="0">
                <a:pos x="1343" y="12"/>
              </a:cxn>
              <a:cxn ang="0">
                <a:pos x="1379" y="38"/>
              </a:cxn>
              <a:cxn ang="0">
                <a:pos x="1401" y="76"/>
              </a:cxn>
              <a:cxn ang="0">
                <a:pos x="1408" y="116"/>
              </a:cxn>
              <a:cxn ang="0">
                <a:pos x="1408" y="850"/>
              </a:cxn>
              <a:cxn ang="0">
                <a:pos x="1398" y="895"/>
              </a:cxn>
              <a:cxn ang="0">
                <a:pos x="1372" y="931"/>
              </a:cxn>
              <a:cxn ang="0">
                <a:pos x="1334" y="953"/>
              </a:cxn>
              <a:cxn ang="0">
                <a:pos x="1293" y="960"/>
              </a:cxn>
              <a:cxn ang="0">
                <a:pos x="112" y="960"/>
              </a:cxn>
              <a:cxn ang="0">
                <a:pos x="67" y="950"/>
              </a:cxn>
              <a:cxn ang="0">
                <a:pos x="32" y="924"/>
              </a:cxn>
              <a:cxn ang="0">
                <a:pos x="8" y="886"/>
              </a:cxn>
              <a:cxn ang="0">
                <a:pos x="0" y="845"/>
              </a:cxn>
              <a:cxn ang="0">
                <a:pos x="48" y="845"/>
              </a:cxn>
              <a:cxn ang="0">
                <a:pos x="55" y="877"/>
              </a:cxn>
              <a:cxn ang="0">
                <a:pos x="71" y="897"/>
              </a:cxn>
              <a:cxn ang="0">
                <a:pos x="94" y="909"/>
              </a:cxn>
              <a:cxn ang="0">
                <a:pos x="121" y="913"/>
              </a:cxn>
              <a:cxn ang="0">
                <a:pos x="1293" y="912"/>
              </a:cxn>
              <a:cxn ang="0">
                <a:pos x="1325" y="906"/>
              </a:cxn>
              <a:cxn ang="0">
                <a:pos x="1345" y="890"/>
              </a:cxn>
              <a:cxn ang="0">
                <a:pos x="1357" y="868"/>
              </a:cxn>
              <a:cxn ang="0">
                <a:pos x="1361" y="841"/>
              </a:cxn>
              <a:cxn ang="0">
                <a:pos x="1360" y="116"/>
              </a:cxn>
              <a:cxn ang="0">
                <a:pos x="1354" y="85"/>
              </a:cxn>
              <a:cxn ang="0">
                <a:pos x="1338" y="65"/>
              </a:cxn>
              <a:cxn ang="0">
                <a:pos x="1316" y="51"/>
              </a:cxn>
              <a:cxn ang="0">
                <a:pos x="1289" y="48"/>
              </a:cxn>
              <a:cxn ang="0">
                <a:pos x="116" y="48"/>
              </a:cxn>
              <a:cxn ang="0">
                <a:pos x="85" y="55"/>
              </a:cxn>
              <a:cxn ang="0">
                <a:pos x="65" y="71"/>
              </a:cxn>
              <a:cxn ang="0">
                <a:pos x="51" y="94"/>
              </a:cxn>
              <a:cxn ang="0">
                <a:pos x="48" y="121"/>
              </a:cxn>
              <a:cxn ang="0">
                <a:pos x="48" y="845"/>
              </a:cxn>
            </a:cxnLst>
            <a:rect l="0" t="0" r="r" b="b"/>
            <a:pathLst>
              <a:path w="1408" h="960">
                <a:moveTo>
                  <a:pt x="0" y="116"/>
                </a:moveTo>
                <a:cubicBezTo>
                  <a:pt x="0" y="115"/>
                  <a:pt x="1" y="113"/>
                  <a:pt x="1" y="112"/>
                </a:cubicBezTo>
                <a:lnTo>
                  <a:pt x="8" y="76"/>
                </a:lnTo>
                <a:cubicBezTo>
                  <a:pt x="9" y="73"/>
                  <a:pt x="10" y="70"/>
                  <a:pt x="12" y="67"/>
                </a:cubicBezTo>
                <a:lnTo>
                  <a:pt x="32" y="38"/>
                </a:lnTo>
                <a:cubicBezTo>
                  <a:pt x="33" y="35"/>
                  <a:pt x="35" y="33"/>
                  <a:pt x="38" y="32"/>
                </a:cubicBezTo>
                <a:lnTo>
                  <a:pt x="67" y="12"/>
                </a:lnTo>
                <a:cubicBezTo>
                  <a:pt x="70" y="10"/>
                  <a:pt x="73" y="9"/>
                  <a:pt x="76" y="8"/>
                </a:cubicBezTo>
                <a:lnTo>
                  <a:pt x="112" y="1"/>
                </a:lnTo>
                <a:cubicBezTo>
                  <a:pt x="113" y="1"/>
                  <a:pt x="115" y="0"/>
                  <a:pt x="116" y="0"/>
                </a:cubicBezTo>
                <a:lnTo>
                  <a:pt x="1293" y="0"/>
                </a:lnTo>
                <a:cubicBezTo>
                  <a:pt x="1295" y="0"/>
                  <a:pt x="1297" y="1"/>
                  <a:pt x="1298" y="1"/>
                </a:cubicBezTo>
                <a:lnTo>
                  <a:pt x="1334" y="8"/>
                </a:lnTo>
                <a:cubicBezTo>
                  <a:pt x="1337" y="9"/>
                  <a:pt x="1340" y="10"/>
                  <a:pt x="1343" y="12"/>
                </a:cubicBezTo>
                <a:lnTo>
                  <a:pt x="1372" y="32"/>
                </a:lnTo>
                <a:cubicBezTo>
                  <a:pt x="1375" y="33"/>
                  <a:pt x="1377" y="36"/>
                  <a:pt x="1379" y="38"/>
                </a:cubicBezTo>
                <a:lnTo>
                  <a:pt x="1398" y="67"/>
                </a:lnTo>
                <a:cubicBezTo>
                  <a:pt x="1399" y="70"/>
                  <a:pt x="1400" y="73"/>
                  <a:pt x="1401" y="76"/>
                </a:cubicBezTo>
                <a:lnTo>
                  <a:pt x="1408" y="112"/>
                </a:lnTo>
                <a:cubicBezTo>
                  <a:pt x="1408" y="113"/>
                  <a:pt x="1408" y="115"/>
                  <a:pt x="1408" y="116"/>
                </a:cubicBezTo>
                <a:lnTo>
                  <a:pt x="1408" y="845"/>
                </a:lnTo>
                <a:cubicBezTo>
                  <a:pt x="1408" y="847"/>
                  <a:pt x="1408" y="849"/>
                  <a:pt x="1408" y="850"/>
                </a:cubicBezTo>
                <a:lnTo>
                  <a:pt x="1401" y="886"/>
                </a:lnTo>
                <a:cubicBezTo>
                  <a:pt x="1400" y="889"/>
                  <a:pt x="1399" y="892"/>
                  <a:pt x="1398" y="895"/>
                </a:cubicBezTo>
                <a:lnTo>
                  <a:pt x="1379" y="924"/>
                </a:lnTo>
                <a:cubicBezTo>
                  <a:pt x="1377" y="926"/>
                  <a:pt x="1374" y="929"/>
                  <a:pt x="1372" y="931"/>
                </a:cubicBezTo>
                <a:lnTo>
                  <a:pt x="1343" y="950"/>
                </a:lnTo>
                <a:cubicBezTo>
                  <a:pt x="1340" y="951"/>
                  <a:pt x="1337" y="952"/>
                  <a:pt x="1334" y="953"/>
                </a:cubicBezTo>
                <a:lnTo>
                  <a:pt x="1298" y="960"/>
                </a:lnTo>
                <a:cubicBezTo>
                  <a:pt x="1297" y="960"/>
                  <a:pt x="1295" y="960"/>
                  <a:pt x="1293" y="960"/>
                </a:cubicBezTo>
                <a:lnTo>
                  <a:pt x="116" y="960"/>
                </a:lnTo>
                <a:cubicBezTo>
                  <a:pt x="115" y="960"/>
                  <a:pt x="113" y="960"/>
                  <a:pt x="112" y="960"/>
                </a:cubicBezTo>
                <a:lnTo>
                  <a:pt x="76" y="953"/>
                </a:lnTo>
                <a:cubicBezTo>
                  <a:pt x="73" y="952"/>
                  <a:pt x="70" y="951"/>
                  <a:pt x="67" y="950"/>
                </a:cubicBezTo>
                <a:lnTo>
                  <a:pt x="38" y="931"/>
                </a:lnTo>
                <a:cubicBezTo>
                  <a:pt x="36" y="929"/>
                  <a:pt x="33" y="927"/>
                  <a:pt x="32" y="924"/>
                </a:cubicBezTo>
                <a:lnTo>
                  <a:pt x="12" y="895"/>
                </a:lnTo>
                <a:cubicBezTo>
                  <a:pt x="10" y="892"/>
                  <a:pt x="9" y="889"/>
                  <a:pt x="8" y="886"/>
                </a:cubicBezTo>
                <a:lnTo>
                  <a:pt x="1" y="850"/>
                </a:lnTo>
                <a:cubicBezTo>
                  <a:pt x="1" y="849"/>
                  <a:pt x="0" y="847"/>
                  <a:pt x="0" y="845"/>
                </a:cubicBezTo>
                <a:lnTo>
                  <a:pt x="0" y="116"/>
                </a:lnTo>
                <a:close/>
                <a:moveTo>
                  <a:pt x="48" y="845"/>
                </a:moveTo>
                <a:lnTo>
                  <a:pt x="48" y="841"/>
                </a:lnTo>
                <a:lnTo>
                  <a:pt x="55" y="877"/>
                </a:lnTo>
                <a:lnTo>
                  <a:pt x="51" y="868"/>
                </a:lnTo>
                <a:lnTo>
                  <a:pt x="71" y="897"/>
                </a:lnTo>
                <a:lnTo>
                  <a:pt x="65" y="890"/>
                </a:lnTo>
                <a:lnTo>
                  <a:pt x="94" y="909"/>
                </a:lnTo>
                <a:lnTo>
                  <a:pt x="85" y="906"/>
                </a:lnTo>
                <a:lnTo>
                  <a:pt x="121" y="913"/>
                </a:lnTo>
                <a:lnTo>
                  <a:pt x="116" y="912"/>
                </a:lnTo>
                <a:lnTo>
                  <a:pt x="1293" y="912"/>
                </a:lnTo>
                <a:lnTo>
                  <a:pt x="1289" y="913"/>
                </a:lnTo>
                <a:lnTo>
                  <a:pt x="1325" y="906"/>
                </a:lnTo>
                <a:lnTo>
                  <a:pt x="1316" y="909"/>
                </a:lnTo>
                <a:lnTo>
                  <a:pt x="1345" y="890"/>
                </a:lnTo>
                <a:lnTo>
                  <a:pt x="1338" y="897"/>
                </a:lnTo>
                <a:lnTo>
                  <a:pt x="1357" y="868"/>
                </a:lnTo>
                <a:lnTo>
                  <a:pt x="1354" y="877"/>
                </a:lnTo>
                <a:lnTo>
                  <a:pt x="1361" y="841"/>
                </a:lnTo>
                <a:lnTo>
                  <a:pt x="1360" y="845"/>
                </a:lnTo>
                <a:lnTo>
                  <a:pt x="1360" y="116"/>
                </a:lnTo>
                <a:lnTo>
                  <a:pt x="1361" y="121"/>
                </a:lnTo>
                <a:lnTo>
                  <a:pt x="1354" y="85"/>
                </a:lnTo>
                <a:lnTo>
                  <a:pt x="1357" y="94"/>
                </a:lnTo>
                <a:lnTo>
                  <a:pt x="1338" y="65"/>
                </a:lnTo>
                <a:lnTo>
                  <a:pt x="1345" y="71"/>
                </a:lnTo>
                <a:lnTo>
                  <a:pt x="1316" y="51"/>
                </a:lnTo>
                <a:lnTo>
                  <a:pt x="1325" y="55"/>
                </a:lnTo>
                <a:lnTo>
                  <a:pt x="1289" y="48"/>
                </a:lnTo>
                <a:lnTo>
                  <a:pt x="1293" y="48"/>
                </a:lnTo>
                <a:lnTo>
                  <a:pt x="116" y="48"/>
                </a:lnTo>
                <a:lnTo>
                  <a:pt x="121" y="48"/>
                </a:lnTo>
                <a:lnTo>
                  <a:pt x="85" y="55"/>
                </a:lnTo>
                <a:lnTo>
                  <a:pt x="94" y="51"/>
                </a:lnTo>
                <a:lnTo>
                  <a:pt x="65" y="71"/>
                </a:lnTo>
                <a:lnTo>
                  <a:pt x="71" y="65"/>
                </a:lnTo>
                <a:lnTo>
                  <a:pt x="51" y="94"/>
                </a:lnTo>
                <a:lnTo>
                  <a:pt x="55" y="85"/>
                </a:lnTo>
                <a:lnTo>
                  <a:pt x="48" y="121"/>
                </a:lnTo>
                <a:lnTo>
                  <a:pt x="48" y="116"/>
                </a:lnTo>
                <a:lnTo>
                  <a:pt x="48" y="845"/>
                </a:lnTo>
                <a:close/>
              </a:path>
            </a:pathLst>
          </a:custGeom>
          <a:solidFill>
            <a:srgbClr val="1B4171"/>
          </a:solidFill>
          <a:ln w="0" cap="flat">
            <a:solidFill>
              <a:srgbClr val="1B417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 sz="1100" b="1"/>
          </a:p>
        </p:txBody>
      </p:sp>
      <p:sp>
        <p:nvSpPr>
          <p:cNvPr id="22" name="Freeform 47"/>
          <p:cNvSpPr>
            <a:spLocks/>
          </p:cNvSpPr>
          <p:nvPr/>
        </p:nvSpPr>
        <p:spPr bwMode="auto">
          <a:xfrm>
            <a:off x="6950348" y="2698694"/>
            <a:ext cx="734367" cy="447675"/>
          </a:xfrm>
          <a:custGeom>
            <a:avLst/>
            <a:gdLst/>
            <a:ahLst/>
            <a:cxnLst>
              <a:cxn ang="0">
                <a:pos x="48" y="0"/>
              </a:cxn>
              <a:cxn ang="0">
                <a:pos x="48" y="376"/>
              </a:cxn>
              <a:cxn ang="0">
                <a:pos x="24" y="352"/>
              </a:cxn>
              <a:cxn ang="0">
                <a:pos x="2686" y="352"/>
              </a:cxn>
              <a:cxn ang="0">
                <a:pos x="2710" y="376"/>
              </a:cxn>
              <a:cxn ang="0">
                <a:pos x="2710" y="752"/>
              </a:cxn>
              <a:cxn ang="0">
                <a:pos x="2662" y="752"/>
              </a:cxn>
              <a:cxn ang="0">
                <a:pos x="2662" y="376"/>
              </a:cxn>
              <a:cxn ang="0">
                <a:pos x="2686" y="400"/>
              </a:cxn>
              <a:cxn ang="0">
                <a:pos x="24" y="400"/>
              </a:cxn>
              <a:cxn ang="0">
                <a:pos x="0" y="376"/>
              </a:cxn>
              <a:cxn ang="0">
                <a:pos x="0" y="0"/>
              </a:cxn>
              <a:cxn ang="0">
                <a:pos x="48" y="0"/>
              </a:cxn>
            </a:cxnLst>
            <a:rect l="0" t="0" r="r" b="b"/>
            <a:pathLst>
              <a:path w="2710" h="752">
                <a:moveTo>
                  <a:pt x="48" y="0"/>
                </a:moveTo>
                <a:lnTo>
                  <a:pt x="48" y="376"/>
                </a:lnTo>
                <a:lnTo>
                  <a:pt x="24" y="352"/>
                </a:lnTo>
                <a:lnTo>
                  <a:pt x="2686" y="352"/>
                </a:lnTo>
                <a:cubicBezTo>
                  <a:pt x="2699" y="352"/>
                  <a:pt x="2710" y="363"/>
                  <a:pt x="2710" y="376"/>
                </a:cubicBezTo>
                <a:lnTo>
                  <a:pt x="2710" y="752"/>
                </a:lnTo>
                <a:lnTo>
                  <a:pt x="2662" y="752"/>
                </a:lnTo>
                <a:lnTo>
                  <a:pt x="2662" y="376"/>
                </a:lnTo>
                <a:lnTo>
                  <a:pt x="2686" y="400"/>
                </a:lnTo>
                <a:lnTo>
                  <a:pt x="24" y="400"/>
                </a:lnTo>
                <a:cubicBezTo>
                  <a:pt x="11" y="400"/>
                  <a:pt x="0" y="390"/>
                  <a:pt x="0" y="376"/>
                </a:cubicBezTo>
                <a:lnTo>
                  <a:pt x="0" y="0"/>
                </a:lnTo>
                <a:lnTo>
                  <a:pt x="48" y="0"/>
                </a:lnTo>
                <a:close/>
              </a:path>
            </a:pathLst>
          </a:custGeom>
          <a:solidFill>
            <a:srgbClr val="1B4171"/>
          </a:solidFill>
          <a:ln w="0" cap="flat">
            <a:solidFill>
              <a:srgbClr val="1B417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 sz="1100" b="1"/>
          </a:p>
        </p:txBody>
      </p:sp>
      <p:sp>
        <p:nvSpPr>
          <p:cNvPr id="23" name="Freeform 49"/>
          <p:cNvSpPr>
            <a:spLocks noEditPoints="1"/>
          </p:cNvSpPr>
          <p:nvPr/>
        </p:nvSpPr>
        <p:spPr bwMode="auto">
          <a:xfrm>
            <a:off x="7252667" y="3132082"/>
            <a:ext cx="847725" cy="571500"/>
          </a:xfrm>
          <a:custGeom>
            <a:avLst/>
            <a:gdLst/>
            <a:ahLst/>
            <a:cxnLst>
              <a:cxn ang="0">
                <a:pos x="1" y="112"/>
              </a:cxn>
              <a:cxn ang="0">
                <a:pos x="12" y="67"/>
              </a:cxn>
              <a:cxn ang="0">
                <a:pos x="38" y="32"/>
              </a:cxn>
              <a:cxn ang="0">
                <a:pos x="76" y="8"/>
              </a:cxn>
              <a:cxn ang="0">
                <a:pos x="116" y="0"/>
              </a:cxn>
              <a:cxn ang="0">
                <a:pos x="1314" y="1"/>
              </a:cxn>
              <a:cxn ang="0">
                <a:pos x="1359" y="12"/>
              </a:cxn>
              <a:cxn ang="0">
                <a:pos x="1395" y="38"/>
              </a:cxn>
              <a:cxn ang="0">
                <a:pos x="1417" y="76"/>
              </a:cxn>
              <a:cxn ang="0">
                <a:pos x="1424" y="116"/>
              </a:cxn>
              <a:cxn ang="0">
                <a:pos x="1424" y="850"/>
              </a:cxn>
              <a:cxn ang="0">
                <a:pos x="1414" y="895"/>
              </a:cxn>
              <a:cxn ang="0">
                <a:pos x="1388" y="931"/>
              </a:cxn>
              <a:cxn ang="0">
                <a:pos x="1350" y="953"/>
              </a:cxn>
              <a:cxn ang="0">
                <a:pos x="1309" y="960"/>
              </a:cxn>
              <a:cxn ang="0">
                <a:pos x="112" y="960"/>
              </a:cxn>
              <a:cxn ang="0">
                <a:pos x="67" y="950"/>
              </a:cxn>
              <a:cxn ang="0">
                <a:pos x="32" y="924"/>
              </a:cxn>
              <a:cxn ang="0">
                <a:pos x="8" y="886"/>
              </a:cxn>
              <a:cxn ang="0">
                <a:pos x="0" y="845"/>
              </a:cxn>
              <a:cxn ang="0">
                <a:pos x="48" y="845"/>
              </a:cxn>
              <a:cxn ang="0">
                <a:pos x="55" y="877"/>
              </a:cxn>
              <a:cxn ang="0">
                <a:pos x="71" y="897"/>
              </a:cxn>
              <a:cxn ang="0">
                <a:pos x="94" y="909"/>
              </a:cxn>
              <a:cxn ang="0">
                <a:pos x="121" y="913"/>
              </a:cxn>
              <a:cxn ang="0">
                <a:pos x="1309" y="912"/>
              </a:cxn>
              <a:cxn ang="0">
                <a:pos x="1341" y="906"/>
              </a:cxn>
              <a:cxn ang="0">
                <a:pos x="1361" y="890"/>
              </a:cxn>
              <a:cxn ang="0">
                <a:pos x="1373" y="868"/>
              </a:cxn>
              <a:cxn ang="0">
                <a:pos x="1377" y="841"/>
              </a:cxn>
              <a:cxn ang="0">
                <a:pos x="1376" y="116"/>
              </a:cxn>
              <a:cxn ang="0">
                <a:pos x="1370" y="85"/>
              </a:cxn>
              <a:cxn ang="0">
                <a:pos x="1354" y="65"/>
              </a:cxn>
              <a:cxn ang="0">
                <a:pos x="1332" y="51"/>
              </a:cxn>
              <a:cxn ang="0">
                <a:pos x="1305" y="48"/>
              </a:cxn>
              <a:cxn ang="0">
                <a:pos x="116" y="48"/>
              </a:cxn>
              <a:cxn ang="0">
                <a:pos x="85" y="55"/>
              </a:cxn>
              <a:cxn ang="0">
                <a:pos x="65" y="71"/>
              </a:cxn>
              <a:cxn ang="0">
                <a:pos x="51" y="94"/>
              </a:cxn>
              <a:cxn ang="0">
                <a:pos x="48" y="121"/>
              </a:cxn>
              <a:cxn ang="0">
                <a:pos x="48" y="845"/>
              </a:cxn>
            </a:cxnLst>
            <a:rect l="0" t="0" r="r" b="b"/>
            <a:pathLst>
              <a:path w="1424" h="960">
                <a:moveTo>
                  <a:pt x="0" y="116"/>
                </a:moveTo>
                <a:cubicBezTo>
                  <a:pt x="0" y="115"/>
                  <a:pt x="1" y="113"/>
                  <a:pt x="1" y="112"/>
                </a:cubicBezTo>
                <a:lnTo>
                  <a:pt x="8" y="76"/>
                </a:lnTo>
                <a:cubicBezTo>
                  <a:pt x="9" y="73"/>
                  <a:pt x="10" y="70"/>
                  <a:pt x="12" y="67"/>
                </a:cubicBezTo>
                <a:lnTo>
                  <a:pt x="32" y="38"/>
                </a:lnTo>
                <a:cubicBezTo>
                  <a:pt x="33" y="35"/>
                  <a:pt x="35" y="33"/>
                  <a:pt x="38" y="32"/>
                </a:cubicBezTo>
                <a:lnTo>
                  <a:pt x="67" y="12"/>
                </a:lnTo>
                <a:cubicBezTo>
                  <a:pt x="70" y="10"/>
                  <a:pt x="73" y="9"/>
                  <a:pt x="76" y="8"/>
                </a:cubicBezTo>
                <a:lnTo>
                  <a:pt x="112" y="1"/>
                </a:lnTo>
                <a:cubicBezTo>
                  <a:pt x="113" y="1"/>
                  <a:pt x="115" y="0"/>
                  <a:pt x="116" y="0"/>
                </a:cubicBezTo>
                <a:lnTo>
                  <a:pt x="1309" y="0"/>
                </a:lnTo>
                <a:cubicBezTo>
                  <a:pt x="1311" y="0"/>
                  <a:pt x="1313" y="1"/>
                  <a:pt x="1314" y="1"/>
                </a:cubicBezTo>
                <a:lnTo>
                  <a:pt x="1350" y="8"/>
                </a:lnTo>
                <a:cubicBezTo>
                  <a:pt x="1353" y="9"/>
                  <a:pt x="1356" y="10"/>
                  <a:pt x="1359" y="12"/>
                </a:cubicBezTo>
                <a:lnTo>
                  <a:pt x="1388" y="32"/>
                </a:lnTo>
                <a:cubicBezTo>
                  <a:pt x="1391" y="33"/>
                  <a:pt x="1393" y="36"/>
                  <a:pt x="1395" y="38"/>
                </a:cubicBezTo>
                <a:lnTo>
                  <a:pt x="1414" y="67"/>
                </a:lnTo>
                <a:cubicBezTo>
                  <a:pt x="1415" y="70"/>
                  <a:pt x="1416" y="73"/>
                  <a:pt x="1417" y="76"/>
                </a:cubicBezTo>
                <a:lnTo>
                  <a:pt x="1424" y="112"/>
                </a:lnTo>
                <a:cubicBezTo>
                  <a:pt x="1424" y="113"/>
                  <a:pt x="1424" y="115"/>
                  <a:pt x="1424" y="116"/>
                </a:cubicBezTo>
                <a:lnTo>
                  <a:pt x="1424" y="845"/>
                </a:lnTo>
                <a:cubicBezTo>
                  <a:pt x="1424" y="847"/>
                  <a:pt x="1424" y="849"/>
                  <a:pt x="1424" y="850"/>
                </a:cubicBezTo>
                <a:lnTo>
                  <a:pt x="1417" y="886"/>
                </a:lnTo>
                <a:cubicBezTo>
                  <a:pt x="1416" y="889"/>
                  <a:pt x="1415" y="892"/>
                  <a:pt x="1414" y="895"/>
                </a:cubicBezTo>
                <a:lnTo>
                  <a:pt x="1395" y="924"/>
                </a:lnTo>
                <a:cubicBezTo>
                  <a:pt x="1393" y="926"/>
                  <a:pt x="1390" y="929"/>
                  <a:pt x="1388" y="931"/>
                </a:cubicBezTo>
                <a:lnTo>
                  <a:pt x="1359" y="950"/>
                </a:lnTo>
                <a:cubicBezTo>
                  <a:pt x="1356" y="951"/>
                  <a:pt x="1353" y="952"/>
                  <a:pt x="1350" y="953"/>
                </a:cubicBezTo>
                <a:lnTo>
                  <a:pt x="1314" y="960"/>
                </a:lnTo>
                <a:cubicBezTo>
                  <a:pt x="1313" y="960"/>
                  <a:pt x="1311" y="960"/>
                  <a:pt x="1309" y="960"/>
                </a:cubicBezTo>
                <a:lnTo>
                  <a:pt x="116" y="960"/>
                </a:lnTo>
                <a:cubicBezTo>
                  <a:pt x="115" y="960"/>
                  <a:pt x="113" y="960"/>
                  <a:pt x="112" y="960"/>
                </a:cubicBezTo>
                <a:lnTo>
                  <a:pt x="76" y="953"/>
                </a:lnTo>
                <a:cubicBezTo>
                  <a:pt x="73" y="952"/>
                  <a:pt x="70" y="951"/>
                  <a:pt x="67" y="950"/>
                </a:cubicBezTo>
                <a:lnTo>
                  <a:pt x="38" y="931"/>
                </a:lnTo>
                <a:cubicBezTo>
                  <a:pt x="36" y="929"/>
                  <a:pt x="33" y="927"/>
                  <a:pt x="32" y="924"/>
                </a:cubicBezTo>
                <a:lnTo>
                  <a:pt x="12" y="895"/>
                </a:lnTo>
                <a:cubicBezTo>
                  <a:pt x="10" y="892"/>
                  <a:pt x="9" y="889"/>
                  <a:pt x="8" y="886"/>
                </a:cubicBezTo>
                <a:lnTo>
                  <a:pt x="1" y="850"/>
                </a:lnTo>
                <a:cubicBezTo>
                  <a:pt x="1" y="849"/>
                  <a:pt x="0" y="847"/>
                  <a:pt x="0" y="845"/>
                </a:cubicBezTo>
                <a:lnTo>
                  <a:pt x="0" y="116"/>
                </a:lnTo>
                <a:close/>
                <a:moveTo>
                  <a:pt x="48" y="845"/>
                </a:moveTo>
                <a:lnTo>
                  <a:pt x="48" y="841"/>
                </a:lnTo>
                <a:lnTo>
                  <a:pt x="55" y="877"/>
                </a:lnTo>
                <a:lnTo>
                  <a:pt x="51" y="868"/>
                </a:lnTo>
                <a:lnTo>
                  <a:pt x="71" y="897"/>
                </a:lnTo>
                <a:lnTo>
                  <a:pt x="65" y="890"/>
                </a:lnTo>
                <a:lnTo>
                  <a:pt x="94" y="909"/>
                </a:lnTo>
                <a:lnTo>
                  <a:pt x="85" y="906"/>
                </a:lnTo>
                <a:lnTo>
                  <a:pt x="121" y="913"/>
                </a:lnTo>
                <a:lnTo>
                  <a:pt x="116" y="912"/>
                </a:lnTo>
                <a:lnTo>
                  <a:pt x="1309" y="912"/>
                </a:lnTo>
                <a:lnTo>
                  <a:pt x="1305" y="913"/>
                </a:lnTo>
                <a:lnTo>
                  <a:pt x="1341" y="906"/>
                </a:lnTo>
                <a:lnTo>
                  <a:pt x="1332" y="909"/>
                </a:lnTo>
                <a:lnTo>
                  <a:pt x="1361" y="890"/>
                </a:lnTo>
                <a:lnTo>
                  <a:pt x="1354" y="897"/>
                </a:lnTo>
                <a:lnTo>
                  <a:pt x="1373" y="868"/>
                </a:lnTo>
                <a:lnTo>
                  <a:pt x="1370" y="877"/>
                </a:lnTo>
                <a:lnTo>
                  <a:pt x="1377" y="841"/>
                </a:lnTo>
                <a:lnTo>
                  <a:pt x="1376" y="845"/>
                </a:lnTo>
                <a:lnTo>
                  <a:pt x="1376" y="116"/>
                </a:lnTo>
                <a:lnTo>
                  <a:pt x="1377" y="121"/>
                </a:lnTo>
                <a:lnTo>
                  <a:pt x="1370" y="85"/>
                </a:lnTo>
                <a:lnTo>
                  <a:pt x="1373" y="94"/>
                </a:lnTo>
                <a:lnTo>
                  <a:pt x="1354" y="65"/>
                </a:lnTo>
                <a:lnTo>
                  <a:pt x="1361" y="71"/>
                </a:lnTo>
                <a:lnTo>
                  <a:pt x="1332" y="51"/>
                </a:lnTo>
                <a:lnTo>
                  <a:pt x="1341" y="55"/>
                </a:lnTo>
                <a:lnTo>
                  <a:pt x="1305" y="48"/>
                </a:lnTo>
                <a:lnTo>
                  <a:pt x="1309" y="48"/>
                </a:lnTo>
                <a:lnTo>
                  <a:pt x="116" y="48"/>
                </a:lnTo>
                <a:lnTo>
                  <a:pt x="121" y="48"/>
                </a:lnTo>
                <a:lnTo>
                  <a:pt x="85" y="55"/>
                </a:lnTo>
                <a:lnTo>
                  <a:pt x="94" y="51"/>
                </a:lnTo>
                <a:lnTo>
                  <a:pt x="65" y="71"/>
                </a:lnTo>
                <a:lnTo>
                  <a:pt x="71" y="65"/>
                </a:lnTo>
                <a:lnTo>
                  <a:pt x="51" y="94"/>
                </a:lnTo>
                <a:lnTo>
                  <a:pt x="55" y="85"/>
                </a:lnTo>
                <a:lnTo>
                  <a:pt x="48" y="121"/>
                </a:lnTo>
                <a:lnTo>
                  <a:pt x="48" y="116"/>
                </a:lnTo>
                <a:lnTo>
                  <a:pt x="48" y="845"/>
                </a:lnTo>
                <a:close/>
              </a:path>
            </a:pathLst>
          </a:custGeom>
          <a:solidFill>
            <a:srgbClr val="1B4171"/>
          </a:solidFill>
          <a:ln w="0" cap="flat">
            <a:solidFill>
              <a:srgbClr val="1B417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 sz="1100" b="1"/>
          </a:p>
        </p:txBody>
      </p:sp>
      <p:sp>
        <p:nvSpPr>
          <p:cNvPr id="68" name="Freeform 20"/>
          <p:cNvSpPr>
            <a:spLocks/>
          </p:cNvSpPr>
          <p:nvPr/>
        </p:nvSpPr>
        <p:spPr bwMode="auto">
          <a:xfrm>
            <a:off x="5922882" y="4799777"/>
            <a:ext cx="342082" cy="428824"/>
          </a:xfrm>
          <a:custGeom>
            <a:avLst/>
            <a:gdLst/>
            <a:ahLst/>
            <a:cxnLst>
              <a:cxn ang="0">
                <a:pos x="2710" y="0"/>
              </a:cxn>
              <a:cxn ang="0">
                <a:pos x="2710" y="376"/>
              </a:cxn>
              <a:cxn ang="0">
                <a:pos x="2686" y="400"/>
              </a:cxn>
              <a:cxn ang="0">
                <a:pos x="24" y="400"/>
              </a:cxn>
              <a:cxn ang="0">
                <a:pos x="48" y="376"/>
              </a:cxn>
              <a:cxn ang="0">
                <a:pos x="48" y="752"/>
              </a:cxn>
              <a:cxn ang="0">
                <a:pos x="0" y="752"/>
              </a:cxn>
              <a:cxn ang="0">
                <a:pos x="0" y="376"/>
              </a:cxn>
              <a:cxn ang="0">
                <a:pos x="24" y="352"/>
              </a:cxn>
              <a:cxn ang="0">
                <a:pos x="2686" y="352"/>
              </a:cxn>
              <a:cxn ang="0">
                <a:pos x="2662" y="376"/>
              </a:cxn>
              <a:cxn ang="0">
                <a:pos x="2662" y="0"/>
              </a:cxn>
              <a:cxn ang="0">
                <a:pos x="2710" y="0"/>
              </a:cxn>
            </a:cxnLst>
            <a:rect l="0" t="0" r="r" b="b"/>
            <a:pathLst>
              <a:path w="2710" h="752">
                <a:moveTo>
                  <a:pt x="2710" y="0"/>
                </a:moveTo>
                <a:lnTo>
                  <a:pt x="2710" y="376"/>
                </a:lnTo>
                <a:cubicBezTo>
                  <a:pt x="2710" y="390"/>
                  <a:pt x="2699" y="400"/>
                  <a:pt x="2686" y="400"/>
                </a:cubicBezTo>
                <a:lnTo>
                  <a:pt x="24" y="400"/>
                </a:lnTo>
                <a:lnTo>
                  <a:pt x="48" y="376"/>
                </a:lnTo>
                <a:lnTo>
                  <a:pt x="48" y="752"/>
                </a:lnTo>
                <a:lnTo>
                  <a:pt x="0" y="752"/>
                </a:lnTo>
                <a:lnTo>
                  <a:pt x="0" y="376"/>
                </a:lnTo>
                <a:cubicBezTo>
                  <a:pt x="0" y="363"/>
                  <a:pt x="11" y="352"/>
                  <a:pt x="24" y="352"/>
                </a:cubicBezTo>
                <a:lnTo>
                  <a:pt x="2686" y="352"/>
                </a:lnTo>
                <a:lnTo>
                  <a:pt x="2662" y="376"/>
                </a:lnTo>
                <a:lnTo>
                  <a:pt x="2662" y="0"/>
                </a:lnTo>
                <a:lnTo>
                  <a:pt x="2710" y="0"/>
                </a:lnTo>
                <a:close/>
              </a:path>
            </a:pathLst>
          </a:custGeom>
          <a:solidFill>
            <a:srgbClr val="1B4171"/>
          </a:solidFill>
          <a:ln w="0" cap="flat">
            <a:solidFill>
              <a:srgbClr val="1B417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 sz="1100" b="1"/>
          </a:p>
        </p:txBody>
      </p:sp>
      <p:sp>
        <p:nvSpPr>
          <p:cNvPr id="69" name="Freeform 22"/>
          <p:cNvSpPr>
            <a:spLocks noEditPoints="1"/>
          </p:cNvSpPr>
          <p:nvPr/>
        </p:nvSpPr>
        <p:spPr bwMode="auto">
          <a:xfrm>
            <a:off x="5424470" y="5229200"/>
            <a:ext cx="731706" cy="360040"/>
          </a:xfrm>
          <a:custGeom>
            <a:avLst/>
            <a:gdLst/>
            <a:ahLst/>
            <a:cxnLst>
              <a:cxn ang="0">
                <a:pos x="1" y="112"/>
              </a:cxn>
              <a:cxn ang="0">
                <a:pos x="12" y="67"/>
              </a:cxn>
              <a:cxn ang="0">
                <a:pos x="38" y="32"/>
              </a:cxn>
              <a:cxn ang="0">
                <a:pos x="76" y="8"/>
              </a:cxn>
              <a:cxn ang="0">
                <a:pos x="116" y="0"/>
              </a:cxn>
              <a:cxn ang="0">
                <a:pos x="1298" y="1"/>
              </a:cxn>
              <a:cxn ang="0">
                <a:pos x="1343" y="12"/>
              </a:cxn>
              <a:cxn ang="0">
                <a:pos x="1379" y="38"/>
              </a:cxn>
              <a:cxn ang="0">
                <a:pos x="1401" y="76"/>
              </a:cxn>
              <a:cxn ang="0">
                <a:pos x="1408" y="116"/>
              </a:cxn>
              <a:cxn ang="0">
                <a:pos x="1408" y="850"/>
              </a:cxn>
              <a:cxn ang="0">
                <a:pos x="1398" y="895"/>
              </a:cxn>
              <a:cxn ang="0">
                <a:pos x="1372" y="931"/>
              </a:cxn>
              <a:cxn ang="0">
                <a:pos x="1334" y="953"/>
              </a:cxn>
              <a:cxn ang="0">
                <a:pos x="1293" y="960"/>
              </a:cxn>
              <a:cxn ang="0">
                <a:pos x="112" y="960"/>
              </a:cxn>
              <a:cxn ang="0">
                <a:pos x="67" y="950"/>
              </a:cxn>
              <a:cxn ang="0">
                <a:pos x="32" y="924"/>
              </a:cxn>
              <a:cxn ang="0">
                <a:pos x="8" y="886"/>
              </a:cxn>
              <a:cxn ang="0">
                <a:pos x="0" y="845"/>
              </a:cxn>
              <a:cxn ang="0">
                <a:pos x="48" y="845"/>
              </a:cxn>
              <a:cxn ang="0">
                <a:pos x="55" y="877"/>
              </a:cxn>
              <a:cxn ang="0">
                <a:pos x="71" y="897"/>
              </a:cxn>
              <a:cxn ang="0">
                <a:pos x="94" y="909"/>
              </a:cxn>
              <a:cxn ang="0">
                <a:pos x="121" y="913"/>
              </a:cxn>
              <a:cxn ang="0">
                <a:pos x="1293" y="912"/>
              </a:cxn>
              <a:cxn ang="0">
                <a:pos x="1325" y="906"/>
              </a:cxn>
              <a:cxn ang="0">
                <a:pos x="1345" y="890"/>
              </a:cxn>
              <a:cxn ang="0">
                <a:pos x="1357" y="868"/>
              </a:cxn>
              <a:cxn ang="0">
                <a:pos x="1361" y="841"/>
              </a:cxn>
              <a:cxn ang="0">
                <a:pos x="1360" y="116"/>
              </a:cxn>
              <a:cxn ang="0">
                <a:pos x="1354" y="85"/>
              </a:cxn>
              <a:cxn ang="0">
                <a:pos x="1338" y="65"/>
              </a:cxn>
              <a:cxn ang="0">
                <a:pos x="1316" y="51"/>
              </a:cxn>
              <a:cxn ang="0">
                <a:pos x="1289" y="48"/>
              </a:cxn>
              <a:cxn ang="0">
                <a:pos x="116" y="48"/>
              </a:cxn>
              <a:cxn ang="0">
                <a:pos x="85" y="55"/>
              </a:cxn>
              <a:cxn ang="0">
                <a:pos x="65" y="71"/>
              </a:cxn>
              <a:cxn ang="0">
                <a:pos x="51" y="94"/>
              </a:cxn>
              <a:cxn ang="0">
                <a:pos x="48" y="121"/>
              </a:cxn>
              <a:cxn ang="0">
                <a:pos x="48" y="845"/>
              </a:cxn>
            </a:cxnLst>
            <a:rect l="0" t="0" r="r" b="b"/>
            <a:pathLst>
              <a:path w="1408" h="960">
                <a:moveTo>
                  <a:pt x="0" y="116"/>
                </a:moveTo>
                <a:cubicBezTo>
                  <a:pt x="0" y="115"/>
                  <a:pt x="1" y="113"/>
                  <a:pt x="1" y="112"/>
                </a:cubicBezTo>
                <a:lnTo>
                  <a:pt x="8" y="76"/>
                </a:lnTo>
                <a:cubicBezTo>
                  <a:pt x="9" y="73"/>
                  <a:pt x="10" y="70"/>
                  <a:pt x="12" y="67"/>
                </a:cubicBezTo>
                <a:lnTo>
                  <a:pt x="32" y="38"/>
                </a:lnTo>
                <a:cubicBezTo>
                  <a:pt x="33" y="35"/>
                  <a:pt x="35" y="33"/>
                  <a:pt x="38" y="32"/>
                </a:cubicBezTo>
                <a:lnTo>
                  <a:pt x="67" y="12"/>
                </a:lnTo>
                <a:cubicBezTo>
                  <a:pt x="70" y="10"/>
                  <a:pt x="73" y="9"/>
                  <a:pt x="76" y="8"/>
                </a:cubicBezTo>
                <a:lnTo>
                  <a:pt x="112" y="1"/>
                </a:lnTo>
                <a:cubicBezTo>
                  <a:pt x="113" y="1"/>
                  <a:pt x="115" y="0"/>
                  <a:pt x="116" y="0"/>
                </a:cubicBezTo>
                <a:lnTo>
                  <a:pt x="1293" y="0"/>
                </a:lnTo>
                <a:cubicBezTo>
                  <a:pt x="1295" y="0"/>
                  <a:pt x="1297" y="1"/>
                  <a:pt x="1298" y="1"/>
                </a:cubicBezTo>
                <a:lnTo>
                  <a:pt x="1334" y="8"/>
                </a:lnTo>
                <a:cubicBezTo>
                  <a:pt x="1337" y="9"/>
                  <a:pt x="1340" y="10"/>
                  <a:pt x="1343" y="12"/>
                </a:cubicBezTo>
                <a:lnTo>
                  <a:pt x="1372" y="32"/>
                </a:lnTo>
                <a:cubicBezTo>
                  <a:pt x="1375" y="33"/>
                  <a:pt x="1377" y="36"/>
                  <a:pt x="1379" y="38"/>
                </a:cubicBezTo>
                <a:lnTo>
                  <a:pt x="1398" y="67"/>
                </a:lnTo>
                <a:cubicBezTo>
                  <a:pt x="1399" y="70"/>
                  <a:pt x="1400" y="73"/>
                  <a:pt x="1401" y="76"/>
                </a:cubicBezTo>
                <a:lnTo>
                  <a:pt x="1408" y="112"/>
                </a:lnTo>
                <a:cubicBezTo>
                  <a:pt x="1408" y="113"/>
                  <a:pt x="1408" y="115"/>
                  <a:pt x="1408" y="116"/>
                </a:cubicBezTo>
                <a:lnTo>
                  <a:pt x="1408" y="845"/>
                </a:lnTo>
                <a:cubicBezTo>
                  <a:pt x="1408" y="847"/>
                  <a:pt x="1408" y="849"/>
                  <a:pt x="1408" y="850"/>
                </a:cubicBezTo>
                <a:lnTo>
                  <a:pt x="1401" y="886"/>
                </a:lnTo>
                <a:cubicBezTo>
                  <a:pt x="1400" y="889"/>
                  <a:pt x="1399" y="892"/>
                  <a:pt x="1398" y="895"/>
                </a:cubicBezTo>
                <a:lnTo>
                  <a:pt x="1379" y="924"/>
                </a:lnTo>
                <a:cubicBezTo>
                  <a:pt x="1377" y="926"/>
                  <a:pt x="1374" y="929"/>
                  <a:pt x="1372" y="931"/>
                </a:cubicBezTo>
                <a:lnTo>
                  <a:pt x="1343" y="950"/>
                </a:lnTo>
                <a:cubicBezTo>
                  <a:pt x="1340" y="951"/>
                  <a:pt x="1337" y="952"/>
                  <a:pt x="1334" y="953"/>
                </a:cubicBezTo>
                <a:lnTo>
                  <a:pt x="1298" y="960"/>
                </a:lnTo>
                <a:cubicBezTo>
                  <a:pt x="1297" y="960"/>
                  <a:pt x="1295" y="960"/>
                  <a:pt x="1293" y="960"/>
                </a:cubicBezTo>
                <a:lnTo>
                  <a:pt x="116" y="960"/>
                </a:lnTo>
                <a:cubicBezTo>
                  <a:pt x="115" y="960"/>
                  <a:pt x="113" y="960"/>
                  <a:pt x="112" y="960"/>
                </a:cubicBezTo>
                <a:lnTo>
                  <a:pt x="76" y="953"/>
                </a:lnTo>
                <a:cubicBezTo>
                  <a:pt x="73" y="952"/>
                  <a:pt x="70" y="951"/>
                  <a:pt x="67" y="950"/>
                </a:cubicBezTo>
                <a:lnTo>
                  <a:pt x="38" y="931"/>
                </a:lnTo>
                <a:cubicBezTo>
                  <a:pt x="36" y="929"/>
                  <a:pt x="33" y="927"/>
                  <a:pt x="32" y="924"/>
                </a:cubicBezTo>
                <a:lnTo>
                  <a:pt x="12" y="895"/>
                </a:lnTo>
                <a:cubicBezTo>
                  <a:pt x="10" y="892"/>
                  <a:pt x="9" y="889"/>
                  <a:pt x="8" y="886"/>
                </a:cubicBezTo>
                <a:lnTo>
                  <a:pt x="1" y="850"/>
                </a:lnTo>
                <a:cubicBezTo>
                  <a:pt x="1" y="849"/>
                  <a:pt x="0" y="847"/>
                  <a:pt x="0" y="845"/>
                </a:cubicBezTo>
                <a:lnTo>
                  <a:pt x="0" y="116"/>
                </a:lnTo>
                <a:close/>
                <a:moveTo>
                  <a:pt x="48" y="845"/>
                </a:moveTo>
                <a:lnTo>
                  <a:pt x="48" y="841"/>
                </a:lnTo>
                <a:lnTo>
                  <a:pt x="55" y="877"/>
                </a:lnTo>
                <a:lnTo>
                  <a:pt x="51" y="868"/>
                </a:lnTo>
                <a:lnTo>
                  <a:pt x="71" y="897"/>
                </a:lnTo>
                <a:lnTo>
                  <a:pt x="65" y="890"/>
                </a:lnTo>
                <a:lnTo>
                  <a:pt x="94" y="909"/>
                </a:lnTo>
                <a:lnTo>
                  <a:pt x="85" y="906"/>
                </a:lnTo>
                <a:lnTo>
                  <a:pt x="121" y="913"/>
                </a:lnTo>
                <a:lnTo>
                  <a:pt x="116" y="912"/>
                </a:lnTo>
                <a:lnTo>
                  <a:pt x="1293" y="912"/>
                </a:lnTo>
                <a:lnTo>
                  <a:pt x="1289" y="913"/>
                </a:lnTo>
                <a:lnTo>
                  <a:pt x="1325" y="906"/>
                </a:lnTo>
                <a:lnTo>
                  <a:pt x="1316" y="909"/>
                </a:lnTo>
                <a:lnTo>
                  <a:pt x="1345" y="890"/>
                </a:lnTo>
                <a:lnTo>
                  <a:pt x="1338" y="897"/>
                </a:lnTo>
                <a:lnTo>
                  <a:pt x="1357" y="868"/>
                </a:lnTo>
                <a:lnTo>
                  <a:pt x="1354" y="877"/>
                </a:lnTo>
                <a:lnTo>
                  <a:pt x="1361" y="841"/>
                </a:lnTo>
                <a:lnTo>
                  <a:pt x="1360" y="845"/>
                </a:lnTo>
                <a:lnTo>
                  <a:pt x="1360" y="116"/>
                </a:lnTo>
                <a:lnTo>
                  <a:pt x="1361" y="121"/>
                </a:lnTo>
                <a:lnTo>
                  <a:pt x="1354" y="85"/>
                </a:lnTo>
                <a:lnTo>
                  <a:pt x="1357" y="94"/>
                </a:lnTo>
                <a:lnTo>
                  <a:pt x="1338" y="65"/>
                </a:lnTo>
                <a:lnTo>
                  <a:pt x="1345" y="71"/>
                </a:lnTo>
                <a:lnTo>
                  <a:pt x="1316" y="51"/>
                </a:lnTo>
                <a:lnTo>
                  <a:pt x="1325" y="55"/>
                </a:lnTo>
                <a:lnTo>
                  <a:pt x="1289" y="48"/>
                </a:lnTo>
                <a:lnTo>
                  <a:pt x="1293" y="48"/>
                </a:lnTo>
                <a:lnTo>
                  <a:pt x="116" y="48"/>
                </a:lnTo>
                <a:lnTo>
                  <a:pt x="121" y="48"/>
                </a:lnTo>
                <a:lnTo>
                  <a:pt x="85" y="55"/>
                </a:lnTo>
                <a:lnTo>
                  <a:pt x="94" y="51"/>
                </a:lnTo>
                <a:lnTo>
                  <a:pt x="65" y="71"/>
                </a:lnTo>
                <a:lnTo>
                  <a:pt x="71" y="65"/>
                </a:lnTo>
                <a:lnTo>
                  <a:pt x="51" y="94"/>
                </a:lnTo>
                <a:lnTo>
                  <a:pt x="55" y="85"/>
                </a:lnTo>
                <a:lnTo>
                  <a:pt x="48" y="121"/>
                </a:lnTo>
                <a:lnTo>
                  <a:pt x="48" y="116"/>
                </a:lnTo>
                <a:lnTo>
                  <a:pt x="48" y="845"/>
                </a:lnTo>
                <a:close/>
              </a:path>
            </a:pathLst>
          </a:custGeom>
          <a:solidFill>
            <a:srgbClr val="1B4171"/>
          </a:solidFill>
          <a:ln w="0" cap="flat">
            <a:solidFill>
              <a:srgbClr val="1B417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 sz="1100" b="1"/>
          </a:p>
        </p:txBody>
      </p:sp>
      <p:sp>
        <p:nvSpPr>
          <p:cNvPr id="70" name="Freeform 47"/>
          <p:cNvSpPr>
            <a:spLocks/>
          </p:cNvSpPr>
          <p:nvPr/>
        </p:nvSpPr>
        <p:spPr bwMode="auto">
          <a:xfrm>
            <a:off x="6242739" y="4791961"/>
            <a:ext cx="328215" cy="447675"/>
          </a:xfrm>
          <a:custGeom>
            <a:avLst/>
            <a:gdLst/>
            <a:ahLst/>
            <a:cxnLst>
              <a:cxn ang="0">
                <a:pos x="48" y="0"/>
              </a:cxn>
              <a:cxn ang="0">
                <a:pos x="48" y="376"/>
              </a:cxn>
              <a:cxn ang="0">
                <a:pos x="24" y="352"/>
              </a:cxn>
              <a:cxn ang="0">
                <a:pos x="2686" y="352"/>
              </a:cxn>
              <a:cxn ang="0">
                <a:pos x="2710" y="376"/>
              </a:cxn>
              <a:cxn ang="0">
                <a:pos x="2710" y="752"/>
              </a:cxn>
              <a:cxn ang="0">
                <a:pos x="2662" y="752"/>
              </a:cxn>
              <a:cxn ang="0">
                <a:pos x="2662" y="376"/>
              </a:cxn>
              <a:cxn ang="0">
                <a:pos x="2686" y="400"/>
              </a:cxn>
              <a:cxn ang="0">
                <a:pos x="24" y="400"/>
              </a:cxn>
              <a:cxn ang="0">
                <a:pos x="0" y="376"/>
              </a:cxn>
              <a:cxn ang="0">
                <a:pos x="0" y="0"/>
              </a:cxn>
              <a:cxn ang="0">
                <a:pos x="48" y="0"/>
              </a:cxn>
            </a:cxnLst>
            <a:rect l="0" t="0" r="r" b="b"/>
            <a:pathLst>
              <a:path w="2710" h="752">
                <a:moveTo>
                  <a:pt x="48" y="0"/>
                </a:moveTo>
                <a:lnTo>
                  <a:pt x="48" y="376"/>
                </a:lnTo>
                <a:lnTo>
                  <a:pt x="24" y="352"/>
                </a:lnTo>
                <a:lnTo>
                  <a:pt x="2686" y="352"/>
                </a:lnTo>
                <a:cubicBezTo>
                  <a:pt x="2699" y="352"/>
                  <a:pt x="2710" y="363"/>
                  <a:pt x="2710" y="376"/>
                </a:cubicBezTo>
                <a:lnTo>
                  <a:pt x="2710" y="752"/>
                </a:lnTo>
                <a:lnTo>
                  <a:pt x="2662" y="752"/>
                </a:lnTo>
                <a:lnTo>
                  <a:pt x="2662" y="376"/>
                </a:lnTo>
                <a:lnTo>
                  <a:pt x="2686" y="400"/>
                </a:lnTo>
                <a:lnTo>
                  <a:pt x="24" y="400"/>
                </a:lnTo>
                <a:cubicBezTo>
                  <a:pt x="11" y="400"/>
                  <a:pt x="0" y="390"/>
                  <a:pt x="0" y="376"/>
                </a:cubicBezTo>
                <a:lnTo>
                  <a:pt x="0" y="0"/>
                </a:lnTo>
                <a:lnTo>
                  <a:pt x="48" y="0"/>
                </a:lnTo>
                <a:close/>
              </a:path>
            </a:pathLst>
          </a:custGeom>
          <a:solidFill>
            <a:srgbClr val="1B4171"/>
          </a:solidFill>
          <a:ln w="0" cap="flat">
            <a:solidFill>
              <a:srgbClr val="1B417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 sz="1100" b="1"/>
          </a:p>
        </p:txBody>
      </p:sp>
      <p:cxnSp>
        <p:nvCxnSpPr>
          <p:cNvPr id="71" name="70 Conector recto"/>
          <p:cNvCxnSpPr/>
          <p:nvPr/>
        </p:nvCxnSpPr>
        <p:spPr>
          <a:xfrm>
            <a:off x="6254044" y="3670902"/>
            <a:ext cx="0" cy="576064"/>
          </a:xfrm>
          <a:prstGeom prst="line">
            <a:avLst/>
          </a:prstGeom>
          <a:ln w="28575">
            <a:solidFill>
              <a:schemeClr val="accent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2" name="Freeform 22"/>
          <p:cNvSpPr>
            <a:spLocks noEditPoints="1"/>
          </p:cNvSpPr>
          <p:nvPr/>
        </p:nvSpPr>
        <p:spPr bwMode="auto">
          <a:xfrm>
            <a:off x="6207601" y="5229200"/>
            <a:ext cx="731706" cy="360040"/>
          </a:xfrm>
          <a:custGeom>
            <a:avLst/>
            <a:gdLst/>
            <a:ahLst/>
            <a:cxnLst>
              <a:cxn ang="0">
                <a:pos x="1" y="112"/>
              </a:cxn>
              <a:cxn ang="0">
                <a:pos x="12" y="67"/>
              </a:cxn>
              <a:cxn ang="0">
                <a:pos x="38" y="32"/>
              </a:cxn>
              <a:cxn ang="0">
                <a:pos x="76" y="8"/>
              </a:cxn>
              <a:cxn ang="0">
                <a:pos x="116" y="0"/>
              </a:cxn>
              <a:cxn ang="0">
                <a:pos x="1298" y="1"/>
              </a:cxn>
              <a:cxn ang="0">
                <a:pos x="1343" y="12"/>
              </a:cxn>
              <a:cxn ang="0">
                <a:pos x="1379" y="38"/>
              </a:cxn>
              <a:cxn ang="0">
                <a:pos x="1401" y="76"/>
              </a:cxn>
              <a:cxn ang="0">
                <a:pos x="1408" y="116"/>
              </a:cxn>
              <a:cxn ang="0">
                <a:pos x="1408" y="850"/>
              </a:cxn>
              <a:cxn ang="0">
                <a:pos x="1398" y="895"/>
              </a:cxn>
              <a:cxn ang="0">
                <a:pos x="1372" y="931"/>
              </a:cxn>
              <a:cxn ang="0">
                <a:pos x="1334" y="953"/>
              </a:cxn>
              <a:cxn ang="0">
                <a:pos x="1293" y="960"/>
              </a:cxn>
              <a:cxn ang="0">
                <a:pos x="112" y="960"/>
              </a:cxn>
              <a:cxn ang="0">
                <a:pos x="67" y="950"/>
              </a:cxn>
              <a:cxn ang="0">
                <a:pos x="32" y="924"/>
              </a:cxn>
              <a:cxn ang="0">
                <a:pos x="8" y="886"/>
              </a:cxn>
              <a:cxn ang="0">
                <a:pos x="0" y="845"/>
              </a:cxn>
              <a:cxn ang="0">
                <a:pos x="48" y="845"/>
              </a:cxn>
              <a:cxn ang="0">
                <a:pos x="55" y="877"/>
              </a:cxn>
              <a:cxn ang="0">
                <a:pos x="71" y="897"/>
              </a:cxn>
              <a:cxn ang="0">
                <a:pos x="94" y="909"/>
              </a:cxn>
              <a:cxn ang="0">
                <a:pos x="121" y="913"/>
              </a:cxn>
              <a:cxn ang="0">
                <a:pos x="1293" y="912"/>
              </a:cxn>
              <a:cxn ang="0">
                <a:pos x="1325" y="906"/>
              </a:cxn>
              <a:cxn ang="0">
                <a:pos x="1345" y="890"/>
              </a:cxn>
              <a:cxn ang="0">
                <a:pos x="1357" y="868"/>
              </a:cxn>
              <a:cxn ang="0">
                <a:pos x="1361" y="841"/>
              </a:cxn>
              <a:cxn ang="0">
                <a:pos x="1360" y="116"/>
              </a:cxn>
              <a:cxn ang="0">
                <a:pos x="1354" y="85"/>
              </a:cxn>
              <a:cxn ang="0">
                <a:pos x="1338" y="65"/>
              </a:cxn>
              <a:cxn ang="0">
                <a:pos x="1316" y="51"/>
              </a:cxn>
              <a:cxn ang="0">
                <a:pos x="1289" y="48"/>
              </a:cxn>
              <a:cxn ang="0">
                <a:pos x="116" y="48"/>
              </a:cxn>
              <a:cxn ang="0">
                <a:pos x="85" y="55"/>
              </a:cxn>
              <a:cxn ang="0">
                <a:pos x="65" y="71"/>
              </a:cxn>
              <a:cxn ang="0">
                <a:pos x="51" y="94"/>
              </a:cxn>
              <a:cxn ang="0">
                <a:pos x="48" y="121"/>
              </a:cxn>
              <a:cxn ang="0">
                <a:pos x="48" y="845"/>
              </a:cxn>
            </a:cxnLst>
            <a:rect l="0" t="0" r="r" b="b"/>
            <a:pathLst>
              <a:path w="1408" h="960">
                <a:moveTo>
                  <a:pt x="0" y="116"/>
                </a:moveTo>
                <a:cubicBezTo>
                  <a:pt x="0" y="115"/>
                  <a:pt x="1" y="113"/>
                  <a:pt x="1" y="112"/>
                </a:cubicBezTo>
                <a:lnTo>
                  <a:pt x="8" y="76"/>
                </a:lnTo>
                <a:cubicBezTo>
                  <a:pt x="9" y="73"/>
                  <a:pt x="10" y="70"/>
                  <a:pt x="12" y="67"/>
                </a:cubicBezTo>
                <a:lnTo>
                  <a:pt x="32" y="38"/>
                </a:lnTo>
                <a:cubicBezTo>
                  <a:pt x="33" y="35"/>
                  <a:pt x="35" y="33"/>
                  <a:pt x="38" y="32"/>
                </a:cubicBezTo>
                <a:lnTo>
                  <a:pt x="67" y="12"/>
                </a:lnTo>
                <a:cubicBezTo>
                  <a:pt x="70" y="10"/>
                  <a:pt x="73" y="9"/>
                  <a:pt x="76" y="8"/>
                </a:cubicBezTo>
                <a:lnTo>
                  <a:pt x="112" y="1"/>
                </a:lnTo>
                <a:cubicBezTo>
                  <a:pt x="113" y="1"/>
                  <a:pt x="115" y="0"/>
                  <a:pt x="116" y="0"/>
                </a:cubicBezTo>
                <a:lnTo>
                  <a:pt x="1293" y="0"/>
                </a:lnTo>
                <a:cubicBezTo>
                  <a:pt x="1295" y="0"/>
                  <a:pt x="1297" y="1"/>
                  <a:pt x="1298" y="1"/>
                </a:cubicBezTo>
                <a:lnTo>
                  <a:pt x="1334" y="8"/>
                </a:lnTo>
                <a:cubicBezTo>
                  <a:pt x="1337" y="9"/>
                  <a:pt x="1340" y="10"/>
                  <a:pt x="1343" y="12"/>
                </a:cubicBezTo>
                <a:lnTo>
                  <a:pt x="1372" y="32"/>
                </a:lnTo>
                <a:cubicBezTo>
                  <a:pt x="1375" y="33"/>
                  <a:pt x="1377" y="36"/>
                  <a:pt x="1379" y="38"/>
                </a:cubicBezTo>
                <a:lnTo>
                  <a:pt x="1398" y="67"/>
                </a:lnTo>
                <a:cubicBezTo>
                  <a:pt x="1399" y="70"/>
                  <a:pt x="1400" y="73"/>
                  <a:pt x="1401" y="76"/>
                </a:cubicBezTo>
                <a:lnTo>
                  <a:pt x="1408" y="112"/>
                </a:lnTo>
                <a:cubicBezTo>
                  <a:pt x="1408" y="113"/>
                  <a:pt x="1408" y="115"/>
                  <a:pt x="1408" y="116"/>
                </a:cubicBezTo>
                <a:lnTo>
                  <a:pt x="1408" y="845"/>
                </a:lnTo>
                <a:cubicBezTo>
                  <a:pt x="1408" y="847"/>
                  <a:pt x="1408" y="849"/>
                  <a:pt x="1408" y="850"/>
                </a:cubicBezTo>
                <a:lnTo>
                  <a:pt x="1401" y="886"/>
                </a:lnTo>
                <a:cubicBezTo>
                  <a:pt x="1400" y="889"/>
                  <a:pt x="1399" y="892"/>
                  <a:pt x="1398" y="895"/>
                </a:cubicBezTo>
                <a:lnTo>
                  <a:pt x="1379" y="924"/>
                </a:lnTo>
                <a:cubicBezTo>
                  <a:pt x="1377" y="926"/>
                  <a:pt x="1374" y="929"/>
                  <a:pt x="1372" y="931"/>
                </a:cubicBezTo>
                <a:lnTo>
                  <a:pt x="1343" y="950"/>
                </a:lnTo>
                <a:cubicBezTo>
                  <a:pt x="1340" y="951"/>
                  <a:pt x="1337" y="952"/>
                  <a:pt x="1334" y="953"/>
                </a:cubicBezTo>
                <a:lnTo>
                  <a:pt x="1298" y="960"/>
                </a:lnTo>
                <a:cubicBezTo>
                  <a:pt x="1297" y="960"/>
                  <a:pt x="1295" y="960"/>
                  <a:pt x="1293" y="960"/>
                </a:cubicBezTo>
                <a:lnTo>
                  <a:pt x="116" y="960"/>
                </a:lnTo>
                <a:cubicBezTo>
                  <a:pt x="115" y="960"/>
                  <a:pt x="113" y="960"/>
                  <a:pt x="112" y="960"/>
                </a:cubicBezTo>
                <a:lnTo>
                  <a:pt x="76" y="953"/>
                </a:lnTo>
                <a:cubicBezTo>
                  <a:pt x="73" y="952"/>
                  <a:pt x="70" y="951"/>
                  <a:pt x="67" y="950"/>
                </a:cubicBezTo>
                <a:lnTo>
                  <a:pt x="38" y="931"/>
                </a:lnTo>
                <a:cubicBezTo>
                  <a:pt x="36" y="929"/>
                  <a:pt x="33" y="927"/>
                  <a:pt x="32" y="924"/>
                </a:cubicBezTo>
                <a:lnTo>
                  <a:pt x="12" y="895"/>
                </a:lnTo>
                <a:cubicBezTo>
                  <a:pt x="10" y="892"/>
                  <a:pt x="9" y="889"/>
                  <a:pt x="8" y="886"/>
                </a:cubicBezTo>
                <a:lnTo>
                  <a:pt x="1" y="850"/>
                </a:lnTo>
                <a:cubicBezTo>
                  <a:pt x="1" y="849"/>
                  <a:pt x="0" y="847"/>
                  <a:pt x="0" y="845"/>
                </a:cubicBezTo>
                <a:lnTo>
                  <a:pt x="0" y="116"/>
                </a:lnTo>
                <a:close/>
                <a:moveTo>
                  <a:pt x="48" y="845"/>
                </a:moveTo>
                <a:lnTo>
                  <a:pt x="48" y="841"/>
                </a:lnTo>
                <a:lnTo>
                  <a:pt x="55" y="877"/>
                </a:lnTo>
                <a:lnTo>
                  <a:pt x="51" y="868"/>
                </a:lnTo>
                <a:lnTo>
                  <a:pt x="71" y="897"/>
                </a:lnTo>
                <a:lnTo>
                  <a:pt x="65" y="890"/>
                </a:lnTo>
                <a:lnTo>
                  <a:pt x="94" y="909"/>
                </a:lnTo>
                <a:lnTo>
                  <a:pt x="85" y="906"/>
                </a:lnTo>
                <a:lnTo>
                  <a:pt x="121" y="913"/>
                </a:lnTo>
                <a:lnTo>
                  <a:pt x="116" y="912"/>
                </a:lnTo>
                <a:lnTo>
                  <a:pt x="1293" y="912"/>
                </a:lnTo>
                <a:lnTo>
                  <a:pt x="1289" y="913"/>
                </a:lnTo>
                <a:lnTo>
                  <a:pt x="1325" y="906"/>
                </a:lnTo>
                <a:lnTo>
                  <a:pt x="1316" y="909"/>
                </a:lnTo>
                <a:lnTo>
                  <a:pt x="1345" y="890"/>
                </a:lnTo>
                <a:lnTo>
                  <a:pt x="1338" y="897"/>
                </a:lnTo>
                <a:lnTo>
                  <a:pt x="1357" y="868"/>
                </a:lnTo>
                <a:lnTo>
                  <a:pt x="1354" y="877"/>
                </a:lnTo>
                <a:lnTo>
                  <a:pt x="1361" y="841"/>
                </a:lnTo>
                <a:lnTo>
                  <a:pt x="1360" y="845"/>
                </a:lnTo>
                <a:lnTo>
                  <a:pt x="1360" y="116"/>
                </a:lnTo>
                <a:lnTo>
                  <a:pt x="1361" y="121"/>
                </a:lnTo>
                <a:lnTo>
                  <a:pt x="1354" y="85"/>
                </a:lnTo>
                <a:lnTo>
                  <a:pt x="1357" y="94"/>
                </a:lnTo>
                <a:lnTo>
                  <a:pt x="1338" y="65"/>
                </a:lnTo>
                <a:lnTo>
                  <a:pt x="1345" y="71"/>
                </a:lnTo>
                <a:lnTo>
                  <a:pt x="1316" y="51"/>
                </a:lnTo>
                <a:lnTo>
                  <a:pt x="1325" y="55"/>
                </a:lnTo>
                <a:lnTo>
                  <a:pt x="1289" y="48"/>
                </a:lnTo>
                <a:lnTo>
                  <a:pt x="1293" y="48"/>
                </a:lnTo>
                <a:lnTo>
                  <a:pt x="116" y="48"/>
                </a:lnTo>
                <a:lnTo>
                  <a:pt x="121" y="48"/>
                </a:lnTo>
                <a:lnTo>
                  <a:pt x="85" y="55"/>
                </a:lnTo>
                <a:lnTo>
                  <a:pt x="94" y="51"/>
                </a:lnTo>
                <a:lnTo>
                  <a:pt x="65" y="71"/>
                </a:lnTo>
                <a:lnTo>
                  <a:pt x="71" y="65"/>
                </a:lnTo>
                <a:lnTo>
                  <a:pt x="51" y="94"/>
                </a:lnTo>
                <a:lnTo>
                  <a:pt x="55" y="85"/>
                </a:lnTo>
                <a:lnTo>
                  <a:pt x="48" y="121"/>
                </a:lnTo>
                <a:lnTo>
                  <a:pt x="48" y="116"/>
                </a:lnTo>
                <a:lnTo>
                  <a:pt x="48" y="845"/>
                </a:lnTo>
                <a:close/>
              </a:path>
            </a:pathLst>
          </a:custGeom>
          <a:solidFill>
            <a:srgbClr val="1B4171"/>
          </a:solidFill>
          <a:ln w="0" cap="flat">
            <a:solidFill>
              <a:srgbClr val="1B417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 sz="1100" b="1"/>
          </a:p>
        </p:txBody>
      </p:sp>
      <p:sp>
        <p:nvSpPr>
          <p:cNvPr id="74" name="Freeform 20"/>
          <p:cNvSpPr>
            <a:spLocks/>
          </p:cNvSpPr>
          <p:nvPr/>
        </p:nvSpPr>
        <p:spPr bwMode="auto">
          <a:xfrm>
            <a:off x="7363042" y="4799777"/>
            <a:ext cx="342082" cy="428824"/>
          </a:xfrm>
          <a:custGeom>
            <a:avLst/>
            <a:gdLst/>
            <a:ahLst/>
            <a:cxnLst>
              <a:cxn ang="0">
                <a:pos x="2710" y="0"/>
              </a:cxn>
              <a:cxn ang="0">
                <a:pos x="2710" y="376"/>
              </a:cxn>
              <a:cxn ang="0">
                <a:pos x="2686" y="400"/>
              </a:cxn>
              <a:cxn ang="0">
                <a:pos x="24" y="400"/>
              </a:cxn>
              <a:cxn ang="0">
                <a:pos x="48" y="376"/>
              </a:cxn>
              <a:cxn ang="0">
                <a:pos x="48" y="752"/>
              </a:cxn>
              <a:cxn ang="0">
                <a:pos x="0" y="752"/>
              </a:cxn>
              <a:cxn ang="0">
                <a:pos x="0" y="376"/>
              </a:cxn>
              <a:cxn ang="0">
                <a:pos x="24" y="352"/>
              </a:cxn>
              <a:cxn ang="0">
                <a:pos x="2686" y="352"/>
              </a:cxn>
              <a:cxn ang="0">
                <a:pos x="2662" y="376"/>
              </a:cxn>
              <a:cxn ang="0">
                <a:pos x="2662" y="0"/>
              </a:cxn>
              <a:cxn ang="0">
                <a:pos x="2710" y="0"/>
              </a:cxn>
            </a:cxnLst>
            <a:rect l="0" t="0" r="r" b="b"/>
            <a:pathLst>
              <a:path w="2710" h="752">
                <a:moveTo>
                  <a:pt x="2710" y="0"/>
                </a:moveTo>
                <a:lnTo>
                  <a:pt x="2710" y="376"/>
                </a:lnTo>
                <a:cubicBezTo>
                  <a:pt x="2710" y="390"/>
                  <a:pt x="2699" y="400"/>
                  <a:pt x="2686" y="400"/>
                </a:cubicBezTo>
                <a:lnTo>
                  <a:pt x="24" y="400"/>
                </a:lnTo>
                <a:lnTo>
                  <a:pt x="48" y="376"/>
                </a:lnTo>
                <a:lnTo>
                  <a:pt x="48" y="752"/>
                </a:lnTo>
                <a:lnTo>
                  <a:pt x="0" y="752"/>
                </a:lnTo>
                <a:lnTo>
                  <a:pt x="0" y="376"/>
                </a:lnTo>
                <a:cubicBezTo>
                  <a:pt x="0" y="363"/>
                  <a:pt x="11" y="352"/>
                  <a:pt x="24" y="352"/>
                </a:cubicBezTo>
                <a:lnTo>
                  <a:pt x="2686" y="352"/>
                </a:lnTo>
                <a:lnTo>
                  <a:pt x="2662" y="376"/>
                </a:lnTo>
                <a:lnTo>
                  <a:pt x="2662" y="0"/>
                </a:lnTo>
                <a:lnTo>
                  <a:pt x="2710" y="0"/>
                </a:lnTo>
                <a:close/>
              </a:path>
            </a:pathLst>
          </a:custGeom>
          <a:solidFill>
            <a:srgbClr val="1B4171"/>
          </a:solidFill>
          <a:ln w="0" cap="flat">
            <a:solidFill>
              <a:srgbClr val="1B417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 sz="1100" b="1"/>
          </a:p>
        </p:txBody>
      </p:sp>
      <p:sp>
        <p:nvSpPr>
          <p:cNvPr id="75" name="Freeform 22"/>
          <p:cNvSpPr>
            <a:spLocks noEditPoints="1"/>
          </p:cNvSpPr>
          <p:nvPr/>
        </p:nvSpPr>
        <p:spPr bwMode="auto">
          <a:xfrm>
            <a:off x="7019628" y="5229200"/>
            <a:ext cx="731706" cy="360040"/>
          </a:xfrm>
          <a:custGeom>
            <a:avLst/>
            <a:gdLst/>
            <a:ahLst/>
            <a:cxnLst>
              <a:cxn ang="0">
                <a:pos x="1" y="112"/>
              </a:cxn>
              <a:cxn ang="0">
                <a:pos x="12" y="67"/>
              </a:cxn>
              <a:cxn ang="0">
                <a:pos x="38" y="32"/>
              </a:cxn>
              <a:cxn ang="0">
                <a:pos x="76" y="8"/>
              </a:cxn>
              <a:cxn ang="0">
                <a:pos x="116" y="0"/>
              </a:cxn>
              <a:cxn ang="0">
                <a:pos x="1298" y="1"/>
              </a:cxn>
              <a:cxn ang="0">
                <a:pos x="1343" y="12"/>
              </a:cxn>
              <a:cxn ang="0">
                <a:pos x="1379" y="38"/>
              </a:cxn>
              <a:cxn ang="0">
                <a:pos x="1401" y="76"/>
              </a:cxn>
              <a:cxn ang="0">
                <a:pos x="1408" y="116"/>
              </a:cxn>
              <a:cxn ang="0">
                <a:pos x="1408" y="850"/>
              </a:cxn>
              <a:cxn ang="0">
                <a:pos x="1398" y="895"/>
              </a:cxn>
              <a:cxn ang="0">
                <a:pos x="1372" y="931"/>
              </a:cxn>
              <a:cxn ang="0">
                <a:pos x="1334" y="953"/>
              </a:cxn>
              <a:cxn ang="0">
                <a:pos x="1293" y="960"/>
              </a:cxn>
              <a:cxn ang="0">
                <a:pos x="112" y="960"/>
              </a:cxn>
              <a:cxn ang="0">
                <a:pos x="67" y="950"/>
              </a:cxn>
              <a:cxn ang="0">
                <a:pos x="32" y="924"/>
              </a:cxn>
              <a:cxn ang="0">
                <a:pos x="8" y="886"/>
              </a:cxn>
              <a:cxn ang="0">
                <a:pos x="0" y="845"/>
              </a:cxn>
              <a:cxn ang="0">
                <a:pos x="48" y="845"/>
              </a:cxn>
              <a:cxn ang="0">
                <a:pos x="55" y="877"/>
              </a:cxn>
              <a:cxn ang="0">
                <a:pos x="71" y="897"/>
              </a:cxn>
              <a:cxn ang="0">
                <a:pos x="94" y="909"/>
              </a:cxn>
              <a:cxn ang="0">
                <a:pos x="121" y="913"/>
              </a:cxn>
              <a:cxn ang="0">
                <a:pos x="1293" y="912"/>
              </a:cxn>
              <a:cxn ang="0">
                <a:pos x="1325" y="906"/>
              </a:cxn>
              <a:cxn ang="0">
                <a:pos x="1345" y="890"/>
              </a:cxn>
              <a:cxn ang="0">
                <a:pos x="1357" y="868"/>
              </a:cxn>
              <a:cxn ang="0">
                <a:pos x="1361" y="841"/>
              </a:cxn>
              <a:cxn ang="0">
                <a:pos x="1360" y="116"/>
              </a:cxn>
              <a:cxn ang="0">
                <a:pos x="1354" y="85"/>
              </a:cxn>
              <a:cxn ang="0">
                <a:pos x="1338" y="65"/>
              </a:cxn>
              <a:cxn ang="0">
                <a:pos x="1316" y="51"/>
              </a:cxn>
              <a:cxn ang="0">
                <a:pos x="1289" y="48"/>
              </a:cxn>
              <a:cxn ang="0">
                <a:pos x="116" y="48"/>
              </a:cxn>
              <a:cxn ang="0">
                <a:pos x="85" y="55"/>
              </a:cxn>
              <a:cxn ang="0">
                <a:pos x="65" y="71"/>
              </a:cxn>
              <a:cxn ang="0">
                <a:pos x="51" y="94"/>
              </a:cxn>
              <a:cxn ang="0">
                <a:pos x="48" y="121"/>
              </a:cxn>
              <a:cxn ang="0">
                <a:pos x="48" y="845"/>
              </a:cxn>
            </a:cxnLst>
            <a:rect l="0" t="0" r="r" b="b"/>
            <a:pathLst>
              <a:path w="1408" h="960">
                <a:moveTo>
                  <a:pt x="0" y="116"/>
                </a:moveTo>
                <a:cubicBezTo>
                  <a:pt x="0" y="115"/>
                  <a:pt x="1" y="113"/>
                  <a:pt x="1" y="112"/>
                </a:cubicBezTo>
                <a:lnTo>
                  <a:pt x="8" y="76"/>
                </a:lnTo>
                <a:cubicBezTo>
                  <a:pt x="9" y="73"/>
                  <a:pt x="10" y="70"/>
                  <a:pt x="12" y="67"/>
                </a:cubicBezTo>
                <a:lnTo>
                  <a:pt x="32" y="38"/>
                </a:lnTo>
                <a:cubicBezTo>
                  <a:pt x="33" y="35"/>
                  <a:pt x="35" y="33"/>
                  <a:pt x="38" y="32"/>
                </a:cubicBezTo>
                <a:lnTo>
                  <a:pt x="67" y="12"/>
                </a:lnTo>
                <a:cubicBezTo>
                  <a:pt x="70" y="10"/>
                  <a:pt x="73" y="9"/>
                  <a:pt x="76" y="8"/>
                </a:cubicBezTo>
                <a:lnTo>
                  <a:pt x="112" y="1"/>
                </a:lnTo>
                <a:cubicBezTo>
                  <a:pt x="113" y="1"/>
                  <a:pt x="115" y="0"/>
                  <a:pt x="116" y="0"/>
                </a:cubicBezTo>
                <a:lnTo>
                  <a:pt x="1293" y="0"/>
                </a:lnTo>
                <a:cubicBezTo>
                  <a:pt x="1295" y="0"/>
                  <a:pt x="1297" y="1"/>
                  <a:pt x="1298" y="1"/>
                </a:cubicBezTo>
                <a:lnTo>
                  <a:pt x="1334" y="8"/>
                </a:lnTo>
                <a:cubicBezTo>
                  <a:pt x="1337" y="9"/>
                  <a:pt x="1340" y="10"/>
                  <a:pt x="1343" y="12"/>
                </a:cubicBezTo>
                <a:lnTo>
                  <a:pt x="1372" y="32"/>
                </a:lnTo>
                <a:cubicBezTo>
                  <a:pt x="1375" y="33"/>
                  <a:pt x="1377" y="36"/>
                  <a:pt x="1379" y="38"/>
                </a:cubicBezTo>
                <a:lnTo>
                  <a:pt x="1398" y="67"/>
                </a:lnTo>
                <a:cubicBezTo>
                  <a:pt x="1399" y="70"/>
                  <a:pt x="1400" y="73"/>
                  <a:pt x="1401" y="76"/>
                </a:cubicBezTo>
                <a:lnTo>
                  <a:pt x="1408" y="112"/>
                </a:lnTo>
                <a:cubicBezTo>
                  <a:pt x="1408" y="113"/>
                  <a:pt x="1408" y="115"/>
                  <a:pt x="1408" y="116"/>
                </a:cubicBezTo>
                <a:lnTo>
                  <a:pt x="1408" y="845"/>
                </a:lnTo>
                <a:cubicBezTo>
                  <a:pt x="1408" y="847"/>
                  <a:pt x="1408" y="849"/>
                  <a:pt x="1408" y="850"/>
                </a:cubicBezTo>
                <a:lnTo>
                  <a:pt x="1401" y="886"/>
                </a:lnTo>
                <a:cubicBezTo>
                  <a:pt x="1400" y="889"/>
                  <a:pt x="1399" y="892"/>
                  <a:pt x="1398" y="895"/>
                </a:cubicBezTo>
                <a:lnTo>
                  <a:pt x="1379" y="924"/>
                </a:lnTo>
                <a:cubicBezTo>
                  <a:pt x="1377" y="926"/>
                  <a:pt x="1374" y="929"/>
                  <a:pt x="1372" y="931"/>
                </a:cubicBezTo>
                <a:lnTo>
                  <a:pt x="1343" y="950"/>
                </a:lnTo>
                <a:cubicBezTo>
                  <a:pt x="1340" y="951"/>
                  <a:pt x="1337" y="952"/>
                  <a:pt x="1334" y="953"/>
                </a:cubicBezTo>
                <a:lnTo>
                  <a:pt x="1298" y="960"/>
                </a:lnTo>
                <a:cubicBezTo>
                  <a:pt x="1297" y="960"/>
                  <a:pt x="1295" y="960"/>
                  <a:pt x="1293" y="960"/>
                </a:cubicBezTo>
                <a:lnTo>
                  <a:pt x="116" y="960"/>
                </a:lnTo>
                <a:cubicBezTo>
                  <a:pt x="115" y="960"/>
                  <a:pt x="113" y="960"/>
                  <a:pt x="112" y="960"/>
                </a:cubicBezTo>
                <a:lnTo>
                  <a:pt x="76" y="953"/>
                </a:lnTo>
                <a:cubicBezTo>
                  <a:pt x="73" y="952"/>
                  <a:pt x="70" y="951"/>
                  <a:pt x="67" y="950"/>
                </a:cubicBezTo>
                <a:lnTo>
                  <a:pt x="38" y="931"/>
                </a:lnTo>
                <a:cubicBezTo>
                  <a:pt x="36" y="929"/>
                  <a:pt x="33" y="927"/>
                  <a:pt x="32" y="924"/>
                </a:cubicBezTo>
                <a:lnTo>
                  <a:pt x="12" y="895"/>
                </a:lnTo>
                <a:cubicBezTo>
                  <a:pt x="10" y="892"/>
                  <a:pt x="9" y="889"/>
                  <a:pt x="8" y="886"/>
                </a:cubicBezTo>
                <a:lnTo>
                  <a:pt x="1" y="850"/>
                </a:lnTo>
                <a:cubicBezTo>
                  <a:pt x="1" y="849"/>
                  <a:pt x="0" y="847"/>
                  <a:pt x="0" y="845"/>
                </a:cubicBezTo>
                <a:lnTo>
                  <a:pt x="0" y="116"/>
                </a:lnTo>
                <a:close/>
                <a:moveTo>
                  <a:pt x="48" y="845"/>
                </a:moveTo>
                <a:lnTo>
                  <a:pt x="48" y="841"/>
                </a:lnTo>
                <a:lnTo>
                  <a:pt x="55" y="877"/>
                </a:lnTo>
                <a:lnTo>
                  <a:pt x="51" y="868"/>
                </a:lnTo>
                <a:lnTo>
                  <a:pt x="71" y="897"/>
                </a:lnTo>
                <a:lnTo>
                  <a:pt x="65" y="890"/>
                </a:lnTo>
                <a:lnTo>
                  <a:pt x="94" y="909"/>
                </a:lnTo>
                <a:lnTo>
                  <a:pt x="85" y="906"/>
                </a:lnTo>
                <a:lnTo>
                  <a:pt x="121" y="913"/>
                </a:lnTo>
                <a:lnTo>
                  <a:pt x="116" y="912"/>
                </a:lnTo>
                <a:lnTo>
                  <a:pt x="1293" y="912"/>
                </a:lnTo>
                <a:lnTo>
                  <a:pt x="1289" y="913"/>
                </a:lnTo>
                <a:lnTo>
                  <a:pt x="1325" y="906"/>
                </a:lnTo>
                <a:lnTo>
                  <a:pt x="1316" y="909"/>
                </a:lnTo>
                <a:lnTo>
                  <a:pt x="1345" y="890"/>
                </a:lnTo>
                <a:lnTo>
                  <a:pt x="1338" y="897"/>
                </a:lnTo>
                <a:lnTo>
                  <a:pt x="1357" y="868"/>
                </a:lnTo>
                <a:lnTo>
                  <a:pt x="1354" y="877"/>
                </a:lnTo>
                <a:lnTo>
                  <a:pt x="1361" y="841"/>
                </a:lnTo>
                <a:lnTo>
                  <a:pt x="1360" y="845"/>
                </a:lnTo>
                <a:lnTo>
                  <a:pt x="1360" y="116"/>
                </a:lnTo>
                <a:lnTo>
                  <a:pt x="1361" y="121"/>
                </a:lnTo>
                <a:lnTo>
                  <a:pt x="1354" y="85"/>
                </a:lnTo>
                <a:lnTo>
                  <a:pt x="1357" y="94"/>
                </a:lnTo>
                <a:lnTo>
                  <a:pt x="1338" y="65"/>
                </a:lnTo>
                <a:lnTo>
                  <a:pt x="1345" y="71"/>
                </a:lnTo>
                <a:lnTo>
                  <a:pt x="1316" y="51"/>
                </a:lnTo>
                <a:lnTo>
                  <a:pt x="1325" y="55"/>
                </a:lnTo>
                <a:lnTo>
                  <a:pt x="1289" y="48"/>
                </a:lnTo>
                <a:lnTo>
                  <a:pt x="1293" y="48"/>
                </a:lnTo>
                <a:lnTo>
                  <a:pt x="116" y="48"/>
                </a:lnTo>
                <a:lnTo>
                  <a:pt x="121" y="48"/>
                </a:lnTo>
                <a:lnTo>
                  <a:pt x="85" y="55"/>
                </a:lnTo>
                <a:lnTo>
                  <a:pt x="94" y="51"/>
                </a:lnTo>
                <a:lnTo>
                  <a:pt x="65" y="71"/>
                </a:lnTo>
                <a:lnTo>
                  <a:pt x="71" y="65"/>
                </a:lnTo>
                <a:lnTo>
                  <a:pt x="51" y="94"/>
                </a:lnTo>
                <a:lnTo>
                  <a:pt x="55" y="85"/>
                </a:lnTo>
                <a:lnTo>
                  <a:pt x="48" y="121"/>
                </a:lnTo>
                <a:lnTo>
                  <a:pt x="48" y="116"/>
                </a:lnTo>
                <a:lnTo>
                  <a:pt x="48" y="845"/>
                </a:lnTo>
                <a:close/>
              </a:path>
            </a:pathLst>
          </a:custGeom>
          <a:solidFill>
            <a:srgbClr val="1B4171"/>
          </a:solidFill>
          <a:ln w="0" cap="flat">
            <a:solidFill>
              <a:srgbClr val="1B417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 sz="1100" b="1"/>
          </a:p>
        </p:txBody>
      </p:sp>
      <p:sp>
        <p:nvSpPr>
          <p:cNvPr id="76" name="Freeform 47"/>
          <p:cNvSpPr>
            <a:spLocks/>
          </p:cNvSpPr>
          <p:nvPr/>
        </p:nvSpPr>
        <p:spPr bwMode="auto">
          <a:xfrm>
            <a:off x="7682899" y="4791961"/>
            <a:ext cx="328215" cy="447675"/>
          </a:xfrm>
          <a:custGeom>
            <a:avLst/>
            <a:gdLst/>
            <a:ahLst/>
            <a:cxnLst>
              <a:cxn ang="0">
                <a:pos x="48" y="0"/>
              </a:cxn>
              <a:cxn ang="0">
                <a:pos x="48" y="376"/>
              </a:cxn>
              <a:cxn ang="0">
                <a:pos x="24" y="352"/>
              </a:cxn>
              <a:cxn ang="0">
                <a:pos x="2686" y="352"/>
              </a:cxn>
              <a:cxn ang="0">
                <a:pos x="2710" y="376"/>
              </a:cxn>
              <a:cxn ang="0">
                <a:pos x="2710" y="752"/>
              </a:cxn>
              <a:cxn ang="0">
                <a:pos x="2662" y="752"/>
              </a:cxn>
              <a:cxn ang="0">
                <a:pos x="2662" y="376"/>
              </a:cxn>
              <a:cxn ang="0">
                <a:pos x="2686" y="400"/>
              </a:cxn>
              <a:cxn ang="0">
                <a:pos x="24" y="400"/>
              </a:cxn>
              <a:cxn ang="0">
                <a:pos x="0" y="376"/>
              </a:cxn>
              <a:cxn ang="0">
                <a:pos x="0" y="0"/>
              </a:cxn>
              <a:cxn ang="0">
                <a:pos x="48" y="0"/>
              </a:cxn>
            </a:cxnLst>
            <a:rect l="0" t="0" r="r" b="b"/>
            <a:pathLst>
              <a:path w="2710" h="752">
                <a:moveTo>
                  <a:pt x="48" y="0"/>
                </a:moveTo>
                <a:lnTo>
                  <a:pt x="48" y="376"/>
                </a:lnTo>
                <a:lnTo>
                  <a:pt x="24" y="352"/>
                </a:lnTo>
                <a:lnTo>
                  <a:pt x="2686" y="352"/>
                </a:lnTo>
                <a:cubicBezTo>
                  <a:pt x="2699" y="352"/>
                  <a:pt x="2710" y="363"/>
                  <a:pt x="2710" y="376"/>
                </a:cubicBezTo>
                <a:lnTo>
                  <a:pt x="2710" y="752"/>
                </a:lnTo>
                <a:lnTo>
                  <a:pt x="2662" y="752"/>
                </a:lnTo>
                <a:lnTo>
                  <a:pt x="2662" y="376"/>
                </a:lnTo>
                <a:lnTo>
                  <a:pt x="2686" y="400"/>
                </a:lnTo>
                <a:lnTo>
                  <a:pt x="24" y="400"/>
                </a:lnTo>
                <a:cubicBezTo>
                  <a:pt x="11" y="400"/>
                  <a:pt x="0" y="390"/>
                  <a:pt x="0" y="376"/>
                </a:cubicBezTo>
                <a:lnTo>
                  <a:pt x="0" y="0"/>
                </a:lnTo>
                <a:lnTo>
                  <a:pt x="48" y="0"/>
                </a:lnTo>
                <a:close/>
              </a:path>
            </a:pathLst>
          </a:custGeom>
          <a:solidFill>
            <a:srgbClr val="1B4171"/>
          </a:solidFill>
          <a:ln w="0" cap="flat">
            <a:solidFill>
              <a:srgbClr val="1B417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 sz="1100" b="1"/>
          </a:p>
        </p:txBody>
      </p:sp>
      <p:cxnSp>
        <p:nvCxnSpPr>
          <p:cNvPr id="77" name="76 Conector recto"/>
          <p:cNvCxnSpPr/>
          <p:nvPr/>
        </p:nvCxnSpPr>
        <p:spPr>
          <a:xfrm>
            <a:off x="7694204" y="3670902"/>
            <a:ext cx="0" cy="576064"/>
          </a:xfrm>
          <a:prstGeom prst="line">
            <a:avLst/>
          </a:prstGeom>
          <a:ln w="28575">
            <a:solidFill>
              <a:schemeClr val="accent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8" name="Freeform 22"/>
          <p:cNvSpPr>
            <a:spLocks noEditPoints="1"/>
          </p:cNvSpPr>
          <p:nvPr/>
        </p:nvSpPr>
        <p:spPr bwMode="auto">
          <a:xfrm>
            <a:off x="7800734" y="5229200"/>
            <a:ext cx="731706" cy="360040"/>
          </a:xfrm>
          <a:custGeom>
            <a:avLst/>
            <a:gdLst/>
            <a:ahLst/>
            <a:cxnLst>
              <a:cxn ang="0">
                <a:pos x="1" y="112"/>
              </a:cxn>
              <a:cxn ang="0">
                <a:pos x="12" y="67"/>
              </a:cxn>
              <a:cxn ang="0">
                <a:pos x="38" y="32"/>
              </a:cxn>
              <a:cxn ang="0">
                <a:pos x="76" y="8"/>
              </a:cxn>
              <a:cxn ang="0">
                <a:pos x="116" y="0"/>
              </a:cxn>
              <a:cxn ang="0">
                <a:pos x="1298" y="1"/>
              </a:cxn>
              <a:cxn ang="0">
                <a:pos x="1343" y="12"/>
              </a:cxn>
              <a:cxn ang="0">
                <a:pos x="1379" y="38"/>
              </a:cxn>
              <a:cxn ang="0">
                <a:pos x="1401" y="76"/>
              </a:cxn>
              <a:cxn ang="0">
                <a:pos x="1408" y="116"/>
              </a:cxn>
              <a:cxn ang="0">
                <a:pos x="1408" y="850"/>
              </a:cxn>
              <a:cxn ang="0">
                <a:pos x="1398" y="895"/>
              </a:cxn>
              <a:cxn ang="0">
                <a:pos x="1372" y="931"/>
              </a:cxn>
              <a:cxn ang="0">
                <a:pos x="1334" y="953"/>
              </a:cxn>
              <a:cxn ang="0">
                <a:pos x="1293" y="960"/>
              </a:cxn>
              <a:cxn ang="0">
                <a:pos x="112" y="960"/>
              </a:cxn>
              <a:cxn ang="0">
                <a:pos x="67" y="950"/>
              </a:cxn>
              <a:cxn ang="0">
                <a:pos x="32" y="924"/>
              </a:cxn>
              <a:cxn ang="0">
                <a:pos x="8" y="886"/>
              </a:cxn>
              <a:cxn ang="0">
                <a:pos x="0" y="845"/>
              </a:cxn>
              <a:cxn ang="0">
                <a:pos x="48" y="845"/>
              </a:cxn>
              <a:cxn ang="0">
                <a:pos x="55" y="877"/>
              </a:cxn>
              <a:cxn ang="0">
                <a:pos x="71" y="897"/>
              </a:cxn>
              <a:cxn ang="0">
                <a:pos x="94" y="909"/>
              </a:cxn>
              <a:cxn ang="0">
                <a:pos x="121" y="913"/>
              </a:cxn>
              <a:cxn ang="0">
                <a:pos x="1293" y="912"/>
              </a:cxn>
              <a:cxn ang="0">
                <a:pos x="1325" y="906"/>
              </a:cxn>
              <a:cxn ang="0">
                <a:pos x="1345" y="890"/>
              </a:cxn>
              <a:cxn ang="0">
                <a:pos x="1357" y="868"/>
              </a:cxn>
              <a:cxn ang="0">
                <a:pos x="1361" y="841"/>
              </a:cxn>
              <a:cxn ang="0">
                <a:pos x="1360" y="116"/>
              </a:cxn>
              <a:cxn ang="0">
                <a:pos x="1354" y="85"/>
              </a:cxn>
              <a:cxn ang="0">
                <a:pos x="1338" y="65"/>
              </a:cxn>
              <a:cxn ang="0">
                <a:pos x="1316" y="51"/>
              </a:cxn>
              <a:cxn ang="0">
                <a:pos x="1289" y="48"/>
              </a:cxn>
              <a:cxn ang="0">
                <a:pos x="116" y="48"/>
              </a:cxn>
              <a:cxn ang="0">
                <a:pos x="85" y="55"/>
              </a:cxn>
              <a:cxn ang="0">
                <a:pos x="65" y="71"/>
              </a:cxn>
              <a:cxn ang="0">
                <a:pos x="51" y="94"/>
              </a:cxn>
              <a:cxn ang="0">
                <a:pos x="48" y="121"/>
              </a:cxn>
              <a:cxn ang="0">
                <a:pos x="48" y="845"/>
              </a:cxn>
            </a:cxnLst>
            <a:rect l="0" t="0" r="r" b="b"/>
            <a:pathLst>
              <a:path w="1408" h="960">
                <a:moveTo>
                  <a:pt x="0" y="116"/>
                </a:moveTo>
                <a:cubicBezTo>
                  <a:pt x="0" y="115"/>
                  <a:pt x="1" y="113"/>
                  <a:pt x="1" y="112"/>
                </a:cubicBezTo>
                <a:lnTo>
                  <a:pt x="8" y="76"/>
                </a:lnTo>
                <a:cubicBezTo>
                  <a:pt x="9" y="73"/>
                  <a:pt x="10" y="70"/>
                  <a:pt x="12" y="67"/>
                </a:cubicBezTo>
                <a:lnTo>
                  <a:pt x="32" y="38"/>
                </a:lnTo>
                <a:cubicBezTo>
                  <a:pt x="33" y="35"/>
                  <a:pt x="35" y="33"/>
                  <a:pt x="38" y="32"/>
                </a:cubicBezTo>
                <a:lnTo>
                  <a:pt x="67" y="12"/>
                </a:lnTo>
                <a:cubicBezTo>
                  <a:pt x="70" y="10"/>
                  <a:pt x="73" y="9"/>
                  <a:pt x="76" y="8"/>
                </a:cubicBezTo>
                <a:lnTo>
                  <a:pt x="112" y="1"/>
                </a:lnTo>
                <a:cubicBezTo>
                  <a:pt x="113" y="1"/>
                  <a:pt x="115" y="0"/>
                  <a:pt x="116" y="0"/>
                </a:cubicBezTo>
                <a:lnTo>
                  <a:pt x="1293" y="0"/>
                </a:lnTo>
                <a:cubicBezTo>
                  <a:pt x="1295" y="0"/>
                  <a:pt x="1297" y="1"/>
                  <a:pt x="1298" y="1"/>
                </a:cubicBezTo>
                <a:lnTo>
                  <a:pt x="1334" y="8"/>
                </a:lnTo>
                <a:cubicBezTo>
                  <a:pt x="1337" y="9"/>
                  <a:pt x="1340" y="10"/>
                  <a:pt x="1343" y="12"/>
                </a:cubicBezTo>
                <a:lnTo>
                  <a:pt x="1372" y="32"/>
                </a:lnTo>
                <a:cubicBezTo>
                  <a:pt x="1375" y="33"/>
                  <a:pt x="1377" y="36"/>
                  <a:pt x="1379" y="38"/>
                </a:cubicBezTo>
                <a:lnTo>
                  <a:pt x="1398" y="67"/>
                </a:lnTo>
                <a:cubicBezTo>
                  <a:pt x="1399" y="70"/>
                  <a:pt x="1400" y="73"/>
                  <a:pt x="1401" y="76"/>
                </a:cubicBezTo>
                <a:lnTo>
                  <a:pt x="1408" y="112"/>
                </a:lnTo>
                <a:cubicBezTo>
                  <a:pt x="1408" y="113"/>
                  <a:pt x="1408" y="115"/>
                  <a:pt x="1408" y="116"/>
                </a:cubicBezTo>
                <a:lnTo>
                  <a:pt x="1408" y="845"/>
                </a:lnTo>
                <a:cubicBezTo>
                  <a:pt x="1408" y="847"/>
                  <a:pt x="1408" y="849"/>
                  <a:pt x="1408" y="850"/>
                </a:cubicBezTo>
                <a:lnTo>
                  <a:pt x="1401" y="886"/>
                </a:lnTo>
                <a:cubicBezTo>
                  <a:pt x="1400" y="889"/>
                  <a:pt x="1399" y="892"/>
                  <a:pt x="1398" y="895"/>
                </a:cubicBezTo>
                <a:lnTo>
                  <a:pt x="1379" y="924"/>
                </a:lnTo>
                <a:cubicBezTo>
                  <a:pt x="1377" y="926"/>
                  <a:pt x="1374" y="929"/>
                  <a:pt x="1372" y="931"/>
                </a:cubicBezTo>
                <a:lnTo>
                  <a:pt x="1343" y="950"/>
                </a:lnTo>
                <a:cubicBezTo>
                  <a:pt x="1340" y="951"/>
                  <a:pt x="1337" y="952"/>
                  <a:pt x="1334" y="953"/>
                </a:cubicBezTo>
                <a:lnTo>
                  <a:pt x="1298" y="960"/>
                </a:lnTo>
                <a:cubicBezTo>
                  <a:pt x="1297" y="960"/>
                  <a:pt x="1295" y="960"/>
                  <a:pt x="1293" y="960"/>
                </a:cubicBezTo>
                <a:lnTo>
                  <a:pt x="116" y="960"/>
                </a:lnTo>
                <a:cubicBezTo>
                  <a:pt x="115" y="960"/>
                  <a:pt x="113" y="960"/>
                  <a:pt x="112" y="960"/>
                </a:cubicBezTo>
                <a:lnTo>
                  <a:pt x="76" y="953"/>
                </a:lnTo>
                <a:cubicBezTo>
                  <a:pt x="73" y="952"/>
                  <a:pt x="70" y="951"/>
                  <a:pt x="67" y="950"/>
                </a:cubicBezTo>
                <a:lnTo>
                  <a:pt x="38" y="931"/>
                </a:lnTo>
                <a:cubicBezTo>
                  <a:pt x="36" y="929"/>
                  <a:pt x="33" y="927"/>
                  <a:pt x="32" y="924"/>
                </a:cubicBezTo>
                <a:lnTo>
                  <a:pt x="12" y="895"/>
                </a:lnTo>
                <a:cubicBezTo>
                  <a:pt x="10" y="892"/>
                  <a:pt x="9" y="889"/>
                  <a:pt x="8" y="886"/>
                </a:cubicBezTo>
                <a:lnTo>
                  <a:pt x="1" y="850"/>
                </a:lnTo>
                <a:cubicBezTo>
                  <a:pt x="1" y="849"/>
                  <a:pt x="0" y="847"/>
                  <a:pt x="0" y="845"/>
                </a:cubicBezTo>
                <a:lnTo>
                  <a:pt x="0" y="116"/>
                </a:lnTo>
                <a:close/>
                <a:moveTo>
                  <a:pt x="48" y="845"/>
                </a:moveTo>
                <a:lnTo>
                  <a:pt x="48" y="841"/>
                </a:lnTo>
                <a:lnTo>
                  <a:pt x="55" y="877"/>
                </a:lnTo>
                <a:lnTo>
                  <a:pt x="51" y="868"/>
                </a:lnTo>
                <a:lnTo>
                  <a:pt x="71" y="897"/>
                </a:lnTo>
                <a:lnTo>
                  <a:pt x="65" y="890"/>
                </a:lnTo>
                <a:lnTo>
                  <a:pt x="94" y="909"/>
                </a:lnTo>
                <a:lnTo>
                  <a:pt x="85" y="906"/>
                </a:lnTo>
                <a:lnTo>
                  <a:pt x="121" y="913"/>
                </a:lnTo>
                <a:lnTo>
                  <a:pt x="116" y="912"/>
                </a:lnTo>
                <a:lnTo>
                  <a:pt x="1293" y="912"/>
                </a:lnTo>
                <a:lnTo>
                  <a:pt x="1289" y="913"/>
                </a:lnTo>
                <a:lnTo>
                  <a:pt x="1325" y="906"/>
                </a:lnTo>
                <a:lnTo>
                  <a:pt x="1316" y="909"/>
                </a:lnTo>
                <a:lnTo>
                  <a:pt x="1345" y="890"/>
                </a:lnTo>
                <a:lnTo>
                  <a:pt x="1338" y="897"/>
                </a:lnTo>
                <a:lnTo>
                  <a:pt x="1357" y="868"/>
                </a:lnTo>
                <a:lnTo>
                  <a:pt x="1354" y="877"/>
                </a:lnTo>
                <a:lnTo>
                  <a:pt x="1361" y="841"/>
                </a:lnTo>
                <a:lnTo>
                  <a:pt x="1360" y="845"/>
                </a:lnTo>
                <a:lnTo>
                  <a:pt x="1360" y="116"/>
                </a:lnTo>
                <a:lnTo>
                  <a:pt x="1361" y="121"/>
                </a:lnTo>
                <a:lnTo>
                  <a:pt x="1354" y="85"/>
                </a:lnTo>
                <a:lnTo>
                  <a:pt x="1357" y="94"/>
                </a:lnTo>
                <a:lnTo>
                  <a:pt x="1338" y="65"/>
                </a:lnTo>
                <a:lnTo>
                  <a:pt x="1345" y="71"/>
                </a:lnTo>
                <a:lnTo>
                  <a:pt x="1316" y="51"/>
                </a:lnTo>
                <a:lnTo>
                  <a:pt x="1325" y="55"/>
                </a:lnTo>
                <a:lnTo>
                  <a:pt x="1289" y="48"/>
                </a:lnTo>
                <a:lnTo>
                  <a:pt x="1293" y="48"/>
                </a:lnTo>
                <a:lnTo>
                  <a:pt x="116" y="48"/>
                </a:lnTo>
                <a:lnTo>
                  <a:pt x="121" y="48"/>
                </a:lnTo>
                <a:lnTo>
                  <a:pt x="85" y="55"/>
                </a:lnTo>
                <a:lnTo>
                  <a:pt x="94" y="51"/>
                </a:lnTo>
                <a:lnTo>
                  <a:pt x="65" y="71"/>
                </a:lnTo>
                <a:lnTo>
                  <a:pt x="71" y="65"/>
                </a:lnTo>
                <a:lnTo>
                  <a:pt x="51" y="94"/>
                </a:lnTo>
                <a:lnTo>
                  <a:pt x="55" y="85"/>
                </a:lnTo>
                <a:lnTo>
                  <a:pt x="48" y="121"/>
                </a:lnTo>
                <a:lnTo>
                  <a:pt x="48" y="116"/>
                </a:lnTo>
                <a:lnTo>
                  <a:pt x="48" y="845"/>
                </a:lnTo>
                <a:close/>
              </a:path>
            </a:pathLst>
          </a:custGeom>
          <a:solidFill>
            <a:srgbClr val="1B4171"/>
          </a:solidFill>
          <a:ln w="0" cap="flat">
            <a:solidFill>
              <a:srgbClr val="1B417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 sz="1100" b="1"/>
          </a:p>
        </p:txBody>
      </p:sp>
      <p:sp>
        <p:nvSpPr>
          <p:cNvPr id="2" name="Freeform 16"/>
          <p:cNvSpPr>
            <a:spLocks noEditPoints="1"/>
          </p:cNvSpPr>
          <p:nvPr/>
        </p:nvSpPr>
        <p:spPr bwMode="auto">
          <a:xfrm>
            <a:off x="1784734" y="2141482"/>
            <a:ext cx="843050" cy="571500"/>
          </a:xfrm>
          <a:custGeom>
            <a:avLst/>
            <a:gdLst/>
            <a:ahLst/>
            <a:cxnLst>
              <a:cxn ang="0">
                <a:pos x="1" y="112"/>
              </a:cxn>
              <a:cxn ang="0">
                <a:pos x="12" y="67"/>
              </a:cxn>
              <a:cxn ang="0">
                <a:pos x="38" y="32"/>
              </a:cxn>
              <a:cxn ang="0">
                <a:pos x="76" y="8"/>
              </a:cxn>
              <a:cxn ang="0">
                <a:pos x="116" y="0"/>
              </a:cxn>
              <a:cxn ang="0">
                <a:pos x="1298" y="1"/>
              </a:cxn>
              <a:cxn ang="0">
                <a:pos x="1343" y="12"/>
              </a:cxn>
              <a:cxn ang="0">
                <a:pos x="1379" y="38"/>
              </a:cxn>
              <a:cxn ang="0">
                <a:pos x="1401" y="76"/>
              </a:cxn>
              <a:cxn ang="0">
                <a:pos x="1408" y="116"/>
              </a:cxn>
              <a:cxn ang="0">
                <a:pos x="1408" y="850"/>
              </a:cxn>
              <a:cxn ang="0">
                <a:pos x="1398" y="895"/>
              </a:cxn>
              <a:cxn ang="0">
                <a:pos x="1372" y="931"/>
              </a:cxn>
              <a:cxn ang="0">
                <a:pos x="1334" y="953"/>
              </a:cxn>
              <a:cxn ang="0">
                <a:pos x="1293" y="960"/>
              </a:cxn>
              <a:cxn ang="0">
                <a:pos x="112" y="960"/>
              </a:cxn>
              <a:cxn ang="0">
                <a:pos x="67" y="950"/>
              </a:cxn>
              <a:cxn ang="0">
                <a:pos x="32" y="924"/>
              </a:cxn>
              <a:cxn ang="0">
                <a:pos x="8" y="886"/>
              </a:cxn>
              <a:cxn ang="0">
                <a:pos x="0" y="845"/>
              </a:cxn>
              <a:cxn ang="0">
                <a:pos x="48" y="845"/>
              </a:cxn>
              <a:cxn ang="0">
                <a:pos x="55" y="877"/>
              </a:cxn>
              <a:cxn ang="0">
                <a:pos x="71" y="897"/>
              </a:cxn>
              <a:cxn ang="0">
                <a:pos x="94" y="909"/>
              </a:cxn>
              <a:cxn ang="0">
                <a:pos x="121" y="913"/>
              </a:cxn>
              <a:cxn ang="0">
                <a:pos x="1293" y="912"/>
              </a:cxn>
              <a:cxn ang="0">
                <a:pos x="1325" y="906"/>
              </a:cxn>
              <a:cxn ang="0">
                <a:pos x="1345" y="890"/>
              </a:cxn>
              <a:cxn ang="0">
                <a:pos x="1357" y="868"/>
              </a:cxn>
              <a:cxn ang="0">
                <a:pos x="1361" y="841"/>
              </a:cxn>
              <a:cxn ang="0">
                <a:pos x="1360" y="116"/>
              </a:cxn>
              <a:cxn ang="0">
                <a:pos x="1354" y="85"/>
              </a:cxn>
              <a:cxn ang="0">
                <a:pos x="1338" y="65"/>
              </a:cxn>
              <a:cxn ang="0">
                <a:pos x="1316" y="51"/>
              </a:cxn>
              <a:cxn ang="0">
                <a:pos x="1289" y="48"/>
              </a:cxn>
              <a:cxn ang="0">
                <a:pos x="116" y="48"/>
              </a:cxn>
              <a:cxn ang="0">
                <a:pos x="85" y="55"/>
              </a:cxn>
              <a:cxn ang="0">
                <a:pos x="65" y="71"/>
              </a:cxn>
              <a:cxn ang="0">
                <a:pos x="51" y="94"/>
              </a:cxn>
              <a:cxn ang="0">
                <a:pos x="48" y="121"/>
              </a:cxn>
              <a:cxn ang="0">
                <a:pos x="48" y="845"/>
              </a:cxn>
            </a:cxnLst>
            <a:rect l="0" t="0" r="r" b="b"/>
            <a:pathLst>
              <a:path w="1408" h="960">
                <a:moveTo>
                  <a:pt x="0" y="116"/>
                </a:moveTo>
                <a:cubicBezTo>
                  <a:pt x="0" y="115"/>
                  <a:pt x="1" y="113"/>
                  <a:pt x="1" y="112"/>
                </a:cubicBezTo>
                <a:lnTo>
                  <a:pt x="8" y="76"/>
                </a:lnTo>
                <a:cubicBezTo>
                  <a:pt x="9" y="73"/>
                  <a:pt x="10" y="70"/>
                  <a:pt x="12" y="67"/>
                </a:cubicBezTo>
                <a:lnTo>
                  <a:pt x="32" y="38"/>
                </a:lnTo>
                <a:cubicBezTo>
                  <a:pt x="33" y="35"/>
                  <a:pt x="35" y="33"/>
                  <a:pt x="38" y="32"/>
                </a:cubicBezTo>
                <a:lnTo>
                  <a:pt x="67" y="12"/>
                </a:lnTo>
                <a:cubicBezTo>
                  <a:pt x="70" y="10"/>
                  <a:pt x="73" y="9"/>
                  <a:pt x="76" y="8"/>
                </a:cubicBezTo>
                <a:lnTo>
                  <a:pt x="112" y="1"/>
                </a:lnTo>
                <a:cubicBezTo>
                  <a:pt x="113" y="1"/>
                  <a:pt x="115" y="0"/>
                  <a:pt x="116" y="0"/>
                </a:cubicBezTo>
                <a:lnTo>
                  <a:pt x="1293" y="0"/>
                </a:lnTo>
                <a:cubicBezTo>
                  <a:pt x="1295" y="0"/>
                  <a:pt x="1297" y="1"/>
                  <a:pt x="1298" y="1"/>
                </a:cubicBezTo>
                <a:lnTo>
                  <a:pt x="1334" y="8"/>
                </a:lnTo>
                <a:cubicBezTo>
                  <a:pt x="1337" y="9"/>
                  <a:pt x="1340" y="10"/>
                  <a:pt x="1343" y="12"/>
                </a:cubicBezTo>
                <a:lnTo>
                  <a:pt x="1372" y="32"/>
                </a:lnTo>
                <a:cubicBezTo>
                  <a:pt x="1375" y="33"/>
                  <a:pt x="1377" y="36"/>
                  <a:pt x="1379" y="38"/>
                </a:cubicBezTo>
                <a:lnTo>
                  <a:pt x="1398" y="67"/>
                </a:lnTo>
                <a:cubicBezTo>
                  <a:pt x="1399" y="70"/>
                  <a:pt x="1400" y="73"/>
                  <a:pt x="1401" y="76"/>
                </a:cubicBezTo>
                <a:lnTo>
                  <a:pt x="1408" y="112"/>
                </a:lnTo>
                <a:cubicBezTo>
                  <a:pt x="1408" y="113"/>
                  <a:pt x="1408" y="115"/>
                  <a:pt x="1408" y="116"/>
                </a:cubicBezTo>
                <a:lnTo>
                  <a:pt x="1408" y="845"/>
                </a:lnTo>
                <a:cubicBezTo>
                  <a:pt x="1408" y="847"/>
                  <a:pt x="1408" y="849"/>
                  <a:pt x="1408" y="850"/>
                </a:cubicBezTo>
                <a:lnTo>
                  <a:pt x="1401" y="886"/>
                </a:lnTo>
                <a:cubicBezTo>
                  <a:pt x="1400" y="889"/>
                  <a:pt x="1399" y="892"/>
                  <a:pt x="1398" y="895"/>
                </a:cubicBezTo>
                <a:lnTo>
                  <a:pt x="1379" y="924"/>
                </a:lnTo>
                <a:cubicBezTo>
                  <a:pt x="1377" y="926"/>
                  <a:pt x="1374" y="929"/>
                  <a:pt x="1372" y="931"/>
                </a:cubicBezTo>
                <a:lnTo>
                  <a:pt x="1343" y="950"/>
                </a:lnTo>
                <a:cubicBezTo>
                  <a:pt x="1340" y="951"/>
                  <a:pt x="1337" y="952"/>
                  <a:pt x="1334" y="953"/>
                </a:cubicBezTo>
                <a:lnTo>
                  <a:pt x="1298" y="960"/>
                </a:lnTo>
                <a:cubicBezTo>
                  <a:pt x="1297" y="960"/>
                  <a:pt x="1295" y="960"/>
                  <a:pt x="1293" y="960"/>
                </a:cubicBezTo>
                <a:lnTo>
                  <a:pt x="116" y="960"/>
                </a:lnTo>
                <a:cubicBezTo>
                  <a:pt x="115" y="960"/>
                  <a:pt x="113" y="960"/>
                  <a:pt x="112" y="960"/>
                </a:cubicBezTo>
                <a:lnTo>
                  <a:pt x="76" y="953"/>
                </a:lnTo>
                <a:cubicBezTo>
                  <a:pt x="73" y="952"/>
                  <a:pt x="70" y="951"/>
                  <a:pt x="67" y="950"/>
                </a:cubicBezTo>
                <a:lnTo>
                  <a:pt x="38" y="931"/>
                </a:lnTo>
                <a:cubicBezTo>
                  <a:pt x="36" y="929"/>
                  <a:pt x="33" y="927"/>
                  <a:pt x="32" y="924"/>
                </a:cubicBezTo>
                <a:lnTo>
                  <a:pt x="12" y="895"/>
                </a:lnTo>
                <a:cubicBezTo>
                  <a:pt x="10" y="892"/>
                  <a:pt x="9" y="889"/>
                  <a:pt x="8" y="886"/>
                </a:cubicBezTo>
                <a:lnTo>
                  <a:pt x="1" y="850"/>
                </a:lnTo>
                <a:cubicBezTo>
                  <a:pt x="1" y="849"/>
                  <a:pt x="0" y="847"/>
                  <a:pt x="0" y="845"/>
                </a:cubicBezTo>
                <a:lnTo>
                  <a:pt x="0" y="116"/>
                </a:lnTo>
                <a:close/>
                <a:moveTo>
                  <a:pt x="48" y="845"/>
                </a:moveTo>
                <a:lnTo>
                  <a:pt x="48" y="841"/>
                </a:lnTo>
                <a:lnTo>
                  <a:pt x="55" y="877"/>
                </a:lnTo>
                <a:lnTo>
                  <a:pt x="51" y="868"/>
                </a:lnTo>
                <a:lnTo>
                  <a:pt x="71" y="897"/>
                </a:lnTo>
                <a:lnTo>
                  <a:pt x="65" y="890"/>
                </a:lnTo>
                <a:lnTo>
                  <a:pt x="94" y="909"/>
                </a:lnTo>
                <a:lnTo>
                  <a:pt x="85" y="906"/>
                </a:lnTo>
                <a:lnTo>
                  <a:pt x="121" y="913"/>
                </a:lnTo>
                <a:lnTo>
                  <a:pt x="116" y="912"/>
                </a:lnTo>
                <a:lnTo>
                  <a:pt x="1293" y="912"/>
                </a:lnTo>
                <a:lnTo>
                  <a:pt x="1289" y="913"/>
                </a:lnTo>
                <a:lnTo>
                  <a:pt x="1325" y="906"/>
                </a:lnTo>
                <a:lnTo>
                  <a:pt x="1316" y="909"/>
                </a:lnTo>
                <a:lnTo>
                  <a:pt x="1345" y="890"/>
                </a:lnTo>
                <a:lnTo>
                  <a:pt x="1338" y="897"/>
                </a:lnTo>
                <a:lnTo>
                  <a:pt x="1357" y="868"/>
                </a:lnTo>
                <a:lnTo>
                  <a:pt x="1354" y="877"/>
                </a:lnTo>
                <a:lnTo>
                  <a:pt x="1361" y="841"/>
                </a:lnTo>
                <a:lnTo>
                  <a:pt x="1360" y="845"/>
                </a:lnTo>
                <a:lnTo>
                  <a:pt x="1360" y="116"/>
                </a:lnTo>
                <a:lnTo>
                  <a:pt x="1361" y="121"/>
                </a:lnTo>
                <a:lnTo>
                  <a:pt x="1354" y="85"/>
                </a:lnTo>
                <a:lnTo>
                  <a:pt x="1357" y="94"/>
                </a:lnTo>
                <a:lnTo>
                  <a:pt x="1338" y="65"/>
                </a:lnTo>
                <a:lnTo>
                  <a:pt x="1345" y="71"/>
                </a:lnTo>
                <a:lnTo>
                  <a:pt x="1316" y="51"/>
                </a:lnTo>
                <a:lnTo>
                  <a:pt x="1325" y="55"/>
                </a:lnTo>
                <a:lnTo>
                  <a:pt x="1289" y="48"/>
                </a:lnTo>
                <a:lnTo>
                  <a:pt x="1293" y="48"/>
                </a:lnTo>
                <a:lnTo>
                  <a:pt x="116" y="48"/>
                </a:lnTo>
                <a:lnTo>
                  <a:pt x="121" y="48"/>
                </a:lnTo>
                <a:lnTo>
                  <a:pt x="85" y="55"/>
                </a:lnTo>
                <a:lnTo>
                  <a:pt x="94" y="51"/>
                </a:lnTo>
                <a:lnTo>
                  <a:pt x="65" y="71"/>
                </a:lnTo>
                <a:lnTo>
                  <a:pt x="71" y="65"/>
                </a:lnTo>
                <a:lnTo>
                  <a:pt x="51" y="94"/>
                </a:lnTo>
                <a:lnTo>
                  <a:pt x="55" y="85"/>
                </a:lnTo>
                <a:lnTo>
                  <a:pt x="48" y="121"/>
                </a:lnTo>
                <a:lnTo>
                  <a:pt x="48" y="116"/>
                </a:lnTo>
                <a:lnTo>
                  <a:pt x="48" y="845"/>
                </a:lnTo>
                <a:close/>
              </a:path>
            </a:pathLst>
          </a:custGeom>
          <a:solidFill>
            <a:srgbClr val="1B4171"/>
          </a:solidFill>
          <a:ln w="0" cap="flat">
            <a:solidFill>
              <a:srgbClr val="1B417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 sz="1100" b="1"/>
          </a:p>
        </p:txBody>
      </p:sp>
      <p:sp>
        <p:nvSpPr>
          <p:cNvPr id="3" name="Freeform 20"/>
          <p:cNvSpPr>
            <a:spLocks/>
          </p:cNvSpPr>
          <p:nvPr/>
        </p:nvSpPr>
        <p:spPr bwMode="auto">
          <a:xfrm>
            <a:off x="1488516" y="2698694"/>
            <a:ext cx="728018" cy="447675"/>
          </a:xfrm>
          <a:custGeom>
            <a:avLst/>
            <a:gdLst/>
            <a:ahLst/>
            <a:cxnLst>
              <a:cxn ang="0">
                <a:pos x="2710" y="0"/>
              </a:cxn>
              <a:cxn ang="0">
                <a:pos x="2710" y="376"/>
              </a:cxn>
              <a:cxn ang="0">
                <a:pos x="2686" y="400"/>
              </a:cxn>
              <a:cxn ang="0">
                <a:pos x="24" y="400"/>
              </a:cxn>
              <a:cxn ang="0">
                <a:pos x="48" y="376"/>
              </a:cxn>
              <a:cxn ang="0">
                <a:pos x="48" y="752"/>
              </a:cxn>
              <a:cxn ang="0">
                <a:pos x="0" y="752"/>
              </a:cxn>
              <a:cxn ang="0">
                <a:pos x="0" y="376"/>
              </a:cxn>
              <a:cxn ang="0">
                <a:pos x="24" y="352"/>
              </a:cxn>
              <a:cxn ang="0">
                <a:pos x="2686" y="352"/>
              </a:cxn>
              <a:cxn ang="0">
                <a:pos x="2662" y="376"/>
              </a:cxn>
              <a:cxn ang="0">
                <a:pos x="2662" y="0"/>
              </a:cxn>
              <a:cxn ang="0">
                <a:pos x="2710" y="0"/>
              </a:cxn>
            </a:cxnLst>
            <a:rect l="0" t="0" r="r" b="b"/>
            <a:pathLst>
              <a:path w="2710" h="752">
                <a:moveTo>
                  <a:pt x="2710" y="0"/>
                </a:moveTo>
                <a:lnTo>
                  <a:pt x="2710" y="376"/>
                </a:lnTo>
                <a:cubicBezTo>
                  <a:pt x="2710" y="390"/>
                  <a:pt x="2699" y="400"/>
                  <a:pt x="2686" y="400"/>
                </a:cubicBezTo>
                <a:lnTo>
                  <a:pt x="24" y="400"/>
                </a:lnTo>
                <a:lnTo>
                  <a:pt x="48" y="376"/>
                </a:lnTo>
                <a:lnTo>
                  <a:pt x="48" y="752"/>
                </a:lnTo>
                <a:lnTo>
                  <a:pt x="0" y="752"/>
                </a:lnTo>
                <a:lnTo>
                  <a:pt x="0" y="376"/>
                </a:lnTo>
                <a:cubicBezTo>
                  <a:pt x="0" y="363"/>
                  <a:pt x="11" y="352"/>
                  <a:pt x="24" y="352"/>
                </a:cubicBezTo>
                <a:lnTo>
                  <a:pt x="2686" y="352"/>
                </a:lnTo>
                <a:lnTo>
                  <a:pt x="2662" y="376"/>
                </a:lnTo>
                <a:lnTo>
                  <a:pt x="2662" y="0"/>
                </a:lnTo>
                <a:lnTo>
                  <a:pt x="2710" y="0"/>
                </a:lnTo>
                <a:close/>
              </a:path>
            </a:pathLst>
          </a:custGeom>
          <a:solidFill>
            <a:srgbClr val="1B4171"/>
          </a:solidFill>
          <a:ln w="0" cap="flat">
            <a:solidFill>
              <a:srgbClr val="1B417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 sz="1100" b="1"/>
          </a:p>
        </p:txBody>
      </p:sp>
      <p:sp>
        <p:nvSpPr>
          <p:cNvPr id="4" name="Freeform 22"/>
          <p:cNvSpPr>
            <a:spLocks noEditPoints="1"/>
          </p:cNvSpPr>
          <p:nvPr/>
        </p:nvSpPr>
        <p:spPr bwMode="auto">
          <a:xfrm>
            <a:off x="1043608" y="3132082"/>
            <a:ext cx="838200" cy="571500"/>
          </a:xfrm>
          <a:custGeom>
            <a:avLst/>
            <a:gdLst/>
            <a:ahLst/>
            <a:cxnLst>
              <a:cxn ang="0">
                <a:pos x="1" y="112"/>
              </a:cxn>
              <a:cxn ang="0">
                <a:pos x="12" y="67"/>
              </a:cxn>
              <a:cxn ang="0">
                <a:pos x="38" y="32"/>
              </a:cxn>
              <a:cxn ang="0">
                <a:pos x="76" y="8"/>
              </a:cxn>
              <a:cxn ang="0">
                <a:pos x="116" y="0"/>
              </a:cxn>
              <a:cxn ang="0">
                <a:pos x="1298" y="1"/>
              </a:cxn>
              <a:cxn ang="0">
                <a:pos x="1343" y="12"/>
              </a:cxn>
              <a:cxn ang="0">
                <a:pos x="1379" y="38"/>
              </a:cxn>
              <a:cxn ang="0">
                <a:pos x="1401" y="76"/>
              </a:cxn>
              <a:cxn ang="0">
                <a:pos x="1408" y="116"/>
              </a:cxn>
              <a:cxn ang="0">
                <a:pos x="1408" y="850"/>
              </a:cxn>
              <a:cxn ang="0">
                <a:pos x="1398" y="895"/>
              </a:cxn>
              <a:cxn ang="0">
                <a:pos x="1372" y="931"/>
              </a:cxn>
              <a:cxn ang="0">
                <a:pos x="1334" y="953"/>
              </a:cxn>
              <a:cxn ang="0">
                <a:pos x="1293" y="960"/>
              </a:cxn>
              <a:cxn ang="0">
                <a:pos x="112" y="960"/>
              </a:cxn>
              <a:cxn ang="0">
                <a:pos x="67" y="950"/>
              </a:cxn>
              <a:cxn ang="0">
                <a:pos x="32" y="924"/>
              </a:cxn>
              <a:cxn ang="0">
                <a:pos x="8" y="886"/>
              </a:cxn>
              <a:cxn ang="0">
                <a:pos x="0" y="845"/>
              </a:cxn>
              <a:cxn ang="0">
                <a:pos x="48" y="845"/>
              </a:cxn>
              <a:cxn ang="0">
                <a:pos x="55" y="877"/>
              </a:cxn>
              <a:cxn ang="0">
                <a:pos x="71" y="897"/>
              </a:cxn>
              <a:cxn ang="0">
                <a:pos x="94" y="909"/>
              </a:cxn>
              <a:cxn ang="0">
                <a:pos x="121" y="913"/>
              </a:cxn>
              <a:cxn ang="0">
                <a:pos x="1293" y="912"/>
              </a:cxn>
              <a:cxn ang="0">
                <a:pos x="1325" y="906"/>
              </a:cxn>
              <a:cxn ang="0">
                <a:pos x="1345" y="890"/>
              </a:cxn>
              <a:cxn ang="0">
                <a:pos x="1357" y="868"/>
              </a:cxn>
              <a:cxn ang="0">
                <a:pos x="1361" y="841"/>
              </a:cxn>
              <a:cxn ang="0">
                <a:pos x="1360" y="116"/>
              </a:cxn>
              <a:cxn ang="0">
                <a:pos x="1354" y="85"/>
              </a:cxn>
              <a:cxn ang="0">
                <a:pos x="1338" y="65"/>
              </a:cxn>
              <a:cxn ang="0">
                <a:pos x="1316" y="51"/>
              </a:cxn>
              <a:cxn ang="0">
                <a:pos x="1289" y="48"/>
              </a:cxn>
              <a:cxn ang="0">
                <a:pos x="116" y="48"/>
              </a:cxn>
              <a:cxn ang="0">
                <a:pos x="85" y="55"/>
              </a:cxn>
              <a:cxn ang="0">
                <a:pos x="65" y="71"/>
              </a:cxn>
              <a:cxn ang="0">
                <a:pos x="51" y="94"/>
              </a:cxn>
              <a:cxn ang="0">
                <a:pos x="48" y="121"/>
              </a:cxn>
              <a:cxn ang="0">
                <a:pos x="48" y="845"/>
              </a:cxn>
            </a:cxnLst>
            <a:rect l="0" t="0" r="r" b="b"/>
            <a:pathLst>
              <a:path w="1408" h="960">
                <a:moveTo>
                  <a:pt x="0" y="116"/>
                </a:moveTo>
                <a:cubicBezTo>
                  <a:pt x="0" y="115"/>
                  <a:pt x="1" y="113"/>
                  <a:pt x="1" y="112"/>
                </a:cubicBezTo>
                <a:lnTo>
                  <a:pt x="8" y="76"/>
                </a:lnTo>
                <a:cubicBezTo>
                  <a:pt x="9" y="73"/>
                  <a:pt x="10" y="70"/>
                  <a:pt x="12" y="67"/>
                </a:cubicBezTo>
                <a:lnTo>
                  <a:pt x="32" y="38"/>
                </a:lnTo>
                <a:cubicBezTo>
                  <a:pt x="33" y="35"/>
                  <a:pt x="35" y="33"/>
                  <a:pt x="38" y="32"/>
                </a:cubicBezTo>
                <a:lnTo>
                  <a:pt x="67" y="12"/>
                </a:lnTo>
                <a:cubicBezTo>
                  <a:pt x="70" y="10"/>
                  <a:pt x="73" y="9"/>
                  <a:pt x="76" y="8"/>
                </a:cubicBezTo>
                <a:lnTo>
                  <a:pt x="112" y="1"/>
                </a:lnTo>
                <a:cubicBezTo>
                  <a:pt x="113" y="1"/>
                  <a:pt x="115" y="0"/>
                  <a:pt x="116" y="0"/>
                </a:cubicBezTo>
                <a:lnTo>
                  <a:pt x="1293" y="0"/>
                </a:lnTo>
                <a:cubicBezTo>
                  <a:pt x="1295" y="0"/>
                  <a:pt x="1297" y="1"/>
                  <a:pt x="1298" y="1"/>
                </a:cubicBezTo>
                <a:lnTo>
                  <a:pt x="1334" y="8"/>
                </a:lnTo>
                <a:cubicBezTo>
                  <a:pt x="1337" y="9"/>
                  <a:pt x="1340" y="10"/>
                  <a:pt x="1343" y="12"/>
                </a:cubicBezTo>
                <a:lnTo>
                  <a:pt x="1372" y="32"/>
                </a:lnTo>
                <a:cubicBezTo>
                  <a:pt x="1375" y="33"/>
                  <a:pt x="1377" y="36"/>
                  <a:pt x="1379" y="38"/>
                </a:cubicBezTo>
                <a:lnTo>
                  <a:pt x="1398" y="67"/>
                </a:lnTo>
                <a:cubicBezTo>
                  <a:pt x="1399" y="70"/>
                  <a:pt x="1400" y="73"/>
                  <a:pt x="1401" y="76"/>
                </a:cubicBezTo>
                <a:lnTo>
                  <a:pt x="1408" y="112"/>
                </a:lnTo>
                <a:cubicBezTo>
                  <a:pt x="1408" y="113"/>
                  <a:pt x="1408" y="115"/>
                  <a:pt x="1408" y="116"/>
                </a:cubicBezTo>
                <a:lnTo>
                  <a:pt x="1408" y="845"/>
                </a:lnTo>
                <a:cubicBezTo>
                  <a:pt x="1408" y="847"/>
                  <a:pt x="1408" y="849"/>
                  <a:pt x="1408" y="850"/>
                </a:cubicBezTo>
                <a:lnTo>
                  <a:pt x="1401" y="886"/>
                </a:lnTo>
                <a:cubicBezTo>
                  <a:pt x="1400" y="889"/>
                  <a:pt x="1399" y="892"/>
                  <a:pt x="1398" y="895"/>
                </a:cubicBezTo>
                <a:lnTo>
                  <a:pt x="1379" y="924"/>
                </a:lnTo>
                <a:cubicBezTo>
                  <a:pt x="1377" y="926"/>
                  <a:pt x="1374" y="929"/>
                  <a:pt x="1372" y="931"/>
                </a:cubicBezTo>
                <a:lnTo>
                  <a:pt x="1343" y="950"/>
                </a:lnTo>
                <a:cubicBezTo>
                  <a:pt x="1340" y="951"/>
                  <a:pt x="1337" y="952"/>
                  <a:pt x="1334" y="953"/>
                </a:cubicBezTo>
                <a:lnTo>
                  <a:pt x="1298" y="960"/>
                </a:lnTo>
                <a:cubicBezTo>
                  <a:pt x="1297" y="960"/>
                  <a:pt x="1295" y="960"/>
                  <a:pt x="1293" y="960"/>
                </a:cubicBezTo>
                <a:lnTo>
                  <a:pt x="116" y="960"/>
                </a:lnTo>
                <a:cubicBezTo>
                  <a:pt x="115" y="960"/>
                  <a:pt x="113" y="960"/>
                  <a:pt x="112" y="960"/>
                </a:cubicBezTo>
                <a:lnTo>
                  <a:pt x="76" y="953"/>
                </a:lnTo>
                <a:cubicBezTo>
                  <a:pt x="73" y="952"/>
                  <a:pt x="70" y="951"/>
                  <a:pt x="67" y="950"/>
                </a:cubicBezTo>
                <a:lnTo>
                  <a:pt x="38" y="931"/>
                </a:lnTo>
                <a:cubicBezTo>
                  <a:pt x="36" y="929"/>
                  <a:pt x="33" y="927"/>
                  <a:pt x="32" y="924"/>
                </a:cubicBezTo>
                <a:lnTo>
                  <a:pt x="12" y="895"/>
                </a:lnTo>
                <a:cubicBezTo>
                  <a:pt x="10" y="892"/>
                  <a:pt x="9" y="889"/>
                  <a:pt x="8" y="886"/>
                </a:cubicBezTo>
                <a:lnTo>
                  <a:pt x="1" y="850"/>
                </a:lnTo>
                <a:cubicBezTo>
                  <a:pt x="1" y="849"/>
                  <a:pt x="0" y="847"/>
                  <a:pt x="0" y="845"/>
                </a:cubicBezTo>
                <a:lnTo>
                  <a:pt x="0" y="116"/>
                </a:lnTo>
                <a:close/>
                <a:moveTo>
                  <a:pt x="48" y="845"/>
                </a:moveTo>
                <a:lnTo>
                  <a:pt x="48" y="841"/>
                </a:lnTo>
                <a:lnTo>
                  <a:pt x="55" y="877"/>
                </a:lnTo>
                <a:lnTo>
                  <a:pt x="51" y="868"/>
                </a:lnTo>
                <a:lnTo>
                  <a:pt x="71" y="897"/>
                </a:lnTo>
                <a:lnTo>
                  <a:pt x="65" y="890"/>
                </a:lnTo>
                <a:lnTo>
                  <a:pt x="94" y="909"/>
                </a:lnTo>
                <a:lnTo>
                  <a:pt x="85" y="906"/>
                </a:lnTo>
                <a:lnTo>
                  <a:pt x="121" y="913"/>
                </a:lnTo>
                <a:lnTo>
                  <a:pt x="116" y="912"/>
                </a:lnTo>
                <a:lnTo>
                  <a:pt x="1293" y="912"/>
                </a:lnTo>
                <a:lnTo>
                  <a:pt x="1289" y="913"/>
                </a:lnTo>
                <a:lnTo>
                  <a:pt x="1325" y="906"/>
                </a:lnTo>
                <a:lnTo>
                  <a:pt x="1316" y="909"/>
                </a:lnTo>
                <a:lnTo>
                  <a:pt x="1345" y="890"/>
                </a:lnTo>
                <a:lnTo>
                  <a:pt x="1338" y="897"/>
                </a:lnTo>
                <a:lnTo>
                  <a:pt x="1357" y="868"/>
                </a:lnTo>
                <a:lnTo>
                  <a:pt x="1354" y="877"/>
                </a:lnTo>
                <a:lnTo>
                  <a:pt x="1361" y="841"/>
                </a:lnTo>
                <a:lnTo>
                  <a:pt x="1360" y="845"/>
                </a:lnTo>
                <a:lnTo>
                  <a:pt x="1360" y="116"/>
                </a:lnTo>
                <a:lnTo>
                  <a:pt x="1361" y="121"/>
                </a:lnTo>
                <a:lnTo>
                  <a:pt x="1354" y="85"/>
                </a:lnTo>
                <a:lnTo>
                  <a:pt x="1357" y="94"/>
                </a:lnTo>
                <a:lnTo>
                  <a:pt x="1338" y="65"/>
                </a:lnTo>
                <a:lnTo>
                  <a:pt x="1345" y="71"/>
                </a:lnTo>
                <a:lnTo>
                  <a:pt x="1316" y="51"/>
                </a:lnTo>
                <a:lnTo>
                  <a:pt x="1325" y="55"/>
                </a:lnTo>
                <a:lnTo>
                  <a:pt x="1289" y="48"/>
                </a:lnTo>
                <a:lnTo>
                  <a:pt x="1293" y="48"/>
                </a:lnTo>
                <a:lnTo>
                  <a:pt x="116" y="48"/>
                </a:lnTo>
                <a:lnTo>
                  <a:pt x="121" y="48"/>
                </a:lnTo>
                <a:lnTo>
                  <a:pt x="85" y="55"/>
                </a:lnTo>
                <a:lnTo>
                  <a:pt x="94" y="51"/>
                </a:lnTo>
                <a:lnTo>
                  <a:pt x="65" y="71"/>
                </a:lnTo>
                <a:lnTo>
                  <a:pt x="71" y="65"/>
                </a:lnTo>
                <a:lnTo>
                  <a:pt x="51" y="94"/>
                </a:lnTo>
                <a:lnTo>
                  <a:pt x="55" y="85"/>
                </a:lnTo>
                <a:lnTo>
                  <a:pt x="48" y="121"/>
                </a:lnTo>
                <a:lnTo>
                  <a:pt x="48" y="116"/>
                </a:lnTo>
                <a:lnTo>
                  <a:pt x="48" y="845"/>
                </a:lnTo>
                <a:close/>
              </a:path>
            </a:pathLst>
          </a:custGeom>
          <a:solidFill>
            <a:srgbClr val="1B4171"/>
          </a:solidFill>
          <a:ln w="0" cap="flat">
            <a:solidFill>
              <a:srgbClr val="1B417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 sz="1100" b="1"/>
          </a:p>
        </p:txBody>
      </p:sp>
      <p:sp>
        <p:nvSpPr>
          <p:cNvPr id="5" name="Freeform 47"/>
          <p:cNvSpPr>
            <a:spLocks/>
          </p:cNvSpPr>
          <p:nvPr/>
        </p:nvSpPr>
        <p:spPr bwMode="auto">
          <a:xfrm>
            <a:off x="2194309" y="2698694"/>
            <a:ext cx="734367" cy="447675"/>
          </a:xfrm>
          <a:custGeom>
            <a:avLst/>
            <a:gdLst/>
            <a:ahLst/>
            <a:cxnLst>
              <a:cxn ang="0">
                <a:pos x="48" y="0"/>
              </a:cxn>
              <a:cxn ang="0">
                <a:pos x="48" y="376"/>
              </a:cxn>
              <a:cxn ang="0">
                <a:pos x="24" y="352"/>
              </a:cxn>
              <a:cxn ang="0">
                <a:pos x="2686" y="352"/>
              </a:cxn>
              <a:cxn ang="0">
                <a:pos x="2710" y="376"/>
              </a:cxn>
              <a:cxn ang="0">
                <a:pos x="2710" y="752"/>
              </a:cxn>
              <a:cxn ang="0">
                <a:pos x="2662" y="752"/>
              </a:cxn>
              <a:cxn ang="0">
                <a:pos x="2662" y="376"/>
              </a:cxn>
              <a:cxn ang="0">
                <a:pos x="2686" y="400"/>
              </a:cxn>
              <a:cxn ang="0">
                <a:pos x="24" y="400"/>
              </a:cxn>
              <a:cxn ang="0">
                <a:pos x="0" y="376"/>
              </a:cxn>
              <a:cxn ang="0">
                <a:pos x="0" y="0"/>
              </a:cxn>
              <a:cxn ang="0">
                <a:pos x="48" y="0"/>
              </a:cxn>
            </a:cxnLst>
            <a:rect l="0" t="0" r="r" b="b"/>
            <a:pathLst>
              <a:path w="2710" h="752">
                <a:moveTo>
                  <a:pt x="48" y="0"/>
                </a:moveTo>
                <a:lnTo>
                  <a:pt x="48" y="376"/>
                </a:lnTo>
                <a:lnTo>
                  <a:pt x="24" y="352"/>
                </a:lnTo>
                <a:lnTo>
                  <a:pt x="2686" y="352"/>
                </a:lnTo>
                <a:cubicBezTo>
                  <a:pt x="2699" y="352"/>
                  <a:pt x="2710" y="363"/>
                  <a:pt x="2710" y="376"/>
                </a:cubicBezTo>
                <a:lnTo>
                  <a:pt x="2710" y="752"/>
                </a:lnTo>
                <a:lnTo>
                  <a:pt x="2662" y="752"/>
                </a:lnTo>
                <a:lnTo>
                  <a:pt x="2662" y="376"/>
                </a:lnTo>
                <a:lnTo>
                  <a:pt x="2686" y="400"/>
                </a:lnTo>
                <a:lnTo>
                  <a:pt x="24" y="400"/>
                </a:lnTo>
                <a:cubicBezTo>
                  <a:pt x="11" y="400"/>
                  <a:pt x="0" y="390"/>
                  <a:pt x="0" y="376"/>
                </a:cubicBezTo>
                <a:lnTo>
                  <a:pt x="0" y="0"/>
                </a:lnTo>
                <a:lnTo>
                  <a:pt x="48" y="0"/>
                </a:lnTo>
                <a:close/>
              </a:path>
            </a:pathLst>
          </a:custGeom>
          <a:solidFill>
            <a:srgbClr val="1B4171"/>
          </a:solidFill>
          <a:ln w="0" cap="flat">
            <a:solidFill>
              <a:srgbClr val="1B417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 sz="1100" b="1"/>
          </a:p>
        </p:txBody>
      </p:sp>
      <p:sp>
        <p:nvSpPr>
          <p:cNvPr id="7" name="Freeform 49"/>
          <p:cNvSpPr>
            <a:spLocks noEditPoints="1"/>
          </p:cNvSpPr>
          <p:nvPr/>
        </p:nvSpPr>
        <p:spPr bwMode="auto">
          <a:xfrm>
            <a:off x="2496628" y="3132082"/>
            <a:ext cx="847725" cy="571500"/>
          </a:xfrm>
          <a:custGeom>
            <a:avLst/>
            <a:gdLst/>
            <a:ahLst/>
            <a:cxnLst>
              <a:cxn ang="0">
                <a:pos x="1" y="112"/>
              </a:cxn>
              <a:cxn ang="0">
                <a:pos x="12" y="67"/>
              </a:cxn>
              <a:cxn ang="0">
                <a:pos x="38" y="32"/>
              </a:cxn>
              <a:cxn ang="0">
                <a:pos x="76" y="8"/>
              </a:cxn>
              <a:cxn ang="0">
                <a:pos x="116" y="0"/>
              </a:cxn>
              <a:cxn ang="0">
                <a:pos x="1314" y="1"/>
              </a:cxn>
              <a:cxn ang="0">
                <a:pos x="1359" y="12"/>
              </a:cxn>
              <a:cxn ang="0">
                <a:pos x="1395" y="38"/>
              </a:cxn>
              <a:cxn ang="0">
                <a:pos x="1417" y="76"/>
              </a:cxn>
              <a:cxn ang="0">
                <a:pos x="1424" y="116"/>
              </a:cxn>
              <a:cxn ang="0">
                <a:pos x="1424" y="850"/>
              </a:cxn>
              <a:cxn ang="0">
                <a:pos x="1414" y="895"/>
              </a:cxn>
              <a:cxn ang="0">
                <a:pos x="1388" y="931"/>
              </a:cxn>
              <a:cxn ang="0">
                <a:pos x="1350" y="953"/>
              </a:cxn>
              <a:cxn ang="0">
                <a:pos x="1309" y="960"/>
              </a:cxn>
              <a:cxn ang="0">
                <a:pos x="112" y="960"/>
              </a:cxn>
              <a:cxn ang="0">
                <a:pos x="67" y="950"/>
              </a:cxn>
              <a:cxn ang="0">
                <a:pos x="32" y="924"/>
              </a:cxn>
              <a:cxn ang="0">
                <a:pos x="8" y="886"/>
              </a:cxn>
              <a:cxn ang="0">
                <a:pos x="0" y="845"/>
              </a:cxn>
              <a:cxn ang="0">
                <a:pos x="48" y="845"/>
              </a:cxn>
              <a:cxn ang="0">
                <a:pos x="55" y="877"/>
              </a:cxn>
              <a:cxn ang="0">
                <a:pos x="71" y="897"/>
              </a:cxn>
              <a:cxn ang="0">
                <a:pos x="94" y="909"/>
              </a:cxn>
              <a:cxn ang="0">
                <a:pos x="121" y="913"/>
              </a:cxn>
              <a:cxn ang="0">
                <a:pos x="1309" y="912"/>
              </a:cxn>
              <a:cxn ang="0">
                <a:pos x="1341" y="906"/>
              </a:cxn>
              <a:cxn ang="0">
                <a:pos x="1361" y="890"/>
              </a:cxn>
              <a:cxn ang="0">
                <a:pos x="1373" y="868"/>
              </a:cxn>
              <a:cxn ang="0">
                <a:pos x="1377" y="841"/>
              </a:cxn>
              <a:cxn ang="0">
                <a:pos x="1376" y="116"/>
              </a:cxn>
              <a:cxn ang="0">
                <a:pos x="1370" y="85"/>
              </a:cxn>
              <a:cxn ang="0">
                <a:pos x="1354" y="65"/>
              </a:cxn>
              <a:cxn ang="0">
                <a:pos x="1332" y="51"/>
              </a:cxn>
              <a:cxn ang="0">
                <a:pos x="1305" y="48"/>
              </a:cxn>
              <a:cxn ang="0">
                <a:pos x="116" y="48"/>
              </a:cxn>
              <a:cxn ang="0">
                <a:pos x="85" y="55"/>
              </a:cxn>
              <a:cxn ang="0">
                <a:pos x="65" y="71"/>
              </a:cxn>
              <a:cxn ang="0">
                <a:pos x="51" y="94"/>
              </a:cxn>
              <a:cxn ang="0">
                <a:pos x="48" y="121"/>
              </a:cxn>
              <a:cxn ang="0">
                <a:pos x="48" y="845"/>
              </a:cxn>
            </a:cxnLst>
            <a:rect l="0" t="0" r="r" b="b"/>
            <a:pathLst>
              <a:path w="1424" h="960">
                <a:moveTo>
                  <a:pt x="0" y="116"/>
                </a:moveTo>
                <a:cubicBezTo>
                  <a:pt x="0" y="115"/>
                  <a:pt x="1" y="113"/>
                  <a:pt x="1" y="112"/>
                </a:cubicBezTo>
                <a:lnTo>
                  <a:pt x="8" y="76"/>
                </a:lnTo>
                <a:cubicBezTo>
                  <a:pt x="9" y="73"/>
                  <a:pt x="10" y="70"/>
                  <a:pt x="12" y="67"/>
                </a:cubicBezTo>
                <a:lnTo>
                  <a:pt x="32" y="38"/>
                </a:lnTo>
                <a:cubicBezTo>
                  <a:pt x="33" y="35"/>
                  <a:pt x="35" y="33"/>
                  <a:pt x="38" y="32"/>
                </a:cubicBezTo>
                <a:lnTo>
                  <a:pt x="67" y="12"/>
                </a:lnTo>
                <a:cubicBezTo>
                  <a:pt x="70" y="10"/>
                  <a:pt x="73" y="9"/>
                  <a:pt x="76" y="8"/>
                </a:cubicBezTo>
                <a:lnTo>
                  <a:pt x="112" y="1"/>
                </a:lnTo>
                <a:cubicBezTo>
                  <a:pt x="113" y="1"/>
                  <a:pt x="115" y="0"/>
                  <a:pt x="116" y="0"/>
                </a:cubicBezTo>
                <a:lnTo>
                  <a:pt x="1309" y="0"/>
                </a:lnTo>
                <a:cubicBezTo>
                  <a:pt x="1311" y="0"/>
                  <a:pt x="1313" y="1"/>
                  <a:pt x="1314" y="1"/>
                </a:cubicBezTo>
                <a:lnTo>
                  <a:pt x="1350" y="8"/>
                </a:lnTo>
                <a:cubicBezTo>
                  <a:pt x="1353" y="9"/>
                  <a:pt x="1356" y="10"/>
                  <a:pt x="1359" y="12"/>
                </a:cubicBezTo>
                <a:lnTo>
                  <a:pt x="1388" y="32"/>
                </a:lnTo>
                <a:cubicBezTo>
                  <a:pt x="1391" y="33"/>
                  <a:pt x="1393" y="36"/>
                  <a:pt x="1395" y="38"/>
                </a:cubicBezTo>
                <a:lnTo>
                  <a:pt x="1414" y="67"/>
                </a:lnTo>
                <a:cubicBezTo>
                  <a:pt x="1415" y="70"/>
                  <a:pt x="1416" y="73"/>
                  <a:pt x="1417" y="76"/>
                </a:cubicBezTo>
                <a:lnTo>
                  <a:pt x="1424" y="112"/>
                </a:lnTo>
                <a:cubicBezTo>
                  <a:pt x="1424" y="113"/>
                  <a:pt x="1424" y="115"/>
                  <a:pt x="1424" y="116"/>
                </a:cubicBezTo>
                <a:lnTo>
                  <a:pt x="1424" y="845"/>
                </a:lnTo>
                <a:cubicBezTo>
                  <a:pt x="1424" y="847"/>
                  <a:pt x="1424" y="849"/>
                  <a:pt x="1424" y="850"/>
                </a:cubicBezTo>
                <a:lnTo>
                  <a:pt x="1417" y="886"/>
                </a:lnTo>
                <a:cubicBezTo>
                  <a:pt x="1416" y="889"/>
                  <a:pt x="1415" y="892"/>
                  <a:pt x="1414" y="895"/>
                </a:cubicBezTo>
                <a:lnTo>
                  <a:pt x="1395" y="924"/>
                </a:lnTo>
                <a:cubicBezTo>
                  <a:pt x="1393" y="926"/>
                  <a:pt x="1390" y="929"/>
                  <a:pt x="1388" y="931"/>
                </a:cubicBezTo>
                <a:lnTo>
                  <a:pt x="1359" y="950"/>
                </a:lnTo>
                <a:cubicBezTo>
                  <a:pt x="1356" y="951"/>
                  <a:pt x="1353" y="952"/>
                  <a:pt x="1350" y="953"/>
                </a:cubicBezTo>
                <a:lnTo>
                  <a:pt x="1314" y="960"/>
                </a:lnTo>
                <a:cubicBezTo>
                  <a:pt x="1313" y="960"/>
                  <a:pt x="1311" y="960"/>
                  <a:pt x="1309" y="960"/>
                </a:cubicBezTo>
                <a:lnTo>
                  <a:pt x="116" y="960"/>
                </a:lnTo>
                <a:cubicBezTo>
                  <a:pt x="115" y="960"/>
                  <a:pt x="113" y="960"/>
                  <a:pt x="112" y="960"/>
                </a:cubicBezTo>
                <a:lnTo>
                  <a:pt x="76" y="953"/>
                </a:lnTo>
                <a:cubicBezTo>
                  <a:pt x="73" y="952"/>
                  <a:pt x="70" y="951"/>
                  <a:pt x="67" y="950"/>
                </a:cubicBezTo>
                <a:lnTo>
                  <a:pt x="38" y="931"/>
                </a:lnTo>
                <a:cubicBezTo>
                  <a:pt x="36" y="929"/>
                  <a:pt x="33" y="927"/>
                  <a:pt x="32" y="924"/>
                </a:cubicBezTo>
                <a:lnTo>
                  <a:pt x="12" y="895"/>
                </a:lnTo>
                <a:cubicBezTo>
                  <a:pt x="10" y="892"/>
                  <a:pt x="9" y="889"/>
                  <a:pt x="8" y="886"/>
                </a:cubicBezTo>
                <a:lnTo>
                  <a:pt x="1" y="850"/>
                </a:lnTo>
                <a:cubicBezTo>
                  <a:pt x="1" y="849"/>
                  <a:pt x="0" y="847"/>
                  <a:pt x="0" y="845"/>
                </a:cubicBezTo>
                <a:lnTo>
                  <a:pt x="0" y="116"/>
                </a:lnTo>
                <a:close/>
                <a:moveTo>
                  <a:pt x="48" y="845"/>
                </a:moveTo>
                <a:lnTo>
                  <a:pt x="48" y="841"/>
                </a:lnTo>
                <a:lnTo>
                  <a:pt x="55" y="877"/>
                </a:lnTo>
                <a:lnTo>
                  <a:pt x="51" y="868"/>
                </a:lnTo>
                <a:lnTo>
                  <a:pt x="71" y="897"/>
                </a:lnTo>
                <a:lnTo>
                  <a:pt x="65" y="890"/>
                </a:lnTo>
                <a:lnTo>
                  <a:pt x="94" y="909"/>
                </a:lnTo>
                <a:lnTo>
                  <a:pt x="85" y="906"/>
                </a:lnTo>
                <a:lnTo>
                  <a:pt x="121" y="913"/>
                </a:lnTo>
                <a:lnTo>
                  <a:pt x="116" y="912"/>
                </a:lnTo>
                <a:lnTo>
                  <a:pt x="1309" y="912"/>
                </a:lnTo>
                <a:lnTo>
                  <a:pt x="1305" y="913"/>
                </a:lnTo>
                <a:lnTo>
                  <a:pt x="1341" y="906"/>
                </a:lnTo>
                <a:lnTo>
                  <a:pt x="1332" y="909"/>
                </a:lnTo>
                <a:lnTo>
                  <a:pt x="1361" y="890"/>
                </a:lnTo>
                <a:lnTo>
                  <a:pt x="1354" y="897"/>
                </a:lnTo>
                <a:lnTo>
                  <a:pt x="1373" y="868"/>
                </a:lnTo>
                <a:lnTo>
                  <a:pt x="1370" y="877"/>
                </a:lnTo>
                <a:lnTo>
                  <a:pt x="1377" y="841"/>
                </a:lnTo>
                <a:lnTo>
                  <a:pt x="1376" y="845"/>
                </a:lnTo>
                <a:lnTo>
                  <a:pt x="1376" y="116"/>
                </a:lnTo>
                <a:lnTo>
                  <a:pt x="1377" y="121"/>
                </a:lnTo>
                <a:lnTo>
                  <a:pt x="1370" y="85"/>
                </a:lnTo>
                <a:lnTo>
                  <a:pt x="1373" y="94"/>
                </a:lnTo>
                <a:lnTo>
                  <a:pt x="1354" y="65"/>
                </a:lnTo>
                <a:lnTo>
                  <a:pt x="1361" y="71"/>
                </a:lnTo>
                <a:lnTo>
                  <a:pt x="1332" y="51"/>
                </a:lnTo>
                <a:lnTo>
                  <a:pt x="1341" y="55"/>
                </a:lnTo>
                <a:lnTo>
                  <a:pt x="1305" y="48"/>
                </a:lnTo>
                <a:lnTo>
                  <a:pt x="1309" y="48"/>
                </a:lnTo>
                <a:lnTo>
                  <a:pt x="116" y="48"/>
                </a:lnTo>
                <a:lnTo>
                  <a:pt x="121" y="48"/>
                </a:lnTo>
                <a:lnTo>
                  <a:pt x="85" y="55"/>
                </a:lnTo>
                <a:lnTo>
                  <a:pt x="94" y="51"/>
                </a:lnTo>
                <a:lnTo>
                  <a:pt x="65" y="71"/>
                </a:lnTo>
                <a:lnTo>
                  <a:pt x="71" y="65"/>
                </a:lnTo>
                <a:lnTo>
                  <a:pt x="51" y="94"/>
                </a:lnTo>
                <a:lnTo>
                  <a:pt x="55" y="85"/>
                </a:lnTo>
                <a:lnTo>
                  <a:pt x="48" y="121"/>
                </a:lnTo>
                <a:lnTo>
                  <a:pt x="48" y="116"/>
                </a:lnTo>
                <a:lnTo>
                  <a:pt x="48" y="845"/>
                </a:lnTo>
                <a:close/>
              </a:path>
            </a:pathLst>
          </a:custGeom>
          <a:solidFill>
            <a:srgbClr val="1B4171"/>
          </a:solidFill>
          <a:ln w="0" cap="flat">
            <a:solidFill>
              <a:srgbClr val="1B417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 sz="1100" b="1"/>
          </a:p>
        </p:txBody>
      </p:sp>
      <p:sp>
        <p:nvSpPr>
          <p:cNvPr id="24" name="Freeform 20"/>
          <p:cNvSpPr>
            <a:spLocks/>
          </p:cNvSpPr>
          <p:nvPr/>
        </p:nvSpPr>
        <p:spPr bwMode="auto">
          <a:xfrm>
            <a:off x="1154372" y="4799777"/>
            <a:ext cx="342082" cy="428824"/>
          </a:xfrm>
          <a:custGeom>
            <a:avLst/>
            <a:gdLst/>
            <a:ahLst/>
            <a:cxnLst>
              <a:cxn ang="0">
                <a:pos x="2710" y="0"/>
              </a:cxn>
              <a:cxn ang="0">
                <a:pos x="2710" y="376"/>
              </a:cxn>
              <a:cxn ang="0">
                <a:pos x="2686" y="400"/>
              </a:cxn>
              <a:cxn ang="0">
                <a:pos x="24" y="400"/>
              </a:cxn>
              <a:cxn ang="0">
                <a:pos x="48" y="376"/>
              </a:cxn>
              <a:cxn ang="0">
                <a:pos x="48" y="752"/>
              </a:cxn>
              <a:cxn ang="0">
                <a:pos x="0" y="752"/>
              </a:cxn>
              <a:cxn ang="0">
                <a:pos x="0" y="376"/>
              </a:cxn>
              <a:cxn ang="0">
                <a:pos x="24" y="352"/>
              </a:cxn>
              <a:cxn ang="0">
                <a:pos x="2686" y="352"/>
              </a:cxn>
              <a:cxn ang="0">
                <a:pos x="2662" y="376"/>
              </a:cxn>
              <a:cxn ang="0">
                <a:pos x="2662" y="0"/>
              </a:cxn>
              <a:cxn ang="0">
                <a:pos x="2710" y="0"/>
              </a:cxn>
            </a:cxnLst>
            <a:rect l="0" t="0" r="r" b="b"/>
            <a:pathLst>
              <a:path w="2710" h="752">
                <a:moveTo>
                  <a:pt x="2710" y="0"/>
                </a:moveTo>
                <a:lnTo>
                  <a:pt x="2710" y="376"/>
                </a:lnTo>
                <a:cubicBezTo>
                  <a:pt x="2710" y="390"/>
                  <a:pt x="2699" y="400"/>
                  <a:pt x="2686" y="400"/>
                </a:cubicBezTo>
                <a:lnTo>
                  <a:pt x="24" y="400"/>
                </a:lnTo>
                <a:lnTo>
                  <a:pt x="48" y="376"/>
                </a:lnTo>
                <a:lnTo>
                  <a:pt x="48" y="752"/>
                </a:lnTo>
                <a:lnTo>
                  <a:pt x="0" y="752"/>
                </a:lnTo>
                <a:lnTo>
                  <a:pt x="0" y="376"/>
                </a:lnTo>
                <a:cubicBezTo>
                  <a:pt x="0" y="363"/>
                  <a:pt x="11" y="352"/>
                  <a:pt x="24" y="352"/>
                </a:cubicBezTo>
                <a:lnTo>
                  <a:pt x="2686" y="352"/>
                </a:lnTo>
                <a:lnTo>
                  <a:pt x="2662" y="376"/>
                </a:lnTo>
                <a:lnTo>
                  <a:pt x="2662" y="0"/>
                </a:lnTo>
                <a:lnTo>
                  <a:pt x="2710" y="0"/>
                </a:lnTo>
                <a:close/>
              </a:path>
            </a:pathLst>
          </a:custGeom>
          <a:solidFill>
            <a:srgbClr val="1B4171"/>
          </a:solidFill>
          <a:ln w="0" cap="flat">
            <a:solidFill>
              <a:srgbClr val="1B417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 sz="1100" b="1"/>
          </a:p>
        </p:txBody>
      </p:sp>
      <p:sp>
        <p:nvSpPr>
          <p:cNvPr id="25" name="Freeform 22"/>
          <p:cNvSpPr>
            <a:spLocks noEditPoints="1"/>
          </p:cNvSpPr>
          <p:nvPr/>
        </p:nvSpPr>
        <p:spPr bwMode="auto">
          <a:xfrm>
            <a:off x="611560" y="5229200"/>
            <a:ext cx="731706" cy="360040"/>
          </a:xfrm>
          <a:custGeom>
            <a:avLst/>
            <a:gdLst/>
            <a:ahLst/>
            <a:cxnLst>
              <a:cxn ang="0">
                <a:pos x="1" y="112"/>
              </a:cxn>
              <a:cxn ang="0">
                <a:pos x="12" y="67"/>
              </a:cxn>
              <a:cxn ang="0">
                <a:pos x="38" y="32"/>
              </a:cxn>
              <a:cxn ang="0">
                <a:pos x="76" y="8"/>
              </a:cxn>
              <a:cxn ang="0">
                <a:pos x="116" y="0"/>
              </a:cxn>
              <a:cxn ang="0">
                <a:pos x="1298" y="1"/>
              </a:cxn>
              <a:cxn ang="0">
                <a:pos x="1343" y="12"/>
              </a:cxn>
              <a:cxn ang="0">
                <a:pos x="1379" y="38"/>
              </a:cxn>
              <a:cxn ang="0">
                <a:pos x="1401" y="76"/>
              </a:cxn>
              <a:cxn ang="0">
                <a:pos x="1408" y="116"/>
              </a:cxn>
              <a:cxn ang="0">
                <a:pos x="1408" y="850"/>
              </a:cxn>
              <a:cxn ang="0">
                <a:pos x="1398" y="895"/>
              </a:cxn>
              <a:cxn ang="0">
                <a:pos x="1372" y="931"/>
              </a:cxn>
              <a:cxn ang="0">
                <a:pos x="1334" y="953"/>
              </a:cxn>
              <a:cxn ang="0">
                <a:pos x="1293" y="960"/>
              </a:cxn>
              <a:cxn ang="0">
                <a:pos x="112" y="960"/>
              </a:cxn>
              <a:cxn ang="0">
                <a:pos x="67" y="950"/>
              </a:cxn>
              <a:cxn ang="0">
                <a:pos x="32" y="924"/>
              </a:cxn>
              <a:cxn ang="0">
                <a:pos x="8" y="886"/>
              </a:cxn>
              <a:cxn ang="0">
                <a:pos x="0" y="845"/>
              </a:cxn>
              <a:cxn ang="0">
                <a:pos x="48" y="845"/>
              </a:cxn>
              <a:cxn ang="0">
                <a:pos x="55" y="877"/>
              </a:cxn>
              <a:cxn ang="0">
                <a:pos x="71" y="897"/>
              </a:cxn>
              <a:cxn ang="0">
                <a:pos x="94" y="909"/>
              </a:cxn>
              <a:cxn ang="0">
                <a:pos x="121" y="913"/>
              </a:cxn>
              <a:cxn ang="0">
                <a:pos x="1293" y="912"/>
              </a:cxn>
              <a:cxn ang="0">
                <a:pos x="1325" y="906"/>
              </a:cxn>
              <a:cxn ang="0">
                <a:pos x="1345" y="890"/>
              </a:cxn>
              <a:cxn ang="0">
                <a:pos x="1357" y="868"/>
              </a:cxn>
              <a:cxn ang="0">
                <a:pos x="1361" y="841"/>
              </a:cxn>
              <a:cxn ang="0">
                <a:pos x="1360" y="116"/>
              </a:cxn>
              <a:cxn ang="0">
                <a:pos x="1354" y="85"/>
              </a:cxn>
              <a:cxn ang="0">
                <a:pos x="1338" y="65"/>
              </a:cxn>
              <a:cxn ang="0">
                <a:pos x="1316" y="51"/>
              </a:cxn>
              <a:cxn ang="0">
                <a:pos x="1289" y="48"/>
              </a:cxn>
              <a:cxn ang="0">
                <a:pos x="116" y="48"/>
              </a:cxn>
              <a:cxn ang="0">
                <a:pos x="85" y="55"/>
              </a:cxn>
              <a:cxn ang="0">
                <a:pos x="65" y="71"/>
              </a:cxn>
              <a:cxn ang="0">
                <a:pos x="51" y="94"/>
              </a:cxn>
              <a:cxn ang="0">
                <a:pos x="48" y="121"/>
              </a:cxn>
              <a:cxn ang="0">
                <a:pos x="48" y="845"/>
              </a:cxn>
            </a:cxnLst>
            <a:rect l="0" t="0" r="r" b="b"/>
            <a:pathLst>
              <a:path w="1408" h="960">
                <a:moveTo>
                  <a:pt x="0" y="116"/>
                </a:moveTo>
                <a:cubicBezTo>
                  <a:pt x="0" y="115"/>
                  <a:pt x="1" y="113"/>
                  <a:pt x="1" y="112"/>
                </a:cubicBezTo>
                <a:lnTo>
                  <a:pt x="8" y="76"/>
                </a:lnTo>
                <a:cubicBezTo>
                  <a:pt x="9" y="73"/>
                  <a:pt x="10" y="70"/>
                  <a:pt x="12" y="67"/>
                </a:cubicBezTo>
                <a:lnTo>
                  <a:pt x="32" y="38"/>
                </a:lnTo>
                <a:cubicBezTo>
                  <a:pt x="33" y="35"/>
                  <a:pt x="35" y="33"/>
                  <a:pt x="38" y="32"/>
                </a:cubicBezTo>
                <a:lnTo>
                  <a:pt x="67" y="12"/>
                </a:lnTo>
                <a:cubicBezTo>
                  <a:pt x="70" y="10"/>
                  <a:pt x="73" y="9"/>
                  <a:pt x="76" y="8"/>
                </a:cubicBezTo>
                <a:lnTo>
                  <a:pt x="112" y="1"/>
                </a:lnTo>
                <a:cubicBezTo>
                  <a:pt x="113" y="1"/>
                  <a:pt x="115" y="0"/>
                  <a:pt x="116" y="0"/>
                </a:cubicBezTo>
                <a:lnTo>
                  <a:pt x="1293" y="0"/>
                </a:lnTo>
                <a:cubicBezTo>
                  <a:pt x="1295" y="0"/>
                  <a:pt x="1297" y="1"/>
                  <a:pt x="1298" y="1"/>
                </a:cubicBezTo>
                <a:lnTo>
                  <a:pt x="1334" y="8"/>
                </a:lnTo>
                <a:cubicBezTo>
                  <a:pt x="1337" y="9"/>
                  <a:pt x="1340" y="10"/>
                  <a:pt x="1343" y="12"/>
                </a:cubicBezTo>
                <a:lnTo>
                  <a:pt x="1372" y="32"/>
                </a:lnTo>
                <a:cubicBezTo>
                  <a:pt x="1375" y="33"/>
                  <a:pt x="1377" y="36"/>
                  <a:pt x="1379" y="38"/>
                </a:cubicBezTo>
                <a:lnTo>
                  <a:pt x="1398" y="67"/>
                </a:lnTo>
                <a:cubicBezTo>
                  <a:pt x="1399" y="70"/>
                  <a:pt x="1400" y="73"/>
                  <a:pt x="1401" y="76"/>
                </a:cubicBezTo>
                <a:lnTo>
                  <a:pt x="1408" y="112"/>
                </a:lnTo>
                <a:cubicBezTo>
                  <a:pt x="1408" y="113"/>
                  <a:pt x="1408" y="115"/>
                  <a:pt x="1408" y="116"/>
                </a:cubicBezTo>
                <a:lnTo>
                  <a:pt x="1408" y="845"/>
                </a:lnTo>
                <a:cubicBezTo>
                  <a:pt x="1408" y="847"/>
                  <a:pt x="1408" y="849"/>
                  <a:pt x="1408" y="850"/>
                </a:cubicBezTo>
                <a:lnTo>
                  <a:pt x="1401" y="886"/>
                </a:lnTo>
                <a:cubicBezTo>
                  <a:pt x="1400" y="889"/>
                  <a:pt x="1399" y="892"/>
                  <a:pt x="1398" y="895"/>
                </a:cubicBezTo>
                <a:lnTo>
                  <a:pt x="1379" y="924"/>
                </a:lnTo>
                <a:cubicBezTo>
                  <a:pt x="1377" y="926"/>
                  <a:pt x="1374" y="929"/>
                  <a:pt x="1372" y="931"/>
                </a:cubicBezTo>
                <a:lnTo>
                  <a:pt x="1343" y="950"/>
                </a:lnTo>
                <a:cubicBezTo>
                  <a:pt x="1340" y="951"/>
                  <a:pt x="1337" y="952"/>
                  <a:pt x="1334" y="953"/>
                </a:cubicBezTo>
                <a:lnTo>
                  <a:pt x="1298" y="960"/>
                </a:lnTo>
                <a:cubicBezTo>
                  <a:pt x="1297" y="960"/>
                  <a:pt x="1295" y="960"/>
                  <a:pt x="1293" y="960"/>
                </a:cubicBezTo>
                <a:lnTo>
                  <a:pt x="116" y="960"/>
                </a:lnTo>
                <a:cubicBezTo>
                  <a:pt x="115" y="960"/>
                  <a:pt x="113" y="960"/>
                  <a:pt x="112" y="960"/>
                </a:cubicBezTo>
                <a:lnTo>
                  <a:pt x="76" y="953"/>
                </a:lnTo>
                <a:cubicBezTo>
                  <a:pt x="73" y="952"/>
                  <a:pt x="70" y="951"/>
                  <a:pt x="67" y="950"/>
                </a:cubicBezTo>
                <a:lnTo>
                  <a:pt x="38" y="931"/>
                </a:lnTo>
                <a:cubicBezTo>
                  <a:pt x="36" y="929"/>
                  <a:pt x="33" y="927"/>
                  <a:pt x="32" y="924"/>
                </a:cubicBezTo>
                <a:lnTo>
                  <a:pt x="12" y="895"/>
                </a:lnTo>
                <a:cubicBezTo>
                  <a:pt x="10" y="892"/>
                  <a:pt x="9" y="889"/>
                  <a:pt x="8" y="886"/>
                </a:cubicBezTo>
                <a:lnTo>
                  <a:pt x="1" y="850"/>
                </a:lnTo>
                <a:cubicBezTo>
                  <a:pt x="1" y="849"/>
                  <a:pt x="0" y="847"/>
                  <a:pt x="0" y="845"/>
                </a:cubicBezTo>
                <a:lnTo>
                  <a:pt x="0" y="116"/>
                </a:lnTo>
                <a:close/>
                <a:moveTo>
                  <a:pt x="48" y="845"/>
                </a:moveTo>
                <a:lnTo>
                  <a:pt x="48" y="841"/>
                </a:lnTo>
                <a:lnTo>
                  <a:pt x="55" y="877"/>
                </a:lnTo>
                <a:lnTo>
                  <a:pt x="51" y="868"/>
                </a:lnTo>
                <a:lnTo>
                  <a:pt x="71" y="897"/>
                </a:lnTo>
                <a:lnTo>
                  <a:pt x="65" y="890"/>
                </a:lnTo>
                <a:lnTo>
                  <a:pt x="94" y="909"/>
                </a:lnTo>
                <a:lnTo>
                  <a:pt x="85" y="906"/>
                </a:lnTo>
                <a:lnTo>
                  <a:pt x="121" y="913"/>
                </a:lnTo>
                <a:lnTo>
                  <a:pt x="116" y="912"/>
                </a:lnTo>
                <a:lnTo>
                  <a:pt x="1293" y="912"/>
                </a:lnTo>
                <a:lnTo>
                  <a:pt x="1289" y="913"/>
                </a:lnTo>
                <a:lnTo>
                  <a:pt x="1325" y="906"/>
                </a:lnTo>
                <a:lnTo>
                  <a:pt x="1316" y="909"/>
                </a:lnTo>
                <a:lnTo>
                  <a:pt x="1345" y="890"/>
                </a:lnTo>
                <a:lnTo>
                  <a:pt x="1338" y="897"/>
                </a:lnTo>
                <a:lnTo>
                  <a:pt x="1357" y="868"/>
                </a:lnTo>
                <a:lnTo>
                  <a:pt x="1354" y="877"/>
                </a:lnTo>
                <a:lnTo>
                  <a:pt x="1361" y="841"/>
                </a:lnTo>
                <a:lnTo>
                  <a:pt x="1360" y="845"/>
                </a:lnTo>
                <a:lnTo>
                  <a:pt x="1360" y="116"/>
                </a:lnTo>
                <a:lnTo>
                  <a:pt x="1361" y="121"/>
                </a:lnTo>
                <a:lnTo>
                  <a:pt x="1354" y="85"/>
                </a:lnTo>
                <a:lnTo>
                  <a:pt x="1357" y="94"/>
                </a:lnTo>
                <a:lnTo>
                  <a:pt x="1338" y="65"/>
                </a:lnTo>
                <a:lnTo>
                  <a:pt x="1345" y="71"/>
                </a:lnTo>
                <a:lnTo>
                  <a:pt x="1316" y="51"/>
                </a:lnTo>
                <a:lnTo>
                  <a:pt x="1325" y="55"/>
                </a:lnTo>
                <a:lnTo>
                  <a:pt x="1289" y="48"/>
                </a:lnTo>
                <a:lnTo>
                  <a:pt x="1293" y="48"/>
                </a:lnTo>
                <a:lnTo>
                  <a:pt x="116" y="48"/>
                </a:lnTo>
                <a:lnTo>
                  <a:pt x="121" y="48"/>
                </a:lnTo>
                <a:lnTo>
                  <a:pt x="85" y="55"/>
                </a:lnTo>
                <a:lnTo>
                  <a:pt x="94" y="51"/>
                </a:lnTo>
                <a:lnTo>
                  <a:pt x="65" y="71"/>
                </a:lnTo>
                <a:lnTo>
                  <a:pt x="71" y="65"/>
                </a:lnTo>
                <a:lnTo>
                  <a:pt x="51" y="94"/>
                </a:lnTo>
                <a:lnTo>
                  <a:pt x="55" y="85"/>
                </a:lnTo>
                <a:lnTo>
                  <a:pt x="48" y="121"/>
                </a:lnTo>
                <a:lnTo>
                  <a:pt x="48" y="116"/>
                </a:lnTo>
                <a:lnTo>
                  <a:pt x="48" y="845"/>
                </a:lnTo>
                <a:close/>
              </a:path>
            </a:pathLst>
          </a:custGeom>
          <a:solidFill>
            <a:srgbClr val="1B4171"/>
          </a:solidFill>
          <a:ln w="0" cap="flat">
            <a:solidFill>
              <a:srgbClr val="1B417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 sz="1100" b="1"/>
          </a:p>
        </p:txBody>
      </p:sp>
      <p:sp>
        <p:nvSpPr>
          <p:cNvPr id="26" name="Freeform 47"/>
          <p:cNvSpPr>
            <a:spLocks/>
          </p:cNvSpPr>
          <p:nvPr/>
        </p:nvSpPr>
        <p:spPr bwMode="auto">
          <a:xfrm>
            <a:off x="1474229" y="4791961"/>
            <a:ext cx="328215" cy="447675"/>
          </a:xfrm>
          <a:custGeom>
            <a:avLst/>
            <a:gdLst/>
            <a:ahLst/>
            <a:cxnLst>
              <a:cxn ang="0">
                <a:pos x="48" y="0"/>
              </a:cxn>
              <a:cxn ang="0">
                <a:pos x="48" y="376"/>
              </a:cxn>
              <a:cxn ang="0">
                <a:pos x="24" y="352"/>
              </a:cxn>
              <a:cxn ang="0">
                <a:pos x="2686" y="352"/>
              </a:cxn>
              <a:cxn ang="0">
                <a:pos x="2710" y="376"/>
              </a:cxn>
              <a:cxn ang="0">
                <a:pos x="2710" y="752"/>
              </a:cxn>
              <a:cxn ang="0">
                <a:pos x="2662" y="752"/>
              </a:cxn>
              <a:cxn ang="0">
                <a:pos x="2662" y="376"/>
              </a:cxn>
              <a:cxn ang="0">
                <a:pos x="2686" y="400"/>
              </a:cxn>
              <a:cxn ang="0">
                <a:pos x="24" y="400"/>
              </a:cxn>
              <a:cxn ang="0">
                <a:pos x="0" y="376"/>
              </a:cxn>
              <a:cxn ang="0">
                <a:pos x="0" y="0"/>
              </a:cxn>
              <a:cxn ang="0">
                <a:pos x="48" y="0"/>
              </a:cxn>
            </a:cxnLst>
            <a:rect l="0" t="0" r="r" b="b"/>
            <a:pathLst>
              <a:path w="2710" h="752">
                <a:moveTo>
                  <a:pt x="48" y="0"/>
                </a:moveTo>
                <a:lnTo>
                  <a:pt x="48" y="376"/>
                </a:lnTo>
                <a:lnTo>
                  <a:pt x="24" y="352"/>
                </a:lnTo>
                <a:lnTo>
                  <a:pt x="2686" y="352"/>
                </a:lnTo>
                <a:cubicBezTo>
                  <a:pt x="2699" y="352"/>
                  <a:pt x="2710" y="363"/>
                  <a:pt x="2710" y="376"/>
                </a:cubicBezTo>
                <a:lnTo>
                  <a:pt x="2710" y="752"/>
                </a:lnTo>
                <a:lnTo>
                  <a:pt x="2662" y="752"/>
                </a:lnTo>
                <a:lnTo>
                  <a:pt x="2662" y="376"/>
                </a:lnTo>
                <a:lnTo>
                  <a:pt x="2686" y="400"/>
                </a:lnTo>
                <a:lnTo>
                  <a:pt x="24" y="400"/>
                </a:lnTo>
                <a:cubicBezTo>
                  <a:pt x="11" y="400"/>
                  <a:pt x="0" y="390"/>
                  <a:pt x="0" y="376"/>
                </a:cubicBezTo>
                <a:lnTo>
                  <a:pt x="0" y="0"/>
                </a:lnTo>
                <a:lnTo>
                  <a:pt x="48" y="0"/>
                </a:lnTo>
                <a:close/>
              </a:path>
            </a:pathLst>
          </a:custGeom>
          <a:solidFill>
            <a:srgbClr val="1B4171"/>
          </a:solidFill>
          <a:ln w="0" cap="flat">
            <a:solidFill>
              <a:srgbClr val="1B417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 sz="1100" b="1"/>
          </a:p>
        </p:txBody>
      </p:sp>
      <p:cxnSp>
        <p:nvCxnSpPr>
          <p:cNvPr id="29" name="28 Conector recto"/>
          <p:cNvCxnSpPr/>
          <p:nvPr/>
        </p:nvCxnSpPr>
        <p:spPr>
          <a:xfrm>
            <a:off x="1485534" y="3670902"/>
            <a:ext cx="0" cy="576064"/>
          </a:xfrm>
          <a:prstGeom prst="line">
            <a:avLst/>
          </a:prstGeom>
          <a:ln w="28575">
            <a:solidFill>
              <a:schemeClr val="accent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Freeform 22"/>
          <p:cNvSpPr>
            <a:spLocks noEditPoints="1"/>
          </p:cNvSpPr>
          <p:nvPr/>
        </p:nvSpPr>
        <p:spPr bwMode="auto">
          <a:xfrm>
            <a:off x="1414152" y="5229200"/>
            <a:ext cx="731706" cy="360040"/>
          </a:xfrm>
          <a:custGeom>
            <a:avLst/>
            <a:gdLst/>
            <a:ahLst/>
            <a:cxnLst>
              <a:cxn ang="0">
                <a:pos x="1" y="112"/>
              </a:cxn>
              <a:cxn ang="0">
                <a:pos x="12" y="67"/>
              </a:cxn>
              <a:cxn ang="0">
                <a:pos x="38" y="32"/>
              </a:cxn>
              <a:cxn ang="0">
                <a:pos x="76" y="8"/>
              </a:cxn>
              <a:cxn ang="0">
                <a:pos x="116" y="0"/>
              </a:cxn>
              <a:cxn ang="0">
                <a:pos x="1298" y="1"/>
              </a:cxn>
              <a:cxn ang="0">
                <a:pos x="1343" y="12"/>
              </a:cxn>
              <a:cxn ang="0">
                <a:pos x="1379" y="38"/>
              </a:cxn>
              <a:cxn ang="0">
                <a:pos x="1401" y="76"/>
              </a:cxn>
              <a:cxn ang="0">
                <a:pos x="1408" y="116"/>
              </a:cxn>
              <a:cxn ang="0">
                <a:pos x="1408" y="850"/>
              </a:cxn>
              <a:cxn ang="0">
                <a:pos x="1398" y="895"/>
              </a:cxn>
              <a:cxn ang="0">
                <a:pos x="1372" y="931"/>
              </a:cxn>
              <a:cxn ang="0">
                <a:pos x="1334" y="953"/>
              </a:cxn>
              <a:cxn ang="0">
                <a:pos x="1293" y="960"/>
              </a:cxn>
              <a:cxn ang="0">
                <a:pos x="112" y="960"/>
              </a:cxn>
              <a:cxn ang="0">
                <a:pos x="67" y="950"/>
              </a:cxn>
              <a:cxn ang="0">
                <a:pos x="32" y="924"/>
              </a:cxn>
              <a:cxn ang="0">
                <a:pos x="8" y="886"/>
              </a:cxn>
              <a:cxn ang="0">
                <a:pos x="0" y="845"/>
              </a:cxn>
              <a:cxn ang="0">
                <a:pos x="48" y="845"/>
              </a:cxn>
              <a:cxn ang="0">
                <a:pos x="55" y="877"/>
              </a:cxn>
              <a:cxn ang="0">
                <a:pos x="71" y="897"/>
              </a:cxn>
              <a:cxn ang="0">
                <a:pos x="94" y="909"/>
              </a:cxn>
              <a:cxn ang="0">
                <a:pos x="121" y="913"/>
              </a:cxn>
              <a:cxn ang="0">
                <a:pos x="1293" y="912"/>
              </a:cxn>
              <a:cxn ang="0">
                <a:pos x="1325" y="906"/>
              </a:cxn>
              <a:cxn ang="0">
                <a:pos x="1345" y="890"/>
              </a:cxn>
              <a:cxn ang="0">
                <a:pos x="1357" y="868"/>
              </a:cxn>
              <a:cxn ang="0">
                <a:pos x="1361" y="841"/>
              </a:cxn>
              <a:cxn ang="0">
                <a:pos x="1360" y="116"/>
              </a:cxn>
              <a:cxn ang="0">
                <a:pos x="1354" y="85"/>
              </a:cxn>
              <a:cxn ang="0">
                <a:pos x="1338" y="65"/>
              </a:cxn>
              <a:cxn ang="0">
                <a:pos x="1316" y="51"/>
              </a:cxn>
              <a:cxn ang="0">
                <a:pos x="1289" y="48"/>
              </a:cxn>
              <a:cxn ang="0">
                <a:pos x="116" y="48"/>
              </a:cxn>
              <a:cxn ang="0">
                <a:pos x="85" y="55"/>
              </a:cxn>
              <a:cxn ang="0">
                <a:pos x="65" y="71"/>
              </a:cxn>
              <a:cxn ang="0">
                <a:pos x="51" y="94"/>
              </a:cxn>
              <a:cxn ang="0">
                <a:pos x="48" y="121"/>
              </a:cxn>
              <a:cxn ang="0">
                <a:pos x="48" y="845"/>
              </a:cxn>
            </a:cxnLst>
            <a:rect l="0" t="0" r="r" b="b"/>
            <a:pathLst>
              <a:path w="1408" h="960">
                <a:moveTo>
                  <a:pt x="0" y="116"/>
                </a:moveTo>
                <a:cubicBezTo>
                  <a:pt x="0" y="115"/>
                  <a:pt x="1" y="113"/>
                  <a:pt x="1" y="112"/>
                </a:cubicBezTo>
                <a:lnTo>
                  <a:pt x="8" y="76"/>
                </a:lnTo>
                <a:cubicBezTo>
                  <a:pt x="9" y="73"/>
                  <a:pt x="10" y="70"/>
                  <a:pt x="12" y="67"/>
                </a:cubicBezTo>
                <a:lnTo>
                  <a:pt x="32" y="38"/>
                </a:lnTo>
                <a:cubicBezTo>
                  <a:pt x="33" y="35"/>
                  <a:pt x="35" y="33"/>
                  <a:pt x="38" y="32"/>
                </a:cubicBezTo>
                <a:lnTo>
                  <a:pt x="67" y="12"/>
                </a:lnTo>
                <a:cubicBezTo>
                  <a:pt x="70" y="10"/>
                  <a:pt x="73" y="9"/>
                  <a:pt x="76" y="8"/>
                </a:cubicBezTo>
                <a:lnTo>
                  <a:pt x="112" y="1"/>
                </a:lnTo>
                <a:cubicBezTo>
                  <a:pt x="113" y="1"/>
                  <a:pt x="115" y="0"/>
                  <a:pt x="116" y="0"/>
                </a:cubicBezTo>
                <a:lnTo>
                  <a:pt x="1293" y="0"/>
                </a:lnTo>
                <a:cubicBezTo>
                  <a:pt x="1295" y="0"/>
                  <a:pt x="1297" y="1"/>
                  <a:pt x="1298" y="1"/>
                </a:cubicBezTo>
                <a:lnTo>
                  <a:pt x="1334" y="8"/>
                </a:lnTo>
                <a:cubicBezTo>
                  <a:pt x="1337" y="9"/>
                  <a:pt x="1340" y="10"/>
                  <a:pt x="1343" y="12"/>
                </a:cubicBezTo>
                <a:lnTo>
                  <a:pt x="1372" y="32"/>
                </a:lnTo>
                <a:cubicBezTo>
                  <a:pt x="1375" y="33"/>
                  <a:pt x="1377" y="36"/>
                  <a:pt x="1379" y="38"/>
                </a:cubicBezTo>
                <a:lnTo>
                  <a:pt x="1398" y="67"/>
                </a:lnTo>
                <a:cubicBezTo>
                  <a:pt x="1399" y="70"/>
                  <a:pt x="1400" y="73"/>
                  <a:pt x="1401" y="76"/>
                </a:cubicBezTo>
                <a:lnTo>
                  <a:pt x="1408" y="112"/>
                </a:lnTo>
                <a:cubicBezTo>
                  <a:pt x="1408" y="113"/>
                  <a:pt x="1408" y="115"/>
                  <a:pt x="1408" y="116"/>
                </a:cubicBezTo>
                <a:lnTo>
                  <a:pt x="1408" y="845"/>
                </a:lnTo>
                <a:cubicBezTo>
                  <a:pt x="1408" y="847"/>
                  <a:pt x="1408" y="849"/>
                  <a:pt x="1408" y="850"/>
                </a:cubicBezTo>
                <a:lnTo>
                  <a:pt x="1401" y="886"/>
                </a:lnTo>
                <a:cubicBezTo>
                  <a:pt x="1400" y="889"/>
                  <a:pt x="1399" y="892"/>
                  <a:pt x="1398" y="895"/>
                </a:cubicBezTo>
                <a:lnTo>
                  <a:pt x="1379" y="924"/>
                </a:lnTo>
                <a:cubicBezTo>
                  <a:pt x="1377" y="926"/>
                  <a:pt x="1374" y="929"/>
                  <a:pt x="1372" y="931"/>
                </a:cubicBezTo>
                <a:lnTo>
                  <a:pt x="1343" y="950"/>
                </a:lnTo>
                <a:cubicBezTo>
                  <a:pt x="1340" y="951"/>
                  <a:pt x="1337" y="952"/>
                  <a:pt x="1334" y="953"/>
                </a:cubicBezTo>
                <a:lnTo>
                  <a:pt x="1298" y="960"/>
                </a:lnTo>
                <a:cubicBezTo>
                  <a:pt x="1297" y="960"/>
                  <a:pt x="1295" y="960"/>
                  <a:pt x="1293" y="960"/>
                </a:cubicBezTo>
                <a:lnTo>
                  <a:pt x="116" y="960"/>
                </a:lnTo>
                <a:cubicBezTo>
                  <a:pt x="115" y="960"/>
                  <a:pt x="113" y="960"/>
                  <a:pt x="112" y="960"/>
                </a:cubicBezTo>
                <a:lnTo>
                  <a:pt x="76" y="953"/>
                </a:lnTo>
                <a:cubicBezTo>
                  <a:pt x="73" y="952"/>
                  <a:pt x="70" y="951"/>
                  <a:pt x="67" y="950"/>
                </a:cubicBezTo>
                <a:lnTo>
                  <a:pt x="38" y="931"/>
                </a:lnTo>
                <a:cubicBezTo>
                  <a:pt x="36" y="929"/>
                  <a:pt x="33" y="927"/>
                  <a:pt x="32" y="924"/>
                </a:cubicBezTo>
                <a:lnTo>
                  <a:pt x="12" y="895"/>
                </a:lnTo>
                <a:cubicBezTo>
                  <a:pt x="10" y="892"/>
                  <a:pt x="9" y="889"/>
                  <a:pt x="8" y="886"/>
                </a:cubicBezTo>
                <a:lnTo>
                  <a:pt x="1" y="850"/>
                </a:lnTo>
                <a:cubicBezTo>
                  <a:pt x="1" y="849"/>
                  <a:pt x="0" y="847"/>
                  <a:pt x="0" y="845"/>
                </a:cubicBezTo>
                <a:lnTo>
                  <a:pt x="0" y="116"/>
                </a:lnTo>
                <a:close/>
                <a:moveTo>
                  <a:pt x="48" y="845"/>
                </a:moveTo>
                <a:lnTo>
                  <a:pt x="48" y="841"/>
                </a:lnTo>
                <a:lnTo>
                  <a:pt x="55" y="877"/>
                </a:lnTo>
                <a:lnTo>
                  <a:pt x="51" y="868"/>
                </a:lnTo>
                <a:lnTo>
                  <a:pt x="71" y="897"/>
                </a:lnTo>
                <a:lnTo>
                  <a:pt x="65" y="890"/>
                </a:lnTo>
                <a:lnTo>
                  <a:pt x="94" y="909"/>
                </a:lnTo>
                <a:lnTo>
                  <a:pt x="85" y="906"/>
                </a:lnTo>
                <a:lnTo>
                  <a:pt x="121" y="913"/>
                </a:lnTo>
                <a:lnTo>
                  <a:pt x="116" y="912"/>
                </a:lnTo>
                <a:lnTo>
                  <a:pt x="1293" y="912"/>
                </a:lnTo>
                <a:lnTo>
                  <a:pt x="1289" y="913"/>
                </a:lnTo>
                <a:lnTo>
                  <a:pt x="1325" y="906"/>
                </a:lnTo>
                <a:lnTo>
                  <a:pt x="1316" y="909"/>
                </a:lnTo>
                <a:lnTo>
                  <a:pt x="1345" y="890"/>
                </a:lnTo>
                <a:lnTo>
                  <a:pt x="1338" y="897"/>
                </a:lnTo>
                <a:lnTo>
                  <a:pt x="1357" y="868"/>
                </a:lnTo>
                <a:lnTo>
                  <a:pt x="1354" y="877"/>
                </a:lnTo>
                <a:lnTo>
                  <a:pt x="1361" y="841"/>
                </a:lnTo>
                <a:lnTo>
                  <a:pt x="1360" y="845"/>
                </a:lnTo>
                <a:lnTo>
                  <a:pt x="1360" y="116"/>
                </a:lnTo>
                <a:lnTo>
                  <a:pt x="1361" y="121"/>
                </a:lnTo>
                <a:lnTo>
                  <a:pt x="1354" y="85"/>
                </a:lnTo>
                <a:lnTo>
                  <a:pt x="1357" y="94"/>
                </a:lnTo>
                <a:lnTo>
                  <a:pt x="1338" y="65"/>
                </a:lnTo>
                <a:lnTo>
                  <a:pt x="1345" y="71"/>
                </a:lnTo>
                <a:lnTo>
                  <a:pt x="1316" y="51"/>
                </a:lnTo>
                <a:lnTo>
                  <a:pt x="1325" y="55"/>
                </a:lnTo>
                <a:lnTo>
                  <a:pt x="1289" y="48"/>
                </a:lnTo>
                <a:lnTo>
                  <a:pt x="1293" y="48"/>
                </a:lnTo>
                <a:lnTo>
                  <a:pt x="116" y="48"/>
                </a:lnTo>
                <a:lnTo>
                  <a:pt x="121" y="48"/>
                </a:lnTo>
                <a:lnTo>
                  <a:pt x="85" y="55"/>
                </a:lnTo>
                <a:lnTo>
                  <a:pt x="94" y="51"/>
                </a:lnTo>
                <a:lnTo>
                  <a:pt x="65" y="71"/>
                </a:lnTo>
                <a:lnTo>
                  <a:pt x="71" y="65"/>
                </a:lnTo>
                <a:lnTo>
                  <a:pt x="51" y="94"/>
                </a:lnTo>
                <a:lnTo>
                  <a:pt x="55" y="85"/>
                </a:lnTo>
                <a:lnTo>
                  <a:pt x="48" y="121"/>
                </a:lnTo>
                <a:lnTo>
                  <a:pt x="48" y="116"/>
                </a:lnTo>
                <a:lnTo>
                  <a:pt x="48" y="845"/>
                </a:lnTo>
                <a:close/>
              </a:path>
            </a:pathLst>
          </a:custGeom>
          <a:solidFill>
            <a:srgbClr val="1B4171"/>
          </a:solidFill>
          <a:ln w="0" cap="flat">
            <a:solidFill>
              <a:srgbClr val="1B417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 sz="1100" b="1"/>
          </a:p>
        </p:txBody>
      </p:sp>
      <p:sp>
        <p:nvSpPr>
          <p:cNvPr id="80" name="Freeform 20"/>
          <p:cNvSpPr>
            <a:spLocks/>
          </p:cNvSpPr>
          <p:nvPr/>
        </p:nvSpPr>
        <p:spPr bwMode="auto">
          <a:xfrm>
            <a:off x="2577262" y="4799777"/>
            <a:ext cx="342082" cy="428824"/>
          </a:xfrm>
          <a:custGeom>
            <a:avLst/>
            <a:gdLst/>
            <a:ahLst/>
            <a:cxnLst>
              <a:cxn ang="0">
                <a:pos x="2710" y="0"/>
              </a:cxn>
              <a:cxn ang="0">
                <a:pos x="2710" y="376"/>
              </a:cxn>
              <a:cxn ang="0">
                <a:pos x="2686" y="400"/>
              </a:cxn>
              <a:cxn ang="0">
                <a:pos x="24" y="400"/>
              </a:cxn>
              <a:cxn ang="0">
                <a:pos x="48" y="376"/>
              </a:cxn>
              <a:cxn ang="0">
                <a:pos x="48" y="752"/>
              </a:cxn>
              <a:cxn ang="0">
                <a:pos x="0" y="752"/>
              </a:cxn>
              <a:cxn ang="0">
                <a:pos x="0" y="376"/>
              </a:cxn>
              <a:cxn ang="0">
                <a:pos x="24" y="352"/>
              </a:cxn>
              <a:cxn ang="0">
                <a:pos x="2686" y="352"/>
              </a:cxn>
              <a:cxn ang="0">
                <a:pos x="2662" y="376"/>
              </a:cxn>
              <a:cxn ang="0">
                <a:pos x="2662" y="0"/>
              </a:cxn>
              <a:cxn ang="0">
                <a:pos x="2710" y="0"/>
              </a:cxn>
            </a:cxnLst>
            <a:rect l="0" t="0" r="r" b="b"/>
            <a:pathLst>
              <a:path w="2710" h="752">
                <a:moveTo>
                  <a:pt x="2710" y="0"/>
                </a:moveTo>
                <a:lnTo>
                  <a:pt x="2710" y="376"/>
                </a:lnTo>
                <a:cubicBezTo>
                  <a:pt x="2710" y="390"/>
                  <a:pt x="2699" y="400"/>
                  <a:pt x="2686" y="400"/>
                </a:cubicBezTo>
                <a:lnTo>
                  <a:pt x="24" y="400"/>
                </a:lnTo>
                <a:lnTo>
                  <a:pt x="48" y="376"/>
                </a:lnTo>
                <a:lnTo>
                  <a:pt x="48" y="752"/>
                </a:lnTo>
                <a:lnTo>
                  <a:pt x="0" y="752"/>
                </a:lnTo>
                <a:lnTo>
                  <a:pt x="0" y="376"/>
                </a:lnTo>
                <a:cubicBezTo>
                  <a:pt x="0" y="363"/>
                  <a:pt x="11" y="352"/>
                  <a:pt x="24" y="352"/>
                </a:cubicBezTo>
                <a:lnTo>
                  <a:pt x="2686" y="352"/>
                </a:lnTo>
                <a:lnTo>
                  <a:pt x="2662" y="376"/>
                </a:lnTo>
                <a:lnTo>
                  <a:pt x="2662" y="0"/>
                </a:lnTo>
                <a:lnTo>
                  <a:pt x="2710" y="0"/>
                </a:lnTo>
                <a:close/>
              </a:path>
            </a:pathLst>
          </a:custGeom>
          <a:solidFill>
            <a:srgbClr val="1B4171"/>
          </a:solidFill>
          <a:ln w="0" cap="flat">
            <a:solidFill>
              <a:srgbClr val="1B417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 sz="1100" b="1"/>
          </a:p>
        </p:txBody>
      </p:sp>
      <p:sp>
        <p:nvSpPr>
          <p:cNvPr id="81" name="Freeform 22"/>
          <p:cNvSpPr>
            <a:spLocks noEditPoints="1"/>
          </p:cNvSpPr>
          <p:nvPr/>
        </p:nvSpPr>
        <p:spPr bwMode="auto">
          <a:xfrm>
            <a:off x="2267100" y="5229200"/>
            <a:ext cx="731706" cy="360040"/>
          </a:xfrm>
          <a:custGeom>
            <a:avLst/>
            <a:gdLst/>
            <a:ahLst/>
            <a:cxnLst>
              <a:cxn ang="0">
                <a:pos x="1" y="112"/>
              </a:cxn>
              <a:cxn ang="0">
                <a:pos x="12" y="67"/>
              </a:cxn>
              <a:cxn ang="0">
                <a:pos x="38" y="32"/>
              </a:cxn>
              <a:cxn ang="0">
                <a:pos x="76" y="8"/>
              </a:cxn>
              <a:cxn ang="0">
                <a:pos x="116" y="0"/>
              </a:cxn>
              <a:cxn ang="0">
                <a:pos x="1298" y="1"/>
              </a:cxn>
              <a:cxn ang="0">
                <a:pos x="1343" y="12"/>
              </a:cxn>
              <a:cxn ang="0">
                <a:pos x="1379" y="38"/>
              </a:cxn>
              <a:cxn ang="0">
                <a:pos x="1401" y="76"/>
              </a:cxn>
              <a:cxn ang="0">
                <a:pos x="1408" y="116"/>
              </a:cxn>
              <a:cxn ang="0">
                <a:pos x="1408" y="850"/>
              </a:cxn>
              <a:cxn ang="0">
                <a:pos x="1398" y="895"/>
              </a:cxn>
              <a:cxn ang="0">
                <a:pos x="1372" y="931"/>
              </a:cxn>
              <a:cxn ang="0">
                <a:pos x="1334" y="953"/>
              </a:cxn>
              <a:cxn ang="0">
                <a:pos x="1293" y="960"/>
              </a:cxn>
              <a:cxn ang="0">
                <a:pos x="112" y="960"/>
              </a:cxn>
              <a:cxn ang="0">
                <a:pos x="67" y="950"/>
              </a:cxn>
              <a:cxn ang="0">
                <a:pos x="32" y="924"/>
              </a:cxn>
              <a:cxn ang="0">
                <a:pos x="8" y="886"/>
              </a:cxn>
              <a:cxn ang="0">
                <a:pos x="0" y="845"/>
              </a:cxn>
              <a:cxn ang="0">
                <a:pos x="48" y="845"/>
              </a:cxn>
              <a:cxn ang="0">
                <a:pos x="55" y="877"/>
              </a:cxn>
              <a:cxn ang="0">
                <a:pos x="71" y="897"/>
              </a:cxn>
              <a:cxn ang="0">
                <a:pos x="94" y="909"/>
              </a:cxn>
              <a:cxn ang="0">
                <a:pos x="121" y="913"/>
              </a:cxn>
              <a:cxn ang="0">
                <a:pos x="1293" y="912"/>
              </a:cxn>
              <a:cxn ang="0">
                <a:pos x="1325" y="906"/>
              </a:cxn>
              <a:cxn ang="0">
                <a:pos x="1345" y="890"/>
              </a:cxn>
              <a:cxn ang="0">
                <a:pos x="1357" y="868"/>
              </a:cxn>
              <a:cxn ang="0">
                <a:pos x="1361" y="841"/>
              </a:cxn>
              <a:cxn ang="0">
                <a:pos x="1360" y="116"/>
              </a:cxn>
              <a:cxn ang="0">
                <a:pos x="1354" y="85"/>
              </a:cxn>
              <a:cxn ang="0">
                <a:pos x="1338" y="65"/>
              </a:cxn>
              <a:cxn ang="0">
                <a:pos x="1316" y="51"/>
              </a:cxn>
              <a:cxn ang="0">
                <a:pos x="1289" y="48"/>
              </a:cxn>
              <a:cxn ang="0">
                <a:pos x="116" y="48"/>
              </a:cxn>
              <a:cxn ang="0">
                <a:pos x="85" y="55"/>
              </a:cxn>
              <a:cxn ang="0">
                <a:pos x="65" y="71"/>
              </a:cxn>
              <a:cxn ang="0">
                <a:pos x="51" y="94"/>
              </a:cxn>
              <a:cxn ang="0">
                <a:pos x="48" y="121"/>
              </a:cxn>
              <a:cxn ang="0">
                <a:pos x="48" y="845"/>
              </a:cxn>
            </a:cxnLst>
            <a:rect l="0" t="0" r="r" b="b"/>
            <a:pathLst>
              <a:path w="1408" h="960">
                <a:moveTo>
                  <a:pt x="0" y="116"/>
                </a:moveTo>
                <a:cubicBezTo>
                  <a:pt x="0" y="115"/>
                  <a:pt x="1" y="113"/>
                  <a:pt x="1" y="112"/>
                </a:cubicBezTo>
                <a:lnTo>
                  <a:pt x="8" y="76"/>
                </a:lnTo>
                <a:cubicBezTo>
                  <a:pt x="9" y="73"/>
                  <a:pt x="10" y="70"/>
                  <a:pt x="12" y="67"/>
                </a:cubicBezTo>
                <a:lnTo>
                  <a:pt x="32" y="38"/>
                </a:lnTo>
                <a:cubicBezTo>
                  <a:pt x="33" y="35"/>
                  <a:pt x="35" y="33"/>
                  <a:pt x="38" y="32"/>
                </a:cubicBezTo>
                <a:lnTo>
                  <a:pt x="67" y="12"/>
                </a:lnTo>
                <a:cubicBezTo>
                  <a:pt x="70" y="10"/>
                  <a:pt x="73" y="9"/>
                  <a:pt x="76" y="8"/>
                </a:cubicBezTo>
                <a:lnTo>
                  <a:pt x="112" y="1"/>
                </a:lnTo>
                <a:cubicBezTo>
                  <a:pt x="113" y="1"/>
                  <a:pt x="115" y="0"/>
                  <a:pt x="116" y="0"/>
                </a:cubicBezTo>
                <a:lnTo>
                  <a:pt x="1293" y="0"/>
                </a:lnTo>
                <a:cubicBezTo>
                  <a:pt x="1295" y="0"/>
                  <a:pt x="1297" y="1"/>
                  <a:pt x="1298" y="1"/>
                </a:cubicBezTo>
                <a:lnTo>
                  <a:pt x="1334" y="8"/>
                </a:lnTo>
                <a:cubicBezTo>
                  <a:pt x="1337" y="9"/>
                  <a:pt x="1340" y="10"/>
                  <a:pt x="1343" y="12"/>
                </a:cubicBezTo>
                <a:lnTo>
                  <a:pt x="1372" y="32"/>
                </a:lnTo>
                <a:cubicBezTo>
                  <a:pt x="1375" y="33"/>
                  <a:pt x="1377" y="36"/>
                  <a:pt x="1379" y="38"/>
                </a:cubicBezTo>
                <a:lnTo>
                  <a:pt x="1398" y="67"/>
                </a:lnTo>
                <a:cubicBezTo>
                  <a:pt x="1399" y="70"/>
                  <a:pt x="1400" y="73"/>
                  <a:pt x="1401" y="76"/>
                </a:cubicBezTo>
                <a:lnTo>
                  <a:pt x="1408" y="112"/>
                </a:lnTo>
                <a:cubicBezTo>
                  <a:pt x="1408" y="113"/>
                  <a:pt x="1408" y="115"/>
                  <a:pt x="1408" y="116"/>
                </a:cubicBezTo>
                <a:lnTo>
                  <a:pt x="1408" y="845"/>
                </a:lnTo>
                <a:cubicBezTo>
                  <a:pt x="1408" y="847"/>
                  <a:pt x="1408" y="849"/>
                  <a:pt x="1408" y="850"/>
                </a:cubicBezTo>
                <a:lnTo>
                  <a:pt x="1401" y="886"/>
                </a:lnTo>
                <a:cubicBezTo>
                  <a:pt x="1400" y="889"/>
                  <a:pt x="1399" y="892"/>
                  <a:pt x="1398" y="895"/>
                </a:cubicBezTo>
                <a:lnTo>
                  <a:pt x="1379" y="924"/>
                </a:lnTo>
                <a:cubicBezTo>
                  <a:pt x="1377" y="926"/>
                  <a:pt x="1374" y="929"/>
                  <a:pt x="1372" y="931"/>
                </a:cubicBezTo>
                <a:lnTo>
                  <a:pt x="1343" y="950"/>
                </a:lnTo>
                <a:cubicBezTo>
                  <a:pt x="1340" y="951"/>
                  <a:pt x="1337" y="952"/>
                  <a:pt x="1334" y="953"/>
                </a:cubicBezTo>
                <a:lnTo>
                  <a:pt x="1298" y="960"/>
                </a:lnTo>
                <a:cubicBezTo>
                  <a:pt x="1297" y="960"/>
                  <a:pt x="1295" y="960"/>
                  <a:pt x="1293" y="960"/>
                </a:cubicBezTo>
                <a:lnTo>
                  <a:pt x="116" y="960"/>
                </a:lnTo>
                <a:cubicBezTo>
                  <a:pt x="115" y="960"/>
                  <a:pt x="113" y="960"/>
                  <a:pt x="112" y="960"/>
                </a:cubicBezTo>
                <a:lnTo>
                  <a:pt x="76" y="953"/>
                </a:lnTo>
                <a:cubicBezTo>
                  <a:pt x="73" y="952"/>
                  <a:pt x="70" y="951"/>
                  <a:pt x="67" y="950"/>
                </a:cubicBezTo>
                <a:lnTo>
                  <a:pt x="38" y="931"/>
                </a:lnTo>
                <a:cubicBezTo>
                  <a:pt x="36" y="929"/>
                  <a:pt x="33" y="927"/>
                  <a:pt x="32" y="924"/>
                </a:cubicBezTo>
                <a:lnTo>
                  <a:pt x="12" y="895"/>
                </a:lnTo>
                <a:cubicBezTo>
                  <a:pt x="10" y="892"/>
                  <a:pt x="9" y="889"/>
                  <a:pt x="8" y="886"/>
                </a:cubicBezTo>
                <a:lnTo>
                  <a:pt x="1" y="850"/>
                </a:lnTo>
                <a:cubicBezTo>
                  <a:pt x="1" y="849"/>
                  <a:pt x="0" y="847"/>
                  <a:pt x="0" y="845"/>
                </a:cubicBezTo>
                <a:lnTo>
                  <a:pt x="0" y="116"/>
                </a:lnTo>
                <a:close/>
                <a:moveTo>
                  <a:pt x="48" y="845"/>
                </a:moveTo>
                <a:lnTo>
                  <a:pt x="48" y="841"/>
                </a:lnTo>
                <a:lnTo>
                  <a:pt x="55" y="877"/>
                </a:lnTo>
                <a:lnTo>
                  <a:pt x="51" y="868"/>
                </a:lnTo>
                <a:lnTo>
                  <a:pt x="71" y="897"/>
                </a:lnTo>
                <a:lnTo>
                  <a:pt x="65" y="890"/>
                </a:lnTo>
                <a:lnTo>
                  <a:pt x="94" y="909"/>
                </a:lnTo>
                <a:lnTo>
                  <a:pt x="85" y="906"/>
                </a:lnTo>
                <a:lnTo>
                  <a:pt x="121" y="913"/>
                </a:lnTo>
                <a:lnTo>
                  <a:pt x="116" y="912"/>
                </a:lnTo>
                <a:lnTo>
                  <a:pt x="1293" y="912"/>
                </a:lnTo>
                <a:lnTo>
                  <a:pt x="1289" y="913"/>
                </a:lnTo>
                <a:lnTo>
                  <a:pt x="1325" y="906"/>
                </a:lnTo>
                <a:lnTo>
                  <a:pt x="1316" y="909"/>
                </a:lnTo>
                <a:lnTo>
                  <a:pt x="1345" y="890"/>
                </a:lnTo>
                <a:lnTo>
                  <a:pt x="1338" y="897"/>
                </a:lnTo>
                <a:lnTo>
                  <a:pt x="1357" y="868"/>
                </a:lnTo>
                <a:lnTo>
                  <a:pt x="1354" y="877"/>
                </a:lnTo>
                <a:lnTo>
                  <a:pt x="1361" y="841"/>
                </a:lnTo>
                <a:lnTo>
                  <a:pt x="1360" y="845"/>
                </a:lnTo>
                <a:lnTo>
                  <a:pt x="1360" y="116"/>
                </a:lnTo>
                <a:lnTo>
                  <a:pt x="1361" y="121"/>
                </a:lnTo>
                <a:lnTo>
                  <a:pt x="1354" y="85"/>
                </a:lnTo>
                <a:lnTo>
                  <a:pt x="1357" y="94"/>
                </a:lnTo>
                <a:lnTo>
                  <a:pt x="1338" y="65"/>
                </a:lnTo>
                <a:lnTo>
                  <a:pt x="1345" y="71"/>
                </a:lnTo>
                <a:lnTo>
                  <a:pt x="1316" y="51"/>
                </a:lnTo>
                <a:lnTo>
                  <a:pt x="1325" y="55"/>
                </a:lnTo>
                <a:lnTo>
                  <a:pt x="1289" y="48"/>
                </a:lnTo>
                <a:lnTo>
                  <a:pt x="1293" y="48"/>
                </a:lnTo>
                <a:lnTo>
                  <a:pt x="116" y="48"/>
                </a:lnTo>
                <a:lnTo>
                  <a:pt x="121" y="48"/>
                </a:lnTo>
                <a:lnTo>
                  <a:pt x="85" y="55"/>
                </a:lnTo>
                <a:lnTo>
                  <a:pt x="94" y="51"/>
                </a:lnTo>
                <a:lnTo>
                  <a:pt x="65" y="71"/>
                </a:lnTo>
                <a:lnTo>
                  <a:pt x="71" y="65"/>
                </a:lnTo>
                <a:lnTo>
                  <a:pt x="51" y="94"/>
                </a:lnTo>
                <a:lnTo>
                  <a:pt x="55" y="85"/>
                </a:lnTo>
                <a:lnTo>
                  <a:pt x="48" y="121"/>
                </a:lnTo>
                <a:lnTo>
                  <a:pt x="48" y="116"/>
                </a:lnTo>
                <a:lnTo>
                  <a:pt x="48" y="845"/>
                </a:lnTo>
                <a:close/>
              </a:path>
            </a:pathLst>
          </a:custGeom>
          <a:solidFill>
            <a:srgbClr val="1B4171"/>
          </a:solidFill>
          <a:ln w="0" cap="flat">
            <a:solidFill>
              <a:srgbClr val="1B417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 sz="1100" b="1"/>
          </a:p>
        </p:txBody>
      </p:sp>
      <p:sp>
        <p:nvSpPr>
          <p:cNvPr id="82" name="Freeform 47"/>
          <p:cNvSpPr>
            <a:spLocks/>
          </p:cNvSpPr>
          <p:nvPr/>
        </p:nvSpPr>
        <p:spPr bwMode="auto">
          <a:xfrm>
            <a:off x="2897119" y="4791961"/>
            <a:ext cx="328215" cy="447675"/>
          </a:xfrm>
          <a:custGeom>
            <a:avLst/>
            <a:gdLst/>
            <a:ahLst/>
            <a:cxnLst>
              <a:cxn ang="0">
                <a:pos x="48" y="0"/>
              </a:cxn>
              <a:cxn ang="0">
                <a:pos x="48" y="376"/>
              </a:cxn>
              <a:cxn ang="0">
                <a:pos x="24" y="352"/>
              </a:cxn>
              <a:cxn ang="0">
                <a:pos x="2686" y="352"/>
              </a:cxn>
              <a:cxn ang="0">
                <a:pos x="2710" y="376"/>
              </a:cxn>
              <a:cxn ang="0">
                <a:pos x="2710" y="752"/>
              </a:cxn>
              <a:cxn ang="0">
                <a:pos x="2662" y="752"/>
              </a:cxn>
              <a:cxn ang="0">
                <a:pos x="2662" y="376"/>
              </a:cxn>
              <a:cxn ang="0">
                <a:pos x="2686" y="400"/>
              </a:cxn>
              <a:cxn ang="0">
                <a:pos x="24" y="400"/>
              </a:cxn>
              <a:cxn ang="0">
                <a:pos x="0" y="376"/>
              </a:cxn>
              <a:cxn ang="0">
                <a:pos x="0" y="0"/>
              </a:cxn>
              <a:cxn ang="0">
                <a:pos x="48" y="0"/>
              </a:cxn>
            </a:cxnLst>
            <a:rect l="0" t="0" r="r" b="b"/>
            <a:pathLst>
              <a:path w="2710" h="752">
                <a:moveTo>
                  <a:pt x="48" y="0"/>
                </a:moveTo>
                <a:lnTo>
                  <a:pt x="48" y="376"/>
                </a:lnTo>
                <a:lnTo>
                  <a:pt x="24" y="352"/>
                </a:lnTo>
                <a:lnTo>
                  <a:pt x="2686" y="352"/>
                </a:lnTo>
                <a:cubicBezTo>
                  <a:pt x="2699" y="352"/>
                  <a:pt x="2710" y="363"/>
                  <a:pt x="2710" y="376"/>
                </a:cubicBezTo>
                <a:lnTo>
                  <a:pt x="2710" y="752"/>
                </a:lnTo>
                <a:lnTo>
                  <a:pt x="2662" y="752"/>
                </a:lnTo>
                <a:lnTo>
                  <a:pt x="2662" y="376"/>
                </a:lnTo>
                <a:lnTo>
                  <a:pt x="2686" y="400"/>
                </a:lnTo>
                <a:lnTo>
                  <a:pt x="24" y="400"/>
                </a:lnTo>
                <a:cubicBezTo>
                  <a:pt x="11" y="400"/>
                  <a:pt x="0" y="390"/>
                  <a:pt x="0" y="376"/>
                </a:cubicBezTo>
                <a:lnTo>
                  <a:pt x="0" y="0"/>
                </a:lnTo>
                <a:lnTo>
                  <a:pt x="48" y="0"/>
                </a:lnTo>
                <a:close/>
              </a:path>
            </a:pathLst>
          </a:custGeom>
          <a:solidFill>
            <a:srgbClr val="1B4171"/>
          </a:solidFill>
          <a:ln w="0" cap="flat">
            <a:solidFill>
              <a:srgbClr val="1B417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 sz="1100" b="1"/>
          </a:p>
        </p:txBody>
      </p:sp>
      <p:cxnSp>
        <p:nvCxnSpPr>
          <p:cNvPr id="83" name="82 Conector recto"/>
          <p:cNvCxnSpPr/>
          <p:nvPr/>
        </p:nvCxnSpPr>
        <p:spPr>
          <a:xfrm>
            <a:off x="2908424" y="3670902"/>
            <a:ext cx="0" cy="576064"/>
          </a:xfrm>
          <a:prstGeom prst="line">
            <a:avLst/>
          </a:prstGeom>
          <a:ln w="28575">
            <a:solidFill>
              <a:schemeClr val="accent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4" name="Freeform 22"/>
          <p:cNvSpPr>
            <a:spLocks noEditPoints="1"/>
          </p:cNvSpPr>
          <p:nvPr/>
        </p:nvSpPr>
        <p:spPr bwMode="auto">
          <a:xfrm>
            <a:off x="3048206" y="5229200"/>
            <a:ext cx="731706" cy="360040"/>
          </a:xfrm>
          <a:custGeom>
            <a:avLst/>
            <a:gdLst/>
            <a:ahLst/>
            <a:cxnLst>
              <a:cxn ang="0">
                <a:pos x="1" y="112"/>
              </a:cxn>
              <a:cxn ang="0">
                <a:pos x="12" y="67"/>
              </a:cxn>
              <a:cxn ang="0">
                <a:pos x="38" y="32"/>
              </a:cxn>
              <a:cxn ang="0">
                <a:pos x="76" y="8"/>
              </a:cxn>
              <a:cxn ang="0">
                <a:pos x="116" y="0"/>
              </a:cxn>
              <a:cxn ang="0">
                <a:pos x="1298" y="1"/>
              </a:cxn>
              <a:cxn ang="0">
                <a:pos x="1343" y="12"/>
              </a:cxn>
              <a:cxn ang="0">
                <a:pos x="1379" y="38"/>
              </a:cxn>
              <a:cxn ang="0">
                <a:pos x="1401" y="76"/>
              </a:cxn>
              <a:cxn ang="0">
                <a:pos x="1408" y="116"/>
              </a:cxn>
              <a:cxn ang="0">
                <a:pos x="1408" y="850"/>
              </a:cxn>
              <a:cxn ang="0">
                <a:pos x="1398" y="895"/>
              </a:cxn>
              <a:cxn ang="0">
                <a:pos x="1372" y="931"/>
              </a:cxn>
              <a:cxn ang="0">
                <a:pos x="1334" y="953"/>
              </a:cxn>
              <a:cxn ang="0">
                <a:pos x="1293" y="960"/>
              </a:cxn>
              <a:cxn ang="0">
                <a:pos x="112" y="960"/>
              </a:cxn>
              <a:cxn ang="0">
                <a:pos x="67" y="950"/>
              </a:cxn>
              <a:cxn ang="0">
                <a:pos x="32" y="924"/>
              </a:cxn>
              <a:cxn ang="0">
                <a:pos x="8" y="886"/>
              </a:cxn>
              <a:cxn ang="0">
                <a:pos x="0" y="845"/>
              </a:cxn>
              <a:cxn ang="0">
                <a:pos x="48" y="845"/>
              </a:cxn>
              <a:cxn ang="0">
                <a:pos x="55" y="877"/>
              </a:cxn>
              <a:cxn ang="0">
                <a:pos x="71" y="897"/>
              </a:cxn>
              <a:cxn ang="0">
                <a:pos x="94" y="909"/>
              </a:cxn>
              <a:cxn ang="0">
                <a:pos x="121" y="913"/>
              </a:cxn>
              <a:cxn ang="0">
                <a:pos x="1293" y="912"/>
              </a:cxn>
              <a:cxn ang="0">
                <a:pos x="1325" y="906"/>
              </a:cxn>
              <a:cxn ang="0">
                <a:pos x="1345" y="890"/>
              </a:cxn>
              <a:cxn ang="0">
                <a:pos x="1357" y="868"/>
              </a:cxn>
              <a:cxn ang="0">
                <a:pos x="1361" y="841"/>
              </a:cxn>
              <a:cxn ang="0">
                <a:pos x="1360" y="116"/>
              </a:cxn>
              <a:cxn ang="0">
                <a:pos x="1354" y="85"/>
              </a:cxn>
              <a:cxn ang="0">
                <a:pos x="1338" y="65"/>
              </a:cxn>
              <a:cxn ang="0">
                <a:pos x="1316" y="51"/>
              </a:cxn>
              <a:cxn ang="0">
                <a:pos x="1289" y="48"/>
              </a:cxn>
              <a:cxn ang="0">
                <a:pos x="116" y="48"/>
              </a:cxn>
              <a:cxn ang="0">
                <a:pos x="85" y="55"/>
              </a:cxn>
              <a:cxn ang="0">
                <a:pos x="65" y="71"/>
              </a:cxn>
              <a:cxn ang="0">
                <a:pos x="51" y="94"/>
              </a:cxn>
              <a:cxn ang="0">
                <a:pos x="48" y="121"/>
              </a:cxn>
              <a:cxn ang="0">
                <a:pos x="48" y="845"/>
              </a:cxn>
            </a:cxnLst>
            <a:rect l="0" t="0" r="r" b="b"/>
            <a:pathLst>
              <a:path w="1408" h="960">
                <a:moveTo>
                  <a:pt x="0" y="116"/>
                </a:moveTo>
                <a:cubicBezTo>
                  <a:pt x="0" y="115"/>
                  <a:pt x="1" y="113"/>
                  <a:pt x="1" y="112"/>
                </a:cubicBezTo>
                <a:lnTo>
                  <a:pt x="8" y="76"/>
                </a:lnTo>
                <a:cubicBezTo>
                  <a:pt x="9" y="73"/>
                  <a:pt x="10" y="70"/>
                  <a:pt x="12" y="67"/>
                </a:cubicBezTo>
                <a:lnTo>
                  <a:pt x="32" y="38"/>
                </a:lnTo>
                <a:cubicBezTo>
                  <a:pt x="33" y="35"/>
                  <a:pt x="35" y="33"/>
                  <a:pt x="38" y="32"/>
                </a:cubicBezTo>
                <a:lnTo>
                  <a:pt x="67" y="12"/>
                </a:lnTo>
                <a:cubicBezTo>
                  <a:pt x="70" y="10"/>
                  <a:pt x="73" y="9"/>
                  <a:pt x="76" y="8"/>
                </a:cubicBezTo>
                <a:lnTo>
                  <a:pt x="112" y="1"/>
                </a:lnTo>
                <a:cubicBezTo>
                  <a:pt x="113" y="1"/>
                  <a:pt x="115" y="0"/>
                  <a:pt x="116" y="0"/>
                </a:cubicBezTo>
                <a:lnTo>
                  <a:pt x="1293" y="0"/>
                </a:lnTo>
                <a:cubicBezTo>
                  <a:pt x="1295" y="0"/>
                  <a:pt x="1297" y="1"/>
                  <a:pt x="1298" y="1"/>
                </a:cubicBezTo>
                <a:lnTo>
                  <a:pt x="1334" y="8"/>
                </a:lnTo>
                <a:cubicBezTo>
                  <a:pt x="1337" y="9"/>
                  <a:pt x="1340" y="10"/>
                  <a:pt x="1343" y="12"/>
                </a:cubicBezTo>
                <a:lnTo>
                  <a:pt x="1372" y="32"/>
                </a:lnTo>
                <a:cubicBezTo>
                  <a:pt x="1375" y="33"/>
                  <a:pt x="1377" y="36"/>
                  <a:pt x="1379" y="38"/>
                </a:cubicBezTo>
                <a:lnTo>
                  <a:pt x="1398" y="67"/>
                </a:lnTo>
                <a:cubicBezTo>
                  <a:pt x="1399" y="70"/>
                  <a:pt x="1400" y="73"/>
                  <a:pt x="1401" y="76"/>
                </a:cubicBezTo>
                <a:lnTo>
                  <a:pt x="1408" y="112"/>
                </a:lnTo>
                <a:cubicBezTo>
                  <a:pt x="1408" y="113"/>
                  <a:pt x="1408" y="115"/>
                  <a:pt x="1408" y="116"/>
                </a:cubicBezTo>
                <a:lnTo>
                  <a:pt x="1408" y="845"/>
                </a:lnTo>
                <a:cubicBezTo>
                  <a:pt x="1408" y="847"/>
                  <a:pt x="1408" y="849"/>
                  <a:pt x="1408" y="850"/>
                </a:cubicBezTo>
                <a:lnTo>
                  <a:pt x="1401" y="886"/>
                </a:lnTo>
                <a:cubicBezTo>
                  <a:pt x="1400" y="889"/>
                  <a:pt x="1399" y="892"/>
                  <a:pt x="1398" y="895"/>
                </a:cubicBezTo>
                <a:lnTo>
                  <a:pt x="1379" y="924"/>
                </a:lnTo>
                <a:cubicBezTo>
                  <a:pt x="1377" y="926"/>
                  <a:pt x="1374" y="929"/>
                  <a:pt x="1372" y="931"/>
                </a:cubicBezTo>
                <a:lnTo>
                  <a:pt x="1343" y="950"/>
                </a:lnTo>
                <a:cubicBezTo>
                  <a:pt x="1340" y="951"/>
                  <a:pt x="1337" y="952"/>
                  <a:pt x="1334" y="953"/>
                </a:cubicBezTo>
                <a:lnTo>
                  <a:pt x="1298" y="960"/>
                </a:lnTo>
                <a:cubicBezTo>
                  <a:pt x="1297" y="960"/>
                  <a:pt x="1295" y="960"/>
                  <a:pt x="1293" y="960"/>
                </a:cubicBezTo>
                <a:lnTo>
                  <a:pt x="116" y="960"/>
                </a:lnTo>
                <a:cubicBezTo>
                  <a:pt x="115" y="960"/>
                  <a:pt x="113" y="960"/>
                  <a:pt x="112" y="960"/>
                </a:cubicBezTo>
                <a:lnTo>
                  <a:pt x="76" y="953"/>
                </a:lnTo>
                <a:cubicBezTo>
                  <a:pt x="73" y="952"/>
                  <a:pt x="70" y="951"/>
                  <a:pt x="67" y="950"/>
                </a:cubicBezTo>
                <a:lnTo>
                  <a:pt x="38" y="931"/>
                </a:lnTo>
                <a:cubicBezTo>
                  <a:pt x="36" y="929"/>
                  <a:pt x="33" y="927"/>
                  <a:pt x="32" y="924"/>
                </a:cubicBezTo>
                <a:lnTo>
                  <a:pt x="12" y="895"/>
                </a:lnTo>
                <a:cubicBezTo>
                  <a:pt x="10" y="892"/>
                  <a:pt x="9" y="889"/>
                  <a:pt x="8" y="886"/>
                </a:cubicBezTo>
                <a:lnTo>
                  <a:pt x="1" y="850"/>
                </a:lnTo>
                <a:cubicBezTo>
                  <a:pt x="1" y="849"/>
                  <a:pt x="0" y="847"/>
                  <a:pt x="0" y="845"/>
                </a:cubicBezTo>
                <a:lnTo>
                  <a:pt x="0" y="116"/>
                </a:lnTo>
                <a:close/>
                <a:moveTo>
                  <a:pt x="48" y="845"/>
                </a:moveTo>
                <a:lnTo>
                  <a:pt x="48" y="841"/>
                </a:lnTo>
                <a:lnTo>
                  <a:pt x="55" y="877"/>
                </a:lnTo>
                <a:lnTo>
                  <a:pt x="51" y="868"/>
                </a:lnTo>
                <a:lnTo>
                  <a:pt x="71" y="897"/>
                </a:lnTo>
                <a:lnTo>
                  <a:pt x="65" y="890"/>
                </a:lnTo>
                <a:lnTo>
                  <a:pt x="94" y="909"/>
                </a:lnTo>
                <a:lnTo>
                  <a:pt x="85" y="906"/>
                </a:lnTo>
                <a:lnTo>
                  <a:pt x="121" y="913"/>
                </a:lnTo>
                <a:lnTo>
                  <a:pt x="116" y="912"/>
                </a:lnTo>
                <a:lnTo>
                  <a:pt x="1293" y="912"/>
                </a:lnTo>
                <a:lnTo>
                  <a:pt x="1289" y="913"/>
                </a:lnTo>
                <a:lnTo>
                  <a:pt x="1325" y="906"/>
                </a:lnTo>
                <a:lnTo>
                  <a:pt x="1316" y="909"/>
                </a:lnTo>
                <a:lnTo>
                  <a:pt x="1345" y="890"/>
                </a:lnTo>
                <a:lnTo>
                  <a:pt x="1338" y="897"/>
                </a:lnTo>
                <a:lnTo>
                  <a:pt x="1357" y="868"/>
                </a:lnTo>
                <a:lnTo>
                  <a:pt x="1354" y="877"/>
                </a:lnTo>
                <a:lnTo>
                  <a:pt x="1361" y="841"/>
                </a:lnTo>
                <a:lnTo>
                  <a:pt x="1360" y="845"/>
                </a:lnTo>
                <a:lnTo>
                  <a:pt x="1360" y="116"/>
                </a:lnTo>
                <a:lnTo>
                  <a:pt x="1361" y="121"/>
                </a:lnTo>
                <a:lnTo>
                  <a:pt x="1354" y="85"/>
                </a:lnTo>
                <a:lnTo>
                  <a:pt x="1357" y="94"/>
                </a:lnTo>
                <a:lnTo>
                  <a:pt x="1338" y="65"/>
                </a:lnTo>
                <a:lnTo>
                  <a:pt x="1345" y="71"/>
                </a:lnTo>
                <a:lnTo>
                  <a:pt x="1316" y="51"/>
                </a:lnTo>
                <a:lnTo>
                  <a:pt x="1325" y="55"/>
                </a:lnTo>
                <a:lnTo>
                  <a:pt x="1289" y="48"/>
                </a:lnTo>
                <a:lnTo>
                  <a:pt x="1293" y="48"/>
                </a:lnTo>
                <a:lnTo>
                  <a:pt x="116" y="48"/>
                </a:lnTo>
                <a:lnTo>
                  <a:pt x="121" y="48"/>
                </a:lnTo>
                <a:lnTo>
                  <a:pt x="85" y="55"/>
                </a:lnTo>
                <a:lnTo>
                  <a:pt x="94" y="51"/>
                </a:lnTo>
                <a:lnTo>
                  <a:pt x="65" y="71"/>
                </a:lnTo>
                <a:lnTo>
                  <a:pt x="71" y="65"/>
                </a:lnTo>
                <a:lnTo>
                  <a:pt x="51" y="94"/>
                </a:lnTo>
                <a:lnTo>
                  <a:pt x="55" y="85"/>
                </a:lnTo>
                <a:lnTo>
                  <a:pt x="48" y="121"/>
                </a:lnTo>
                <a:lnTo>
                  <a:pt x="48" y="116"/>
                </a:lnTo>
                <a:lnTo>
                  <a:pt x="48" y="845"/>
                </a:lnTo>
                <a:close/>
              </a:path>
            </a:pathLst>
          </a:custGeom>
          <a:solidFill>
            <a:srgbClr val="1B4171"/>
          </a:solidFill>
          <a:ln w="0" cap="flat">
            <a:solidFill>
              <a:srgbClr val="1B417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 sz="1100" b="1"/>
          </a:p>
        </p:txBody>
      </p:sp>
      <p:sp>
        <p:nvSpPr>
          <p:cNvPr id="92" name="Freeform 20"/>
          <p:cNvSpPr>
            <a:spLocks/>
          </p:cNvSpPr>
          <p:nvPr/>
        </p:nvSpPr>
        <p:spPr bwMode="auto">
          <a:xfrm>
            <a:off x="2195736" y="1685181"/>
            <a:ext cx="2384202" cy="447675"/>
          </a:xfrm>
          <a:custGeom>
            <a:avLst/>
            <a:gdLst/>
            <a:ahLst/>
            <a:cxnLst>
              <a:cxn ang="0">
                <a:pos x="2710" y="0"/>
              </a:cxn>
              <a:cxn ang="0">
                <a:pos x="2710" y="376"/>
              </a:cxn>
              <a:cxn ang="0">
                <a:pos x="2686" y="400"/>
              </a:cxn>
              <a:cxn ang="0">
                <a:pos x="24" y="400"/>
              </a:cxn>
              <a:cxn ang="0">
                <a:pos x="48" y="376"/>
              </a:cxn>
              <a:cxn ang="0">
                <a:pos x="48" y="752"/>
              </a:cxn>
              <a:cxn ang="0">
                <a:pos x="0" y="752"/>
              </a:cxn>
              <a:cxn ang="0">
                <a:pos x="0" y="376"/>
              </a:cxn>
              <a:cxn ang="0">
                <a:pos x="24" y="352"/>
              </a:cxn>
              <a:cxn ang="0">
                <a:pos x="2686" y="352"/>
              </a:cxn>
              <a:cxn ang="0">
                <a:pos x="2662" y="376"/>
              </a:cxn>
              <a:cxn ang="0">
                <a:pos x="2662" y="0"/>
              </a:cxn>
              <a:cxn ang="0">
                <a:pos x="2710" y="0"/>
              </a:cxn>
            </a:cxnLst>
            <a:rect l="0" t="0" r="r" b="b"/>
            <a:pathLst>
              <a:path w="2710" h="752">
                <a:moveTo>
                  <a:pt x="2710" y="0"/>
                </a:moveTo>
                <a:lnTo>
                  <a:pt x="2710" y="376"/>
                </a:lnTo>
                <a:cubicBezTo>
                  <a:pt x="2710" y="390"/>
                  <a:pt x="2699" y="400"/>
                  <a:pt x="2686" y="400"/>
                </a:cubicBezTo>
                <a:lnTo>
                  <a:pt x="24" y="400"/>
                </a:lnTo>
                <a:lnTo>
                  <a:pt x="48" y="376"/>
                </a:lnTo>
                <a:lnTo>
                  <a:pt x="48" y="752"/>
                </a:lnTo>
                <a:lnTo>
                  <a:pt x="0" y="752"/>
                </a:lnTo>
                <a:lnTo>
                  <a:pt x="0" y="376"/>
                </a:lnTo>
                <a:cubicBezTo>
                  <a:pt x="0" y="363"/>
                  <a:pt x="11" y="352"/>
                  <a:pt x="24" y="352"/>
                </a:cubicBezTo>
                <a:lnTo>
                  <a:pt x="2686" y="352"/>
                </a:lnTo>
                <a:lnTo>
                  <a:pt x="2662" y="376"/>
                </a:lnTo>
                <a:lnTo>
                  <a:pt x="2662" y="0"/>
                </a:lnTo>
                <a:lnTo>
                  <a:pt x="2710" y="0"/>
                </a:lnTo>
                <a:close/>
              </a:path>
            </a:pathLst>
          </a:custGeom>
          <a:solidFill>
            <a:srgbClr val="1B4171"/>
          </a:solidFill>
          <a:ln w="0" cap="flat">
            <a:solidFill>
              <a:srgbClr val="1B417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 sz="1100" b="1"/>
          </a:p>
        </p:txBody>
      </p:sp>
      <p:sp>
        <p:nvSpPr>
          <p:cNvPr id="93" name="Freeform 47"/>
          <p:cNvSpPr>
            <a:spLocks/>
          </p:cNvSpPr>
          <p:nvPr/>
        </p:nvSpPr>
        <p:spPr bwMode="auto">
          <a:xfrm>
            <a:off x="4557713" y="1685181"/>
            <a:ext cx="2462560" cy="447675"/>
          </a:xfrm>
          <a:custGeom>
            <a:avLst/>
            <a:gdLst/>
            <a:ahLst/>
            <a:cxnLst>
              <a:cxn ang="0">
                <a:pos x="48" y="0"/>
              </a:cxn>
              <a:cxn ang="0">
                <a:pos x="48" y="376"/>
              </a:cxn>
              <a:cxn ang="0">
                <a:pos x="24" y="352"/>
              </a:cxn>
              <a:cxn ang="0">
                <a:pos x="2686" y="352"/>
              </a:cxn>
              <a:cxn ang="0">
                <a:pos x="2710" y="376"/>
              </a:cxn>
              <a:cxn ang="0">
                <a:pos x="2710" y="752"/>
              </a:cxn>
              <a:cxn ang="0">
                <a:pos x="2662" y="752"/>
              </a:cxn>
              <a:cxn ang="0">
                <a:pos x="2662" y="376"/>
              </a:cxn>
              <a:cxn ang="0">
                <a:pos x="2686" y="400"/>
              </a:cxn>
              <a:cxn ang="0">
                <a:pos x="24" y="400"/>
              </a:cxn>
              <a:cxn ang="0">
                <a:pos x="0" y="376"/>
              </a:cxn>
              <a:cxn ang="0">
                <a:pos x="0" y="0"/>
              </a:cxn>
              <a:cxn ang="0">
                <a:pos x="48" y="0"/>
              </a:cxn>
            </a:cxnLst>
            <a:rect l="0" t="0" r="r" b="b"/>
            <a:pathLst>
              <a:path w="2710" h="752">
                <a:moveTo>
                  <a:pt x="48" y="0"/>
                </a:moveTo>
                <a:lnTo>
                  <a:pt x="48" y="376"/>
                </a:lnTo>
                <a:lnTo>
                  <a:pt x="24" y="352"/>
                </a:lnTo>
                <a:lnTo>
                  <a:pt x="2686" y="352"/>
                </a:lnTo>
                <a:cubicBezTo>
                  <a:pt x="2699" y="352"/>
                  <a:pt x="2710" y="363"/>
                  <a:pt x="2710" y="376"/>
                </a:cubicBezTo>
                <a:lnTo>
                  <a:pt x="2710" y="752"/>
                </a:lnTo>
                <a:lnTo>
                  <a:pt x="2662" y="752"/>
                </a:lnTo>
                <a:lnTo>
                  <a:pt x="2662" y="376"/>
                </a:lnTo>
                <a:lnTo>
                  <a:pt x="2686" y="400"/>
                </a:lnTo>
                <a:lnTo>
                  <a:pt x="24" y="400"/>
                </a:lnTo>
                <a:cubicBezTo>
                  <a:pt x="11" y="400"/>
                  <a:pt x="0" y="390"/>
                  <a:pt x="0" y="376"/>
                </a:cubicBezTo>
                <a:lnTo>
                  <a:pt x="0" y="0"/>
                </a:lnTo>
                <a:lnTo>
                  <a:pt x="48" y="0"/>
                </a:lnTo>
                <a:close/>
              </a:path>
            </a:pathLst>
          </a:custGeom>
          <a:solidFill>
            <a:srgbClr val="1B4171"/>
          </a:solidFill>
          <a:ln w="0" cap="flat">
            <a:solidFill>
              <a:srgbClr val="1B417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 sz="1100" b="1"/>
          </a:p>
        </p:txBody>
      </p:sp>
      <p:sp>
        <p:nvSpPr>
          <p:cNvPr id="103" name="Freeform 16"/>
          <p:cNvSpPr>
            <a:spLocks noEditPoints="1"/>
          </p:cNvSpPr>
          <p:nvPr/>
        </p:nvSpPr>
        <p:spPr bwMode="auto">
          <a:xfrm>
            <a:off x="4067944" y="908720"/>
            <a:ext cx="1008112" cy="779211"/>
          </a:xfrm>
          <a:custGeom>
            <a:avLst/>
            <a:gdLst/>
            <a:ahLst/>
            <a:cxnLst>
              <a:cxn ang="0">
                <a:pos x="1" y="112"/>
              </a:cxn>
              <a:cxn ang="0">
                <a:pos x="12" y="67"/>
              </a:cxn>
              <a:cxn ang="0">
                <a:pos x="38" y="32"/>
              </a:cxn>
              <a:cxn ang="0">
                <a:pos x="76" y="8"/>
              </a:cxn>
              <a:cxn ang="0">
                <a:pos x="116" y="0"/>
              </a:cxn>
              <a:cxn ang="0">
                <a:pos x="1298" y="1"/>
              </a:cxn>
              <a:cxn ang="0">
                <a:pos x="1343" y="12"/>
              </a:cxn>
              <a:cxn ang="0">
                <a:pos x="1379" y="38"/>
              </a:cxn>
              <a:cxn ang="0">
                <a:pos x="1401" y="76"/>
              </a:cxn>
              <a:cxn ang="0">
                <a:pos x="1408" y="116"/>
              </a:cxn>
              <a:cxn ang="0">
                <a:pos x="1408" y="850"/>
              </a:cxn>
              <a:cxn ang="0">
                <a:pos x="1398" y="895"/>
              </a:cxn>
              <a:cxn ang="0">
                <a:pos x="1372" y="931"/>
              </a:cxn>
              <a:cxn ang="0">
                <a:pos x="1334" y="953"/>
              </a:cxn>
              <a:cxn ang="0">
                <a:pos x="1293" y="960"/>
              </a:cxn>
              <a:cxn ang="0">
                <a:pos x="112" y="960"/>
              </a:cxn>
              <a:cxn ang="0">
                <a:pos x="67" y="950"/>
              </a:cxn>
              <a:cxn ang="0">
                <a:pos x="32" y="924"/>
              </a:cxn>
              <a:cxn ang="0">
                <a:pos x="8" y="886"/>
              </a:cxn>
              <a:cxn ang="0">
                <a:pos x="0" y="845"/>
              </a:cxn>
              <a:cxn ang="0">
                <a:pos x="48" y="845"/>
              </a:cxn>
              <a:cxn ang="0">
                <a:pos x="55" y="877"/>
              </a:cxn>
              <a:cxn ang="0">
                <a:pos x="71" y="897"/>
              </a:cxn>
              <a:cxn ang="0">
                <a:pos x="94" y="909"/>
              </a:cxn>
              <a:cxn ang="0">
                <a:pos x="121" y="913"/>
              </a:cxn>
              <a:cxn ang="0">
                <a:pos x="1293" y="912"/>
              </a:cxn>
              <a:cxn ang="0">
                <a:pos x="1325" y="906"/>
              </a:cxn>
              <a:cxn ang="0">
                <a:pos x="1345" y="890"/>
              </a:cxn>
              <a:cxn ang="0">
                <a:pos x="1357" y="868"/>
              </a:cxn>
              <a:cxn ang="0">
                <a:pos x="1361" y="841"/>
              </a:cxn>
              <a:cxn ang="0">
                <a:pos x="1360" y="116"/>
              </a:cxn>
              <a:cxn ang="0">
                <a:pos x="1354" y="85"/>
              </a:cxn>
              <a:cxn ang="0">
                <a:pos x="1338" y="65"/>
              </a:cxn>
              <a:cxn ang="0">
                <a:pos x="1316" y="51"/>
              </a:cxn>
              <a:cxn ang="0">
                <a:pos x="1289" y="48"/>
              </a:cxn>
              <a:cxn ang="0">
                <a:pos x="116" y="48"/>
              </a:cxn>
              <a:cxn ang="0">
                <a:pos x="85" y="55"/>
              </a:cxn>
              <a:cxn ang="0">
                <a:pos x="65" y="71"/>
              </a:cxn>
              <a:cxn ang="0">
                <a:pos x="51" y="94"/>
              </a:cxn>
              <a:cxn ang="0">
                <a:pos x="48" y="121"/>
              </a:cxn>
              <a:cxn ang="0">
                <a:pos x="48" y="845"/>
              </a:cxn>
            </a:cxnLst>
            <a:rect l="0" t="0" r="r" b="b"/>
            <a:pathLst>
              <a:path w="1408" h="960">
                <a:moveTo>
                  <a:pt x="0" y="116"/>
                </a:moveTo>
                <a:cubicBezTo>
                  <a:pt x="0" y="115"/>
                  <a:pt x="1" y="113"/>
                  <a:pt x="1" y="112"/>
                </a:cubicBezTo>
                <a:lnTo>
                  <a:pt x="8" y="76"/>
                </a:lnTo>
                <a:cubicBezTo>
                  <a:pt x="9" y="73"/>
                  <a:pt x="10" y="70"/>
                  <a:pt x="12" y="67"/>
                </a:cubicBezTo>
                <a:lnTo>
                  <a:pt x="32" y="38"/>
                </a:lnTo>
                <a:cubicBezTo>
                  <a:pt x="33" y="35"/>
                  <a:pt x="35" y="33"/>
                  <a:pt x="38" y="32"/>
                </a:cubicBezTo>
                <a:lnTo>
                  <a:pt x="67" y="12"/>
                </a:lnTo>
                <a:cubicBezTo>
                  <a:pt x="70" y="10"/>
                  <a:pt x="73" y="9"/>
                  <a:pt x="76" y="8"/>
                </a:cubicBezTo>
                <a:lnTo>
                  <a:pt x="112" y="1"/>
                </a:lnTo>
                <a:cubicBezTo>
                  <a:pt x="113" y="1"/>
                  <a:pt x="115" y="0"/>
                  <a:pt x="116" y="0"/>
                </a:cubicBezTo>
                <a:lnTo>
                  <a:pt x="1293" y="0"/>
                </a:lnTo>
                <a:cubicBezTo>
                  <a:pt x="1295" y="0"/>
                  <a:pt x="1297" y="1"/>
                  <a:pt x="1298" y="1"/>
                </a:cubicBezTo>
                <a:lnTo>
                  <a:pt x="1334" y="8"/>
                </a:lnTo>
                <a:cubicBezTo>
                  <a:pt x="1337" y="9"/>
                  <a:pt x="1340" y="10"/>
                  <a:pt x="1343" y="12"/>
                </a:cubicBezTo>
                <a:lnTo>
                  <a:pt x="1372" y="32"/>
                </a:lnTo>
                <a:cubicBezTo>
                  <a:pt x="1375" y="33"/>
                  <a:pt x="1377" y="36"/>
                  <a:pt x="1379" y="38"/>
                </a:cubicBezTo>
                <a:lnTo>
                  <a:pt x="1398" y="67"/>
                </a:lnTo>
                <a:cubicBezTo>
                  <a:pt x="1399" y="70"/>
                  <a:pt x="1400" y="73"/>
                  <a:pt x="1401" y="76"/>
                </a:cubicBezTo>
                <a:lnTo>
                  <a:pt x="1408" y="112"/>
                </a:lnTo>
                <a:cubicBezTo>
                  <a:pt x="1408" y="113"/>
                  <a:pt x="1408" y="115"/>
                  <a:pt x="1408" y="116"/>
                </a:cubicBezTo>
                <a:lnTo>
                  <a:pt x="1408" y="845"/>
                </a:lnTo>
                <a:cubicBezTo>
                  <a:pt x="1408" y="847"/>
                  <a:pt x="1408" y="849"/>
                  <a:pt x="1408" y="850"/>
                </a:cubicBezTo>
                <a:lnTo>
                  <a:pt x="1401" y="886"/>
                </a:lnTo>
                <a:cubicBezTo>
                  <a:pt x="1400" y="889"/>
                  <a:pt x="1399" y="892"/>
                  <a:pt x="1398" y="895"/>
                </a:cubicBezTo>
                <a:lnTo>
                  <a:pt x="1379" y="924"/>
                </a:lnTo>
                <a:cubicBezTo>
                  <a:pt x="1377" y="926"/>
                  <a:pt x="1374" y="929"/>
                  <a:pt x="1372" y="931"/>
                </a:cubicBezTo>
                <a:lnTo>
                  <a:pt x="1343" y="950"/>
                </a:lnTo>
                <a:cubicBezTo>
                  <a:pt x="1340" y="951"/>
                  <a:pt x="1337" y="952"/>
                  <a:pt x="1334" y="953"/>
                </a:cubicBezTo>
                <a:lnTo>
                  <a:pt x="1298" y="960"/>
                </a:lnTo>
                <a:cubicBezTo>
                  <a:pt x="1297" y="960"/>
                  <a:pt x="1295" y="960"/>
                  <a:pt x="1293" y="960"/>
                </a:cubicBezTo>
                <a:lnTo>
                  <a:pt x="116" y="960"/>
                </a:lnTo>
                <a:cubicBezTo>
                  <a:pt x="115" y="960"/>
                  <a:pt x="113" y="960"/>
                  <a:pt x="112" y="960"/>
                </a:cubicBezTo>
                <a:lnTo>
                  <a:pt x="76" y="953"/>
                </a:lnTo>
                <a:cubicBezTo>
                  <a:pt x="73" y="952"/>
                  <a:pt x="70" y="951"/>
                  <a:pt x="67" y="950"/>
                </a:cubicBezTo>
                <a:lnTo>
                  <a:pt x="38" y="931"/>
                </a:lnTo>
                <a:cubicBezTo>
                  <a:pt x="36" y="929"/>
                  <a:pt x="33" y="927"/>
                  <a:pt x="32" y="924"/>
                </a:cubicBezTo>
                <a:lnTo>
                  <a:pt x="12" y="895"/>
                </a:lnTo>
                <a:cubicBezTo>
                  <a:pt x="10" y="892"/>
                  <a:pt x="9" y="889"/>
                  <a:pt x="8" y="886"/>
                </a:cubicBezTo>
                <a:lnTo>
                  <a:pt x="1" y="850"/>
                </a:lnTo>
                <a:cubicBezTo>
                  <a:pt x="1" y="849"/>
                  <a:pt x="0" y="847"/>
                  <a:pt x="0" y="845"/>
                </a:cubicBezTo>
                <a:lnTo>
                  <a:pt x="0" y="116"/>
                </a:lnTo>
                <a:close/>
                <a:moveTo>
                  <a:pt x="48" y="845"/>
                </a:moveTo>
                <a:lnTo>
                  <a:pt x="48" y="841"/>
                </a:lnTo>
                <a:lnTo>
                  <a:pt x="55" y="877"/>
                </a:lnTo>
                <a:lnTo>
                  <a:pt x="51" y="868"/>
                </a:lnTo>
                <a:lnTo>
                  <a:pt x="71" y="897"/>
                </a:lnTo>
                <a:lnTo>
                  <a:pt x="65" y="890"/>
                </a:lnTo>
                <a:lnTo>
                  <a:pt x="94" y="909"/>
                </a:lnTo>
                <a:lnTo>
                  <a:pt x="85" y="906"/>
                </a:lnTo>
                <a:lnTo>
                  <a:pt x="121" y="913"/>
                </a:lnTo>
                <a:lnTo>
                  <a:pt x="116" y="912"/>
                </a:lnTo>
                <a:lnTo>
                  <a:pt x="1293" y="912"/>
                </a:lnTo>
                <a:lnTo>
                  <a:pt x="1289" y="913"/>
                </a:lnTo>
                <a:lnTo>
                  <a:pt x="1325" y="906"/>
                </a:lnTo>
                <a:lnTo>
                  <a:pt x="1316" y="909"/>
                </a:lnTo>
                <a:lnTo>
                  <a:pt x="1345" y="890"/>
                </a:lnTo>
                <a:lnTo>
                  <a:pt x="1338" y="897"/>
                </a:lnTo>
                <a:lnTo>
                  <a:pt x="1357" y="868"/>
                </a:lnTo>
                <a:lnTo>
                  <a:pt x="1354" y="877"/>
                </a:lnTo>
                <a:lnTo>
                  <a:pt x="1361" y="841"/>
                </a:lnTo>
                <a:lnTo>
                  <a:pt x="1360" y="845"/>
                </a:lnTo>
                <a:lnTo>
                  <a:pt x="1360" y="116"/>
                </a:lnTo>
                <a:lnTo>
                  <a:pt x="1361" y="121"/>
                </a:lnTo>
                <a:lnTo>
                  <a:pt x="1354" y="85"/>
                </a:lnTo>
                <a:lnTo>
                  <a:pt x="1357" y="94"/>
                </a:lnTo>
                <a:lnTo>
                  <a:pt x="1338" y="65"/>
                </a:lnTo>
                <a:lnTo>
                  <a:pt x="1345" y="71"/>
                </a:lnTo>
                <a:lnTo>
                  <a:pt x="1316" y="51"/>
                </a:lnTo>
                <a:lnTo>
                  <a:pt x="1325" y="55"/>
                </a:lnTo>
                <a:lnTo>
                  <a:pt x="1289" y="48"/>
                </a:lnTo>
                <a:lnTo>
                  <a:pt x="1293" y="48"/>
                </a:lnTo>
                <a:lnTo>
                  <a:pt x="116" y="48"/>
                </a:lnTo>
                <a:lnTo>
                  <a:pt x="121" y="48"/>
                </a:lnTo>
                <a:lnTo>
                  <a:pt x="85" y="55"/>
                </a:lnTo>
                <a:lnTo>
                  <a:pt x="94" y="51"/>
                </a:lnTo>
                <a:lnTo>
                  <a:pt x="65" y="71"/>
                </a:lnTo>
                <a:lnTo>
                  <a:pt x="71" y="65"/>
                </a:lnTo>
                <a:lnTo>
                  <a:pt x="51" y="94"/>
                </a:lnTo>
                <a:lnTo>
                  <a:pt x="55" y="85"/>
                </a:lnTo>
                <a:lnTo>
                  <a:pt x="48" y="121"/>
                </a:lnTo>
                <a:lnTo>
                  <a:pt x="48" y="116"/>
                </a:lnTo>
                <a:lnTo>
                  <a:pt x="48" y="845"/>
                </a:lnTo>
                <a:close/>
              </a:path>
            </a:pathLst>
          </a:custGeom>
          <a:solidFill>
            <a:srgbClr val="1B4171"/>
          </a:solidFill>
          <a:ln w="0" cap="flat">
            <a:solidFill>
              <a:srgbClr val="1B417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 sz="1100" b="1"/>
          </a:p>
        </p:txBody>
      </p:sp>
      <p:sp>
        <p:nvSpPr>
          <p:cNvPr id="104" name="103 CuadroTexto"/>
          <p:cNvSpPr txBox="1"/>
          <p:nvPr/>
        </p:nvSpPr>
        <p:spPr>
          <a:xfrm>
            <a:off x="4290136" y="1357394"/>
            <a:ext cx="64807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dirty="0" smtClean="0"/>
              <a:t>N=458</a:t>
            </a:r>
            <a:endParaRPr lang="es-ES" sz="1100" dirty="0"/>
          </a:p>
        </p:txBody>
      </p:sp>
      <p:sp>
        <p:nvSpPr>
          <p:cNvPr id="105" name="104 CuadroTexto"/>
          <p:cNvSpPr txBox="1"/>
          <p:nvPr/>
        </p:nvSpPr>
        <p:spPr>
          <a:xfrm>
            <a:off x="1691680" y="2204864"/>
            <a:ext cx="1041364" cy="4462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200" b="1" dirty="0" smtClean="0"/>
              <a:t>R-PFBC</a:t>
            </a:r>
          </a:p>
          <a:p>
            <a:pPr algn="ctr"/>
            <a:r>
              <a:rPr lang="es-ES" sz="1100" dirty="0" smtClean="0"/>
              <a:t>N=173 </a:t>
            </a:r>
          </a:p>
        </p:txBody>
      </p:sp>
      <p:sp>
        <p:nvSpPr>
          <p:cNvPr id="107" name="106 CuadroTexto"/>
          <p:cNvSpPr txBox="1"/>
          <p:nvPr/>
        </p:nvSpPr>
        <p:spPr>
          <a:xfrm>
            <a:off x="6444208" y="2204864"/>
            <a:ext cx="1028364" cy="4462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200" b="1" dirty="0" smtClean="0"/>
              <a:t>NR-PFBC</a:t>
            </a:r>
          </a:p>
          <a:p>
            <a:pPr algn="ctr"/>
            <a:r>
              <a:rPr lang="es-ES" sz="1100" dirty="0" smtClean="0"/>
              <a:t>N=285 </a:t>
            </a:r>
          </a:p>
        </p:txBody>
      </p:sp>
      <p:sp>
        <p:nvSpPr>
          <p:cNvPr id="108" name="107 CuadroTexto"/>
          <p:cNvSpPr txBox="1"/>
          <p:nvPr/>
        </p:nvSpPr>
        <p:spPr>
          <a:xfrm>
            <a:off x="1154372" y="3212976"/>
            <a:ext cx="64807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100" dirty="0" smtClean="0"/>
              <a:t>155 </a:t>
            </a:r>
          </a:p>
          <a:p>
            <a:pPr algn="ctr"/>
            <a:r>
              <a:rPr lang="es-ES" sz="1100" dirty="0" smtClean="0"/>
              <a:t>Test (+)</a:t>
            </a:r>
            <a:endParaRPr lang="es-ES" sz="1100" dirty="0"/>
          </a:p>
        </p:txBody>
      </p:sp>
      <p:sp>
        <p:nvSpPr>
          <p:cNvPr id="109" name="108 CuadroTexto"/>
          <p:cNvSpPr txBox="1"/>
          <p:nvPr/>
        </p:nvSpPr>
        <p:spPr>
          <a:xfrm>
            <a:off x="2594532" y="3212976"/>
            <a:ext cx="64807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100" dirty="0" smtClean="0"/>
              <a:t>18</a:t>
            </a:r>
          </a:p>
          <a:p>
            <a:pPr algn="ctr"/>
            <a:r>
              <a:rPr lang="es-ES" sz="1100" dirty="0" smtClean="0"/>
              <a:t>Test (-)</a:t>
            </a:r>
            <a:endParaRPr lang="es-ES" sz="1100" dirty="0"/>
          </a:p>
        </p:txBody>
      </p:sp>
      <p:sp>
        <p:nvSpPr>
          <p:cNvPr id="112" name="111 Rectángulo redondeado"/>
          <p:cNvSpPr/>
          <p:nvPr/>
        </p:nvSpPr>
        <p:spPr>
          <a:xfrm>
            <a:off x="3059832" y="3861048"/>
            <a:ext cx="936104" cy="216024"/>
          </a:xfrm>
          <a:prstGeom prst="roundRect">
            <a:avLst/>
          </a:prstGeom>
          <a:noFill/>
          <a:ln w="28575">
            <a:solidFill>
              <a:schemeClr val="tx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sz="1100" b="1" dirty="0" smtClean="0">
                <a:solidFill>
                  <a:schemeClr val="tx1"/>
                </a:solidFill>
                <a:latin typeface="+mj-lt"/>
              </a:rPr>
              <a:t>6 NA </a:t>
            </a:r>
            <a:r>
              <a:rPr lang="es-ES" sz="1100" b="1" dirty="0" err="1" smtClean="0">
                <a:solidFill>
                  <a:schemeClr val="tx1"/>
                </a:solidFill>
                <a:latin typeface="+mj-lt"/>
              </a:rPr>
              <a:t>Cytol</a:t>
            </a:r>
            <a:endParaRPr lang="es-ES" sz="1100" b="1" dirty="0">
              <a:solidFill>
                <a:schemeClr val="tx1"/>
              </a:solidFill>
              <a:latin typeface="+mj-lt"/>
            </a:endParaRPr>
          </a:p>
        </p:txBody>
      </p:sp>
      <p:cxnSp>
        <p:nvCxnSpPr>
          <p:cNvPr id="115" name="114 Conector recto"/>
          <p:cNvCxnSpPr/>
          <p:nvPr/>
        </p:nvCxnSpPr>
        <p:spPr>
          <a:xfrm>
            <a:off x="2912381" y="3996751"/>
            <a:ext cx="144016" cy="0"/>
          </a:xfrm>
          <a:prstGeom prst="line">
            <a:avLst/>
          </a:prstGeom>
          <a:ln w="28575">
            <a:solidFill>
              <a:schemeClr val="tx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9" name="118 Rectángulo redondeado"/>
          <p:cNvSpPr/>
          <p:nvPr/>
        </p:nvSpPr>
        <p:spPr>
          <a:xfrm>
            <a:off x="294650" y="3885987"/>
            <a:ext cx="1036990" cy="216024"/>
          </a:xfrm>
          <a:prstGeom prst="roundRect">
            <a:avLst/>
          </a:prstGeom>
          <a:noFill/>
          <a:ln w="28575">
            <a:solidFill>
              <a:schemeClr val="tx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sz="1100" b="1" dirty="0" smtClean="0">
                <a:solidFill>
                  <a:schemeClr val="tx1"/>
                </a:solidFill>
                <a:latin typeface="+mj-lt"/>
              </a:rPr>
              <a:t>31 NA </a:t>
            </a:r>
            <a:r>
              <a:rPr lang="es-ES" sz="1100" b="1" dirty="0" err="1" smtClean="0">
                <a:solidFill>
                  <a:schemeClr val="tx1"/>
                </a:solidFill>
                <a:latin typeface="+mj-lt"/>
              </a:rPr>
              <a:t>Cytol</a:t>
            </a:r>
            <a:endParaRPr lang="es-ES" sz="1100" b="1" dirty="0">
              <a:solidFill>
                <a:schemeClr val="tx1"/>
              </a:solidFill>
              <a:latin typeface="+mj-lt"/>
            </a:endParaRPr>
          </a:p>
        </p:txBody>
      </p:sp>
      <p:cxnSp>
        <p:nvCxnSpPr>
          <p:cNvPr id="120" name="119 Conector recto"/>
          <p:cNvCxnSpPr/>
          <p:nvPr/>
        </p:nvCxnSpPr>
        <p:spPr>
          <a:xfrm>
            <a:off x="1331640" y="4005064"/>
            <a:ext cx="144016" cy="0"/>
          </a:xfrm>
          <a:prstGeom prst="line">
            <a:avLst/>
          </a:prstGeom>
          <a:ln w="28575">
            <a:solidFill>
              <a:schemeClr val="tx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1" name="120 CuadroTexto"/>
          <p:cNvSpPr txBox="1"/>
          <p:nvPr/>
        </p:nvSpPr>
        <p:spPr>
          <a:xfrm>
            <a:off x="2195736" y="5279078"/>
            <a:ext cx="86409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100" dirty="0" smtClean="0"/>
              <a:t>6 </a:t>
            </a:r>
            <a:r>
              <a:rPr lang="es-ES" sz="1100" dirty="0" err="1" smtClean="0"/>
              <a:t>Cytol</a:t>
            </a:r>
            <a:r>
              <a:rPr lang="es-ES" sz="1100" dirty="0" smtClean="0"/>
              <a:t> (-)</a:t>
            </a:r>
            <a:endParaRPr lang="es-ES" sz="1100" dirty="0"/>
          </a:p>
        </p:txBody>
      </p:sp>
      <p:sp>
        <p:nvSpPr>
          <p:cNvPr id="123" name="122 CuadroTexto"/>
          <p:cNvSpPr txBox="1"/>
          <p:nvPr/>
        </p:nvSpPr>
        <p:spPr>
          <a:xfrm>
            <a:off x="2975259" y="5279078"/>
            <a:ext cx="9016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100" dirty="0" smtClean="0"/>
              <a:t>6 </a:t>
            </a:r>
            <a:r>
              <a:rPr lang="es-ES" sz="1100" dirty="0" err="1" smtClean="0"/>
              <a:t>Cytol</a:t>
            </a:r>
            <a:r>
              <a:rPr lang="es-ES" sz="1100" dirty="0" smtClean="0"/>
              <a:t> (+)</a:t>
            </a:r>
            <a:endParaRPr lang="es-ES" sz="1100" dirty="0"/>
          </a:p>
        </p:txBody>
      </p:sp>
      <p:sp>
        <p:nvSpPr>
          <p:cNvPr id="124" name="123 CuadroTexto"/>
          <p:cNvSpPr txBox="1"/>
          <p:nvPr/>
        </p:nvSpPr>
        <p:spPr>
          <a:xfrm>
            <a:off x="539552" y="5279078"/>
            <a:ext cx="87791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100" dirty="0" smtClean="0"/>
              <a:t>68 </a:t>
            </a:r>
            <a:r>
              <a:rPr lang="es-ES" sz="1100" dirty="0" err="1" smtClean="0"/>
              <a:t>Cytol</a:t>
            </a:r>
            <a:r>
              <a:rPr lang="es-ES" sz="1100" dirty="0" smtClean="0"/>
              <a:t> (-)           </a:t>
            </a:r>
            <a:endParaRPr lang="es-ES" sz="1100" dirty="0"/>
          </a:p>
        </p:txBody>
      </p:sp>
      <p:sp>
        <p:nvSpPr>
          <p:cNvPr id="125" name="124 CuadroTexto"/>
          <p:cNvSpPr txBox="1"/>
          <p:nvPr/>
        </p:nvSpPr>
        <p:spPr>
          <a:xfrm>
            <a:off x="1226380" y="5279078"/>
            <a:ext cx="110899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100" dirty="0" smtClean="0"/>
              <a:t>56 </a:t>
            </a:r>
            <a:r>
              <a:rPr lang="es-ES" sz="1100" dirty="0" err="1" smtClean="0"/>
              <a:t>Cytol</a:t>
            </a:r>
            <a:r>
              <a:rPr lang="es-ES" sz="1100" dirty="0" smtClean="0"/>
              <a:t> (+)</a:t>
            </a:r>
            <a:endParaRPr lang="es-ES" sz="1100" dirty="0"/>
          </a:p>
        </p:txBody>
      </p:sp>
      <p:sp>
        <p:nvSpPr>
          <p:cNvPr id="91" name="107 CuadroTexto"/>
          <p:cNvSpPr txBox="1"/>
          <p:nvPr/>
        </p:nvSpPr>
        <p:spPr>
          <a:xfrm>
            <a:off x="5940152" y="3212976"/>
            <a:ext cx="64807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100" dirty="0" smtClean="0"/>
              <a:t>198</a:t>
            </a:r>
          </a:p>
          <a:p>
            <a:pPr algn="ctr"/>
            <a:r>
              <a:rPr lang="es-ES" sz="1100" dirty="0" smtClean="0"/>
              <a:t>Test (+)</a:t>
            </a:r>
            <a:endParaRPr lang="es-ES" sz="1100" dirty="0"/>
          </a:p>
        </p:txBody>
      </p:sp>
      <p:sp>
        <p:nvSpPr>
          <p:cNvPr id="94" name="108 CuadroTexto"/>
          <p:cNvSpPr txBox="1"/>
          <p:nvPr/>
        </p:nvSpPr>
        <p:spPr>
          <a:xfrm>
            <a:off x="7452320" y="3212976"/>
            <a:ext cx="64807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100" dirty="0" smtClean="0"/>
              <a:t>87</a:t>
            </a:r>
          </a:p>
          <a:p>
            <a:pPr algn="ctr"/>
            <a:r>
              <a:rPr lang="es-ES" sz="1100" dirty="0" smtClean="0"/>
              <a:t>Test (-)</a:t>
            </a:r>
            <a:endParaRPr lang="es-ES" sz="1100" dirty="0"/>
          </a:p>
        </p:txBody>
      </p:sp>
      <p:sp>
        <p:nvSpPr>
          <p:cNvPr id="95" name="118 Rectángulo redondeado"/>
          <p:cNvSpPr/>
          <p:nvPr/>
        </p:nvSpPr>
        <p:spPr>
          <a:xfrm>
            <a:off x="5109308" y="3861048"/>
            <a:ext cx="1008112" cy="216024"/>
          </a:xfrm>
          <a:prstGeom prst="roundRect">
            <a:avLst/>
          </a:prstGeom>
          <a:noFill/>
          <a:ln w="28575">
            <a:solidFill>
              <a:schemeClr val="tx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sz="1100" b="1" dirty="0" smtClean="0">
                <a:solidFill>
                  <a:schemeClr val="tx1"/>
                </a:solidFill>
                <a:latin typeface="+mj-lt"/>
              </a:rPr>
              <a:t>78 NA </a:t>
            </a:r>
            <a:r>
              <a:rPr lang="es-ES" sz="1100" b="1" dirty="0" err="1" smtClean="0">
                <a:solidFill>
                  <a:schemeClr val="tx1"/>
                </a:solidFill>
                <a:latin typeface="+mj-lt"/>
              </a:rPr>
              <a:t>Cytol</a:t>
            </a:r>
            <a:endParaRPr lang="es-ES" sz="1100" b="1" dirty="0">
              <a:solidFill>
                <a:schemeClr val="tx1"/>
              </a:solidFill>
              <a:latin typeface="+mj-lt"/>
            </a:endParaRPr>
          </a:p>
        </p:txBody>
      </p:sp>
      <p:cxnSp>
        <p:nvCxnSpPr>
          <p:cNvPr id="96" name="119 Conector recto"/>
          <p:cNvCxnSpPr/>
          <p:nvPr/>
        </p:nvCxnSpPr>
        <p:spPr>
          <a:xfrm>
            <a:off x="6114298" y="4005064"/>
            <a:ext cx="144016" cy="0"/>
          </a:xfrm>
          <a:prstGeom prst="line">
            <a:avLst/>
          </a:prstGeom>
          <a:ln w="28575">
            <a:solidFill>
              <a:schemeClr val="tx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7" name="111 Rectángulo redondeado"/>
          <p:cNvSpPr/>
          <p:nvPr/>
        </p:nvSpPr>
        <p:spPr>
          <a:xfrm>
            <a:off x="7837299" y="3861048"/>
            <a:ext cx="936104" cy="216024"/>
          </a:xfrm>
          <a:prstGeom prst="roundRect">
            <a:avLst/>
          </a:prstGeom>
          <a:noFill/>
          <a:ln w="28575">
            <a:solidFill>
              <a:schemeClr val="tx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sz="1100" b="1" dirty="0" smtClean="0">
                <a:solidFill>
                  <a:schemeClr val="tx1"/>
                </a:solidFill>
                <a:latin typeface="+mj-lt"/>
              </a:rPr>
              <a:t>35 NA </a:t>
            </a:r>
            <a:r>
              <a:rPr lang="es-ES" sz="1100" b="1" dirty="0" err="1" smtClean="0">
                <a:solidFill>
                  <a:schemeClr val="tx1"/>
                </a:solidFill>
                <a:latin typeface="+mj-lt"/>
              </a:rPr>
              <a:t>Cytol</a:t>
            </a:r>
            <a:endParaRPr lang="es-ES" sz="1100" b="1" dirty="0">
              <a:solidFill>
                <a:schemeClr val="tx1"/>
              </a:solidFill>
              <a:latin typeface="+mj-lt"/>
            </a:endParaRPr>
          </a:p>
        </p:txBody>
      </p:sp>
      <p:cxnSp>
        <p:nvCxnSpPr>
          <p:cNvPr id="98" name="114 Conector recto"/>
          <p:cNvCxnSpPr/>
          <p:nvPr/>
        </p:nvCxnSpPr>
        <p:spPr>
          <a:xfrm>
            <a:off x="7706474" y="4005064"/>
            <a:ext cx="144016" cy="0"/>
          </a:xfrm>
          <a:prstGeom prst="line">
            <a:avLst/>
          </a:prstGeom>
          <a:ln w="28575">
            <a:solidFill>
              <a:schemeClr val="tx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5" name="120 CuadroTexto"/>
          <p:cNvSpPr txBox="1"/>
          <p:nvPr/>
        </p:nvSpPr>
        <p:spPr>
          <a:xfrm>
            <a:off x="6956577" y="5279078"/>
            <a:ext cx="86409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100" dirty="0" smtClean="0"/>
              <a:t>50 </a:t>
            </a:r>
            <a:r>
              <a:rPr lang="es-ES" sz="1100" dirty="0" err="1" smtClean="0"/>
              <a:t>Cytol</a:t>
            </a:r>
            <a:r>
              <a:rPr lang="es-ES" sz="1100" dirty="0" smtClean="0"/>
              <a:t> (-)</a:t>
            </a:r>
            <a:endParaRPr lang="es-ES" sz="1100" dirty="0"/>
          </a:p>
        </p:txBody>
      </p:sp>
      <p:sp>
        <p:nvSpPr>
          <p:cNvPr id="106" name="122 CuadroTexto"/>
          <p:cNvSpPr txBox="1"/>
          <p:nvPr/>
        </p:nvSpPr>
        <p:spPr>
          <a:xfrm>
            <a:off x="7747108" y="5279078"/>
            <a:ext cx="9016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100" dirty="0" smtClean="0"/>
              <a:t>2 </a:t>
            </a:r>
            <a:r>
              <a:rPr lang="es-ES" sz="1100" dirty="0" err="1" smtClean="0"/>
              <a:t>Cytol</a:t>
            </a:r>
            <a:r>
              <a:rPr lang="es-ES" sz="1100" dirty="0" smtClean="0"/>
              <a:t> (+)</a:t>
            </a:r>
            <a:endParaRPr lang="es-ES" sz="1100" dirty="0"/>
          </a:p>
        </p:txBody>
      </p:sp>
      <p:sp>
        <p:nvSpPr>
          <p:cNvPr id="118" name="123 CuadroTexto"/>
          <p:cNvSpPr txBox="1"/>
          <p:nvPr/>
        </p:nvSpPr>
        <p:spPr>
          <a:xfrm>
            <a:off x="5321660" y="5279078"/>
            <a:ext cx="96373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100" dirty="0" smtClean="0"/>
              <a:t>111 </a:t>
            </a:r>
            <a:r>
              <a:rPr lang="es-ES" sz="1100" dirty="0" err="1" smtClean="0"/>
              <a:t>Cytol</a:t>
            </a:r>
            <a:r>
              <a:rPr lang="es-ES" sz="1100" dirty="0" smtClean="0"/>
              <a:t> (-)           </a:t>
            </a:r>
            <a:endParaRPr lang="es-ES" sz="1100" dirty="0"/>
          </a:p>
        </p:txBody>
      </p:sp>
      <p:sp>
        <p:nvSpPr>
          <p:cNvPr id="122" name="124 CuadroTexto"/>
          <p:cNvSpPr txBox="1"/>
          <p:nvPr/>
        </p:nvSpPr>
        <p:spPr>
          <a:xfrm>
            <a:off x="6032834" y="5279078"/>
            <a:ext cx="110899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100" dirty="0" smtClean="0"/>
              <a:t>9 </a:t>
            </a:r>
            <a:r>
              <a:rPr lang="es-ES" sz="1100" dirty="0" err="1" smtClean="0"/>
              <a:t>Cytol</a:t>
            </a:r>
            <a:r>
              <a:rPr lang="es-ES" sz="1100" dirty="0" smtClean="0"/>
              <a:t> (+)</a:t>
            </a:r>
            <a:endParaRPr lang="es-ES" sz="1100" dirty="0"/>
          </a:p>
        </p:txBody>
      </p:sp>
      <p:sp>
        <p:nvSpPr>
          <p:cNvPr id="127" name="Rechthoek 126"/>
          <p:cNvSpPr/>
          <p:nvPr/>
        </p:nvSpPr>
        <p:spPr>
          <a:xfrm>
            <a:off x="4139952" y="980728"/>
            <a:ext cx="857927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s-ES" sz="1200" b="1" dirty="0" err="1" smtClean="0"/>
              <a:t>Testing</a:t>
            </a:r>
            <a:r>
              <a:rPr lang="es-ES" sz="1200" b="1" dirty="0" smtClean="0"/>
              <a:t> set</a:t>
            </a:r>
          </a:p>
          <a:p>
            <a:pPr algn="ctr"/>
            <a:r>
              <a:rPr lang="es-ES" sz="1200" b="1" dirty="0" smtClean="0"/>
              <a:t>PFBC</a:t>
            </a:r>
          </a:p>
          <a:p>
            <a:pPr algn="ctr"/>
            <a:endParaRPr lang="es-ES" sz="1200" b="1" dirty="0" smtClean="0"/>
          </a:p>
        </p:txBody>
      </p:sp>
      <p:sp>
        <p:nvSpPr>
          <p:cNvPr id="60" name="Freeform 22"/>
          <p:cNvSpPr>
            <a:spLocks noEditPoints="1"/>
          </p:cNvSpPr>
          <p:nvPr/>
        </p:nvSpPr>
        <p:spPr bwMode="auto">
          <a:xfrm>
            <a:off x="1043608" y="4221088"/>
            <a:ext cx="838200" cy="571500"/>
          </a:xfrm>
          <a:custGeom>
            <a:avLst/>
            <a:gdLst/>
            <a:ahLst/>
            <a:cxnLst>
              <a:cxn ang="0">
                <a:pos x="1" y="112"/>
              </a:cxn>
              <a:cxn ang="0">
                <a:pos x="12" y="67"/>
              </a:cxn>
              <a:cxn ang="0">
                <a:pos x="38" y="32"/>
              </a:cxn>
              <a:cxn ang="0">
                <a:pos x="76" y="8"/>
              </a:cxn>
              <a:cxn ang="0">
                <a:pos x="116" y="0"/>
              </a:cxn>
              <a:cxn ang="0">
                <a:pos x="1298" y="1"/>
              </a:cxn>
              <a:cxn ang="0">
                <a:pos x="1343" y="12"/>
              </a:cxn>
              <a:cxn ang="0">
                <a:pos x="1379" y="38"/>
              </a:cxn>
              <a:cxn ang="0">
                <a:pos x="1401" y="76"/>
              </a:cxn>
              <a:cxn ang="0">
                <a:pos x="1408" y="116"/>
              </a:cxn>
              <a:cxn ang="0">
                <a:pos x="1408" y="850"/>
              </a:cxn>
              <a:cxn ang="0">
                <a:pos x="1398" y="895"/>
              </a:cxn>
              <a:cxn ang="0">
                <a:pos x="1372" y="931"/>
              </a:cxn>
              <a:cxn ang="0">
                <a:pos x="1334" y="953"/>
              </a:cxn>
              <a:cxn ang="0">
                <a:pos x="1293" y="960"/>
              </a:cxn>
              <a:cxn ang="0">
                <a:pos x="112" y="960"/>
              </a:cxn>
              <a:cxn ang="0">
                <a:pos x="67" y="950"/>
              </a:cxn>
              <a:cxn ang="0">
                <a:pos x="32" y="924"/>
              </a:cxn>
              <a:cxn ang="0">
                <a:pos x="8" y="886"/>
              </a:cxn>
              <a:cxn ang="0">
                <a:pos x="0" y="845"/>
              </a:cxn>
              <a:cxn ang="0">
                <a:pos x="48" y="845"/>
              </a:cxn>
              <a:cxn ang="0">
                <a:pos x="55" y="877"/>
              </a:cxn>
              <a:cxn ang="0">
                <a:pos x="71" y="897"/>
              </a:cxn>
              <a:cxn ang="0">
                <a:pos x="94" y="909"/>
              </a:cxn>
              <a:cxn ang="0">
                <a:pos x="121" y="913"/>
              </a:cxn>
              <a:cxn ang="0">
                <a:pos x="1293" y="912"/>
              </a:cxn>
              <a:cxn ang="0">
                <a:pos x="1325" y="906"/>
              </a:cxn>
              <a:cxn ang="0">
                <a:pos x="1345" y="890"/>
              </a:cxn>
              <a:cxn ang="0">
                <a:pos x="1357" y="868"/>
              </a:cxn>
              <a:cxn ang="0">
                <a:pos x="1361" y="841"/>
              </a:cxn>
              <a:cxn ang="0">
                <a:pos x="1360" y="116"/>
              </a:cxn>
              <a:cxn ang="0">
                <a:pos x="1354" y="85"/>
              </a:cxn>
              <a:cxn ang="0">
                <a:pos x="1338" y="65"/>
              </a:cxn>
              <a:cxn ang="0">
                <a:pos x="1316" y="51"/>
              </a:cxn>
              <a:cxn ang="0">
                <a:pos x="1289" y="48"/>
              </a:cxn>
              <a:cxn ang="0">
                <a:pos x="116" y="48"/>
              </a:cxn>
              <a:cxn ang="0">
                <a:pos x="85" y="55"/>
              </a:cxn>
              <a:cxn ang="0">
                <a:pos x="65" y="71"/>
              </a:cxn>
              <a:cxn ang="0">
                <a:pos x="51" y="94"/>
              </a:cxn>
              <a:cxn ang="0">
                <a:pos x="48" y="121"/>
              </a:cxn>
              <a:cxn ang="0">
                <a:pos x="48" y="845"/>
              </a:cxn>
            </a:cxnLst>
            <a:rect l="0" t="0" r="r" b="b"/>
            <a:pathLst>
              <a:path w="1408" h="960">
                <a:moveTo>
                  <a:pt x="0" y="116"/>
                </a:moveTo>
                <a:cubicBezTo>
                  <a:pt x="0" y="115"/>
                  <a:pt x="1" y="113"/>
                  <a:pt x="1" y="112"/>
                </a:cubicBezTo>
                <a:lnTo>
                  <a:pt x="8" y="76"/>
                </a:lnTo>
                <a:cubicBezTo>
                  <a:pt x="9" y="73"/>
                  <a:pt x="10" y="70"/>
                  <a:pt x="12" y="67"/>
                </a:cubicBezTo>
                <a:lnTo>
                  <a:pt x="32" y="38"/>
                </a:lnTo>
                <a:cubicBezTo>
                  <a:pt x="33" y="35"/>
                  <a:pt x="35" y="33"/>
                  <a:pt x="38" y="32"/>
                </a:cubicBezTo>
                <a:lnTo>
                  <a:pt x="67" y="12"/>
                </a:lnTo>
                <a:cubicBezTo>
                  <a:pt x="70" y="10"/>
                  <a:pt x="73" y="9"/>
                  <a:pt x="76" y="8"/>
                </a:cubicBezTo>
                <a:lnTo>
                  <a:pt x="112" y="1"/>
                </a:lnTo>
                <a:cubicBezTo>
                  <a:pt x="113" y="1"/>
                  <a:pt x="115" y="0"/>
                  <a:pt x="116" y="0"/>
                </a:cubicBezTo>
                <a:lnTo>
                  <a:pt x="1293" y="0"/>
                </a:lnTo>
                <a:cubicBezTo>
                  <a:pt x="1295" y="0"/>
                  <a:pt x="1297" y="1"/>
                  <a:pt x="1298" y="1"/>
                </a:cubicBezTo>
                <a:lnTo>
                  <a:pt x="1334" y="8"/>
                </a:lnTo>
                <a:cubicBezTo>
                  <a:pt x="1337" y="9"/>
                  <a:pt x="1340" y="10"/>
                  <a:pt x="1343" y="12"/>
                </a:cubicBezTo>
                <a:lnTo>
                  <a:pt x="1372" y="32"/>
                </a:lnTo>
                <a:cubicBezTo>
                  <a:pt x="1375" y="33"/>
                  <a:pt x="1377" y="36"/>
                  <a:pt x="1379" y="38"/>
                </a:cubicBezTo>
                <a:lnTo>
                  <a:pt x="1398" y="67"/>
                </a:lnTo>
                <a:cubicBezTo>
                  <a:pt x="1399" y="70"/>
                  <a:pt x="1400" y="73"/>
                  <a:pt x="1401" y="76"/>
                </a:cubicBezTo>
                <a:lnTo>
                  <a:pt x="1408" y="112"/>
                </a:lnTo>
                <a:cubicBezTo>
                  <a:pt x="1408" y="113"/>
                  <a:pt x="1408" y="115"/>
                  <a:pt x="1408" y="116"/>
                </a:cubicBezTo>
                <a:lnTo>
                  <a:pt x="1408" y="845"/>
                </a:lnTo>
                <a:cubicBezTo>
                  <a:pt x="1408" y="847"/>
                  <a:pt x="1408" y="849"/>
                  <a:pt x="1408" y="850"/>
                </a:cubicBezTo>
                <a:lnTo>
                  <a:pt x="1401" y="886"/>
                </a:lnTo>
                <a:cubicBezTo>
                  <a:pt x="1400" y="889"/>
                  <a:pt x="1399" y="892"/>
                  <a:pt x="1398" y="895"/>
                </a:cubicBezTo>
                <a:lnTo>
                  <a:pt x="1379" y="924"/>
                </a:lnTo>
                <a:cubicBezTo>
                  <a:pt x="1377" y="926"/>
                  <a:pt x="1374" y="929"/>
                  <a:pt x="1372" y="931"/>
                </a:cubicBezTo>
                <a:lnTo>
                  <a:pt x="1343" y="950"/>
                </a:lnTo>
                <a:cubicBezTo>
                  <a:pt x="1340" y="951"/>
                  <a:pt x="1337" y="952"/>
                  <a:pt x="1334" y="953"/>
                </a:cubicBezTo>
                <a:lnTo>
                  <a:pt x="1298" y="960"/>
                </a:lnTo>
                <a:cubicBezTo>
                  <a:pt x="1297" y="960"/>
                  <a:pt x="1295" y="960"/>
                  <a:pt x="1293" y="960"/>
                </a:cubicBezTo>
                <a:lnTo>
                  <a:pt x="116" y="960"/>
                </a:lnTo>
                <a:cubicBezTo>
                  <a:pt x="115" y="960"/>
                  <a:pt x="113" y="960"/>
                  <a:pt x="112" y="960"/>
                </a:cubicBezTo>
                <a:lnTo>
                  <a:pt x="76" y="953"/>
                </a:lnTo>
                <a:cubicBezTo>
                  <a:pt x="73" y="952"/>
                  <a:pt x="70" y="951"/>
                  <a:pt x="67" y="950"/>
                </a:cubicBezTo>
                <a:lnTo>
                  <a:pt x="38" y="931"/>
                </a:lnTo>
                <a:cubicBezTo>
                  <a:pt x="36" y="929"/>
                  <a:pt x="33" y="927"/>
                  <a:pt x="32" y="924"/>
                </a:cubicBezTo>
                <a:lnTo>
                  <a:pt x="12" y="895"/>
                </a:lnTo>
                <a:cubicBezTo>
                  <a:pt x="10" y="892"/>
                  <a:pt x="9" y="889"/>
                  <a:pt x="8" y="886"/>
                </a:cubicBezTo>
                <a:lnTo>
                  <a:pt x="1" y="850"/>
                </a:lnTo>
                <a:cubicBezTo>
                  <a:pt x="1" y="849"/>
                  <a:pt x="0" y="847"/>
                  <a:pt x="0" y="845"/>
                </a:cubicBezTo>
                <a:lnTo>
                  <a:pt x="0" y="116"/>
                </a:lnTo>
                <a:close/>
                <a:moveTo>
                  <a:pt x="48" y="845"/>
                </a:moveTo>
                <a:lnTo>
                  <a:pt x="48" y="841"/>
                </a:lnTo>
                <a:lnTo>
                  <a:pt x="55" y="877"/>
                </a:lnTo>
                <a:lnTo>
                  <a:pt x="51" y="868"/>
                </a:lnTo>
                <a:lnTo>
                  <a:pt x="71" y="897"/>
                </a:lnTo>
                <a:lnTo>
                  <a:pt x="65" y="890"/>
                </a:lnTo>
                <a:lnTo>
                  <a:pt x="94" y="909"/>
                </a:lnTo>
                <a:lnTo>
                  <a:pt x="85" y="906"/>
                </a:lnTo>
                <a:lnTo>
                  <a:pt x="121" y="913"/>
                </a:lnTo>
                <a:lnTo>
                  <a:pt x="116" y="912"/>
                </a:lnTo>
                <a:lnTo>
                  <a:pt x="1293" y="912"/>
                </a:lnTo>
                <a:lnTo>
                  <a:pt x="1289" y="913"/>
                </a:lnTo>
                <a:lnTo>
                  <a:pt x="1325" y="906"/>
                </a:lnTo>
                <a:lnTo>
                  <a:pt x="1316" y="909"/>
                </a:lnTo>
                <a:lnTo>
                  <a:pt x="1345" y="890"/>
                </a:lnTo>
                <a:lnTo>
                  <a:pt x="1338" y="897"/>
                </a:lnTo>
                <a:lnTo>
                  <a:pt x="1357" y="868"/>
                </a:lnTo>
                <a:lnTo>
                  <a:pt x="1354" y="877"/>
                </a:lnTo>
                <a:lnTo>
                  <a:pt x="1361" y="841"/>
                </a:lnTo>
                <a:lnTo>
                  <a:pt x="1360" y="845"/>
                </a:lnTo>
                <a:lnTo>
                  <a:pt x="1360" y="116"/>
                </a:lnTo>
                <a:lnTo>
                  <a:pt x="1361" y="121"/>
                </a:lnTo>
                <a:lnTo>
                  <a:pt x="1354" y="85"/>
                </a:lnTo>
                <a:lnTo>
                  <a:pt x="1357" y="94"/>
                </a:lnTo>
                <a:lnTo>
                  <a:pt x="1338" y="65"/>
                </a:lnTo>
                <a:lnTo>
                  <a:pt x="1345" y="71"/>
                </a:lnTo>
                <a:lnTo>
                  <a:pt x="1316" y="51"/>
                </a:lnTo>
                <a:lnTo>
                  <a:pt x="1325" y="55"/>
                </a:lnTo>
                <a:lnTo>
                  <a:pt x="1289" y="48"/>
                </a:lnTo>
                <a:lnTo>
                  <a:pt x="1293" y="48"/>
                </a:lnTo>
                <a:lnTo>
                  <a:pt x="116" y="48"/>
                </a:lnTo>
                <a:lnTo>
                  <a:pt x="121" y="48"/>
                </a:lnTo>
                <a:lnTo>
                  <a:pt x="85" y="55"/>
                </a:lnTo>
                <a:lnTo>
                  <a:pt x="94" y="51"/>
                </a:lnTo>
                <a:lnTo>
                  <a:pt x="65" y="71"/>
                </a:lnTo>
                <a:lnTo>
                  <a:pt x="71" y="65"/>
                </a:lnTo>
                <a:lnTo>
                  <a:pt x="51" y="94"/>
                </a:lnTo>
                <a:lnTo>
                  <a:pt x="55" y="85"/>
                </a:lnTo>
                <a:lnTo>
                  <a:pt x="48" y="121"/>
                </a:lnTo>
                <a:lnTo>
                  <a:pt x="48" y="116"/>
                </a:lnTo>
                <a:lnTo>
                  <a:pt x="48" y="845"/>
                </a:lnTo>
                <a:close/>
              </a:path>
            </a:pathLst>
          </a:custGeom>
          <a:solidFill>
            <a:srgbClr val="1B4171"/>
          </a:solidFill>
          <a:ln w="0" cap="flat">
            <a:solidFill>
              <a:srgbClr val="1B417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 sz="1100" b="1"/>
          </a:p>
        </p:txBody>
      </p:sp>
      <p:sp>
        <p:nvSpPr>
          <p:cNvPr id="61" name="Freeform 22"/>
          <p:cNvSpPr>
            <a:spLocks noEditPoints="1"/>
          </p:cNvSpPr>
          <p:nvPr/>
        </p:nvSpPr>
        <p:spPr bwMode="auto">
          <a:xfrm>
            <a:off x="2506153" y="4221088"/>
            <a:ext cx="838200" cy="571500"/>
          </a:xfrm>
          <a:custGeom>
            <a:avLst/>
            <a:gdLst/>
            <a:ahLst/>
            <a:cxnLst>
              <a:cxn ang="0">
                <a:pos x="1" y="112"/>
              </a:cxn>
              <a:cxn ang="0">
                <a:pos x="12" y="67"/>
              </a:cxn>
              <a:cxn ang="0">
                <a:pos x="38" y="32"/>
              </a:cxn>
              <a:cxn ang="0">
                <a:pos x="76" y="8"/>
              </a:cxn>
              <a:cxn ang="0">
                <a:pos x="116" y="0"/>
              </a:cxn>
              <a:cxn ang="0">
                <a:pos x="1298" y="1"/>
              </a:cxn>
              <a:cxn ang="0">
                <a:pos x="1343" y="12"/>
              </a:cxn>
              <a:cxn ang="0">
                <a:pos x="1379" y="38"/>
              </a:cxn>
              <a:cxn ang="0">
                <a:pos x="1401" y="76"/>
              </a:cxn>
              <a:cxn ang="0">
                <a:pos x="1408" y="116"/>
              </a:cxn>
              <a:cxn ang="0">
                <a:pos x="1408" y="850"/>
              </a:cxn>
              <a:cxn ang="0">
                <a:pos x="1398" y="895"/>
              </a:cxn>
              <a:cxn ang="0">
                <a:pos x="1372" y="931"/>
              </a:cxn>
              <a:cxn ang="0">
                <a:pos x="1334" y="953"/>
              </a:cxn>
              <a:cxn ang="0">
                <a:pos x="1293" y="960"/>
              </a:cxn>
              <a:cxn ang="0">
                <a:pos x="112" y="960"/>
              </a:cxn>
              <a:cxn ang="0">
                <a:pos x="67" y="950"/>
              </a:cxn>
              <a:cxn ang="0">
                <a:pos x="32" y="924"/>
              </a:cxn>
              <a:cxn ang="0">
                <a:pos x="8" y="886"/>
              </a:cxn>
              <a:cxn ang="0">
                <a:pos x="0" y="845"/>
              </a:cxn>
              <a:cxn ang="0">
                <a:pos x="48" y="845"/>
              </a:cxn>
              <a:cxn ang="0">
                <a:pos x="55" y="877"/>
              </a:cxn>
              <a:cxn ang="0">
                <a:pos x="71" y="897"/>
              </a:cxn>
              <a:cxn ang="0">
                <a:pos x="94" y="909"/>
              </a:cxn>
              <a:cxn ang="0">
                <a:pos x="121" y="913"/>
              </a:cxn>
              <a:cxn ang="0">
                <a:pos x="1293" y="912"/>
              </a:cxn>
              <a:cxn ang="0">
                <a:pos x="1325" y="906"/>
              </a:cxn>
              <a:cxn ang="0">
                <a:pos x="1345" y="890"/>
              </a:cxn>
              <a:cxn ang="0">
                <a:pos x="1357" y="868"/>
              </a:cxn>
              <a:cxn ang="0">
                <a:pos x="1361" y="841"/>
              </a:cxn>
              <a:cxn ang="0">
                <a:pos x="1360" y="116"/>
              </a:cxn>
              <a:cxn ang="0">
                <a:pos x="1354" y="85"/>
              </a:cxn>
              <a:cxn ang="0">
                <a:pos x="1338" y="65"/>
              </a:cxn>
              <a:cxn ang="0">
                <a:pos x="1316" y="51"/>
              </a:cxn>
              <a:cxn ang="0">
                <a:pos x="1289" y="48"/>
              </a:cxn>
              <a:cxn ang="0">
                <a:pos x="116" y="48"/>
              </a:cxn>
              <a:cxn ang="0">
                <a:pos x="85" y="55"/>
              </a:cxn>
              <a:cxn ang="0">
                <a:pos x="65" y="71"/>
              </a:cxn>
              <a:cxn ang="0">
                <a:pos x="51" y="94"/>
              </a:cxn>
              <a:cxn ang="0">
                <a:pos x="48" y="121"/>
              </a:cxn>
              <a:cxn ang="0">
                <a:pos x="48" y="845"/>
              </a:cxn>
            </a:cxnLst>
            <a:rect l="0" t="0" r="r" b="b"/>
            <a:pathLst>
              <a:path w="1408" h="960">
                <a:moveTo>
                  <a:pt x="0" y="116"/>
                </a:moveTo>
                <a:cubicBezTo>
                  <a:pt x="0" y="115"/>
                  <a:pt x="1" y="113"/>
                  <a:pt x="1" y="112"/>
                </a:cubicBezTo>
                <a:lnTo>
                  <a:pt x="8" y="76"/>
                </a:lnTo>
                <a:cubicBezTo>
                  <a:pt x="9" y="73"/>
                  <a:pt x="10" y="70"/>
                  <a:pt x="12" y="67"/>
                </a:cubicBezTo>
                <a:lnTo>
                  <a:pt x="32" y="38"/>
                </a:lnTo>
                <a:cubicBezTo>
                  <a:pt x="33" y="35"/>
                  <a:pt x="35" y="33"/>
                  <a:pt x="38" y="32"/>
                </a:cubicBezTo>
                <a:lnTo>
                  <a:pt x="67" y="12"/>
                </a:lnTo>
                <a:cubicBezTo>
                  <a:pt x="70" y="10"/>
                  <a:pt x="73" y="9"/>
                  <a:pt x="76" y="8"/>
                </a:cubicBezTo>
                <a:lnTo>
                  <a:pt x="112" y="1"/>
                </a:lnTo>
                <a:cubicBezTo>
                  <a:pt x="113" y="1"/>
                  <a:pt x="115" y="0"/>
                  <a:pt x="116" y="0"/>
                </a:cubicBezTo>
                <a:lnTo>
                  <a:pt x="1293" y="0"/>
                </a:lnTo>
                <a:cubicBezTo>
                  <a:pt x="1295" y="0"/>
                  <a:pt x="1297" y="1"/>
                  <a:pt x="1298" y="1"/>
                </a:cubicBezTo>
                <a:lnTo>
                  <a:pt x="1334" y="8"/>
                </a:lnTo>
                <a:cubicBezTo>
                  <a:pt x="1337" y="9"/>
                  <a:pt x="1340" y="10"/>
                  <a:pt x="1343" y="12"/>
                </a:cubicBezTo>
                <a:lnTo>
                  <a:pt x="1372" y="32"/>
                </a:lnTo>
                <a:cubicBezTo>
                  <a:pt x="1375" y="33"/>
                  <a:pt x="1377" y="36"/>
                  <a:pt x="1379" y="38"/>
                </a:cubicBezTo>
                <a:lnTo>
                  <a:pt x="1398" y="67"/>
                </a:lnTo>
                <a:cubicBezTo>
                  <a:pt x="1399" y="70"/>
                  <a:pt x="1400" y="73"/>
                  <a:pt x="1401" y="76"/>
                </a:cubicBezTo>
                <a:lnTo>
                  <a:pt x="1408" y="112"/>
                </a:lnTo>
                <a:cubicBezTo>
                  <a:pt x="1408" y="113"/>
                  <a:pt x="1408" y="115"/>
                  <a:pt x="1408" y="116"/>
                </a:cubicBezTo>
                <a:lnTo>
                  <a:pt x="1408" y="845"/>
                </a:lnTo>
                <a:cubicBezTo>
                  <a:pt x="1408" y="847"/>
                  <a:pt x="1408" y="849"/>
                  <a:pt x="1408" y="850"/>
                </a:cubicBezTo>
                <a:lnTo>
                  <a:pt x="1401" y="886"/>
                </a:lnTo>
                <a:cubicBezTo>
                  <a:pt x="1400" y="889"/>
                  <a:pt x="1399" y="892"/>
                  <a:pt x="1398" y="895"/>
                </a:cubicBezTo>
                <a:lnTo>
                  <a:pt x="1379" y="924"/>
                </a:lnTo>
                <a:cubicBezTo>
                  <a:pt x="1377" y="926"/>
                  <a:pt x="1374" y="929"/>
                  <a:pt x="1372" y="931"/>
                </a:cubicBezTo>
                <a:lnTo>
                  <a:pt x="1343" y="950"/>
                </a:lnTo>
                <a:cubicBezTo>
                  <a:pt x="1340" y="951"/>
                  <a:pt x="1337" y="952"/>
                  <a:pt x="1334" y="953"/>
                </a:cubicBezTo>
                <a:lnTo>
                  <a:pt x="1298" y="960"/>
                </a:lnTo>
                <a:cubicBezTo>
                  <a:pt x="1297" y="960"/>
                  <a:pt x="1295" y="960"/>
                  <a:pt x="1293" y="960"/>
                </a:cubicBezTo>
                <a:lnTo>
                  <a:pt x="116" y="960"/>
                </a:lnTo>
                <a:cubicBezTo>
                  <a:pt x="115" y="960"/>
                  <a:pt x="113" y="960"/>
                  <a:pt x="112" y="960"/>
                </a:cubicBezTo>
                <a:lnTo>
                  <a:pt x="76" y="953"/>
                </a:lnTo>
                <a:cubicBezTo>
                  <a:pt x="73" y="952"/>
                  <a:pt x="70" y="951"/>
                  <a:pt x="67" y="950"/>
                </a:cubicBezTo>
                <a:lnTo>
                  <a:pt x="38" y="931"/>
                </a:lnTo>
                <a:cubicBezTo>
                  <a:pt x="36" y="929"/>
                  <a:pt x="33" y="927"/>
                  <a:pt x="32" y="924"/>
                </a:cubicBezTo>
                <a:lnTo>
                  <a:pt x="12" y="895"/>
                </a:lnTo>
                <a:cubicBezTo>
                  <a:pt x="10" y="892"/>
                  <a:pt x="9" y="889"/>
                  <a:pt x="8" y="886"/>
                </a:cubicBezTo>
                <a:lnTo>
                  <a:pt x="1" y="850"/>
                </a:lnTo>
                <a:cubicBezTo>
                  <a:pt x="1" y="849"/>
                  <a:pt x="0" y="847"/>
                  <a:pt x="0" y="845"/>
                </a:cubicBezTo>
                <a:lnTo>
                  <a:pt x="0" y="116"/>
                </a:lnTo>
                <a:close/>
                <a:moveTo>
                  <a:pt x="48" y="845"/>
                </a:moveTo>
                <a:lnTo>
                  <a:pt x="48" y="841"/>
                </a:lnTo>
                <a:lnTo>
                  <a:pt x="55" y="877"/>
                </a:lnTo>
                <a:lnTo>
                  <a:pt x="51" y="868"/>
                </a:lnTo>
                <a:lnTo>
                  <a:pt x="71" y="897"/>
                </a:lnTo>
                <a:lnTo>
                  <a:pt x="65" y="890"/>
                </a:lnTo>
                <a:lnTo>
                  <a:pt x="94" y="909"/>
                </a:lnTo>
                <a:lnTo>
                  <a:pt x="85" y="906"/>
                </a:lnTo>
                <a:lnTo>
                  <a:pt x="121" y="913"/>
                </a:lnTo>
                <a:lnTo>
                  <a:pt x="116" y="912"/>
                </a:lnTo>
                <a:lnTo>
                  <a:pt x="1293" y="912"/>
                </a:lnTo>
                <a:lnTo>
                  <a:pt x="1289" y="913"/>
                </a:lnTo>
                <a:lnTo>
                  <a:pt x="1325" y="906"/>
                </a:lnTo>
                <a:lnTo>
                  <a:pt x="1316" y="909"/>
                </a:lnTo>
                <a:lnTo>
                  <a:pt x="1345" y="890"/>
                </a:lnTo>
                <a:lnTo>
                  <a:pt x="1338" y="897"/>
                </a:lnTo>
                <a:lnTo>
                  <a:pt x="1357" y="868"/>
                </a:lnTo>
                <a:lnTo>
                  <a:pt x="1354" y="877"/>
                </a:lnTo>
                <a:lnTo>
                  <a:pt x="1361" y="841"/>
                </a:lnTo>
                <a:lnTo>
                  <a:pt x="1360" y="845"/>
                </a:lnTo>
                <a:lnTo>
                  <a:pt x="1360" y="116"/>
                </a:lnTo>
                <a:lnTo>
                  <a:pt x="1361" y="121"/>
                </a:lnTo>
                <a:lnTo>
                  <a:pt x="1354" y="85"/>
                </a:lnTo>
                <a:lnTo>
                  <a:pt x="1357" y="94"/>
                </a:lnTo>
                <a:lnTo>
                  <a:pt x="1338" y="65"/>
                </a:lnTo>
                <a:lnTo>
                  <a:pt x="1345" y="71"/>
                </a:lnTo>
                <a:lnTo>
                  <a:pt x="1316" y="51"/>
                </a:lnTo>
                <a:lnTo>
                  <a:pt x="1325" y="55"/>
                </a:lnTo>
                <a:lnTo>
                  <a:pt x="1289" y="48"/>
                </a:lnTo>
                <a:lnTo>
                  <a:pt x="1293" y="48"/>
                </a:lnTo>
                <a:lnTo>
                  <a:pt x="116" y="48"/>
                </a:lnTo>
                <a:lnTo>
                  <a:pt x="121" y="48"/>
                </a:lnTo>
                <a:lnTo>
                  <a:pt x="85" y="55"/>
                </a:lnTo>
                <a:lnTo>
                  <a:pt x="94" y="51"/>
                </a:lnTo>
                <a:lnTo>
                  <a:pt x="65" y="71"/>
                </a:lnTo>
                <a:lnTo>
                  <a:pt x="71" y="65"/>
                </a:lnTo>
                <a:lnTo>
                  <a:pt x="51" y="94"/>
                </a:lnTo>
                <a:lnTo>
                  <a:pt x="55" y="85"/>
                </a:lnTo>
                <a:lnTo>
                  <a:pt x="48" y="121"/>
                </a:lnTo>
                <a:lnTo>
                  <a:pt x="48" y="116"/>
                </a:lnTo>
                <a:lnTo>
                  <a:pt x="48" y="845"/>
                </a:lnTo>
                <a:close/>
              </a:path>
            </a:pathLst>
          </a:custGeom>
          <a:solidFill>
            <a:srgbClr val="1B4171"/>
          </a:solidFill>
          <a:ln w="0" cap="flat">
            <a:solidFill>
              <a:srgbClr val="1B417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 sz="1100" b="1"/>
          </a:p>
        </p:txBody>
      </p:sp>
      <p:sp>
        <p:nvSpPr>
          <p:cNvPr id="62" name="Freeform 22"/>
          <p:cNvSpPr>
            <a:spLocks noEditPoints="1"/>
          </p:cNvSpPr>
          <p:nvPr/>
        </p:nvSpPr>
        <p:spPr bwMode="auto">
          <a:xfrm>
            <a:off x="7252667" y="4221088"/>
            <a:ext cx="838200" cy="571500"/>
          </a:xfrm>
          <a:custGeom>
            <a:avLst/>
            <a:gdLst/>
            <a:ahLst/>
            <a:cxnLst>
              <a:cxn ang="0">
                <a:pos x="1" y="112"/>
              </a:cxn>
              <a:cxn ang="0">
                <a:pos x="12" y="67"/>
              </a:cxn>
              <a:cxn ang="0">
                <a:pos x="38" y="32"/>
              </a:cxn>
              <a:cxn ang="0">
                <a:pos x="76" y="8"/>
              </a:cxn>
              <a:cxn ang="0">
                <a:pos x="116" y="0"/>
              </a:cxn>
              <a:cxn ang="0">
                <a:pos x="1298" y="1"/>
              </a:cxn>
              <a:cxn ang="0">
                <a:pos x="1343" y="12"/>
              </a:cxn>
              <a:cxn ang="0">
                <a:pos x="1379" y="38"/>
              </a:cxn>
              <a:cxn ang="0">
                <a:pos x="1401" y="76"/>
              </a:cxn>
              <a:cxn ang="0">
                <a:pos x="1408" y="116"/>
              </a:cxn>
              <a:cxn ang="0">
                <a:pos x="1408" y="850"/>
              </a:cxn>
              <a:cxn ang="0">
                <a:pos x="1398" y="895"/>
              </a:cxn>
              <a:cxn ang="0">
                <a:pos x="1372" y="931"/>
              </a:cxn>
              <a:cxn ang="0">
                <a:pos x="1334" y="953"/>
              </a:cxn>
              <a:cxn ang="0">
                <a:pos x="1293" y="960"/>
              </a:cxn>
              <a:cxn ang="0">
                <a:pos x="112" y="960"/>
              </a:cxn>
              <a:cxn ang="0">
                <a:pos x="67" y="950"/>
              </a:cxn>
              <a:cxn ang="0">
                <a:pos x="32" y="924"/>
              </a:cxn>
              <a:cxn ang="0">
                <a:pos x="8" y="886"/>
              </a:cxn>
              <a:cxn ang="0">
                <a:pos x="0" y="845"/>
              </a:cxn>
              <a:cxn ang="0">
                <a:pos x="48" y="845"/>
              </a:cxn>
              <a:cxn ang="0">
                <a:pos x="55" y="877"/>
              </a:cxn>
              <a:cxn ang="0">
                <a:pos x="71" y="897"/>
              </a:cxn>
              <a:cxn ang="0">
                <a:pos x="94" y="909"/>
              </a:cxn>
              <a:cxn ang="0">
                <a:pos x="121" y="913"/>
              </a:cxn>
              <a:cxn ang="0">
                <a:pos x="1293" y="912"/>
              </a:cxn>
              <a:cxn ang="0">
                <a:pos x="1325" y="906"/>
              </a:cxn>
              <a:cxn ang="0">
                <a:pos x="1345" y="890"/>
              </a:cxn>
              <a:cxn ang="0">
                <a:pos x="1357" y="868"/>
              </a:cxn>
              <a:cxn ang="0">
                <a:pos x="1361" y="841"/>
              </a:cxn>
              <a:cxn ang="0">
                <a:pos x="1360" y="116"/>
              </a:cxn>
              <a:cxn ang="0">
                <a:pos x="1354" y="85"/>
              </a:cxn>
              <a:cxn ang="0">
                <a:pos x="1338" y="65"/>
              </a:cxn>
              <a:cxn ang="0">
                <a:pos x="1316" y="51"/>
              </a:cxn>
              <a:cxn ang="0">
                <a:pos x="1289" y="48"/>
              </a:cxn>
              <a:cxn ang="0">
                <a:pos x="116" y="48"/>
              </a:cxn>
              <a:cxn ang="0">
                <a:pos x="85" y="55"/>
              </a:cxn>
              <a:cxn ang="0">
                <a:pos x="65" y="71"/>
              </a:cxn>
              <a:cxn ang="0">
                <a:pos x="51" y="94"/>
              </a:cxn>
              <a:cxn ang="0">
                <a:pos x="48" y="121"/>
              </a:cxn>
              <a:cxn ang="0">
                <a:pos x="48" y="845"/>
              </a:cxn>
            </a:cxnLst>
            <a:rect l="0" t="0" r="r" b="b"/>
            <a:pathLst>
              <a:path w="1408" h="960">
                <a:moveTo>
                  <a:pt x="0" y="116"/>
                </a:moveTo>
                <a:cubicBezTo>
                  <a:pt x="0" y="115"/>
                  <a:pt x="1" y="113"/>
                  <a:pt x="1" y="112"/>
                </a:cubicBezTo>
                <a:lnTo>
                  <a:pt x="8" y="76"/>
                </a:lnTo>
                <a:cubicBezTo>
                  <a:pt x="9" y="73"/>
                  <a:pt x="10" y="70"/>
                  <a:pt x="12" y="67"/>
                </a:cubicBezTo>
                <a:lnTo>
                  <a:pt x="32" y="38"/>
                </a:lnTo>
                <a:cubicBezTo>
                  <a:pt x="33" y="35"/>
                  <a:pt x="35" y="33"/>
                  <a:pt x="38" y="32"/>
                </a:cubicBezTo>
                <a:lnTo>
                  <a:pt x="67" y="12"/>
                </a:lnTo>
                <a:cubicBezTo>
                  <a:pt x="70" y="10"/>
                  <a:pt x="73" y="9"/>
                  <a:pt x="76" y="8"/>
                </a:cubicBezTo>
                <a:lnTo>
                  <a:pt x="112" y="1"/>
                </a:lnTo>
                <a:cubicBezTo>
                  <a:pt x="113" y="1"/>
                  <a:pt x="115" y="0"/>
                  <a:pt x="116" y="0"/>
                </a:cubicBezTo>
                <a:lnTo>
                  <a:pt x="1293" y="0"/>
                </a:lnTo>
                <a:cubicBezTo>
                  <a:pt x="1295" y="0"/>
                  <a:pt x="1297" y="1"/>
                  <a:pt x="1298" y="1"/>
                </a:cubicBezTo>
                <a:lnTo>
                  <a:pt x="1334" y="8"/>
                </a:lnTo>
                <a:cubicBezTo>
                  <a:pt x="1337" y="9"/>
                  <a:pt x="1340" y="10"/>
                  <a:pt x="1343" y="12"/>
                </a:cubicBezTo>
                <a:lnTo>
                  <a:pt x="1372" y="32"/>
                </a:lnTo>
                <a:cubicBezTo>
                  <a:pt x="1375" y="33"/>
                  <a:pt x="1377" y="36"/>
                  <a:pt x="1379" y="38"/>
                </a:cubicBezTo>
                <a:lnTo>
                  <a:pt x="1398" y="67"/>
                </a:lnTo>
                <a:cubicBezTo>
                  <a:pt x="1399" y="70"/>
                  <a:pt x="1400" y="73"/>
                  <a:pt x="1401" y="76"/>
                </a:cubicBezTo>
                <a:lnTo>
                  <a:pt x="1408" y="112"/>
                </a:lnTo>
                <a:cubicBezTo>
                  <a:pt x="1408" y="113"/>
                  <a:pt x="1408" y="115"/>
                  <a:pt x="1408" y="116"/>
                </a:cubicBezTo>
                <a:lnTo>
                  <a:pt x="1408" y="845"/>
                </a:lnTo>
                <a:cubicBezTo>
                  <a:pt x="1408" y="847"/>
                  <a:pt x="1408" y="849"/>
                  <a:pt x="1408" y="850"/>
                </a:cubicBezTo>
                <a:lnTo>
                  <a:pt x="1401" y="886"/>
                </a:lnTo>
                <a:cubicBezTo>
                  <a:pt x="1400" y="889"/>
                  <a:pt x="1399" y="892"/>
                  <a:pt x="1398" y="895"/>
                </a:cubicBezTo>
                <a:lnTo>
                  <a:pt x="1379" y="924"/>
                </a:lnTo>
                <a:cubicBezTo>
                  <a:pt x="1377" y="926"/>
                  <a:pt x="1374" y="929"/>
                  <a:pt x="1372" y="931"/>
                </a:cubicBezTo>
                <a:lnTo>
                  <a:pt x="1343" y="950"/>
                </a:lnTo>
                <a:cubicBezTo>
                  <a:pt x="1340" y="951"/>
                  <a:pt x="1337" y="952"/>
                  <a:pt x="1334" y="953"/>
                </a:cubicBezTo>
                <a:lnTo>
                  <a:pt x="1298" y="960"/>
                </a:lnTo>
                <a:cubicBezTo>
                  <a:pt x="1297" y="960"/>
                  <a:pt x="1295" y="960"/>
                  <a:pt x="1293" y="960"/>
                </a:cubicBezTo>
                <a:lnTo>
                  <a:pt x="116" y="960"/>
                </a:lnTo>
                <a:cubicBezTo>
                  <a:pt x="115" y="960"/>
                  <a:pt x="113" y="960"/>
                  <a:pt x="112" y="960"/>
                </a:cubicBezTo>
                <a:lnTo>
                  <a:pt x="76" y="953"/>
                </a:lnTo>
                <a:cubicBezTo>
                  <a:pt x="73" y="952"/>
                  <a:pt x="70" y="951"/>
                  <a:pt x="67" y="950"/>
                </a:cubicBezTo>
                <a:lnTo>
                  <a:pt x="38" y="931"/>
                </a:lnTo>
                <a:cubicBezTo>
                  <a:pt x="36" y="929"/>
                  <a:pt x="33" y="927"/>
                  <a:pt x="32" y="924"/>
                </a:cubicBezTo>
                <a:lnTo>
                  <a:pt x="12" y="895"/>
                </a:lnTo>
                <a:cubicBezTo>
                  <a:pt x="10" y="892"/>
                  <a:pt x="9" y="889"/>
                  <a:pt x="8" y="886"/>
                </a:cubicBezTo>
                <a:lnTo>
                  <a:pt x="1" y="850"/>
                </a:lnTo>
                <a:cubicBezTo>
                  <a:pt x="1" y="849"/>
                  <a:pt x="0" y="847"/>
                  <a:pt x="0" y="845"/>
                </a:cubicBezTo>
                <a:lnTo>
                  <a:pt x="0" y="116"/>
                </a:lnTo>
                <a:close/>
                <a:moveTo>
                  <a:pt x="48" y="845"/>
                </a:moveTo>
                <a:lnTo>
                  <a:pt x="48" y="841"/>
                </a:lnTo>
                <a:lnTo>
                  <a:pt x="55" y="877"/>
                </a:lnTo>
                <a:lnTo>
                  <a:pt x="51" y="868"/>
                </a:lnTo>
                <a:lnTo>
                  <a:pt x="71" y="897"/>
                </a:lnTo>
                <a:lnTo>
                  <a:pt x="65" y="890"/>
                </a:lnTo>
                <a:lnTo>
                  <a:pt x="94" y="909"/>
                </a:lnTo>
                <a:lnTo>
                  <a:pt x="85" y="906"/>
                </a:lnTo>
                <a:lnTo>
                  <a:pt x="121" y="913"/>
                </a:lnTo>
                <a:lnTo>
                  <a:pt x="116" y="912"/>
                </a:lnTo>
                <a:lnTo>
                  <a:pt x="1293" y="912"/>
                </a:lnTo>
                <a:lnTo>
                  <a:pt x="1289" y="913"/>
                </a:lnTo>
                <a:lnTo>
                  <a:pt x="1325" y="906"/>
                </a:lnTo>
                <a:lnTo>
                  <a:pt x="1316" y="909"/>
                </a:lnTo>
                <a:lnTo>
                  <a:pt x="1345" y="890"/>
                </a:lnTo>
                <a:lnTo>
                  <a:pt x="1338" y="897"/>
                </a:lnTo>
                <a:lnTo>
                  <a:pt x="1357" y="868"/>
                </a:lnTo>
                <a:lnTo>
                  <a:pt x="1354" y="877"/>
                </a:lnTo>
                <a:lnTo>
                  <a:pt x="1361" y="841"/>
                </a:lnTo>
                <a:lnTo>
                  <a:pt x="1360" y="845"/>
                </a:lnTo>
                <a:lnTo>
                  <a:pt x="1360" y="116"/>
                </a:lnTo>
                <a:lnTo>
                  <a:pt x="1361" y="121"/>
                </a:lnTo>
                <a:lnTo>
                  <a:pt x="1354" y="85"/>
                </a:lnTo>
                <a:lnTo>
                  <a:pt x="1357" y="94"/>
                </a:lnTo>
                <a:lnTo>
                  <a:pt x="1338" y="65"/>
                </a:lnTo>
                <a:lnTo>
                  <a:pt x="1345" y="71"/>
                </a:lnTo>
                <a:lnTo>
                  <a:pt x="1316" y="51"/>
                </a:lnTo>
                <a:lnTo>
                  <a:pt x="1325" y="55"/>
                </a:lnTo>
                <a:lnTo>
                  <a:pt x="1289" y="48"/>
                </a:lnTo>
                <a:lnTo>
                  <a:pt x="1293" y="48"/>
                </a:lnTo>
                <a:lnTo>
                  <a:pt x="116" y="48"/>
                </a:lnTo>
                <a:lnTo>
                  <a:pt x="121" y="48"/>
                </a:lnTo>
                <a:lnTo>
                  <a:pt x="85" y="55"/>
                </a:lnTo>
                <a:lnTo>
                  <a:pt x="94" y="51"/>
                </a:lnTo>
                <a:lnTo>
                  <a:pt x="65" y="71"/>
                </a:lnTo>
                <a:lnTo>
                  <a:pt x="71" y="65"/>
                </a:lnTo>
                <a:lnTo>
                  <a:pt x="51" y="94"/>
                </a:lnTo>
                <a:lnTo>
                  <a:pt x="55" y="85"/>
                </a:lnTo>
                <a:lnTo>
                  <a:pt x="48" y="121"/>
                </a:lnTo>
                <a:lnTo>
                  <a:pt x="48" y="116"/>
                </a:lnTo>
                <a:lnTo>
                  <a:pt x="48" y="845"/>
                </a:lnTo>
                <a:close/>
              </a:path>
            </a:pathLst>
          </a:custGeom>
          <a:solidFill>
            <a:srgbClr val="1B4171"/>
          </a:solidFill>
          <a:ln w="0" cap="flat">
            <a:solidFill>
              <a:srgbClr val="1B417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 sz="1100" b="1"/>
          </a:p>
        </p:txBody>
      </p:sp>
      <p:sp>
        <p:nvSpPr>
          <p:cNvPr id="63" name="Freeform 22"/>
          <p:cNvSpPr>
            <a:spLocks noEditPoints="1"/>
          </p:cNvSpPr>
          <p:nvPr/>
        </p:nvSpPr>
        <p:spPr bwMode="auto">
          <a:xfrm>
            <a:off x="5838403" y="4221088"/>
            <a:ext cx="838200" cy="571500"/>
          </a:xfrm>
          <a:custGeom>
            <a:avLst/>
            <a:gdLst/>
            <a:ahLst/>
            <a:cxnLst>
              <a:cxn ang="0">
                <a:pos x="1" y="112"/>
              </a:cxn>
              <a:cxn ang="0">
                <a:pos x="12" y="67"/>
              </a:cxn>
              <a:cxn ang="0">
                <a:pos x="38" y="32"/>
              </a:cxn>
              <a:cxn ang="0">
                <a:pos x="76" y="8"/>
              </a:cxn>
              <a:cxn ang="0">
                <a:pos x="116" y="0"/>
              </a:cxn>
              <a:cxn ang="0">
                <a:pos x="1298" y="1"/>
              </a:cxn>
              <a:cxn ang="0">
                <a:pos x="1343" y="12"/>
              </a:cxn>
              <a:cxn ang="0">
                <a:pos x="1379" y="38"/>
              </a:cxn>
              <a:cxn ang="0">
                <a:pos x="1401" y="76"/>
              </a:cxn>
              <a:cxn ang="0">
                <a:pos x="1408" y="116"/>
              </a:cxn>
              <a:cxn ang="0">
                <a:pos x="1408" y="850"/>
              </a:cxn>
              <a:cxn ang="0">
                <a:pos x="1398" y="895"/>
              </a:cxn>
              <a:cxn ang="0">
                <a:pos x="1372" y="931"/>
              </a:cxn>
              <a:cxn ang="0">
                <a:pos x="1334" y="953"/>
              </a:cxn>
              <a:cxn ang="0">
                <a:pos x="1293" y="960"/>
              </a:cxn>
              <a:cxn ang="0">
                <a:pos x="112" y="960"/>
              </a:cxn>
              <a:cxn ang="0">
                <a:pos x="67" y="950"/>
              </a:cxn>
              <a:cxn ang="0">
                <a:pos x="32" y="924"/>
              </a:cxn>
              <a:cxn ang="0">
                <a:pos x="8" y="886"/>
              </a:cxn>
              <a:cxn ang="0">
                <a:pos x="0" y="845"/>
              </a:cxn>
              <a:cxn ang="0">
                <a:pos x="48" y="845"/>
              </a:cxn>
              <a:cxn ang="0">
                <a:pos x="55" y="877"/>
              </a:cxn>
              <a:cxn ang="0">
                <a:pos x="71" y="897"/>
              </a:cxn>
              <a:cxn ang="0">
                <a:pos x="94" y="909"/>
              </a:cxn>
              <a:cxn ang="0">
                <a:pos x="121" y="913"/>
              </a:cxn>
              <a:cxn ang="0">
                <a:pos x="1293" y="912"/>
              </a:cxn>
              <a:cxn ang="0">
                <a:pos x="1325" y="906"/>
              </a:cxn>
              <a:cxn ang="0">
                <a:pos x="1345" y="890"/>
              </a:cxn>
              <a:cxn ang="0">
                <a:pos x="1357" y="868"/>
              </a:cxn>
              <a:cxn ang="0">
                <a:pos x="1361" y="841"/>
              </a:cxn>
              <a:cxn ang="0">
                <a:pos x="1360" y="116"/>
              </a:cxn>
              <a:cxn ang="0">
                <a:pos x="1354" y="85"/>
              </a:cxn>
              <a:cxn ang="0">
                <a:pos x="1338" y="65"/>
              </a:cxn>
              <a:cxn ang="0">
                <a:pos x="1316" y="51"/>
              </a:cxn>
              <a:cxn ang="0">
                <a:pos x="1289" y="48"/>
              </a:cxn>
              <a:cxn ang="0">
                <a:pos x="116" y="48"/>
              </a:cxn>
              <a:cxn ang="0">
                <a:pos x="85" y="55"/>
              </a:cxn>
              <a:cxn ang="0">
                <a:pos x="65" y="71"/>
              </a:cxn>
              <a:cxn ang="0">
                <a:pos x="51" y="94"/>
              </a:cxn>
              <a:cxn ang="0">
                <a:pos x="48" y="121"/>
              </a:cxn>
              <a:cxn ang="0">
                <a:pos x="48" y="845"/>
              </a:cxn>
            </a:cxnLst>
            <a:rect l="0" t="0" r="r" b="b"/>
            <a:pathLst>
              <a:path w="1408" h="960">
                <a:moveTo>
                  <a:pt x="0" y="116"/>
                </a:moveTo>
                <a:cubicBezTo>
                  <a:pt x="0" y="115"/>
                  <a:pt x="1" y="113"/>
                  <a:pt x="1" y="112"/>
                </a:cubicBezTo>
                <a:lnTo>
                  <a:pt x="8" y="76"/>
                </a:lnTo>
                <a:cubicBezTo>
                  <a:pt x="9" y="73"/>
                  <a:pt x="10" y="70"/>
                  <a:pt x="12" y="67"/>
                </a:cubicBezTo>
                <a:lnTo>
                  <a:pt x="32" y="38"/>
                </a:lnTo>
                <a:cubicBezTo>
                  <a:pt x="33" y="35"/>
                  <a:pt x="35" y="33"/>
                  <a:pt x="38" y="32"/>
                </a:cubicBezTo>
                <a:lnTo>
                  <a:pt x="67" y="12"/>
                </a:lnTo>
                <a:cubicBezTo>
                  <a:pt x="70" y="10"/>
                  <a:pt x="73" y="9"/>
                  <a:pt x="76" y="8"/>
                </a:cubicBezTo>
                <a:lnTo>
                  <a:pt x="112" y="1"/>
                </a:lnTo>
                <a:cubicBezTo>
                  <a:pt x="113" y="1"/>
                  <a:pt x="115" y="0"/>
                  <a:pt x="116" y="0"/>
                </a:cubicBezTo>
                <a:lnTo>
                  <a:pt x="1293" y="0"/>
                </a:lnTo>
                <a:cubicBezTo>
                  <a:pt x="1295" y="0"/>
                  <a:pt x="1297" y="1"/>
                  <a:pt x="1298" y="1"/>
                </a:cubicBezTo>
                <a:lnTo>
                  <a:pt x="1334" y="8"/>
                </a:lnTo>
                <a:cubicBezTo>
                  <a:pt x="1337" y="9"/>
                  <a:pt x="1340" y="10"/>
                  <a:pt x="1343" y="12"/>
                </a:cubicBezTo>
                <a:lnTo>
                  <a:pt x="1372" y="32"/>
                </a:lnTo>
                <a:cubicBezTo>
                  <a:pt x="1375" y="33"/>
                  <a:pt x="1377" y="36"/>
                  <a:pt x="1379" y="38"/>
                </a:cubicBezTo>
                <a:lnTo>
                  <a:pt x="1398" y="67"/>
                </a:lnTo>
                <a:cubicBezTo>
                  <a:pt x="1399" y="70"/>
                  <a:pt x="1400" y="73"/>
                  <a:pt x="1401" y="76"/>
                </a:cubicBezTo>
                <a:lnTo>
                  <a:pt x="1408" y="112"/>
                </a:lnTo>
                <a:cubicBezTo>
                  <a:pt x="1408" y="113"/>
                  <a:pt x="1408" y="115"/>
                  <a:pt x="1408" y="116"/>
                </a:cubicBezTo>
                <a:lnTo>
                  <a:pt x="1408" y="845"/>
                </a:lnTo>
                <a:cubicBezTo>
                  <a:pt x="1408" y="847"/>
                  <a:pt x="1408" y="849"/>
                  <a:pt x="1408" y="850"/>
                </a:cubicBezTo>
                <a:lnTo>
                  <a:pt x="1401" y="886"/>
                </a:lnTo>
                <a:cubicBezTo>
                  <a:pt x="1400" y="889"/>
                  <a:pt x="1399" y="892"/>
                  <a:pt x="1398" y="895"/>
                </a:cubicBezTo>
                <a:lnTo>
                  <a:pt x="1379" y="924"/>
                </a:lnTo>
                <a:cubicBezTo>
                  <a:pt x="1377" y="926"/>
                  <a:pt x="1374" y="929"/>
                  <a:pt x="1372" y="931"/>
                </a:cubicBezTo>
                <a:lnTo>
                  <a:pt x="1343" y="950"/>
                </a:lnTo>
                <a:cubicBezTo>
                  <a:pt x="1340" y="951"/>
                  <a:pt x="1337" y="952"/>
                  <a:pt x="1334" y="953"/>
                </a:cubicBezTo>
                <a:lnTo>
                  <a:pt x="1298" y="960"/>
                </a:lnTo>
                <a:cubicBezTo>
                  <a:pt x="1297" y="960"/>
                  <a:pt x="1295" y="960"/>
                  <a:pt x="1293" y="960"/>
                </a:cubicBezTo>
                <a:lnTo>
                  <a:pt x="116" y="960"/>
                </a:lnTo>
                <a:cubicBezTo>
                  <a:pt x="115" y="960"/>
                  <a:pt x="113" y="960"/>
                  <a:pt x="112" y="960"/>
                </a:cubicBezTo>
                <a:lnTo>
                  <a:pt x="76" y="953"/>
                </a:lnTo>
                <a:cubicBezTo>
                  <a:pt x="73" y="952"/>
                  <a:pt x="70" y="951"/>
                  <a:pt x="67" y="950"/>
                </a:cubicBezTo>
                <a:lnTo>
                  <a:pt x="38" y="931"/>
                </a:lnTo>
                <a:cubicBezTo>
                  <a:pt x="36" y="929"/>
                  <a:pt x="33" y="927"/>
                  <a:pt x="32" y="924"/>
                </a:cubicBezTo>
                <a:lnTo>
                  <a:pt x="12" y="895"/>
                </a:lnTo>
                <a:cubicBezTo>
                  <a:pt x="10" y="892"/>
                  <a:pt x="9" y="889"/>
                  <a:pt x="8" y="886"/>
                </a:cubicBezTo>
                <a:lnTo>
                  <a:pt x="1" y="850"/>
                </a:lnTo>
                <a:cubicBezTo>
                  <a:pt x="1" y="849"/>
                  <a:pt x="0" y="847"/>
                  <a:pt x="0" y="845"/>
                </a:cubicBezTo>
                <a:lnTo>
                  <a:pt x="0" y="116"/>
                </a:lnTo>
                <a:close/>
                <a:moveTo>
                  <a:pt x="48" y="845"/>
                </a:moveTo>
                <a:lnTo>
                  <a:pt x="48" y="841"/>
                </a:lnTo>
                <a:lnTo>
                  <a:pt x="55" y="877"/>
                </a:lnTo>
                <a:lnTo>
                  <a:pt x="51" y="868"/>
                </a:lnTo>
                <a:lnTo>
                  <a:pt x="71" y="897"/>
                </a:lnTo>
                <a:lnTo>
                  <a:pt x="65" y="890"/>
                </a:lnTo>
                <a:lnTo>
                  <a:pt x="94" y="909"/>
                </a:lnTo>
                <a:lnTo>
                  <a:pt x="85" y="906"/>
                </a:lnTo>
                <a:lnTo>
                  <a:pt x="121" y="913"/>
                </a:lnTo>
                <a:lnTo>
                  <a:pt x="116" y="912"/>
                </a:lnTo>
                <a:lnTo>
                  <a:pt x="1293" y="912"/>
                </a:lnTo>
                <a:lnTo>
                  <a:pt x="1289" y="913"/>
                </a:lnTo>
                <a:lnTo>
                  <a:pt x="1325" y="906"/>
                </a:lnTo>
                <a:lnTo>
                  <a:pt x="1316" y="909"/>
                </a:lnTo>
                <a:lnTo>
                  <a:pt x="1345" y="890"/>
                </a:lnTo>
                <a:lnTo>
                  <a:pt x="1338" y="897"/>
                </a:lnTo>
                <a:lnTo>
                  <a:pt x="1357" y="868"/>
                </a:lnTo>
                <a:lnTo>
                  <a:pt x="1354" y="877"/>
                </a:lnTo>
                <a:lnTo>
                  <a:pt x="1361" y="841"/>
                </a:lnTo>
                <a:lnTo>
                  <a:pt x="1360" y="845"/>
                </a:lnTo>
                <a:lnTo>
                  <a:pt x="1360" y="116"/>
                </a:lnTo>
                <a:lnTo>
                  <a:pt x="1361" y="121"/>
                </a:lnTo>
                <a:lnTo>
                  <a:pt x="1354" y="85"/>
                </a:lnTo>
                <a:lnTo>
                  <a:pt x="1357" y="94"/>
                </a:lnTo>
                <a:lnTo>
                  <a:pt x="1338" y="65"/>
                </a:lnTo>
                <a:lnTo>
                  <a:pt x="1345" y="71"/>
                </a:lnTo>
                <a:lnTo>
                  <a:pt x="1316" y="51"/>
                </a:lnTo>
                <a:lnTo>
                  <a:pt x="1325" y="55"/>
                </a:lnTo>
                <a:lnTo>
                  <a:pt x="1289" y="48"/>
                </a:lnTo>
                <a:lnTo>
                  <a:pt x="1293" y="48"/>
                </a:lnTo>
                <a:lnTo>
                  <a:pt x="116" y="48"/>
                </a:lnTo>
                <a:lnTo>
                  <a:pt x="121" y="48"/>
                </a:lnTo>
                <a:lnTo>
                  <a:pt x="85" y="55"/>
                </a:lnTo>
                <a:lnTo>
                  <a:pt x="94" y="51"/>
                </a:lnTo>
                <a:lnTo>
                  <a:pt x="65" y="71"/>
                </a:lnTo>
                <a:lnTo>
                  <a:pt x="71" y="65"/>
                </a:lnTo>
                <a:lnTo>
                  <a:pt x="51" y="94"/>
                </a:lnTo>
                <a:lnTo>
                  <a:pt x="55" y="85"/>
                </a:lnTo>
                <a:lnTo>
                  <a:pt x="48" y="121"/>
                </a:lnTo>
                <a:lnTo>
                  <a:pt x="48" y="116"/>
                </a:lnTo>
                <a:lnTo>
                  <a:pt x="48" y="845"/>
                </a:lnTo>
                <a:close/>
              </a:path>
            </a:pathLst>
          </a:custGeom>
          <a:solidFill>
            <a:srgbClr val="1B4171"/>
          </a:solidFill>
          <a:ln w="0" cap="flat">
            <a:solidFill>
              <a:srgbClr val="1B417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 sz="1100" b="1"/>
          </a:p>
        </p:txBody>
      </p:sp>
      <p:sp>
        <p:nvSpPr>
          <p:cNvPr id="65" name="64 CuadroTexto"/>
          <p:cNvSpPr txBox="1"/>
          <p:nvPr/>
        </p:nvSpPr>
        <p:spPr>
          <a:xfrm>
            <a:off x="1115616" y="4293096"/>
            <a:ext cx="64807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100" dirty="0" smtClean="0"/>
              <a:t>124</a:t>
            </a:r>
          </a:p>
          <a:p>
            <a:pPr algn="ctr"/>
            <a:r>
              <a:rPr lang="es-ES" sz="1100" dirty="0" smtClean="0"/>
              <a:t>Test (+)</a:t>
            </a:r>
            <a:endParaRPr lang="es-ES" sz="1100" dirty="0"/>
          </a:p>
        </p:txBody>
      </p:sp>
      <p:sp>
        <p:nvSpPr>
          <p:cNvPr id="66" name="65 CuadroTexto"/>
          <p:cNvSpPr txBox="1"/>
          <p:nvPr/>
        </p:nvSpPr>
        <p:spPr>
          <a:xfrm>
            <a:off x="2627784" y="4293096"/>
            <a:ext cx="64807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100" dirty="0" smtClean="0"/>
              <a:t>12</a:t>
            </a:r>
          </a:p>
          <a:p>
            <a:pPr algn="ctr"/>
            <a:r>
              <a:rPr lang="es-ES" sz="1100" dirty="0" smtClean="0"/>
              <a:t>Test (-)</a:t>
            </a:r>
            <a:endParaRPr lang="es-ES" sz="1100" dirty="0"/>
          </a:p>
        </p:txBody>
      </p:sp>
      <p:sp>
        <p:nvSpPr>
          <p:cNvPr id="67" name="66 CuadroTexto"/>
          <p:cNvSpPr txBox="1"/>
          <p:nvPr/>
        </p:nvSpPr>
        <p:spPr>
          <a:xfrm>
            <a:off x="5940152" y="4293096"/>
            <a:ext cx="64807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100" dirty="0" smtClean="0"/>
              <a:t>120</a:t>
            </a:r>
          </a:p>
          <a:p>
            <a:pPr algn="ctr"/>
            <a:r>
              <a:rPr lang="es-ES" sz="1100" dirty="0" smtClean="0"/>
              <a:t>Test (+)</a:t>
            </a:r>
            <a:endParaRPr lang="es-ES" sz="1100" dirty="0"/>
          </a:p>
        </p:txBody>
      </p:sp>
      <p:sp>
        <p:nvSpPr>
          <p:cNvPr id="73" name="72 CuadroTexto"/>
          <p:cNvSpPr txBox="1"/>
          <p:nvPr/>
        </p:nvSpPr>
        <p:spPr>
          <a:xfrm>
            <a:off x="7380312" y="4293096"/>
            <a:ext cx="64807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100" dirty="0" smtClean="0"/>
              <a:t>52</a:t>
            </a:r>
          </a:p>
          <a:p>
            <a:pPr algn="ctr"/>
            <a:r>
              <a:rPr lang="es-ES" sz="1100" dirty="0" smtClean="0"/>
              <a:t>Test (-)</a:t>
            </a:r>
            <a:endParaRPr lang="es-ES" sz="1100" dirty="0"/>
          </a:p>
        </p:txBody>
      </p:sp>
      <p:sp>
        <p:nvSpPr>
          <p:cNvPr id="79" name="78 CuadroTexto"/>
          <p:cNvSpPr txBox="1"/>
          <p:nvPr/>
        </p:nvSpPr>
        <p:spPr>
          <a:xfrm>
            <a:off x="539552" y="332656"/>
            <a:ext cx="12241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a-ES" sz="1200" dirty="0" err="1" smtClean="0"/>
              <a:t>Figure</a:t>
            </a:r>
            <a:r>
              <a:rPr lang="ca-ES" sz="1200" dirty="0" smtClean="0"/>
              <a:t> </a:t>
            </a:r>
            <a:r>
              <a:rPr lang="ca-ES" sz="1200" dirty="0" smtClean="0"/>
              <a:t>S5 </a:t>
            </a:r>
            <a:endParaRPr lang="ca-ES" sz="1200" dirty="0" smtClean="0"/>
          </a:p>
        </p:txBody>
      </p:sp>
      <p:sp>
        <p:nvSpPr>
          <p:cNvPr id="86" name="85 CuadroTexto"/>
          <p:cNvSpPr txBox="1"/>
          <p:nvPr/>
        </p:nvSpPr>
        <p:spPr>
          <a:xfrm>
            <a:off x="755576" y="1196752"/>
            <a:ext cx="5040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a-ES" dirty="0" smtClean="0"/>
              <a:t>a)</a:t>
            </a:r>
            <a:endParaRPr lang="ca-ES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Freeform 16"/>
          <p:cNvSpPr>
            <a:spLocks noEditPoints="1"/>
          </p:cNvSpPr>
          <p:nvPr/>
        </p:nvSpPr>
        <p:spPr bwMode="auto">
          <a:xfrm>
            <a:off x="5669188" y="2498227"/>
            <a:ext cx="955343" cy="693964"/>
          </a:xfrm>
          <a:custGeom>
            <a:avLst/>
            <a:gdLst/>
            <a:ahLst/>
            <a:cxnLst>
              <a:cxn ang="0">
                <a:pos x="1" y="112"/>
              </a:cxn>
              <a:cxn ang="0">
                <a:pos x="12" y="67"/>
              </a:cxn>
              <a:cxn ang="0">
                <a:pos x="38" y="32"/>
              </a:cxn>
              <a:cxn ang="0">
                <a:pos x="76" y="8"/>
              </a:cxn>
              <a:cxn ang="0">
                <a:pos x="116" y="0"/>
              </a:cxn>
              <a:cxn ang="0">
                <a:pos x="1298" y="1"/>
              </a:cxn>
              <a:cxn ang="0">
                <a:pos x="1343" y="12"/>
              </a:cxn>
              <a:cxn ang="0">
                <a:pos x="1379" y="38"/>
              </a:cxn>
              <a:cxn ang="0">
                <a:pos x="1401" y="76"/>
              </a:cxn>
              <a:cxn ang="0">
                <a:pos x="1408" y="116"/>
              </a:cxn>
              <a:cxn ang="0">
                <a:pos x="1408" y="850"/>
              </a:cxn>
              <a:cxn ang="0">
                <a:pos x="1398" y="895"/>
              </a:cxn>
              <a:cxn ang="0">
                <a:pos x="1372" y="931"/>
              </a:cxn>
              <a:cxn ang="0">
                <a:pos x="1334" y="953"/>
              </a:cxn>
              <a:cxn ang="0">
                <a:pos x="1293" y="960"/>
              </a:cxn>
              <a:cxn ang="0">
                <a:pos x="112" y="960"/>
              </a:cxn>
              <a:cxn ang="0">
                <a:pos x="67" y="950"/>
              </a:cxn>
              <a:cxn ang="0">
                <a:pos x="32" y="924"/>
              </a:cxn>
              <a:cxn ang="0">
                <a:pos x="8" y="886"/>
              </a:cxn>
              <a:cxn ang="0">
                <a:pos x="0" y="845"/>
              </a:cxn>
              <a:cxn ang="0">
                <a:pos x="48" y="845"/>
              </a:cxn>
              <a:cxn ang="0">
                <a:pos x="55" y="877"/>
              </a:cxn>
              <a:cxn ang="0">
                <a:pos x="71" y="897"/>
              </a:cxn>
              <a:cxn ang="0">
                <a:pos x="94" y="909"/>
              </a:cxn>
              <a:cxn ang="0">
                <a:pos x="121" y="913"/>
              </a:cxn>
              <a:cxn ang="0">
                <a:pos x="1293" y="912"/>
              </a:cxn>
              <a:cxn ang="0">
                <a:pos x="1325" y="906"/>
              </a:cxn>
              <a:cxn ang="0">
                <a:pos x="1345" y="890"/>
              </a:cxn>
              <a:cxn ang="0">
                <a:pos x="1357" y="868"/>
              </a:cxn>
              <a:cxn ang="0">
                <a:pos x="1361" y="841"/>
              </a:cxn>
              <a:cxn ang="0">
                <a:pos x="1360" y="116"/>
              </a:cxn>
              <a:cxn ang="0">
                <a:pos x="1354" y="85"/>
              </a:cxn>
              <a:cxn ang="0">
                <a:pos x="1338" y="65"/>
              </a:cxn>
              <a:cxn ang="0">
                <a:pos x="1316" y="51"/>
              </a:cxn>
              <a:cxn ang="0">
                <a:pos x="1289" y="48"/>
              </a:cxn>
              <a:cxn ang="0">
                <a:pos x="116" y="48"/>
              </a:cxn>
              <a:cxn ang="0">
                <a:pos x="85" y="55"/>
              </a:cxn>
              <a:cxn ang="0">
                <a:pos x="65" y="71"/>
              </a:cxn>
              <a:cxn ang="0">
                <a:pos x="51" y="94"/>
              </a:cxn>
              <a:cxn ang="0">
                <a:pos x="48" y="121"/>
              </a:cxn>
              <a:cxn ang="0">
                <a:pos x="48" y="845"/>
              </a:cxn>
            </a:cxnLst>
            <a:rect l="0" t="0" r="r" b="b"/>
            <a:pathLst>
              <a:path w="1408" h="960">
                <a:moveTo>
                  <a:pt x="0" y="116"/>
                </a:moveTo>
                <a:cubicBezTo>
                  <a:pt x="0" y="115"/>
                  <a:pt x="1" y="113"/>
                  <a:pt x="1" y="112"/>
                </a:cubicBezTo>
                <a:lnTo>
                  <a:pt x="8" y="76"/>
                </a:lnTo>
                <a:cubicBezTo>
                  <a:pt x="9" y="73"/>
                  <a:pt x="10" y="70"/>
                  <a:pt x="12" y="67"/>
                </a:cubicBezTo>
                <a:lnTo>
                  <a:pt x="32" y="38"/>
                </a:lnTo>
                <a:cubicBezTo>
                  <a:pt x="33" y="35"/>
                  <a:pt x="35" y="33"/>
                  <a:pt x="38" y="32"/>
                </a:cubicBezTo>
                <a:lnTo>
                  <a:pt x="67" y="12"/>
                </a:lnTo>
                <a:cubicBezTo>
                  <a:pt x="70" y="10"/>
                  <a:pt x="73" y="9"/>
                  <a:pt x="76" y="8"/>
                </a:cubicBezTo>
                <a:lnTo>
                  <a:pt x="112" y="1"/>
                </a:lnTo>
                <a:cubicBezTo>
                  <a:pt x="113" y="1"/>
                  <a:pt x="115" y="0"/>
                  <a:pt x="116" y="0"/>
                </a:cubicBezTo>
                <a:lnTo>
                  <a:pt x="1293" y="0"/>
                </a:lnTo>
                <a:cubicBezTo>
                  <a:pt x="1295" y="0"/>
                  <a:pt x="1297" y="1"/>
                  <a:pt x="1298" y="1"/>
                </a:cubicBezTo>
                <a:lnTo>
                  <a:pt x="1334" y="8"/>
                </a:lnTo>
                <a:cubicBezTo>
                  <a:pt x="1337" y="9"/>
                  <a:pt x="1340" y="10"/>
                  <a:pt x="1343" y="12"/>
                </a:cubicBezTo>
                <a:lnTo>
                  <a:pt x="1372" y="32"/>
                </a:lnTo>
                <a:cubicBezTo>
                  <a:pt x="1375" y="33"/>
                  <a:pt x="1377" y="36"/>
                  <a:pt x="1379" y="38"/>
                </a:cubicBezTo>
                <a:lnTo>
                  <a:pt x="1398" y="67"/>
                </a:lnTo>
                <a:cubicBezTo>
                  <a:pt x="1399" y="70"/>
                  <a:pt x="1400" y="73"/>
                  <a:pt x="1401" y="76"/>
                </a:cubicBezTo>
                <a:lnTo>
                  <a:pt x="1408" y="112"/>
                </a:lnTo>
                <a:cubicBezTo>
                  <a:pt x="1408" y="113"/>
                  <a:pt x="1408" y="115"/>
                  <a:pt x="1408" y="116"/>
                </a:cubicBezTo>
                <a:lnTo>
                  <a:pt x="1408" y="845"/>
                </a:lnTo>
                <a:cubicBezTo>
                  <a:pt x="1408" y="847"/>
                  <a:pt x="1408" y="849"/>
                  <a:pt x="1408" y="850"/>
                </a:cubicBezTo>
                <a:lnTo>
                  <a:pt x="1401" y="886"/>
                </a:lnTo>
                <a:cubicBezTo>
                  <a:pt x="1400" y="889"/>
                  <a:pt x="1399" y="892"/>
                  <a:pt x="1398" y="895"/>
                </a:cubicBezTo>
                <a:lnTo>
                  <a:pt x="1379" y="924"/>
                </a:lnTo>
                <a:cubicBezTo>
                  <a:pt x="1377" y="926"/>
                  <a:pt x="1374" y="929"/>
                  <a:pt x="1372" y="931"/>
                </a:cubicBezTo>
                <a:lnTo>
                  <a:pt x="1343" y="950"/>
                </a:lnTo>
                <a:cubicBezTo>
                  <a:pt x="1340" y="951"/>
                  <a:pt x="1337" y="952"/>
                  <a:pt x="1334" y="953"/>
                </a:cubicBezTo>
                <a:lnTo>
                  <a:pt x="1298" y="960"/>
                </a:lnTo>
                <a:cubicBezTo>
                  <a:pt x="1297" y="960"/>
                  <a:pt x="1295" y="960"/>
                  <a:pt x="1293" y="960"/>
                </a:cubicBezTo>
                <a:lnTo>
                  <a:pt x="116" y="960"/>
                </a:lnTo>
                <a:cubicBezTo>
                  <a:pt x="115" y="960"/>
                  <a:pt x="113" y="960"/>
                  <a:pt x="112" y="960"/>
                </a:cubicBezTo>
                <a:lnTo>
                  <a:pt x="76" y="953"/>
                </a:lnTo>
                <a:cubicBezTo>
                  <a:pt x="73" y="952"/>
                  <a:pt x="70" y="951"/>
                  <a:pt x="67" y="950"/>
                </a:cubicBezTo>
                <a:lnTo>
                  <a:pt x="38" y="931"/>
                </a:lnTo>
                <a:cubicBezTo>
                  <a:pt x="36" y="929"/>
                  <a:pt x="33" y="927"/>
                  <a:pt x="32" y="924"/>
                </a:cubicBezTo>
                <a:lnTo>
                  <a:pt x="12" y="895"/>
                </a:lnTo>
                <a:cubicBezTo>
                  <a:pt x="10" y="892"/>
                  <a:pt x="9" y="889"/>
                  <a:pt x="8" y="886"/>
                </a:cubicBezTo>
                <a:lnTo>
                  <a:pt x="1" y="850"/>
                </a:lnTo>
                <a:cubicBezTo>
                  <a:pt x="1" y="849"/>
                  <a:pt x="0" y="847"/>
                  <a:pt x="0" y="845"/>
                </a:cubicBezTo>
                <a:lnTo>
                  <a:pt x="0" y="116"/>
                </a:lnTo>
                <a:close/>
                <a:moveTo>
                  <a:pt x="48" y="845"/>
                </a:moveTo>
                <a:lnTo>
                  <a:pt x="48" y="841"/>
                </a:lnTo>
                <a:lnTo>
                  <a:pt x="55" y="877"/>
                </a:lnTo>
                <a:lnTo>
                  <a:pt x="51" y="868"/>
                </a:lnTo>
                <a:lnTo>
                  <a:pt x="71" y="897"/>
                </a:lnTo>
                <a:lnTo>
                  <a:pt x="65" y="890"/>
                </a:lnTo>
                <a:lnTo>
                  <a:pt x="94" y="909"/>
                </a:lnTo>
                <a:lnTo>
                  <a:pt x="85" y="906"/>
                </a:lnTo>
                <a:lnTo>
                  <a:pt x="121" y="913"/>
                </a:lnTo>
                <a:lnTo>
                  <a:pt x="116" y="912"/>
                </a:lnTo>
                <a:lnTo>
                  <a:pt x="1293" y="912"/>
                </a:lnTo>
                <a:lnTo>
                  <a:pt x="1289" y="913"/>
                </a:lnTo>
                <a:lnTo>
                  <a:pt x="1325" y="906"/>
                </a:lnTo>
                <a:lnTo>
                  <a:pt x="1316" y="909"/>
                </a:lnTo>
                <a:lnTo>
                  <a:pt x="1345" y="890"/>
                </a:lnTo>
                <a:lnTo>
                  <a:pt x="1338" y="897"/>
                </a:lnTo>
                <a:lnTo>
                  <a:pt x="1357" y="868"/>
                </a:lnTo>
                <a:lnTo>
                  <a:pt x="1354" y="877"/>
                </a:lnTo>
                <a:lnTo>
                  <a:pt x="1361" y="841"/>
                </a:lnTo>
                <a:lnTo>
                  <a:pt x="1360" y="845"/>
                </a:lnTo>
                <a:lnTo>
                  <a:pt x="1360" y="116"/>
                </a:lnTo>
                <a:lnTo>
                  <a:pt x="1361" y="121"/>
                </a:lnTo>
                <a:lnTo>
                  <a:pt x="1354" y="85"/>
                </a:lnTo>
                <a:lnTo>
                  <a:pt x="1357" y="94"/>
                </a:lnTo>
                <a:lnTo>
                  <a:pt x="1338" y="65"/>
                </a:lnTo>
                <a:lnTo>
                  <a:pt x="1345" y="71"/>
                </a:lnTo>
                <a:lnTo>
                  <a:pt x="1316" y="51"/>
                </a:lnTo>
                <a:lnTo>
                  <a:pt x="1325" y="55"/>
                </a:lnTo>
                <a:lnTo>
                  <a:pt x="1289" y="48"/>
                </a:lnTo>
                <a:lnTo>
                  <a:pt x="1293" y="48"/>
                </a:lnTo>
                <a:lnTo>
                  <a:pt x="116" y="48"/>
                </a:lnTo>
                <a:lnTo>
                  <a:pt x="121" y="48"/>
                </a:lnTo>
                <a:lnTo>
                  <a:pt x="85" y="55"/>
                </a:lnTo>
                <a:lnTo>
                  <a:pt x="94" y="51"/>
                </a:lnTo>
                <a:lnTo>
                  <a:pt x="65" y="71"/>
                </a:lnTo>
                <a:lnTo>
                  <a:pt x="71" y="65"/>
                </a:lnTo>
                <a:lnTo>
                  <a:pt x="51" y="94"/>
                </a:lnTo>
                <a:lnTo>
                  <a:pt x="55" y="85"/>
                </a:lnTo>
                <a:lnTo>
                  <a:pt x="48" y="121"/>
                </a:lnTo>
                <a:lnTo>
                  <a:pt x="48" y="116"/>
                </a:lnTo>
                <a:lnTo>
                  <a:pt x="48" y="845"/>
                </a:lnTo>
                <a:close/>
              </a:path>
            </a:pathLst>
          </a:custGeom>
          <a:solidFill>
            <a:srgbClr val="1B4171"/>
          </a:solidFill>
          <a:ln w="0" cap="flat">
            <a:solidFill>
              <a:srgbClr val="1B417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 sz="1100" b="1"/>
          </a:p>
        </p:txBody>
      </p:sp>
      <p:sp>
        <p:nvSpPr>
          <p:cNvPr id="20" name="Freeform 20"/>
          <p:cNvSpPr>
            <a:spLocks/>
          </p:cNvSpPr>
          <p:nvPr/>
        </p:nvSpPr>
        <p:spPr bwMode="auto">
          <a:xfrm>
            <a:off x="5331572" y="3174842"/>
            <a:ext cx="829763" cy="543605"/>
          </a:xfrm>
          <a:custGeom>
            <a:avLst/>
            <a:gdLst/>
            <a:ahLst/>
            <a:cxnLst>
              <a:cxn ang="0">
                <a:pos x="2710" y="0"/>
              </a:cxn>
              <a:cxn ang="0">
                <a:pos x="2710" y="376"/>
              </a:cxn>
              <a:cxn ang="0">
                <a:pos x="2686" y="400"/>
              </a:cxn>
              <a:cxn ang="0">
                <a:pos x="24" y="400"/>
              </a:cxn>
              <a:cxn ang="0">
                <a:pos x="48" y="376"/>
              </a:cxn>
              <a:cxn ang="0">
                <a:pos x="48" y="752"/>
              </a:cxn>
              <a:cxn ang="0">
                <a:pos x="0" y="752"/>
              </a:cxn>
              <a:cxn ang="0">
                <a:pos x="0" y="376"/>
              </a:cxn>
              <a:cxn ang="0">
                <a:pos x="24" y="352"/>
              </a:cxn>
              <a:cxn ang="0">
                <a:pos x="2686" y="352"/>
              </a:cxn>
              <a:cxn ang="0">
                <a:pos x="2662" y="376"/>
              </a:cxn>
              <a:cxn ang="0">
                <a:pos x="2662" y="0"/>
              </a:cxn>
              <a:cxn ang="0">
                <a:pos x="2710" y="0"/>
              </a:cxn>
            </a:cxnLst>
            <a:rect l="0" t="0" r="r" b="b"/>
            <a:pathLst>
              <a:path w="2710" h="752">
                <a:moveTo>
                  <a:pt x="2710" y="0"/>
                </a:moveTo>
                <a:lnTo>
                  <a:pt x="2710" y="376"/>
                </a:lnTo>
                <a:cubicBezTo>
                  <a:pt x="2710" y="390"/>
                  <a:pt x="2699" y="400"/>
                  <a:pt x="2686" y="400"/>
                </a:cubicBezTo>
                <a:lnTo>
                  <a:pt x="24" y="400"/>
                </a:lnTo>
                <a:lnTo>
                  <a:pt x="48" y="376"/>
                </a:lnTo>
                <a:lnTo>
                  <a:pt x="48" y="752"/>
                </a:lnTo>
                <a:lnTo>
                  <a:pt x="0" y="752"/>
                </a:lnTo>
                <a:lnTo>
                  <a:pt x="0" y="376"/>
                </a:lnTo>
                <a:cubicBezTo>
                  <a:pt x="0" y="363"/>
                  <a:pt x="11" y="352"/>
                  <a:pt x="24" y="352"/>
                </a:cubicBezTo>
                <a:lnTo>
                  <a:pt x="2686" y="352"/>
                </a:lnTo>
                <a:lnTo>
                  <a:pt x="2662" y="376"/>
                </a:lnTo>
                <a:lnTo>
                  <a:pt x="2662" y="0"/>
                </a:lnTo>
                <a:lnTo>
                  <a:pt x="2710" y="0"/>
                </a:lnTo>
                <a:close/>
              </a:path>
            </a:pathLst>
          </a:custGeom>
          <a:solidFill>
            <a:srgbClr val="1B4171"/>
          </a:solidFill>
          <a:ln w="0" cap="flat">
            <a:solidFill>
              <a:srgbClr val="1B417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 sz="1100" b="1"/>
          </a:p>
        </p:txBody>
      </p:sp>
      <p:sp>
        <p:nvSpPr>
          <p:cNvPr id="22" name="Freeform 47"/>
          <p:cNvSpPr>
            <a:spLocks/>
          </p:cNvSpPr>
          <p:nvPr/>
        </p:nvSpPr>
        <p:spPr bwMode="auto">
          <a:xfrm>
            <a:off x="6136004" y="3174842"/>
            <a:ext cx="836999" cy="543605"/>
          </a:xfrm>
          <a:custGeom>
            <a:avLst/>
            <a:gdLst/>
            <a:ahLst/>
            <a:cxnLst>
              <a:cxn ang="0">
                <a:pos x="48" y="0"/>
              </a:cxn>
              <a:cxn ang="0">
                <a:pos x="48" y="376"/>
              </a:cxn>
              <a:cxn ang="0">
                <a:pos x="24" y="352"/>
              </a:cxn>
              <a:cxn ang="0">
                <a:pos x="2686" y="352"/>
              </a:cxn>
              <a:cxn ang="0">
                <a:pos x="2710" y="376"/>
              </a:cxn>
              <a:cxn ang="0">
                <a:pos x="2710" y="752"/>
              </a:cxn>
              <a:cxn ang="0">
                <a:pos x="2662" y="752"/>
              </a:cxn>
              <a:cxn ang="0">
                <a:pos x="2662" y="376"/>
              </a:cxn>
              <a:cxn ang="0">
                <a:pos x="2686" y="400"/>
              </a:cxn>
              <a:cxn ang="0">
                <a:pos x="24" y="400"/>
              </a:cxn>
              <a:cxn ang="0">
                <a:pos x="0" y="376"/>
              </a:cxn>
              <a:cxn ang="0">
                <a:pos x="0" y="0"/>
              </a:cxn>
              <a:cxn ang="0">
                <a:pos x="48" y="0"/>
              </a:cxn>
            </a:cxnLst>
            <a:rect l="0" t="0" r="r" b="b"/>
            <a:pathLst>
              <a:path w="2710" h="752">
                <a:moveTo>
                  <a:pt x="48" y="0"/>
                </a:moveTo>
                <a:lnTo>
                  <a:pt x="48" y="376"/>
                </a:lnTo>
                <a:lnTo>
                  <a:pt x="24" y="352"/>
                </a:lnTo>
                <a:lnTo>
                  <a:pt x="2686" y="352"/>
                </a:lnTo>
                <a:cubicBezTo>
                  <a:pt x="2699" y="352"/>
                  <a:pt x="2710" y="363"/>
                  <a:pt x="2710" y="376"/>
                </a:cubicBezTo>
                <a:lnTo>
                  <a:pt x="2710" y="752"/>
                </a:lnTo>
                <a:lnTo>
                  <a:pt x="2662" y="752"/>
                </a:lnTo>
                <a:lnTo>
                  <a:pt x="2662" y="376"/>
                </a:lnTo>
                <a:lnTo>
                  <a:pt x="2686" y="400"/>
                </a:lnTo>
                <a:lnTo>
                  <a:pt x="24" y="400"/>
                </a:lnTo>
                <a:cubicBezTo>
                  <a:pt x="11" y="400"/>
                  <a:pt x="0" y="390"/>
                  <a:pt x="0" y="376"/>
                </a:cubicBezTo>
                <a:lnTo>
                  <a:pt x="0" y="0"/>
                </a:lnTo>
                <a:lnTo>
                  <a:pt x="48" y="0"/>
                </a:lnTo>
                <a:close/>
              </a:path>
            </a:pathLst>
          </a:custGeom>
          <a:solidFill>
            <a:srgbClr val="1B4171"/>
          </a:solidFill>
          <a:ln w="0" cap="flat">
            <a:solidFill>
              <a:srgbClr val="1B417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 sz="1100" b="1"/>
          </a:p>
        </p:txBody>
      </p:sp>
      <p:sp>
        <p:nvSpPr>
          <p:cNvPr id="2" name="Freeform 16"/>
          <p:cNvSpPr>
            <a:spLocks noEditPoints="1"/>
          </p:cNvSpPr>
          <p:nvPr/>
        </p:nvSpPr>
        <p:spPr bwMode="auto">
          <a:xfrm>
            <a:off x="2388246" y="2498227"/>
            <a:ext cx="960871" cy="693964"/>
          </a:xfrm>
          <a:custGeom>
            <a:avLst/>
            <a:gdLst/>
            <a:ahLst/>
            <a:cxnLst>
              <a:cxn ang="0">
                <a:pos x="1" y="112"/>
              </a:cxn>
              <a:cxn ang="0">
                <a:pos x="12" y="67"/>
              </a:cxn>
              <a:cxn ang="0">
                <a:pos x="38" y="32"/>
              </a:cxn>
              <a:cxn ang="0">
                <a:pos x="76" y="8"/>
              </a:cxn>
              <a:cxn ang="0">
                <a:pos x="116" y="0"/>
              </a:cxn>
              <a:cxn ang="0">
                <a:pos x="1298" y="1"/>
              </a:cxn>
              <a:cxn ang="0">
                <a:pos x="1343" y="12"/>
              </a:cxn>
              <a:cxn ang="0">
                <a:pos x="1379" y="38"/>
              </a:cxn>
              <a:cxn ang="0">
                <a:pos x="1401" y="76"/>
              </a:cxn>
              <a:cxn ang="0">
                <a:pos x="1408" y="116"/>
              </a:cxn>
              <a:cxn ang="0">
                <a:pos x="1408" y="850"/>
              </a:cxn>
              <a:cxn ang="0">
                <a:pos x="1398" y="895"/>
              </a:cxn>
              <a:cxn ang="0">
                <a:pos x="1372" y="931"/>
              </a:cxn>
              <a:cxn ang="0">
                <a:pos x="1334" y="953"/>
              </a:cxn>
              <a:cxn ang="0">
                <a:pos x="1293" y="960"/>
              </a:cxn>
              <a:cxn ang="0">
                <a:pos x="112" y="960"/>
              </a:cxn>
              <a:cxn ang="0">
                <a:pos x="67" y="950"/>
              </a:cxn>
              <a:cxn ang="0">
                <a:pos x="32" y="924"/>
              </a:cxn>
              <a:cxn ang="0">
                <a:pos x="8" y="886"/>
              </a:cxn>
              <a:cxn ang="0">
                <a:pos x="0" y="845"/>
              </a:cxn>
              <a:cxn ang="0">
                <a:pos x="48" y="845"/>
              </a:cxn>
              <a:cxn ang="0">
                <a:pos x="55" y="877"/>
              </a:cxn>
              <a:cxn ang="0">
                <a:pos x="71" y="897"/>
              </a:cxn>
              <a:cxn ang="0">
                <a:pos x="94" y="909"/>
              </a:cxn>
              <a:cxn ang="0">
                <a:pos x="121" y="913"/>
              </a:cxn>
              <a:cxn ang="0">
                <a:pos x="1293" y="912"/>
              </a:cxn>
              <a:cxn ang="0">
                <a:pos x="1325" y="906"/>
              </a:cxn>
              <a:cxn ang="0">
                <a:pos x="1345" y="890"/>
              </a:cxn>
              <a:cxn ang="0">
                <a:pos x="1357" y="868"/>
              </a:cxn>
              <a:cxn ang="0">
                <a:pos x="1361" y="841"/>
              </a:cxn>
              <a:cxn ang="0">
                <a:pos x="1360" y="116"/>
              </a:cxn>
              <a:cxn ang="0">
                <a:pos x="1354" y="85"/>
              </a:cxn>
              <a:cxn ang="0">
                <a:pos x="1338" y="65"/>
              </a:cxn>
              <a:cxn ang="0">
                <a:pos x="1316" y="51"/>
              </a:cxn>
              <a:cxn ang="0">
                <a:pos x="1289" y="48"/>
              </a:cxn>
              <a:cxn ang="0">
                <a:pos x="116" y="48"/>
              </a:cxn>
              <a:cxn ang="0">
                <a:pos x="85" y="55"/>
              </a:cxn>
              <a:cxn ang="0">
                <a:pos x="65" y="71"/>
              </a:cxn>
              <a:cxn ang="0">
                <a:pos x="51" y="94"/>
              </a:cxn>
              <a:cxn ang="0">
                <a:pos x="48" y="121"/>
              </a:cxn>
              <a:cxn ang="0">
                <a:pos x="48" y="845"/>
              </a:cxn>
            </a:cxnLst>
            <a:rect l="0" t="0" r="r" b="b"/>
            <a:pathLst>
              <a:path w="1408" h="960">
                <a:moveTo>
                  <a:pt x="0" y="116"/>
                </a:moveTo>
                <a:cubicBezTo>
                  <a:pt x="0" y="115"/>
                  <a:pt x="1" y="113"/>
                  <a:pt x="1" y="112"/>
                </a:cubicBezTo>
                <a:lnTo>
                  <a:pt x="8" y="76"/>
                </a:lnTo>
                <a:cubicBezTo>
                  <a:pt x="9" y="73"/>
                  <a:pt x="10" y="70"/>
                  <a:pt x="12" y="67"/>
                </a:cubicBezTo>
                <a:lnTo>
                  <a:pt x="32" y="38"/>
                </a:lnTo>
                <a:cubicBezTo>
                  <a:pt x="33" y="35"/>
                  <a:pt x="35" y="33"/>
                  <a:pt x="38" y="32"/>
                </a:cubicBezTo>
                <a:lnTo>
                  <a:pt x="67" y="12"/>
                </a:lnTo>
                <a:cubicBezTo>
                  <a:pt x="70" y="10"/>
                  <a:pt x="73" y="9"/>
                  <a:pt x="76" y="8"/>
                </a:cubicBezTo>
                <a:lnTo>
                  <a:pt x="112" y="1"/>
                </a:lnTo>
                <a:cubicBezTo>
                  <a:pt x="113" y="1"/>
                  <a:pt x="115" y="0"/>
                  <a:pt x="116" y="0"/>
                </a:cubicBezTo>
                <a:lnTo>
                  <a:pt x="1293" y="0"/>
                </a:lnTo>
                <a:cubicBezTo>
                  <a:pt x="1295" y="0"/>
                  <a:pt x="1297" y="1"/>
                  <a:pt x="1298" y="1"/>
                </a:cubicBezTo>
                <a:lnTo>
                  <a:pt x="1334" y="8"/>
                </a:lnTo>
                <a:cubicBezTo>
                  <a:pt x="1337" y="9"/>
                  <a:pt x="1340" y="10"/>
                  <a:pt x="1343" y="12"/>
                </a:cubicBezTo>
                <a:lnTo>
                  <a:pt x="1372" y="32"/>
                </a:lnTo>
                <a:cubicBezTo>
                  <a:pt x="1375" y="33"/>
                  <a:pt x="1377" y="36"/>
                  <a:pt x="1379" y="38"/>
                </a:cubicBezTo>
                <a:lnTo>
                  <a:pt x="1398" y="67"/>
                </a:lnTo>
                <a:cubicBezTo>
                  <a:pt x="1399" y="70"/>
                  <a:pt x="1400" y="73"/>
                  <a:pt x="1401" y="76"/>
                </a:cubicBezTo>
                <a:lnTo>
                  <a:pt x="1408" y="112"/>
                </a:lnTo>
                <a:cubicBezTo>
                  <a:pt x="1408" y="113"/>
                  <a:pt x="1408" y="115"/>
                  <a:pt x="1408" y="116"/>
                </a:cubicBezTo>
                <a:lnTo>
                  <a:pt x="1408" y="845"/>
                </a:lnTo>
                <a:cubicBezTo>
                  <a:pt x="1408" y="847"/>
                  <a:pt x="1408" y="849"/>
                  <a:pt x="1408" y="850"/>
                </a:cubicBezTo>
                <a:lnTo>
                  <a:pt x="1401" y="886"/>
                </a:lnTo>
                <a:cubicBezTo>
                  <a:pt x="1400" y="889"/>
                  <a:pt x="1399" y="892"/>
                  <a:pt x="1398" y="895"/>
                </a:cubicBezTo>
                <a:lnTo>
                  <a:pt x="1379" y="924"/>
                </a:lnTo>
                <a:cubicBezTo>
                  <a:pt x="1377" y="926"/>
                  <a:pt x="1374" y="929"/>
                  <a:pt x="1372" y="931"/>
                </a:cubicBezTo>
                <a:lnTo>
                  <a:pt x="1343" y="950"/>
                </a:lnTo>
                <a:cubicBezTo>
                  <a:pt x="1340" y="951"/>
                  <a:pt x="1337" y="952"/>
                  <a:pt x="1334" y="953"/>
                </a:cubicBezTo>
                <a:lnTo>
                  <a:pt x="1298" y="960"/>
                </a:lnTo>
                <a:cubicBezTo>
                  <a:pt x="1297" y="960"/>
                  <a:pt x="1295" y="960"/>
                  <a:pt x="1293" y="960"/>
                </a:cubicBezTo>
                <a:lnTo>
                  <a:pt x="116" y="960"/>
                </a:lnTo>
                <a:cubicBezTo>
                  <a:pt x="115" y="960"/>
                  <a:pt x="113" y="960"/>
                  <a:pt x="112" y="960"/>
                </a:cubicBezTo>
                <a:lnTo>
                  <a:pt x="76" y="953"/>
                </a:lnTo>
                <a:cubicBezTo>
                  <a:pt x="73" y="952"/>
                  <a:pt x="70" y="951"/>
                  <a:pt x="67" y="950"/>
                </a:cubicBezTo>
                <a:lnTo>
                  <a:pt x="38" y="931"/>
                </a:lnTo>
                <a:cubicBezTo>
                  <a:pt x="36" y="929"/>
                  <a:pt x="33" y="927"/>
                  <a:pt x="32" y="924"/>
                </a:cubicBezTo>
                <a:lnTo>
                  <a:pt x="12" y="895"/>
                </a:lnTo>
                <a:cubicBezTo>
                  <a:pt x="10" y="892"/>
                  <a:pt x="9" y="889"/>
                  <a:pt x="8" y="886"/>
                </a:cubicBezTo>
                <a:lnTo>
                  <a:pt x="1" y="850"/>
                </a:lnTo>
                <a:cubicBezTo>
                  <a:pt x="1" y="849"/>
                  <a:pt x="0" y="847"/>
                  <a:pt x="0" y="845"/>
                </a:cubicBezTo>
                <a:lnTo>
                  <a:pt x="0" y="116"/>
                </a:lnTo>
                <a:close/>
                <a:moveTo>
                  <a:pt x="48" y="845"/>
                </a:moveTo>
                <a:lnTo>
                  <a:pt x="48" y="841"/>
                </a:lnTo>
                <a:lnTo>
                  <a:pt x="55" y="877"/>
                </a:lnTo>
                <a:lnTo>
                  <a:pt x="51" y="868"/>
                </a:lnTo>
                <a:lnTo>
                  <a:pt x="71" y="897"/>
                </a:lnTo>
                <a:lnTo>
                  <a:pt x="65" y="890"/>
                </a:lnTo>
                <a:lnTo>
                  <a:pt x="94" y="909"/>
                </a:lnTo>
                <a:lnTo>
                  <a:pt x="85" y="906"/>
                </a:lnTo>
                <a:lnTo>
                  <a:pt x="121" y="913"/>
                </a:lnTo>
                <a:lnTo>
                  <a:pt x="116" y="912"/>
                </a:lnTo>
                <a:lnTo>
                  <a:pt x="1293" y="912"/>
                </a:lnTo>
                <a:lnTo>
                  <a:pt x="1289" y="913"/>
                </a:lnTo>
                <a:lnTo>
                  <a:pt x="1325" y="906"/>
                </a:lnTo>
                <a:lnTo>
                  <a:pt x="1316" y="909"/>
                </a:lnTo>
                <a:lnTo>
                  <a:pt x="1345" y="890"/>
                </a:lnTo>
                <a:lnTo>
                  <a:pt x="1338" y="897"/>
                </a:lnTo>
                <a:lnTo>
                  <a:pt x="1357" y="868"/>
                </a:lnTo>
                <a:lnTo>
                  <a:pt x="1354" y="877"/>
                </a:lnTo>
                <a:lnTo>
                  <a:pt x="1361" y="841"/>
                </a:lnTo>
                <a:lnTo>
                  <a:pt x="1360" y="845"/>
                </a:lnTo>
                <a:lnTo>
                  <a:pt x="1360" y="116"/>
                </a:lnTo>
                <a:lnTo>
                  <a:pt x="1361" y="121"/>
                </a:lnTo>
                <a:lnTo>
                  <a:pt x="1354" y="85"/>
                </a:lnTo>
                <a:lnTo>
                  <a:pt x="1357" y="94"/>
                </a:lnTo>
                <a:lnTo>
                  <a:pt x="1338" y="65"/>
                </a:lnTo>
                <a:lnTo>
                  <a:pt x="1345" y="71"/>
                </a:lnTo>
                <a:lnTo>
                  <a:pt x="1316" y="51"/>
                </a:lnTo>
                <a:lnTo>
                  <a:pt x="1325" y="55"/>
                </a:lnTo>
                <a:lnTo>
                  <a:pt x="1289" y="48"/>
                </a:lnTo>
                <a:lnTo>
                  <a:pt x="1293" y="48"/>
                </a:lnTo>
                <a:lnTo>
                  <a:pt x="116" y="48"/>
                </a:lnTo>
                <a:lnTo>
                  <a:pt x="121" y="48"/>
                </a:lnTo>
                <a:lnTo>
                  <a:pt x="85" y="55"/>
                </a:lnTo>
                <a:lnTo>
                  <a:pt x="94" y="51"/>
                </a:lnTo>
                <a:lnTo>
                  <a:pt x="65" y="71"/>
                </a:lnTo>
                <a:lnTo>
                  <a:pt x="71" y="65"/>
                </a:lnTo>
                <a:lnTo>
                  <a:pt x="51" y="94"/>
                </a:lnTo>
                <a:lnTo>
                  <a:pt x="55" y="85"/>
                </a:lnTo>
                <a:lnTo>
                  <a:pt x="48" y="121"/>
                </a:lnTo>
                <a:lnTo>
                  <a:pt x="48" y="116"/>
                </a:lnTo>
                <a:lnTo>
                  <a:pt x="48" y="845"/>
                </a:lnTo>
                <a:close/>
              </a:path>
            </a:pathLst>
          </a:custGeom>
          <a:solidFill>
            <a:srgbClr val="1B4171"/>
          </a:solidFill>
          <a:ln w="0" cap="flat">
            <a:solidFill>
              <a:srgbClr val="1B417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 sz="1100" b="1"/>
          </a:p>
        </p:txBody>
      </p:sp>
      <p:sp>
        <p:nvSpPr>
          <p:cNvPr id="3" name="Freeform 20"/>
          <p:cNvSpPr>
            <a:spLocks/>
          </p:cNvSpPr>
          <p:nvPr/>
        </p:nvSpPr>
        <p:spPr bwMode="auto">
          <a:xfrm>
            <a:off x="2050630" y="3174842"/>
            <a:ext cx="829763" cy="543605"/>
          </a:xfrm>
          <a:custGeom>
            <a:avLst/>
            <a:gdLst/>
            <a:ahLst/>
            <a:cxnLst>
              <a:cxn ang="0">
                <a:pos x="2710" y="0"/>
              </a:cxn>
              <a:cxn ang="0">
                <a:pos x="2710" y="376"/>
              </a:cxn>
              <a:cxn ang="0">
                <a:pos x="2686" y="400"/>
              </a:cxn>
              <a:cxn ang="0">
                <a:pos x="24" y="400"/>
              </a:cxn>
              <a:cxn ang="0">
                <a:pos x="48" y="376"/>
              </a:cxn>
              <a:cxn ang="0">
                <a:pos x="48" y="752"/>
              </a:cxn>
              <a:cxn ang="0">
                <a:pos x="0" y="752"/>
              </a:cxn>
              <a:cxn ang="0">
                <a:pos x="0" y="376"/>
              </a:cxn>
              <a:cxn ang="0">
                <a:pos x="24" y="352"/>
              </a:cxn>
              <a:cxn ang="0">
                <a:pos x="2686" y="352"/>
              </a:cxn>
              <a:cxn ang="0">
                <a:pos x="2662" y="376"/>
              </a:cxn>
              <a:cxn ang="0">
                <a:pos x="2662" y="0"/>
              </a:cxn>
              <a:cxn ang="0">
                <a:pos x="2710" y="0"/>
              </a:cxn>
            </a:cxnLst>
            <a:rect l="0" t="0" r="r" b="b"/>
            <a:pathLst>
              <a:path w="2710" h="752">
                <a:moveTo>
                  <a:pt x="2710" y="0"/>
                </a:moveTo>
                <a:lnTo>
                  <a:pt x="2710" y="376"/>
                </a:lnTo>
                <a:cubicBezTo>
                  <a:pt x="2710" y="390"/>
                  <a:pt x="2699" y="400"/>
                  <a:pt x="2686" y="400"/>
                </a:cubicBezTo>
                <a:lnTo>
                  <a:pt x="24" y="400"/>
                </a:lnTo>
                <a:lnTo>
                  <a:pt x="48" y="376"/>
                </a:lnTo>
                <a:lnTo>
                  <a:pt x="48" y="752"/>
                </a:lnTo>
                <a:lnTo>
                  <a:pt x="0" y="752"/>
                </a:lnTo>
                <a:lnTo>
                  <a:pt x="0" y="376"/>
                </a:lnTo>
                <a:cubicBezTo>
                  <a:pt x="0" y="363"/>
                  <a:pt x="11" y="352"/>
                  <a:pt x="24" y="352"/>
                </a:cubicBezTo>
                <a:lnTo>
                  <a:pt x="2686" y="352"/>
                </a:lnTo>
                <a:lnTo>
                  <a:pt x="2662" y="376"/>
                </a:lnTo>
                <a:lnTo>
                  <a:pt x="2662" y="0"/>
                </a:lnTo>
                <a:lnTo>
                  <a:pt x="2710" y="0"/>
                </a:lnTo>
                <a:close/>
              </a:path>
            </a:pathLst>
          </a:custGeom>
          <a:solidFill>
            <a:srgbClr val="1B4171"/>
          </a:solidFill>
          <a:ln w="0" cap="flat">
            <a:solidFill>
              <a:srgbClr val="1B417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 sz="1100" b="1"/>
          </a:p>
        </p:txBody>
      </p:sp>
      <p:sp>
        <p:nvSpPr>
          <p:cNvPr id="5" name="Freeform 47"/>
          <p:cNvSpPr>
            <a:spLocks/>
          </p:cNvSpPr>
          <p:nvPr/>
        </p:nvSpPr>
        <p:spPr bwMode="auto">
          <a:xfrm>
            <a:off x="2855061" y="3174842"/>
            <a:ext cx="836999" cy="543605"/>
          </a:xfrm>
          <a:custGeom>
            <a:avLst/>
            <a:gdLst/>
            <a:ahLst/>
            <a:cxnLst>
              <a:cxn ang="0">
                <a:pos x="48" y="0"/>
              </a:cxn>
              <a:cxn ang="0">
                <a:pos x="48" y="376"/>
              </a:cxn>
              <a:cxn ang="0">
                <a:pos x="24" y="352"/>
              </a:cxn>
              <a:cxn ang="0">
                <a:pos x="2686" y="352"/>
              </a:cxn>
              <a:cxn ang="0">
                <a:pos x="2710" y="376"/>
              </a:cxn>
              <a:cxn ang="0">
                <a:pos x="2710" y="752"/>
              </a:cxn>
              <a:cxn ang="0">
                <a:pos x="2662" y="752"/>
              </a:cxn>
              <a:cxn ang="0">
                <a:pos x="2662" y="376"/>
              </a:cxn>
              <a:cxn ang="0">
                <a:pos x="2686" y="400"/>
              </a:cxn>
              <a:cxn ang="0">
                <a:pos x="24" y="400"/>
              </a:cxn>
              <a:cxn ang="0">
                <a:pos x="0" y="376"/>
              </a:cxn>
              <a:cxn ang="0">
                <a:pos x="0" y="0"/>
              </a:cxn>
              <a:cxn ang="0">
                <a:pos x="48" y="0"/>
              </a:cxn>
            </a:cxnLst>
            <a:rect l="0" t="0" r="r" b="b"/>
            <a:pathLst>
              <a:path w="2710" h="752">
                <a:moveTo>
                  <a:pt x="48" y="0"/>
                </a:moveTo>
                <a:lnTo>
                  <a:pt x="48" y="376"/>
                </a:lnTo>
                <a:lnTo>
                  <a:pt x="24" y="352"/>
                </a:lnTo>
                <a:lnTo>
                  <a:pt x="2686" y="352"/>
                </a:lnTo>
                <a:cubicBezTo>
                  <a:pt x="2699" y="352"/>
                  <a:pt x="2710" y="363"/>
                  <a:pt x="2710" y="376"/>
                </a:cubicBezTo>
                <a:lnTo>
                  <a:pt x="2710" y="752"/>
                </a:lnTo>
                <a:lnTo>
                  <a:pt x="2662" y="752"/>
                </a:lnTo>
                <a:lnTo>
                  <a:pt x="2662" y="376"/>
                </a:lnTo>
                <a:lnTo>
                  <a:pt x="2686" y="400"/>
                </a:lnTo>
                <a:lnTo>
                  <a:pt x="24" y="400"/>
                </a:lnTo>
                <a:cubicBezTo>
                  <a:pt x="11" y="400"/>
                  <a:pt x="0" y="390"/>
                  <a:pt x="0" y="376"/>
                </a:cubicBezTo>
                <a:lnTo>
                  <a:pt x="0" y="0"/>
                </a:lnTo>
                <a:lnTo>
                  <a:pt x="48" y="0"/>
                </a:lnTo>
                <a:close/>
              </a:path>
            </a:pathLst>
          </a:custGeom>
          <a:solidFill>
            <a:srgbClr val="1B4171"/>
          </a:solidFill>
          <a:ln w="0" cap="flat">
            <a:solidFill>
              <a:srgbClr val="1B417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 sz="1100" b="1"/>
          </a:p>
        </p:txBody>
      </p:sp>
      <p:sp>
        <p:nvSpPr>
          <p:cNvPr id="92" name="Freeform 20"/>
          <p:cNvSpPr>
            <a:spLocks/>
          </p:cNvSpPr>
          <p:nvPr/>
        </p:nvSpPr>
        <p:spPr bwMode="auto">
          <a:xfrm>
            <a:off x="2843808" y="1944147"/>
            <a:ext cx="1662788" cy="543605"/>
          </a:xfrm>
          <a:custGeom>
            <a:avLst/>
            <a:gdLst/>
            <a:ahLst/>
            <a:cxnLst>
              <a:cxn ang="0">
                <a:pos x="2710" y="0"/>
              </a:cxn>
              <a:cxn ang="0">
                <a:pos x="2710" y="376"/>
              </a:cxn>
              <a:cxn ang="0">
                <a:pos x="2686" y="400"/>
              </a:cxn>
              <a:cxn ang="0">
                <a:pos x="24" y="400"/>
              </a:cxn>
              <a:cxn ang="0">
                <a:pos x="48" y="376"/>
              </a:cxn>
              <a:cxn ang="0">
                <a:pos x="48" y="752"/>
              </a:cxn>
              <a:cxn ang="0">
                <a:pos x="0" y="752"/>
              </a:cxn>
              <a:cxn ang="0">
                <a:pos x="0" y="376"/>
              </a:cxn>
              <a:cxn ang="0">
                <a:pos x="24" y="352"/>
              </a:cxn>
              <a:cxn ang="0">
                <a:pos x="2686" y="352"/>
              </a:cxn>
              <a:cxn ang="0">
                <a:pos x="2662" y="376"/>
              </a:cxn>
              <a:cxn ang="0">
                <a:pos x="2662" y="0"/>
              </a:cxn>
              <a:cxn ang="0">
                <a:pos x="2710" y="0"/>
              </a:cxn>
            </a:cxnLst>
            <a:rect l="0" t="0" r="r" b="b"/>
            <a:pathLst>
              <a:path w="2710" h="752">
                <a:moveTo>
                  <a:pt x="2710" y="0"/>
                </a:moveTo>
                <a:lnTo>
                  <a:pt x="2710" y="376"/>
                </a:lnTo>
                <a:cubicBezTo>
                  <a:pt x="2710" y="390"/>
                  <a:pt x="2699" y="400"/>
                  <a:pt x="2686" y="400"/>
                </a:cubicBezTo>
                <a:lnTo>
                  <a:pt x="24" y="400"/>
                </a:lnTo>
                <a:lnTo>
                  <a:pt x="48" y="376"/>
                </a:lnTo>
                <a:lnTo>
                  <a:pt x="48" y="752"/>
                </a:lnTo>
                <a:lnTo>
                  <a:pt x="0" y="752"/>
                </a:lnTo>
                <a:lnTo>
                  <a:pt x="0" y="376"/>
                </a:lnTo>
                <a:cubicBezTo>
                  <a:pt x="0" y="363"/>
                  <a:pt x="11" y="352"/>
                  <a:pt x="24" y="352"/>
                </a:cubicBezTo>
                <a:lnTo>
                  <a:pt x="2686" y="352"/>
                </a:lnTo>
                <a:lnTo>
                  <a:pt x="2662" y="376"/>
                </a:lnTo>
                <a:lnTo>
                  <a:pt x="2662" y="0"/>
                </a:lnTo>
                <a:lnTo>
                  <a:pt x="2710" y="0"/>
                </a:lnTo>
                <a:close/>
              </a:path>
            </a:pathLst>
          </a:custGeom>
          <a:solidFill>
            <a:srgbClr val="1B4171"/>
          </a:solidFill>
          <a:ln w="0" cap="flat">
            <a:solidFill>
              <a:srgbClr val="1B417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 sz="1100" b="1"/>
          </a:p>
        </p:txBody>
      </p:sp>
      <p:sp>
        <p:nvSpPr>
          <p:cNvPr id="93" name="Freeform 47"/>
          <p:cNvSpPr>
            <a:spLocks/>
          </p:cNvSpPr>
          <p:nvPr/>
        </p:nvSpPr>
        <p:spPr bwMode="auto">
          <a:xfrm>
            <a:off x="4481265" y="1944147"/>
            <a:ext cx="1674911" cy="543605"/>
          </a:xfrm>
          <a:custGeom>
            <a:avLst/>
            <a:gdLst/>
            <a:ahLst/>
            <a:cxnLst>
              <a:cxn ang="0">
                <a:pos x="48" y="0"/>
              </a:cxn>
              <a:cxn ang="0">
                <a:pos x="48" y="376"/>
              </a:cxn>
              <a:cxn ang="0">
                <a:pos x="24" y="352"/>
              </a:cxn>
              <a:cxn ang="0">
                <a:pos x="2686" y="352"/>
              </a:cxn>
              <a:cxn ang="0">
                <a:pos x="2710" y="376"/>
              </a:cxn>
              <a:cxn ang="0">
                <a:pos x="2710" y="752"/>
              </a:cxn>
              <a:cxn ang="0">
                <a:pos x="2662" y="752"/>
              </a:cxn>
              <a:cxn ang="0">
                <a:pos x="2662" y="376"/>
              </a:cxn>
              <a:cxn ang="0">
                <a:pos x="2686" y="400"/>
              </a:cxn>
              <a:cxn ang="0">
                <a:pos x="24" y="400"/>
              </a:cxn>
              <a:cxn ang="0">
                <a:pos x="0" y="376"/>
              </a:cxn>
              <a:cxn ang="0">
                <a:pos x="0" y="0"/>
              </a:cxn>
              <a:cxn ang="0">
                <a:pos x="48" y="0"/>
              </a:cxn>
            </a:cxnLst>
            <a:rect l="0" t="0" r="r" b="b"/>
            <a:pathLst>
              <a:path w="2710" h="752">
                <a:moveTo>
                  <a:pt x="48" y="0"/>
                </a:moveTo>
                <a:lnTo>
                  <a:pt x="48" y="376"/>
                </a:lnTo>
                <a:lnTo>
                  <a:pt x="24" y="352"/>
                </a:lnTo>
                <a:lnTo>
                  <a:pt x="2686" y="352"/>
                </a:lnTo>
                <a:cubicBezTo>
                  <a:pt x="2699" y="352"/>
                  <a:pt x="2710" y="363"/>
                  <a:pt x="2710" y="376"/>
                </a:cubicBezTo>
                <a:lnTo>
                  <a:pt x="2710" y="752"/>
                </a:lnTo>
                <a:lnTo>
                  <a:pt x="2662" y="752"/>
                </a:lnTo>
                <a:lnTo>
                  <a:pt x="2662" y="376"/>
                </a:lnTo>
                <a:lnTo>
                  <a:pt x="2686" y="400"/>
                </a:lnTo>
                <a:lnTo>
                  <a:pt x="24" y="400"/>
                </a:lnTo>
                <a:cubicBezTo>
                  <a:pt x="11" y="400"/>
                  <a:pt x="0" y="390"/>
                  <a:pt x="0" y="376"/>
                </a:cubicBezTo>
                <a:lnTo>
                  <a:pt x="0" y="0"/>
                </a:lnTo>
                <a:lnTo>
                  <a:pt x="48" y="0"/>
                </a:lnTo>
                <a:close/>
              </a:path>
            </a:pathLst>
          </a:custGeom>
          <a:solidFill>
            <a:srgbClr val="1B4171"/>
          </a:solidFill>
          <a:ln w="0" cap="flat">
            <a:solidFill>
              <a:srgbClr val="1B417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 sz="1100" b="1"/>
          </a:p>
        </p:txBody>
      </p:sp>
      <p:sp>
        <p:nvSpPr>
          <p:cNvPr id="103" name="Freeform 16"/>
          <p:cNvSpPr>
            <a:spLocks noEditPoints="1"/>
          </p:cNvSpPr>
          <p:nvPr/>
        </p:nvSpPr>
        <p:spPr bwMode="auto">
          <a:xfrm>
            <a:off x="3943233" y="1253522"/>
            <a:ext cx="1128816" cy="693964"/>
          </a:xfrm>
          <a:custGeom>
            <a:avLst/>
            <a:gdLst/>
            <a:ahLst/>
            <a:cxnLst>
              <a:cxn ang="0">
                <a:pos x="1" y="112"/>
              </a:cxn>
              <a:cxn ang="0">
                <a:pos x="12" y="67"/>
              </a:cxn>
              <a:cxn ang="0">
                <a:pos x="38" y="32"/>
              </a:cxn>
              <a:cxn ang="0">
                <a:pos x="76" y="8"/>
              </a:cxn>
              <a:cxn ang="0">
                <a:pos x="116" y="0"/>
              </a:cxn>
              <a:cxn ang="0">
                <a:pos x="1298" y="1"/>
              </a:cxn>
              <a:cxn ang="0">
                <a:pos x="1343" y="12"/>
              </a:cxn>
              <a:cxn ang="0">
                <a:pos x="1379" y="38"/>
              </a:cxn>
              <a:cxn ang="0">
                <a:pos x="1401" y="76"/>
              </a:cxn>
              <a:cxn ang="0">
                <a:pos x="1408" y="116"/>
              </a:cxn>
              <a:cxn ang="0">
                <a:pos x="1408" y="850"/>
              </a:cxn>
              <a:cxn ang="0">
                <a:pos x="1398" y="895"/>
              </a:cxn>
              <a:cxn ang="0">
                <a:pos x="1372" y="931"/>
              </a:cxn>
              <a:cxn ang="0">
                <a:pos x="1334" y="953"/>
              </a:cxn>
              <a:cxn ang="0">
                <a:pos x="1293" y="960"/>
              </a:cxn>
              <a:cxn ang="0">
                <a:pos x="112" y="960"/>
              </a:cxn>
              <a:cxn ang="0">
                <a:pos x="67" y="950"/>
              </a:cxn>
              <a:cxn ang="0">
                <a:pos x="32" y="924"/>
              </a:cxn>
              <a:cxn ang="0">
                <a:pos x="8" y="886"/>
              </a:cxn>
              <a:cxn ang="0">
                <a:pos x="0" y="845"/>
              </a:cxn>
              <a:cxn ang="0">
                <a:pos x="48" y="845"/>
              </a:cxn>
              <a:cxn ang="0">
                <a:pos x="55" y="877"/>
              </a:cxn>
              <a:cxn ang="0">
                <a:pos x="71" y="897"/>
              </a:cxn>
              <a:cxn ang="0">
                <a:pos x="94" y="909"/>
              </a:cxn>
              <a:cxn ang="0">
                <a:pos x="121" y="913"/>
              </a:cxn>
              <a:cxn ang="0">
                <a:pos x="1293" y="912"/>
              </a:cxn>
              <a:cxn ang="0">
                <a:pos x="1325" y="906"/>
              </a:cxn>
              <a:cxn ang="0">
                <a:pos x="1345" y="890"/>
              </a:cxn>
              <a:cxn ang="0">
                <a:pos x="1357" y="868"/>
              </a:cxn>
              <a:cxn ang="0">
                <a:pos x="1361" y="841"/>
              </a:cxn>
              <a:cxn ang="0">
                <a:pos x="1360" y="116"/>
              </a:cxn>
              <a:cxn ang="0">
                <a:pos x="1354" y="85"/>
              </a:cxn>
              <a:cxn ang="0">
                <a:pos x="1338" y="65"/>
              </a:cxn>
              <a:cxn ang="0">
                <a:pos x="1316" y="51"/>
              </a:cxn>
              <a:cxn ang="0">
                <a:pos x="1289" y="48"/>
              </a:cxn>
              <a:cxn ang="0">
                <a:pos x="116" y="48"/>
              </a:cxn>
              <a:cxn ang="0">
                <a:pos x="85" y="55"/>
              </a:cxn>
              <a:cxn ang="0">
                <a:pos x="65" y="71"/>
              </a:cxn>
              <a:cxn ang="0">
                <a:pos x="51" y="94"/>
              </a:cxn>
              <a:cxn ang="0">
                <a:pos x="48" y="121"/>
              </a:cxn>
              <a:cxn ang="0">
                <a:pos x="48" y="845"/>
              </a:cxn>
            </a:cxnLst>
            <a:rect l="0" t="0" r="r" b="b"/>
            <a:pathLst>
              <a:path w="1408" h="960">
                <a:moveTo>
                  <a:pt x="0" y="116"/>
                </a:moveTo>
                <a:cubicBezTo>
                  <a:pt x="0" y="115"/>
                  <a:pt x="1" y="113"/>
                  <a:pt x="1" y="112"/>
                </a:cubicBezTo>
                <a:lnTo>
                  <a:pt x="8" y="76"/>
                </a:lnTo>
                <a:cubicBezTo>
                  <a:pt x="9" y="73"/>
                  <a:pt x="10" y="70"/>
                  <a:pt x="12" y="67"/>
                </a:cubicBezTo>
                <a:lnTo>
                  <a:pt x="32" y="38"/>
                </a:lnTo>
                <a:cubicBezTo>
                  <a:pt x="33" y="35"/>
                  <a:pt x="35" y="33"/>
                  <a:pt x="38" y="32"/>
                </a:cubicBezTo>
                <a:lnTo>
                  <a:pt x="67" y="12"/>
                </a:lnTo>
                <a:cubicBezTo>
                  <a:pt x="70" y="10"/>
                  <a:pt x="73" y="9"/>
                  <a:pt x="76" y="8"/>
                </a:cubicBezTo>
                <a:lnTo>
                  <a:pt x="112" y="1"/>
                </a:lnTo>
                <a:cubicBezTo>
                  <a:pt x="113" y="1"/>
                  <a:pt x="115" y="0"/>
                  <a:pt x="116" y="0"/>
                </a:cubicBezTo>
                <a:lnTo>
                  <a:pt x="1293" y="0"/>
                </a:lnTo>
                <a:cubicBezTo>
                  <a:pt x="1295" y="0"/>
                  <a:pt x="1297" y="1"/>
                  <a:pt x="1298" y="1"/>
                </a:cubicBezTo>
                <a:lnTo>
                  <a:pt x="1334" y="8"/>
                </a:lnTo>
                <a:cubicBezTo>
                  <a:pt x="1337" y="9"/>
                  <a:pt x="1340" y="10"/>
                  <a:pt x="1343" y="12"/>
                </a:cubicBezTo>
                <a:lnTo>
                  <a:pt x="1372" y="32"/>
                </a:lnTo>
                <a:cubicBezTo>
                  <a:pt x="1375" y="33"/>
                  <a:pt x="1377" y="36"/>
                  <a:pt x="1379" y="38"/>
                </a:cubicBezTo>
                <a:lnTo>
                  <a:pt x="1398" y="67"/>
                </a:lnTo>
                <a:cubicBezTo>
                  <a:pt x="1399" y="70"/>
                  <a:pt x="1400" y="73"/>
                  <a:pt x="1401" y="76"/>
                </a:cubicBezTo>
                <a:lnTo>
                  <a:pt x="1408" y="112"/>
                </a:lnTo>
                <a:cubicBezTo>
                  <a:pt x="1408" y="113"/>
                  <a:pt x="1408" y="115"/>
                  <a:pt x="1408" y="116"/>
                </a:cubicBezTo>
                <a:lnTo>
                  <a:pt x="1408" y="845"/>
                </a:lnTo>
                <a:cubicBezTo>
                  <a:pt x="1408" y="847"/>
                  <a:pt x="1408" y="849"/>
                  <a:pt x="1408" y="850"/>
                </a:cubicBezTo>
                <a:lnTo>
                  <a:pt x="1401" y="886"/>
                </a:lnTo>
                <a:cubicBezTo>
                  <a:pt x="1400" y="889"/>
                  <a:pt x="1399" y="892"/>
                  <a:pt x="1398" y="895"/>
                </a:cubicBezTo>
                <a:lnTo>
                  <a:pt x="1379" y="924"/>
                </a:lnTo>
                <a:cubicBezTo>
                  <a:pt x="1377" y="926"/>
                  <a:pt x="1374" y="929"/>
                  <a:pt x="1372" y="931"/>
                </a:cubicBezTo>
                <a:lnTo>
                  <a:pt x="1343" y="950"/>
                </a:lnTo>
                <a:cubicBezTo>
                  <a:pt x="1340" y="951"/>
                  <a:pt x="1337" y="952"/>
                  <a:pt x="1334" y="953"/>
                </a:cubicBezTo>
                <a:lnTo>
                  <a:pt x="1298" y="960"/>
                </a:lnTo>
                <a:cubicBezTo>
                  <a:pt x="1297" y="960"/>
                  <a:pt x="1295" y="960"/>
                  <a:pt x="1293" y="960"/>
                </a:cubicBezTo>
                <a:lnTo>
                  <a:pt x="116" y="960"/>
                </a:lnTo>
                <a:cubicBezTo>
                  <a:pt x="115" y="960"/>
                  <a:pt x="113" y="960"/>
                  <a:pt x="112" y="960"/>
                </a:cubicBezTo>
                <a:lnTo>
                  <a:pt x="76" y="953"/>
                </a:lnTo>
                <a:cubicBezTo>
                  <a:pt x="73" y="952"/>
                  <a:pt x="70" y="951"/>
                  <a:pt x="67" y="950"/>
                </a:cubicBezTo>
                <a:lnTo>
                  <a:pt x="38" y="931"/>
                </a:lnTo>
                <a:cubicBezTo>
                  <a:pt x="36" y="929"/>
                  <a:pt x="33" y="927"/>
                  <a:pt x="32" y="924"/>
                </a:cubicBezTo>
                <a:lnTo>
                  <a:pt x="12" y="895"/>
                </a:lnTo>
                <a:cubicBezTo>
                  <a:pt x="10" y="892"/>
                  <a:pt x="9" y="889"/>
                  <a:pt x="8" y="886"/>
                </a:cubicBezTo>
                <a:lnTo>
                  <a:pt x="1" y="850"/>
                </a:lnTo>
                <a:cubicBezTo>
                  <a:pt x="1" y="849"/>
                  <a:pt x="0" y="847"/>
                  <a:pt x="0" y="845"/>
                </a:cubicBezTo>
                <a:lnTo>
                  <a:pt x="0" y="116"/>
                </a:lnTo>
                <a:close/>
                <a:moveTo>
                  <a:pt x="48" y="845"/>
                </a:moveTo>
                <a:lnTo>
                  <a:pt x="48" y="841"/>
                </a:lnTo>
                <a:lnTo>
                  <a:pt x="55" y="877"/>
                </a:lnTo>
                <a:lnTo>
                  <a:pt x="51" y="868"/>
                </a:lnTo>
                <a:lnTo>
                  <a:pt x="71" y="897"/>
                </a:lnTo>
                <a:lnTo>
                  <a:pt x="65" y="890"/>
                </a:lnTo>
                <a:lnTo>
                  <a:pt x="94" y="909"/>
                </a:lnTo>
                <a:lnTo>
                  <a:pt x="85" y="906"/>
                </a:lnTo>
                <a:lnTo>
                  <a:pt x="121" y="913"/>
                </a:lnTo>
                <a:lnTo>
                  <a:pt x="116" y="912"/>
                </a:lnTo>
                <a:lnTo>
                  <a:pt x="1293" y="912"/>
                </a:lnTo>
                <a:lnTo>
                  <a:pt x="1289" y="913"/>
                </a:lnTo>
                <a:lnTo>
                  <a:pt x="1325" y="906"/>
                </a:lnTo>
                <a:lnTo>
                  <a:pt x="1316" y="909"/>
                </a:lnTo>
                <a:lnTo>
                  <a:pt x="1345" y="890"/>
                </a:lnTo>
                <a:lnTo>
                  <a:pt x="1338" y="897"/>
                </a:lnTo>
                <a:lnTo>
                  <a:pt x="1357" y="868"/>
                </a:lnTo>
                <a:lnTo>
                  <a:pt x="1354" y="877"/>
                </a:lnTo>
                <a:lnTo>
                  <a:pt x="1361" y="841"/>
                </a:lnTo>
                <a:lnTo>
                  <a:pt x="1360" y="845"/>
                </a:lnTo>
                <a:lnTo>
                  <a:pt x="1360" y="116"/>
                </a:lnTo>
                <a:lnTo>
                  <a:pt x="1361" y="121"/>
                </a:lnTo>
                <a:lnTo>
                  <a:pt x="1354" y="85"/>
                </a:lnTo>
                <a:lnTo>
                  <a:pt x="1357" y="94"/>
                </a:lnTo>
                <a:lnTo>
                  <a:pt x="1338" y="65"/>
                </a:lnTo>
                <a:lnTo>
                  <a:pt x="1345" y="71"/>
                </a:lnTo>
                <a:lnTo>
                  <a:pt x="1316" y="51"/>
                </a:lnTo>
                <a:lnTo>
                  <a:pt x="1325" y="55"/>
                </a:lnTo>
                <a:lnTo>
                  <a:pt x="1289" y="48"/>
                </a:lnTo>
                <a:lnTo>
                  <a:pt x="1293" y="48"/>
                </a:lnTo>
                <a:lnTo>
                  <a:pt x="116" y="48"/>
                </a:lnTo>
                <a:lnTo>
                  <a:pt x="121" y="48"/>
                </a:lnTo>
                <a:lnTo>
                  <a:pt x="85" y="55"/>
                </a:lnTo>
                <a:lnTo>
                  <a:pt x="94" y="51"/>
                </a:lnTo>
                <a:lnTo>
                  <a:pt x="65" y="71"/>
                </a:lnTo>
                <a:lnTo>
                  <a:pt x="71" y="65"/>
                </a:lnTo>
                <a:lnTo>
                  <a:pt x="51" y="94"/>
                </a:lnTo>
                <a:lnTo>
                  <a:pt x="55" y="85"/>
                </a:lnTo>
                <a:lnTo>
                  <a:pt x="48" y="121"/>
                </a:lnTo>
                <a:lnTo>
                  <a:pt x="48" y="116"/>
                </a:lnTo>
                <a:lnTo>
                  <a:pt x="48" y="845"/>
                </a:lnTo>
                <a:close/>
              </a:path>
            </a:pathLst>
          </a:custGeom>
          <a:solidFill>
            <a:srgbClr val="1B4171"/>
          </a:solidFill>
          <a:ln w="0" cap="flat">
            <a:solidFill>
              <a:srgbClr val="1B417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 sz="1100" b="1"/>
          </a:p>
        </p:txBody>
      </p:sp>
      <p:sp>
        <p:nvSpPr>
          <p:cNvPr id="104" name="103 CuadroTexto"/>
          <p:cNvSpPr txBox="1"/>
          <p:nvPr/>
        </p:nvSpPr>
        <p:spPr>
          <a:xfrm>
            <a:off x="4256778" y="1629344"/>
            <a:ext cx="73864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dirty="0" smtClean="0"/>
              <a:t>N=308</a:t>
            </a:r>
            <a:endParaRPr lang="es-ES" sz="1100" dirty="0"/>
          </a:p>
        </p:txBody>
      </p:sp>
      <p:sp>
        <p:nvSpPr>
          <p:cNvPr id="105" name="104 CuadroTexto"/>
          <p:cNvSpPr txBox="1"/>
          <p:nvPr/>
        </p:nvSpPr>
        <p:spPr>
          <a:xfrm>
            <a:off x="2504020" y="2852936"/>
            <a:ext cx="73122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100" dirty="0" smtClean="0"/>
              <a:t>N=136</a:t>
            </a:r>
            <a:endParaRPr lang="es-ES" sz="1100" dirty="0"/>
          </a:p>
        </p:txBody>
      </p:sp>
      <p:sp>
        <p:nvSpPr>
          <p:cNvPr id="107" name="106 CuadroTexto"/>
          <p:cNvSpPr txBox="1"/>
          <p:nvPr/>
        </p:nvSpPr>
        <p:spPr>
          <a:xfrm>
            <a:off x="5796136" y="2852936"/>
            <a:ext cx="74196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100" dirty="0" smtClean="0"/>
              <a:t>N=172</a:t>
            </a:r>
            <a:endParaRPr lang="es-ES" sz="1100" dirty="0"/>
          </a:p>
        </p:txBody>
      </p:sp>
      <p:sp>
        <p:nvSpPr>
          <p:cNvPr id="127" name="Rechthoek 126"/>
          <p:cNvSpPr/>
          <p:nvPr/>
        </p:nvSpPr>
        <p:spPr>
          <a:xfrm>
            <a:off x="4072100" y="1283805"/>
            <a:ext cx="857927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s-ES" sz="1200" b="1" dirty="0" err="1" smtClean="0"/>
              <a:t>Testing</a:t>
            </a:r>
            <a:r>
              <a:rPr lang="es-ES" sz="1200" b="1" dirty="0" smtClean="0"/>
              <a:t> set</a:t>
            </a:r>
          </a:p>
          <a:p>
            <a:pPr algn="ctr"/>
            <a:r>
              <a:rPr lang="es-ES" sz="1200" b="1" dirty="0" smtClean="0"/>
              <a:t>PFBC</a:t>
            </a:r>
          </a:p>
          <a:p>
            <a:pPr algn="ctr"/>
            <a:endParaRPr lang="es-ES" sz="1200" b="1" dirty="0" smtClean="0"/>
          </a:p>
        </p:txBody>
      </p:sp>
      <p:sp>
        <p:nvSpPr>
          <p:cNvPr id="60" name="Freeform 22"/>
          <p:cNvSpPr>
            <a:spLocks noEditPoints="1"/>
          </p:cNvSpPr>
          <p:nvPr/>
        </p:nvSpPr>
        <p:spPr bwMode="auto">
          <a:xfrm>
            <a:off x="1543543" y="3711889"/>
            <a:ext cx="955343" cy="693964"/>
          </a:xfrm>
          <a:custGeom>
            <a:avLst/>
            <a:gdLst/>
            <a:ahLst/>
            <a:cxnLst>
              <a:cxn ang="0">
                <a:pos x="1" y="112"/>
              </a:cxn>
              <a:cxn ang="0">
                <a:pos x="12" y="67"/>
              </a:cxn>
              <a:cxn ang="0">
                <a:pos x="38" y="32"/>
              </a:cxn>
              <a:cxn ang="0">
                <a:pos x="76" y="8"/>
              </a:cxn>
              <a:cxn ang="0">
                <a:pos x="116" y="0"/>
              </a:cxn>
              <a:cxn ang="0">
                <a:pos x="1298" y="1"/>
              </a:cxn>
              <a:cxn ang="0">
                <a:pos x="1343" y="12"/>
              </a:cxn>
              <a:cxn ang="0">
                <a:pos x="1379" y="38"/>
              </a:cxn>
              <a:cxn ang="0">
                <a:pos x="1401" y="76"/>
              </a:cxn>
              <a:cxn ang="0">
                <a:pos x="1408" y="116"/>
              </a:cxn>
              <a:cxn ang="0">
                <a:pos x="1408" y="850"/>
              </a:cxn>
              <a:cxn ang="0">
                <a:pos x="1398" y="895"/>
              </a:cxn>
              <a:cxn ang="0">
                <a:pos x="1372" y="931"/>
              </a:cxn>
              <a:cxn ang="0">
                <a:pos x="1334" y="953"/>
              </a:cxn>
              <a:cxn ang="0">
                <a:pos x="1293" y="960"/>
              </a:cxn>
              <a:cxn ang="0">
                <a:pos x="112" y="960"/>
              </a:cxn>
              <a:cxn ang="0">
                <a:pos x="67" y="950"/>
              </a:cxn>
              <a:cxn ang="0">
                <a:pos x="32" y="924"/>
              </a:cxn>
              <a:cxn ang="0">
                <a:pos x="8" y="886"/>
              </a:cxn>
              <a:cxn ang="0">
                <a:pos x="0" y="845"/>
              </a:cxn>
              <a:cxn ang="0">
                <a:pos x="48" y="845"/>
              </a:cxn>
              <a:cxn ang="0">
                <a:pos x="55" y="877"/>
              </a:cxn>
              <a:cxn ang="0">
                <a:pos x="71" y="897"/>
              </a:cxn>
              <a:cxn ang="0">
                <a:pos x="94" y="909"/>
              </a:cxn>
              <a:cxn ang="0">
                <a:pos x="121" y="913"/>
              </a:cxn>
              <a:cxn ang="0">
                <a:pos x="1293" y="912"/>
              </a:cxn>
              <a:cxn ang="0">
                <a:pos x="1325" y="906"/>
              </a:cxn>
              <a:cxn ang="0">
                <a:pos x="1345" y="890"/>
              </a:cxn>
              <a:cxn ang="0">
                <a:pos x="1357" y="868"/>
              </a:cxn>
              <a:cxn ang="0">
                <a:pos x="1361" y="841"/>
              </a:cxn>
              <a:cxn ang="0">
                <a:pos x="1360" y="116"/>
              </a:cxn>
              <a:cxn ang="0">
                <a:pos x="1354" y="85"/>
              </a:cxn>
              <a:cxn ang="0">
                <a:pos x="1338" y="65"/>
              </a:cxn>
              <a:cxn ang="0">
                <a:pos x="1316" y="51"/>
              </a:cxn>
              <a:cxn ang="0">
                <a:pos x="1289" y="48"/>
              </a:cxn>
              <a:cxn ang="0">
                <a:pos x="116" y="48"/>
              </a:cxn>
              <a:cxn ang="0">
                <a:pos x="85" y="55"/>
              </a:cxn>
              <a:cxn ang="0">
                <a:pos x="65" y="71"/>
              </a:cxn>
              <a:cxn ang="0">
                <a:pos x="51" y="94"/>
              </a:cxn>
              <a:cxn ang="0">
                <a:pos x="48" y="121"/>
              </a:cxn>
              <a:cxn ang="0">
                <a:pos x="48" y="845"/>
              </a:cxn>
            </a:cxnLst>
            <a:rect l="0" t="0" r="r" b="b"/>
            <a:pathLst>
              <a:path w="1408" h="960">
                <a:moveTo>
                  <a:pt x="0" y="116"/>
                </a:moveTo>
                <a:cubicBezTo>
                  <a:pt x="0" y="115"/>
                  <a:pt x="1" y="113"/>
                  <a:pt x="1" y="112"/>
                </a:cubicBezTo>
                <a:lnTo>
                  <a:pt x="8" y="76"/>
                </a:lnTo>
                <a:cubicBezTo>
                  <a:pt x="9" y="73"/>
                  <a:pt x="10" y="70"/>
                  <a:pt x="12" y="67"/>
                </a:cubicBezTo>
                <a:lnTo>
                  <a:pt x="32" y="38"/>
                </a:lnTo>
                <a:cubicBezTo>
                  <a:pt x="33" y="35"/>
                  <a:pt x="35" y="33"/>
                  <a:pt x="38" y="32"/>
                </a:cubicBezTo>
                <a:lnTo>
                  <a:pt x="67" y="12"/>
                </a:lnTo>
                <a:cubicBezTo>
                  <a:pt x="70" y="10"/>
                  <a:pt x="73" y="9"/>
                  <a:pt x="76" y="8"/>
                </a:cubicBezTo>
                <a:lnTo>
                  <a:pt x="112" y="1"/>
                </a:lnTo>
                <a:cubicBezTo>
                  <a:pt x="113" y="1"/>
                  <a:pt x="115" y="0"/>
                  <a:pt x="116" y="0"/>
                </a:cubicBezTo>
                <a:lnTo>
                  <a:pt x="1293" y="0"/>
                </a:lnTo>
                <a:cubicBezTo>
                  <a:pt x="1295" y="0"/>
                  <a:pt x="1297" y="1"/>
                  <a:pt x="1298" y="1"/>
                </a:cubicBezTo>
                <a:lnTo>
                  <a:pt x="1334" y="8"/>
                </a:lnTo>
                <a:cubicBezTo>
                  <a:pt x="1337" y="9"/>
                  <a:pt x="1340" y="10"/>
                  <a:pt x="1343" y="12"/>
                </a:cubicBezTo>
                <a:lnTo>
                  <a:pt x="1372" y="32"/>
                </a:lnTo>
                <a:cubicBezTo>
                  <a:pt x="1375" y="33"/>
                  <a:pt x="1377" y="36"/>
                  <a:pt x="1379" y="38"/>
                </a:cubicBezTo>
                <a:lnTo>
                  <a:pt x="1398" y="67"/>
                </a:lnTo>
                <a:cubicBezTo>
                  <a:pt x="1399" y="70"/>
                  <a:pt x="1400" y="73"/>
                  <a:pt x="1401" y="76"/>
                </a:cubicBezTo>
                <a:lnTo>
                  <a:pt x="1408" y="112"/>
                </a:lnTo>
                <a:cubicBezTo>
                  <a:pt x="1408" y="113"/>
                  <a:pt x="1408" y="115"/>
                  <a:pt x="1408" y="116"/>
                </a:cubicBezTo>
                <a:lnTo>
                  <a:pt x="1408" y="845"/>
                </a:lnTo>
                <a:cubicBezTo>
                  <a:pt x="1408" y="847"/>
                  <a:pt x="1408" y="849"/>
                  <a:pt x="1408" y="850"/>
                </a:cubicBezTo>
                <a:lnTo>
                  <a:pt x="1401" y="886"/>
                </a:lnTo>
                <a:cubicBezTo>
                  <a:pt x="1400" y="889"/>
                  <a:pt x="1399" y="892"/>
                  <a:pt x="1398" y="895"/>
                </a:cubicBezTo>
                <a:lnTo>
                  <a:pt x="1379" y="924"/>
                </a:lnTo>
                <a:cubicBezTo>
                  <a:pt x="1377" y="926"/>
                  <a:pt x="1374" y="929"/>
                  <a:pt x="1372" y="931"/>
                </a:cubicBezTo>
                <a:lnTo>
                  <a:pt x="1343" y="950"/>
                </a:lnTo>
                <a:cubicBezTo>
                  <a:pt x="1340" y="951"/>
                  <a:pt x="1337" y="952"/>
                  <a:pt x="1334" y="953"/>
                </a:cubicBezTo>
                <a:lnTo>
                  <a:pt x="1298" y="960"/>
                </a:lnTo>
                <a:cubicBezTo>
                  <a:pt x="1297" y="960"/>
                  <a:pt x="1295" y="960"/>
                  <a:pt x="1293" y="960"/>
                </a:cubicBezTo>
                <a:lnTo>
                  <a:pt x="116" y="960"/>
                </a:lnTo>
                <a:cubicBezTo>
                  <a:pt x="115" y="960"/>
                  <a:pt x="113" y="960"/>
                  <a:pt x="112" y="960"/>
                </a:cubicBezTo>
                <a:lnTo>
                  <a:pt x="76" y="953"/>
                </a:lnTo>
                <a:cubicBezTo>
                  <a:pt x="73" y="952"/>
                  <a:pt x="70" y="951"/>
                  <a:pt x="67" y="950"/>
                </a:cubicBezTo>
                <a:lnTo>
                  <a:pt x="38" y="931"/>
                </a:lnTo>
                <a:cubicBezTo>
                  <a:pt x="36" y="929"/>
                  <a:pt x="33" y="927"/>
                  <a:pt x="32" y="924"/>
                </a:cubicBezTo>
                <a:lnTo>
                  <a:pt x="12" y="895"/>
                </a:lnTo>
                <a:cubicBezTo>
                  <a:pt x="10" y="892"/>
                  <a:pt x="9" y="889"/>
                  <a:pt x="8" y="886"/>
                </a:cubicBezTo>
                <a:lnTo>
                  <a:pt x="1" y="850"/>
                </a:lnTo>
                <a:cubicBezTo>
                  <a:pt x="1" y="849"/>
                  <a:pt x="0" y="847"/>
                  <a:pt x="0" y="845"/>
                </a:cubicBezTo>
                <a:lnTo>
                  <a:pt x="0" y="116"/>
                </a:lnTo>
                <a:close/>
                <a:moveTo>
                  <a:pt x="48" y="845"/>
                </a:moveTo>
                <a:lnTo>
                  <a:pt x="48" y="841"/>
                </a:lnTo>
                <a:lnTo>
                  <a:pt x="55" y="877"/>
                </a:lnTo>
                <a:lnTo>
                  <a:pt x="51" y="868"/>
                </a:lnTo>
                <a:lnTo>
                  <a:pt x="71" y="897"/>
                </a:lnTo>
                <a:lnTo>
                  <a:pt x="65" y="890"/>
                </a:lnTo>
                <a:lnTo>
                  <a:pt x="94" y="909"/>
                </a:lnTo>
                <a:lnTo>
                  <a:pt x="85" y="906"/>
                </a:lnTo>
                <a:lnTo>
                  <a:pt x="121" y="913"/>
                </a:lnTo>
                <a:lnTo>
                  <a:pt x="116" y="912"/>
                </a:lnTo>
                <a:lnTo>
                  <a:pt x="1293" y="912"/>
                </a:lnTo>
                <a:lnTo>
                  <a:pt x="1289" y="913"/>
                </a:lnTo>
                <a:lnTo>
                  <a:pt x="1325" y="906"/>
                </a:lnTo>
                <a:lnTo>
                  <a:pt x="1316" y="909"/>
                </a:lnTo>
                <a:lnTo>
                  <a:pt x="1345" y="890"/>
                </a:lnTo>
                <a:lnTo>
                  <a:pt x="1338" y="897"/>
                </a:lnTo>
                <a:lnTo>
                  <a:pt x="1357" y="868"/>
                </a:lnTo>
                <a:lnTo>
                  <a:pt x="1354" y="877"/>
                </a:lnTo>
                <a:lnTo>
                  <a:pt x="1361" y="841"/>
                </a:lnTo>
                <a:lnTo>
                  <a:pt x="1360" y="845"/>
                </a:lnTo>
                <a:lnTo>
                  <a:pt x="1360" y="116"/>
                </a:lnTo>
                <a:lnTo>
                  <a:pt x="1361" y="121"/>
                </a:lnTo>
                <a:lnTo>
                  <a:pt x="1354" y="85"/>
                </a:lnTo>
                <a:lnTo>
                  <a:pt x="1357" y="94"/>
                </a:lnTo>
                <a:lnTo>
                  <a:pt x="1338" y="65"/>
                </a:lnTo>
                <a:lnTo>
                  <a:pt x="1345" y="71"/>
                </a:lnTo>
                <a:lnTo>
                  <a:pt x="1316" y="51"/>
                </a:lnTo>
                <a:lnTo>
                  <a:pt x="1325" y="55"/>
                </a:lnTo>
                <a:lnTo>
                  <a:pt x="1289" y="48"/>
                </a:lnTo>
                <a:lnTo>
                  <a:pt x="1293" y="48"/>
                </a:lnTo>
                <a:lnTo>
                  <a:pt x="116" y="48"/>
                </a:lnTo>
                <a:lnTo>
                  <a:pt x="121" y="48"/>
                </a:lnTo>
                <a:lnTo>
                  <a:pt x="85" y="55"/>
                </a:lnTo>
                <a:lnTo>
                  <a:pt x="94" y="51"/>
                </a:lnTo>
                <a:lnTo>
                  <a:pt x="65" y="71"/>
                </a:lnTo>
                <a:lnTo>
                  <a:pt x="71" y="65"/>
                </a:lnTo>
                <a:lnTo>
                  <a:pt x="51" y="94"/>
                </a:lnTo>
                <a:lnTo>
                  <a:pt x="55" y="85"/>
                </a:lnTo>
                <a:lnTo>
                  <a:pt x="48" y="121"/>
                </a:lnTo>
                <a:lnTo>
                  <a:pt x="48" y="116"/>
                </a:lnTo>
                <a:lnTo>
                  <a:pt x="48" y="845"/>
                </a:lnTo>
                <a:close/>
              </a:path>
            </a:pathLst>
          </a:custGeom>
          <a:solidFill>
            <a:srgbClr val="1B4171"/>
          </a:solidFill>
          <a:ln w="0" cap="flat">
            <a:solidFill>
              <a:srgbClr val="1B417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 sz="1100" b="1"/>
          </a:p>
        </p:txBody>
      </p:sp>
      <p:sp>
        <p:nvSpPr>
          <p:cNvPr id="61" name="Freeform 22"/>
          <p:cNvSpPr>
            <a:spLocks noEditPoints="1"/>
          </p:cNvSpPr>
          <p:nvPr/>
        </p:nvSpPr>
        <p:spPr bwMode="auto">
          <a:xfrm>
            <a:off x="3210487" y="3711889"/>
            <a:ext cx="955343" cy="693964"/>
          </a:xfrm>
          <a:custGeom>
            <a:avLst/>
            <a:gdLst/>
            <a:ahLst/>
            <a:cxnLst>
              <a:cxn ang="0">
                <a:pos x="1" y="112"/>
              </a:cxn>
              <a:cxn ang="0">
                <a:pos x="12" y="67"/>
              </a:cxn>
              <a:cxn ang="0">
                <a:pos x="38" y="32"/>
              </a:cxn>
              <a:cxn ang="0">
                <a:pos x="76" y="8"/>
              </a:cxn>
              <a:cxn ang="0">
                <a:pos x="116" y="0"/>
              </a:cxn>
              <a:cxn ang="0">
                <a:pos x="1298" y="1"/>
              </a:cxn>
              <a:cxn ang="0">
                <a:pos x="1343" y="12"/>
              </a:cxn>
              <a:cxn ang="0">
                <a:pos x="1379" y="38"/>
              </a:cxn>
              <a:cxn ang="0">
                <a:pos x="1401" y="76"/>
              </a:cxn>
              <a:cxn ang="0">
                <a:pos x="1408" y="116"/>
              </a:cxn>
              <a:cxn ang="0">
                <a:pos x="1408" y="850"/>
              </a:cxn>
              <a:cxn ang="0">
                <a:pos x="1398" y="895"/>
              </a:cxn>
              <a:cxn ang="0">
                <a:pos x="1372" y="931"/>
              </a:cxn>
              <a:cxn ang="0">
                <a:pos x="1334" y="953"/>
              </a:cxn>
              <a:cxn ang="0">
                <a:pos x="1293" y="960"/>
              </a:cxn>
              <a:cxn ang="0">
                <a:pos x="112" y="960"/>
              </a:cxn>
              <a:cxn ang="0">
                <a:pos x="67" y="950"/>
              </a:cxn>
              <a:cxn ang="0">
                <a:pos x="32" y="924"/>
              </a:cxn>
              <a:cxn ang="0">
                <a:pos x="8" y="886"/>
              </a:cxn>
              <a:cxn ang="0">
                <a:pos x="0" y="845"/>
              </a:cxn>
              <a:cxn ang="0">
                <a:pos x="48" y="845"/>
              </a:cxn>
              <a:cxn ang="0">
                <a:pos x="55" y="877"/>
              </a:cxn>
              <a:cxn ang="0">
                <a:pos x="71" y="897"/>
              </a:cxn>
              <a:cxn ang="0">
                <a:pos x="94" y="909"/>
              </a:cxn>
              <a:cxn ang="0">
                <a:pos x="121" y="913"/>
              </a:cxn>
              <a:cxn ang="0">
                <a:pos x="1293" y="912"/>
              </a:cxn>
              <a:cxn ang="0">
                <a:pos x="1325" y="906"/>
              </a:cxn>
              <a:cxn ang="0">
                <a:pos x="1345" y="890"/>
              </a:cxn>
              <a:cxn ang="0">
                <a:pos x="1357" y="868"/>
              </a:cxn>
              <a:cxn ang="0">
                <a:pos x="1361" y="841"/>
              </a:cxn>
              <a:cxn ang="0">
                <a:pos x="1360" y="116"/>
              </a:cxn>
              <a:cxn ang="0">
                <a:pos x="1354" y="85"/>
              </a:cxn>
              <a:cxn ang="0">
                <a:pos x="1338" y="65"/>
              </a:cxn>
              <a:cxn ang="0">
                <a:pos x="1316" y="51"/>
              </a:cxn>
              <a:cxn ang="0">
                <a:pos x="1289" y="48"/>
              </a:cxn>
              <a:cxn ang="0">
                <a:pos x="116" y="48"/>
              </a:cxn>
              <a:cxn ang="0">
                <a:pos x="85" y="55"/>
              </a:cxn>
              <a:cxn ang="0">
                <a:pos x="65" y="71"/>
              </a:cxn>
              <a:cxn ang="0">
                <a:pos x="51" y="94"/>
              </a:cxn>
              <a:cxn ang="0">
                <a:pos x="48" y="121"/>
              </a:cxn>
              <a:cxn ang="0">
                <a:pos x="48" y="845"/>
              </a:cxn>
            </a:cxnLst>
            <a:rect l="0" t="0" r="r" b="b"/>
            <a:pathLst>
              <a:path w="1408" h="960">
                <a:moveTo>
                  <a:pt x="0" y="116"/>
                </a:moveTo>
                <a:cubicBezTo>
                  <a:pt x="0" y="115"/>
                  <a:pt x="1" y="113"/>
                  <a:pt x="1" y="112"/>
                </a:cubicBezTo>
                <a:lnTo>
                  <a:pt x="8" y="76"/>
                </a:lnTo>
                <a:cubicBezTo>
                  <a:pt x="9" y="73"/>
                  <a:pt x="10" y="70"/>
                  <a:pt x="12" y="67"/>
                </a:cubicBezTo>
                <a:lnTo>
                  <a:pt x="32" y="38"/>
                </a:lnTo>
                <a:cubicBezTo>
                  <a:pt x="33" y="35"/>
                  <a:pt x="35" y="33"/>
                  <a:pt x="38" y="32"/>
                </a:cubicBezTo>
                <a:lnTo>
                  <a:pt x="67" y="12"/>
                </a:lnTo>
                <a:cubicBezTo>
                  <a:pt x="70" y="10"/>
                  <a:pt x="73" y="9"/>
                  <a:pt x="76" y="8"/>
                </a:cubicBezTo>
                <a:lnTo>
                  <a:pt x="112" y="1"/>
                </a:lnTo>
                <a:cubicBezTo>
                  <a:pt x="113" y="1"/>
                  <a:pt x="115" y="0"/>
                  <a:pt x="116" y="0"/>
                </a:cubicBezTo>
                <a:lnTo>
                  <a:pt x="1293" y="0"/>
                </a:lnTo>
                <a:cubicBezTo>
                  <a:pt x="1295" y="0"/>
                  <a:pt x="1297" y="1"/>
                  <a:pt x="1298" y="1"/>
                </a:cubicBezTo>
                <a:lnTo>
                  <a:pt x="1334" y="8"/>
                </a:lnTo>
                <a:cubicBezTo>
                  <a:pt x="1337" y="9"/>
                  <a:pt x="1340" y="10"/>
                  <a:pt x="1343" y="12"/>
                </a:cubicBezTo>
                <a:lnTo>
                  <a:pt x="1372" y="32"/>
                </a:lnTo>
                <a:cubicBezTo>
                  <a:pt x="1375" y="33"/>
                  <a:pt x="1377" y="36"/>
                  <a:pt x="1379" y="38"/>
                </a:cubicBezTo>
                <a:lnTo>
                  <a:pt x="1398" y="67"/>
                </a:lnTo>
                <a:cubicBezTo>
                  <a:pt x="1399" y="70"/>
                  <a:pt x="1400" y="73"/>
                  <a:pt x="1401" y="76"/>
                </a:cubicBezTo>
                <a:lnTo>
                  <a:pt x="1408" y="112"/>
                </a:lnTo>
                <a:cubicBezTo>
                  <a:pt x="1408" y="113"/>
                  <a:pt x="1408" y="115"/>
                  <a:pt x="1408" y="116"/>
                </a:cubicBezTo>
                <a:lnTo>
                  <a:pt x="1408" y="845"/>
                </a:lnTo>
                <a:cubicBezTo>
                  <a:pt x="1408" y="847"/>
                  <a:pt x="1408" y="849"/>
                  <a:pt x="1408" y="850"/>
                </a:cubicBezTo>
                <a:lnTo>
                  <a:pt x="1401" y="886"/>
                </a:lnTo>
                <a:cubicBezTo>
                  <a:pt x="1400" y="889"/>
                  <a:pt x="1399" y="892"/>
                  <a:pt x="1398" y="895"/>
                </a:cubicBezTo>
                <a:lnTo>
                  <a:pt x="1379" y="924"/>
                </a:lnTo>
                <a:cubicBezTo>
                  <a:pt x="1377" y="926"/>
                  <a:pt x="1374" y="929"/>
                  <a:pt x="1372" y="931"/>
                </a:cubicBezTo>
                <a:lnTo>
                  <a:pt x="1343" y="950"/>
                </a:lnTo>
                <a:cubicBezTo>
                  <a:pt x="1340" y="951"/>
                  <a:pt x="1337" y="952"/>
                  <a:pt x="1334" y="953"/>
                </a:cubicBezTo>
                <a:lnTo>
                  <a:pt x="1298" y="960"/>
                </a:lnTo>
                <a:cubicBezTo>
                  <a:pt x="1297" y="960"/>
                  <a:pt x="1295" y="960"/>
                  <a:pt x="1293" y="960"/>
                </a:cubicBezTo>
                <a:lnTo>
                  <a:pt x="116" y="960"/>
                </a:lnTo>
                <a:cubicBezTo>
                  <a:pt x="115" y="960"/>
                  <a:pt x="113" y="960"/>
                  <a:pt x="112" y="960"/>
                </a:cubicBezTo>
                <a:lnTo>
                  <a:pt x="76" y="953"/>
                </a:lnTo>
                <a:cubicBezTo>
                  <a:pt x="73" y="952"/>
                  <a:pt x="70" y="951"/>
                  <a:pt x="67" y="950"/>
                </a:cubicBezTo>
                <a:lnTo>
                  <a:pt x="38" y="931"/>
                </a:lnTo>
                <a:cubicBezTo>
                  <a:pt x="36" y="929"/>
                  <a:pt x="33" y="927"/>
                  <a:pt x="32" y="924"/>
                </a:cubicBezTo>
                <a:lnTo>
                  <a:pt x="12" y="895"/>
                </a:lnTo>
                <a:cubicBezTo>
                  <a:pt x="10" y="892"/>
                  <a:pt x="9" y="889"/>
                  <a:pt x="8" y="886"/>
                </a:cubicBezTo>
                <a:lnTo>
                  <a:pt x="1" y="850"/>
                </a:lnTo>
                <a:cubicBezTo>
                  <a:pt x="1" y="849"/>
                  <a:pt x="0" y="847"/>
                  <a:pt x="0" y="845"/>
                </a:cubicBezTo>
                <a:lnTo>
                  <a:pt x="0" y="116"/>
                </a:lnTo>
                <a:close/>
                <a:moveTo>
                  <a:pt x="48" y="845"/>
                </a:moveTo>
                <a:lnTo>
                  <a:pt x="48" y="841"/>
                </a:lnTo>
                <a:lnTo>
                  <a:pt x="55" y="877"/>
                </a:lnTo>
                <a:lnTo>
                  <a:pt x="51" y="868"/>
                </a:lnTo>
                <a:lnTo>
                  <a:pt x="71" y="897"/>
                </a:lnTo>
                <a:lnTo>
                  <a:pt x="65" y="890"/>
                </a:lnTo>
                <a:lnTo>
                  <a:pt x="94" y="909"/>
                </a:lnTo>
                <a:lnTo>
                  <a:pt x="85" y="906"/>
                </a:lnTo>
                <a:lnTo>
                  <a:pt x="121" y="913"/>
                </a:lnTo>
                <a:lnTo>
                  <a:pt x="116" y="912"/>
                </a:lnTo>
                <a:lnTo>
                  <a:pt x="1293" y="912"/>
                </a:lnTo>
                <a:lnTo>
                  <a:pt x="1289" y="913"/>
                </a:lnTo>
                <a:lnTo>
                  <a:pt x="1325" y="906"/>
                </a:lnTo>
                <a:lnTo>
                  <a:pt x="1316" y="909"/>
                </a:lnTo>
                <a:lnTo>
                  <a:pt x="1345" y="890"/>
                </a:lnTo>
                <a:lnTo>
                  <a:pt x="1338" y="897"/>
                </a:lnTo>
                <a:lnTo>
                  <a:pt x="1357" y="868"/>
                </a:lnTo>
                <a:lnTo>
                  <a:pt x="1354" y="877"/>
                </a:lnTo>
                <a:lnTo>
                  <a:pt x="1361" y="841"/>
                </a:lnTo>
                <a:lnTo>
                  <a:pt x="1360" y="845"/>
                </a:lnTo>
                <a:lnTo>
                  <a:pt x="1360" y="116"/>
                </a:lnTo>
                <a:lnTo>
                  <a:pt x="1361" y="121"/>
                </a:lnTo>
                <a:lnTo>
                  <a:pt x="1354" y="85"/>
                </a:lnTo>
                <a:lnTo>
                  <a:pt x="1357" y="94"/>
                </a:lnTo>
                <a:lnTo>
                  <a:pt x="1338" y="65"/>
                </a:lnTo>
                <a:lnTo>
                  <a:pt x="1345" y="71"/>
                </a:lnTo>
                <a:lnTo>
                  <a:pt x="1316" y="51"/>
                </a:lnTo>
                <a:lnTo>
                  <a:pt x="1325" y="55"/>
                </a:lnTo>
                <a:lnTo>
                  <a:pt x="1289" y="48"/>
                </a:lnTo>
                <a:lnTo>
                  <a:pt x="1293" y="48"/>
                </a:lnTo>
                <a:lnTo>
                  <a:pt x="116" y="48"/>
                </a:lnTo>
                <a:lnTo>
                  <a:pt x="121" y="48"/>
                </a:lnTo>
                <a:lnTo>
                  <a:pt x="85" y="55"/>
                </a:lnTo>
                <a:lnTo>
                  <a:pt x="94" y="51"/>
                </a:lnTo>
                <a:lnTo>
                  <a:pt x="65" y="71"/>
                </a:lnTo>
                <a:lnTo>
                  <a:pt x="71" y="65"/>
                </a:lnTo>
                <a:lnTo>
                  <a:pt x="51" y="94"/>
                </a:lnTo>
                <a:lnTo>
                  <a:pt x="55" y="85"/>
                </a:lnTo>
                <a:lnTo>
                  <a:pt x="48" y="121"/>
                </a:lnTo>
                <a:lnTo>
                  <a:pt x="48" y="116"/>
                </a:lnTo>
                <a:lnTo>
                  <a:pt x="48" y="845"/>
                </a:lnTo>
                <a:close/>
              </a:path>
            </a:pathLst>
          </a:custGeom>
          <a:solidFill>
            <a:srgbClr val="1B4171"/>
          </a:solidFill>
          <a:ln w="0" cap="flat">
            <a:solidFill>
              <a:srgbClr val="1B417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 sz="1100" b="1"/>
          </a:p>
        </p:txBody>
      </p:sp>
      <p:sp>
        <p:nvSpPr>
          <p:cNvPr id="62" name="Freeform 22"/>
          <p:cNvSpPr>
            <a:spLocks noEditPoints="1"/>
          </p:cNvSpPr>
          <p:nvPr/>
        </p:nvSpPr>
        <p:spPr bwMode="auto">
          <a:xfrm>
            <a:off x="6480573" y="3711889"/>
            <a:ext cx="955343" cy="693964"/>
          </a:xfrm>
          <a:custGeom>
            <a:avLst/>
            <a:gdLst/>
            <a:ahLst/>
            <a:cxnLst>
              <a:cxn ang="0">
                <a:pos x="1" y="112"/>
              </a:cxn>
              <a:cxn ang="0">
                <a:pos x="12" y="67"/>
              </a:cxn>
              <a:cxn ang="0">
                <a:pos x="38" y="32"/>
              </a:cxn>
              <a:cxn ang="0">
                <a:pos x="76" y="8"/>
              </a:cxn>
              <a:cxn ang="0">
                <a:pos x="116" y="0"/>
              </a:cxn>
              <a:cxn ang="0">
                <a:pos x="1298" y="1"/>
              </a:cxn>
              <a:cxn ang="0">
                <a:pos x="1343" y="12"/>
              </a:cxn>
              <a:cxn ang="0">
                <a:pos x="1379" y="38"/>
              </a:cxn>
              <a:cxn ang="0">
                <a:pos x="1401" y="76"/>
              </a:cxn>
              <a:cxn ang="0">
                <a:pos x="1408" y="116"/>
              </a:cxn>
              <a:cxn ang="0">
                <a:pos x="1408" y="850"/>
              </a:cxn>
              <a:cxn ang="0">
                <a:pos x="1398" y="895"/>
              </a:cxn>
              <a:cxn ang="0">
                <a:pos x="1372" y="931"/>
              </a:cxn>
              <a:cxn ang="0">
                <a:pos x="1334" y="953"/>
              </a:cxn>
              <a:cxn ang="0">
                <a:pos x="1293" y="960"/>
              </a:cxn>
              <a:cxn ang="0">
                <a:pos x="112" y="960"/>
              </a:cxn>
              <a:cxn ang="0">
                <a:pos x="67" y="950"/>
              </a:cxn>
              <a:cxn ang="0">
                <a:pos x="32" y="924"/>
              </a:cxn>
              <a:cxn ang="0">
                <a:pos x="8" y="886"/>
              </a:cxn>
              <a:cxn ang="0">
                <a:pos x="0" y="845"/>
              </a:cxn>
              <a:cxn ang="0">
                <a:pos x="48" y="845"/>
              </a:cxn>
              <a:cxn ang="0">
                <a:pos x="55" y="877"/>
              </a:cxn>
              <a:cxn ang="0">
                <a:pos x="71" y="897"/>
              </a:cxn>
              <a:cxn ang="0">
                <a:pos x="94" y="909"/>
              </a:cxn>
              <a:cxn ang="0">
                <a:pos x="121" y="913"/>
              </a:cxn>
              <a:cxn ang="0">
                <a:pos x="1293" y="912"/>
              </a:cxn>
              <a:cxn ang="0">
                <a:pos x="1325" y="906"/>
              </a:cxn>
              <a:cxn ang="0">
                <a:pos x="1345" y="890"/>
              </a:cxn>
              <a:cxn ang="0">
                <a:pos x="1357" y="868"/>
              </a:cxn>
              <a:cxn ang="0">
                <a:pos x="1361" y="841"/>
              </a:cxn>
              <a:cxn ang="0">
                <a:pos x="1360" y="116"/>
              </a:cxn>
              <a:cxn ang="0">
                <a:pos x="1354" y="85"/>
              </a:cxn>
              <a:cxn ang="0">
                <a:pos x="1338" y="65"/>
              </a:cxn>
              <a:cxn ang="0">
                <a:pos x="1316" y="51"/>
              </a:cxn>
              <a:cxn ang="0">
                <a:pos x="1289" y="48"/>
              </a:cxn>
              <a:cxn ang="0">
                <a:pos x="116" y="48"/>
              </a:cxn>
              <a:cxn ang="0">
                <a:pos x="85" y="55"/>
              </a:cxn>
              <a:cxn ang="0">
                <a:pos x="65" y="71"/>
              </a:cxn>
              <a:cxn ang="0">
                <a:pos x="51" y="94"/>
              </a:cxn>
              <a:cxn ang="0">
                <a:pos x="48" y="121"/>
              </a:cxn>
              <a:cxn ang="0">
                <a:pos x="48" y="845"/>
              </a:cxn>
            </a:cxnLst>
            <a:rect l="0" t="0" r="r" b="b"/>
            <a:pathLst>
              <a:path w="1408" h="960">
                <a:moveTo>
                  <a:pt x="0" y="116"/>
                </a:moveTo>
                <a:cubicBezTo>
                  <a:pt x="0" y="115"/>
                  <a:pt x="1" y="113"/>
                  <a:pt x="1" y="112"/>
                </a:cubicBezTo>
                <a:lnTo>
                  <a:pt x="8" y="76"/>
                </a:lnTo>
                <a:cubicBezTo>
                  <a:pt x="9" y="73"/>
                  <a:pt x="10" y="70"/>
                  <a:pt x="12" y="67"/>
                </a:cubicBezTo>
                <a:lnTo>
                  <a:pt x="32" y="38"/>
                </a:lnTo>
                <a:cubicBezTo>
                  <a:pt x="33" y="35"/>
                  <a:pt x="35" y="33"/>
                  <a:pt x="38" y="32"/>
                </a:cubicBezTo>
                <a:lnTo>
                  <a:pt x="67" y="12"/>
                </a:lnTo>
                <a:cubicBezTo>
                  <a:pt x="70" y="10"/>
                  <a:pt x="73" y="9"/>
                  <a:pt x="76" y="8"/>
                </a:cubicBezTo>
                <a:lnTo>
                  <a:pt x="112" y="1"/>
                </a:lnTo>
                <a:cubicBezTo>
                  <a:pt x="113" y="1"/>
                  <a:pt x="115" y="0"/>
                  <a:pt x="116" y="0"/>
                </a:cubicBezTo>
                <a:lnTo>
                  <a:pt x="1293" y="0"/>
                </a:lnTo>
                <a:cubicBezTo>
                  <a:pt x="1295" y="0"/>
                  <a:pt x="1297" y="1"/>
                  <a:pt x="1298" y="1"/>
                </a:cubicBezTo>
                <a:lnTo>
                  <a:pt x="1334" y="8"/>
                </a:lnTo>
                <a:cubicBezTo>
                  <a:pt x="1337" y="9"/>
                  <a:pt x="1340" y="10"/>
                  <a:pt x="1343" y="12"/>
                </a:cubicBezTo>
                <a:lnTo>
                  <a:pt x="1372" y="32"/>
                </a:lnTo>
                <a:cubicBezTo>
                  <a:pt x="1375" y="33"/>
                  <a:pt x="1377" y="36"/>
                  <a:pt x="1379" y="38"/>
                </a:cubicBezTo>
                <a:lnTo>
                  <a:pt x="1398" y="67"/>
                </a:lnTo>
                <a:cubicBezTo>
                  <a:pt x="1399" y="70"/>
                  <a:pt x="1400" y="73"/>
                  <a:pt x="1401" y="76"/>
                </a:cubicBezTo>
                <a:lnTo>
                  <a:pt x="1408" y="112"/>
                </a:lnTo>
                <a:cubicBezTo>
                  <a:pt x="1408" y="113"/>
                  <a:pt x="1408" y="115"/>
                  <a:pt x="1408" y="116"/>
                </a:cubicBezTo>
                <a:lnTo>
                  <a:pt x="1408" y="845"/>
                </a:lnTo>
                <a:cubicBezTo>
                  <a:pt x="1408" y="847"/>
                  <a:pt x="1408" y="849"/>
                  <a:pt x="1408" y="850"/>
                </a:cubicBezTo>
                <a:lnTo>
                  <a:pt x="1401" y="886"/>
                </a:lnTo>
                <a:cubicBezTo>
                  <a:pt x="1400" y="889"/>
                  <a:pt x="1399" y="892"/>
                  <a:pt x="1398" y="895"/>
                </a:cubicBezTo>
                <a:lnTo>
                  <a:pt x="1379" y="924"/>
                </a:lnTo>
                <a:cubicBezTo>
                  <a:pt x="1377" y="926"/>
                  <a:pt x="1374" y="929"/>
                  <a:pt x="1372" y="931"/>
                </a:cubicBezTo>
                <a:lnTo>
                  <a:pt x="1343" y="950"/>
                </a:lnTo>
                <a:cubicBezTo>
                  <a:pt x="1340" y="951"/>
                  <a:pt x="1337" y="952"/>
                  <a:pt x="1334" y="953"/>
                </a:cubicBezTo>
                <a:lnTo>
                  <a:pt x="1298" y="960"/>
                </a:lnTo>
                <a:cubicBezTo>
                  <a:pt x="1297" y="960"/>
                  <a:pt x="1295" y="960"/>
                  <a:pt x="1293" y="960"/>
                </a:cubicBezTo>
                <a:lnTo>
                  <a:pt x="116" y="960"/>
                </a:lnTo>
                <a:cubicBezTo>
                  <a:pt x="115" y="960"/>
                  <a:pt x="113" y="960"/>
                  <a:pt x="112" y="960"/>
                </a:cubicBezTo>
                <a:lnTo>
                  <a:pt x="76" y="953"/>
                </a:lnTo>
                <a:cubicBezTo>
                  <a:pt x="73" y="952"/>
                  <a:pt x="70" y="951"/>
                  <a:pt x="67" y="950"/>
                </a:cubicBezTo>
                <a:lnTo>
                  <a:pt x="38" y="931"/>
                </a:lnTo>
                <a:cubicBezTo>
                  <a:pt x="36" y="929"/>
                  <a:pt x="33" y="927"/>
                  <a:pt x="32" y="924"/>
                </a:cubicBezTo>
                <a:lnTo>
                  <a:pt x="12" y="895"/>
                </a:lnTo>
                <a:cubicBezTo>
                  <a:pt x="10" y="892"/>
                  <a:pt x="9" y="889"/>
                  <a:pt x="8" y="886"/>
                </a:cubicBezTo>
                <a:lnTo>
                  <a:pt x="1" y="850"/>
                </a:lnTo>
                <a:cubicBezTo>
                  <a:pt x="1" y="849"/>
                  <a:pt x="0" y="847"/>
                  <a:pt x="0" y="845"/>
                </a:cubicBezTo>
                <a:lnTo>
                  <a:pt x="0" y="116"/>
                </a:lnTo>
                <a:close/>
                <a:moveTo>
                  <a:pt x="48" y="845"/>
                </a:moveTo>
                <a:lnTo>
                  <a:pt x="48" y="841"/>
                </a:lnTo>
                <a:lnTo>
                  <a:pt x="55" y="877"/>
                </a:lnTo>
                <a:lnTo>
                  <a:pt x="51" y="868"/>
                </a:lnTo>
                <a:lnTo>
                  <a:pt x="71" y="897"/>
                </a:lnTo>
                <a:lnTo>
                  <a:pt x="65" y="890"/>
                </a:lnTo>
                <a:lnTo>
                  <a:pt x="94" y="909"/>
                </a:lnTo>
                <a:lnTo>
                  <a:pt x="85" y="906"/>
                </a:lnTo>
                <a:lnTo>
                  <a:pt x="121" y="913"/>
                </a:lnTo>
                <a:lnTo>
                  <a:pt x="116" y="912"/>
                </a:lnTo>
                <a:lnTo>
                  <a:pt x="1293" y="912"/>
                </a:lnTo>
                <a:lnTo>
                  <a:pt x="1289" y="913"/>
                </a:lnTo>
                <a:lnTo>
                  <a:pt x="1325" y="906"/>
                </a:lnTo>
                <a:lnTo>
                  <a:pt x="1316" y="909"/>
                </a:lnTo>
                <a:lnTo>
                  <a:pt x="1345" y="890"/>
                </a:lnTo>
                <a:lnTo>
                  <a:pt x="1338" y="897"/>
                </a:lnTo>
                <a:lnTo>
                  <a:pt x="1357" y="868"/>
                </a:lnTo>
                <a:lnTo>
                  <a:pt x="1354" y="877"/>
                </a:lnTo>
                <a:lnTo>
                  <a:pt x="1361" y="841"/>
                </a:lnTo>
                <a:lnTo>
                  <a:pt x="1360" y="845"/>
                </a:lnTo>
                <a:lnTo>
                  <a:pt x="1360" y="116"/>
                </a:lnTo>
                <a:lnTo>
                  <a:pt x="1361" y="121"/>
                </a:lnTo>
                <a:lnTo>
                  <a:pt x="1354" y="85"/>
                </a:lnTo>
                <a:lnTo>
                  <a:pt x="1357" y="94"/>
                </a:lnTo>
                <a:lnTo>
                  <a:pt x="1338" y="65"/>
                </a:lnTo>
                <a:lnTo>
                  <a:pt x="1345" y="71"/>
                </a:lnTo>
                <a:lnTo>
                  <a:pt x="1316" y="51"/>
                </a:lnTo>
                <a:lnTo>
                  <a:pt x="1325" y="55"/>
                </a:lnTo>
                <a:lnTo>
                  <a:pt x="1289" y="48"/>
                </a:lnTo>
                <a:lnTo>
                  <a:pt x="1293" y="48"/>
                </a:lnTo>
                <a:lnTo>
                  <a:pt x="116" y="48"/>
                </a:lnTo>
                <a:lnTo>
                  <a:pt x="121" y="48"/>
                </a:lnTo>
                <a:lnTo>
                  <a:pt x="85" y="55"/>
                </a:lnTo>
                <a:lnTo>
                  <a:pt x="94" y="51"/>
                </a:lnTo>
                <a:lnTo>
                  <a:pt x="65" y="71"/>
                </a:lnTo>
                <a:lnTo>
                  <a:pt x="71" y="65"/>
                </a:lnTo>
                <a:lnTo>
                  <a:pt x="51" y="94"/>
                </a:lnTo>
                <a:lnTo>
                  <a:pt x="55" y="85"/>
                </a:lnTo>
                <a:lnTo>
                  <a:pt x="48" y="121"/>
                </a:lnTo>
                <a:lnTo>
                  <a:pt x="48" y="116"/>
                </a:lnTo>
                <a:lnTo>
                  <a:pt x="48" y="845"/>
                </a:lnTo>
                <a:close/>
              </a:path>
            </a:pathLst>
          </a:custGeom>
          <a:solidFill>
            <a:srgbClr val="1B4171"/>
          </a:solidFill>
          <a:ln w="0" cap="flat">
            <a:solidFill>
              <a:srgbClr val="1B417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 sz="1100" b="1"/>
          </a:p>
        </p:txBody>
      </p:sp>
      <p:sp>
        <p:nvSpPr>
          <p:cNvPr id="63" name="Freeform 22"/>
          <p:cNvSpPr>
            <a:spLocks noEditPoints="1"/>
          </p:cNvSpPr>
          <p:nvPr/>
        </p:nvSpPr>
        <p:spPr bwMode="auto">
          <a:xfrm>
            <a:off x="4868658" y="3711889"/>
            <a:ext cx="955343" cy="693964"/>
          </a:xfrm>
          <a:custGeom>
            <a:avLst/>
            <a:gdLst/>
            <a:ahLst/>
            <a:cxnLst>
              <a:cxn ang="0">
                <a:pos x="1" y="112"/>
              </a:cxn>
              <a:cxn ang="0">
                <a:pos x="12" y="67"/>
              </a:cxn>
              <a:cxn ang="0">
                <a:pos x="38" y="32"/>
              </a:cxn>
              <a:cxn ang="0">
                <a:pos x="76" y="8"/>
              </a:cxn>
              <a:cxn ang="0">
                <a:pos x="116" y="0"/>
              </a:cxn>
              <a:cxn ang="0">
                <a:pos x="1298" y="1"/>
              </a:cxn>
              <a:cxn ang="0">
                <a:pos x="1343" y="12"/>
              </a:cxn>
              <a:cxn ang="0">
                <a:pos x="1379" y="38"/>
              </a:cxn>
              <a:cxn ang="0">
                <a:pos x="1401" y="76"/>
              </a:cxn>
              <a:cxn ang="0">
                <a:pos x="1408" y="116"/>
              </a:cxn>
              <a:cxn ang="0">
                <a:pos x="1408" y="850"/>
              </a:cxn>
              <a:cxn ang="0">
                <a:pos x="1398" y="895"/>
              </a:cxn>
              <a:cxn ang="0">
                <a:pos x="1372" y="931"/>
              </a:cxn>
              <a:cxn ang="0">
                <a:pos x="1334" y="953"/>
              </a:cxn>
              <a:cxn ang="0">
                <a:pos x="1293" y="960"/>
              </a:cxn>
              <a:cxn ang="0">
                <a:pos x="112" y="960"/>
              </a:cxn>
              <a:cxn ang="0">
                <a:pos x="67" y="950"/>
              </a:cxn>
              <a:cxn ang="0">
                <a:pos x="32" y="924"/>
              </a:cxn>
              <a:cxn ang="0">
                <a:pos x="8" y="886"/>
              </a:cxn>
              <a:cxn ang="0">
                <a:pos x="0" y="845"/>
              </a:cxn>
              <a:cxn ang="0">
                <a:pos x="48" y="845"/>
              </a:cxn>
              <a:cxn ang="0">
                <a:pos x="55" y="877"/>
              </a:cxn>
              <a:cxn ang="0">
                <a:pos x="71" y="897"/>
              </a:cxn>
              <a:cxn ang="0">
                <a:pos x="94" y="909"/>
              </a:cxn>
              <a:cxn ang="0">
                <a:pos x="121" y="913"/>
              </a:cxn>
              <a:cxn ang="0">
                <a:pos x="1293" y="912"/>
              </a:cxn>
              <a:cxn ang="0">
                <a:pos x="1325" y="906"/>
              </a:cxn>
              <a:cxn ang="0">
                <a:pos x="1345" y="890"/>
              </a:cxn>
              <a:cxn ang="0">
                <a:pos x="1357" y="868"/>
              </a:cxn>
              <a:cxn ang="0">
                <a:pos x="1361" y="841"/>
              </a:cxn>
              <a:cxn ang="0">
                <a:pos x="1360" y="116"/>
              </a:cxn>
              <a:cxn ang="0">
                <a:pos x="1354" y="85"/>
              </a:cxn>
              <a:cxn ang="0">
                <a:pos x="1338" y="65"/>
              </a:cxn>
              <a:cxn ang="0">
                <a:pos x="1316" y="51"/>
              </a:cxn>
              <a:cxn ang="0">
                <a:pos x="1289" y="48"/>
              </a:cxn>
              <a:cxn ang="0">
                <a:pos x="116" y="48"/>
              </a:cxn>
              <a:cxn ang="0">
                <a:pos x="85" y="55"/>
              </a:cxn>
              <a:cxn ang="0">
                <a:pos x="65" y="71"/>
              </a:cxn>
              <a:cxn ang="0">
                <a:pos x="51" y="94"/>
              </a:cxn>
              <a:cxn ang="0">
                <a:pos x="48" y="121"/>
              </a:cxn>
              <a:cxn ang="0">
                <a:pos x="48" y="845"/>
              </a:cxn>
            </a:cxnLst>
            <a:rect l="0" t="0" r="r" b="b"/>
            <a:pathLst>
              <a:path w="1408" h="960">
                <a:moveTo>
                  <a:pt x="0" y="116"/>
                </a:moveTo>
                <a:cubicBezTo>
                  <a:pt x="0" y="115"/>
                  <a:pt x="1" y="113"/>
                  <a:pt x="1" y="112"/>
                </a:cubicBezTo>
                <a:lnTo>
                  <a:pt x="8" y="76"/>
                </a:lnTo>
                <a:cubicBezTo>
                  <a:pt x="9" y="73"/>
                  <a:pt x="10" y="70"/>
                  <a:pt x="12" y="67"/>
                </a:cubicBezTo>
                <a:lnTo>
                  <a:pt x="32" y="38"/>
                </a:lnTo>
                <a:cubicBezTo>
                  <a:pt x="33" y="35"/>
                  <a:pt x="35" y="33"/>
                  <a:pt x="38" y="32"/>
                </a:cubicBezTo>
                <a:lnTo>
                  <a:pt x="67" y="12"/>
                </a:lnTo>
                <a:cubicBezTo>
                  <a:pt x="70" y="10"/>
                  <a:pt x="73" y="9"/>
                  <a:pt x="76" y="8"/>
                </a:cubicBezTo>
                <a:lnTo>
                  <a:pt x="112" y="1"/>
                </a:lnTo>
                <a:cubicBezTo>
                  <a:pt x="113" y="1"/>
                  <a:pt x="115" y="0"/>
                  <a:pt x="116" y="0"/>
                </a:cubicBezTo>
                <a:lnTo>
                  <a:pt x="1293" y="0"/>
                </a:lnTo>
                <a:cubicBezTo>
                  <a:pt x="1295" y="0"/>
                  <a:pt x="1297" y="1"/>
                  <a:pt x="1298" y="1"/>
                </a:cubicBezTo>
                <a:lnTo>
                  <a:pt x="1334" y="8"/>
                </a:lnTo>
                <a:cubicBezTo>
                  <a:pt x="1337" y="9"/>
                  <a:pt x="1340" y="10"/>
                  <a:pt x="1343" y="12"/>
                </a:cubicBezTo>
                <a:lnTo>
                  <a:pt x="1372" y="32"/>
                </a:lnTo>
                <a:cubicBezTo>
                  <a:pt x="1375" y="33"/>
                  <a:pt x="1377" y="36"/>
                  <a:pt x="1379" y="38"/>
                </a:cubicBezTo>
                <a:lnTo>
                  <a:pt x="1398" y="67"/>
                </a:lnTo>
                <a:cubicBezTo>
                  <a:pt x="1399" y="70"/>
                  <a:pt x="1400" y="73"/>
                  <a:pt x="1401" y="76"/>
                </a:cubicBezTo>
                <a:lnTo>
                  <a:pt x="1408" y="112"/>
                </a:lnTo>
                <a:cubicBezTo>
                  <a:pt x="1408" y="113"/>
                  <a:pt x="1408" y="115"/>
                  <a:pt x="1408" y="116"/>
                </a:cubicBezTo>
                <a:lnTo>
                  <a:pt x="1408" y="845"/>
                </a:lnTo>
                <a:cubicBezTo>
                  <a:pt x="1408" y="847"/>
                  <a:pt x="1408" y="849"/>
                  <a:pt x="1408" y="850"/>
                </a:cubicBezTo>
                <a:lnTo>
                  <a:pt x="1401" y="886"/>
                </a:lnTo>
                <a:cubicBezTo>
                  <a:pt x="1400" y="889"/>
                  <a:pt x="1399" y="892"/>
                  <a:pt x="1398" y="895"/>
                </a:cubicBezTo>
                <a:lnTo>
                  <a:pt x="1379" y="924"/>
                </a:lnTo>
                <a:cubicBezTo>
                  <a:pt x="1377" y="926"/>
                  <a:pt x="1374" y="929"/>
                  <a:pt x="1372" y="931"/>
                </a:cubicBezTo>
                <a:lnTo>
                  <a:pt x="1343" y="950"/>
                </a:lnTo>
                <a:cubicBezTo>
                  <a:pt x="1340" y="951"/>
                  <a:pt x="1337" y="952"/>
                  <a:pt x="1334" y="953"/>
                </a:cubicBezTo>
                <a:lnTo>
                  <a:pt x="1298" y="960"/>
                </a:lnTo>
                <a:cubicBezTo>
                  <a:pt x="1297" y="960"/>
                  <a:pt x="1295" y="960"/>
                  <a:pt x="1293" y="960"/>
                </a:cubicBezTo>
                <a:lnTo>
                  <a:pt x="116" y="960"/>
                </a:lnTo>
                <a:cubicBezTo>
                  <a:pt x="115" y="960"/>
                  <a:pt x="113" y="960"/>
                  <a:pt x="112" y="960"/>
                </a:cubicBezTo>
                <a:lnTo>
                  <a:pt x="76" y="953"/>
                </a:lnTo>
                <a:cubicBezTo>
                  <a:pt x="73" y="952"/>
                  <a:pt x="70" y="951"/>
                  <a:pt x="67" y="950"/>
                </a:cubicBezTo>
                <a:lnTo>
                  <a:pt x="38" y="931"/>
                </a:lnTo>
                <a:cubicBezTo>
                  <a:pt x="36" y="929"/>
                  <a:pt x="33" y="927"/>
                  <a:pt x="32" y="924"/>
                </a:cubicBezTo>
                <a:lnTo>
                  <a:pt x="12" y="895"/>
                </a:lnTo>
                <a:cubicBezTo>
                  <a:pt x="10" y="892"/>
                  <a:pt x="9" y="889"/>
                  <a:pt x="8" y="886"/>
                </a:cubicBezTo>
                <a:lnTo>
                  <a:pt x="1" y="850"/>
                </a:lnTo>
                <a:cubicBezTo>
                  <a:pt x="1" y="849"/>
                  <a:pt x="0" y="847"/>
                  <a:pt x="0" y="845"/>
                </a:cubicBezTo>
                <a:lnTo>
                  <a:pt x="0" y="116"/>
                </a:lnTo>
                <a:close/>
                <a:moveTo>
                  <a:pt x="48" y="845"/>
                </a:moveTo>
                <a:lnTo>
                  <a:pt x="48" y="841"/>
                </a:lnTo>
                <a:lnTo>
                  <a:pt x="55" y="877"/>
                </a:lnTo>
                <a:lnTo>
                  <a:pt x="51" y="868"/>
                </a:lnTo>
                <a:lnTo>
                  <a:pt x="71" y="897"/>
                </a:lnTo>
                <a:lnTo>
                  <a:pt x="65" y="890"/>
                </a:lnTo>
                <a:lnTo>
                  <a:pt x="94" y="909"/>
                </a:lnTo>
                <a:lnTo>
                  <a:pt x="85" y="906"/>
                </a:lnTo>
                <a:lnTo>
                  <a:pt x="121" y="913"/>
                </a:lnTo>
                <a:lnTo>
                  <a:pt x="116" y="912"/>
                </a:lnTo>
                <a:lnTo>
                  <a:pt x="1293" y="912"/>
                </a:lnTo>
                <a:lnTo>
                  <a:pt x="1289" y="913"/>
                </a:lnTo>
                <a:lnTo>
                  <a:pt x="1325" y="906"/>
                </a:lnTo>
                <a:lnTo>
                  <a:pt x="1316" y="909"/>
                </a:lnTo>
                <a:lnTo>
                  <a:pt x="1345" y="890"/>
                </a:lnTo>
                <a:lnTo>
                  <a:pt x="1338" y="897"/>
                </a:lnTo>
                <a:lnTo>
                  <a:pt x="1357" y="868"/>
                </a:lnTo>
                <a:lnTo>
                  <a:pt x="1354" y="877"/>
                </a:lnTo>
                <a:lnTo>
                  <a:pt x="1361" y="841"/>
                </a:lnTo>
                <a:lnTo>
                  <a:pt x="1360" y="845"/>
                </a:lnTo>
                <a:lnTo>
                  <a:pt x="1360" y="116"/>
                </a:lnTo>
                <a:lnTo>
                  <a:pt x="1361" y="121"/>
                </a:lnTo>
                <a:lnTo>
                  <a:pt x="1354" y="85"/>
                </a:lnTo>
                <a:lnTo>
                  <a:pt x="1357" y="94"/>
                </a:lnTo>
                <a:lnTo>
                  <a:pt x="1338" y="65"/>
                </a:lnTo>
                <a:lnTo>
                  <a:pt x="1345" y="71"/>
                </a:lnTo>
                <a:lnTo>
                  <a:pt x="1316" y="51"/>
                </a:lnTo>
                <a:lnTo>
                  <a:pt x="1325" y="55"/>
                </a:lnTo>
                <a:lnTo>
                  <a:pt x="1289" y="48"/>
                </a:lnTo>
                <a:lnTo>
                  <a:pt x="1293" y="48"/>
                </a:lnTo>
                <a:lnTo>
                  <a:pt x="116" y="48"/>
                </a:lnTo>
                <a:lnTo>
                  <a:pt x="121" y="48"/>
                </a:lnTo>
                <a:lnTo>
                  <a:pt x="85" y="55"/>
                </a:lnTo>
                <a:lnTo>
                  <a:pt x="94" y="51"/>
                </a:lnTo>
                <a:lnTo>
                  <a:pt x="65" y="71"/>
                </a:lnTo>
                <a:lnTo>
                  <a:pt x="71" y="65"/>
                </a:lnTo>
                <a:lnTo>
                  <a:pt x="51" y="94"/>
                </a:lnTo>
                <a:lnTo>
                  <a:pt x="55" y="85"/>
                </a:lnTo>
                <a:lnTo>
                  <a:pt x="48" y="121"/>
                </a:lnTo>
                <a:lnTo>
                  <a:pt x="48" y="116"/>
                </a:lnTo>
                <a:lnTo>
                  <a:pt x="48" y="845"/>
                </a:lnTo>
                <a:close/>
              </a:path>
            </a:pathLst>
          </a:custGeom>
          <a:solidFill>
            <a:srgbClr val="1B4171"/>
          </a:solidFill>
          <a:ln w="0" cap="flat">
            <a:solidFill>
              <a:srgbClr val="1B417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 sz="1100" b="1"/>
          </a:p>
        </p:txBody>
      </p:sp>
      <p:sp>
        <p:nvSpPr>
          <p:cNvPr id="65" name="64 CuadroTexto"/>
          <p:cNvSpPr txBox="1"/>
          <p:nvPr/>
        </p:nvSpPr>
        <p:spPr>
          <a:xfrm>
            <a:off x="1625615" y="3799327"/>
            <a:ext cx="738644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100" dirty="0" smtClean="0"/>
              <a:t>130</a:t>
            </a:r>
          </a:p>
          <a:p>
            <a:pPr algn="ctr"/>
            <a:r>
              <a:rPr lang="es-ES" sz="1100" dirty="0" smtClean="0"/>
              <a:t>Test (+)</a:t>
            </a:r>
            <a:endParaRPr lang="es-ES" sz="1100" dirty="0"/>
          </a:p>
        </p:txBody>
      </p:sp>
      <p:sp>
        <p:nvSpPr>
          <p:cNvPr id="66" name="65 CuadroTexto"/>
          <p:cNvSpPr txBox="1"/>
          <p:nvPr/>
        </p:nvSpPr>
        <p:spPr>
          <a:xfrm>
            <a:off x="3349117" y="3799327"/>
            <a:ext cx="738644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100" dirty="0" smtClean="0"/>
              <a:t>6</a:t>
            </a:r>
          </a:p>
          <a:p>
            <a:pPr algn="ctr"/>
            <a:r>
              <a:rPr lang="es-ES" sz="1100" dirty="0" smtClean="0"/>
              <a:t>Test (-)</a:t>
            </a:r>
            <a:endParaRPr lang="es-ES" sz="1100" dirty="0"/>
          </a:p>
        </p:txBody>
      </p:sp>
      <p:sp>
        <p:nvSpPr>
          <p:cNvPr id="67" name="66 CuadroTexto"/>
          <p:cNvSpPr txBox="1"/>
          <p:nvPr/>
        </p:nvSpPr>
        <p:spPr>
          <a:xfrm>
            <a:off x="4984627" y="3799327"/>
            <a:ext cx="738644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100" dirty="0" smtClean="0"/>
              <a:t>104</a:t>
            </a:r>
          </a:p>
          <a:p>
            <a:pPr algn="ctr"/>
            <a:r>
              <a:rPr lang="es-ES" sz="1100" dirty="0" smtClean="0"/>
              <a:t>Test (+)</a:t>
            </a:r>
            <a:endParaRPr lang="es-ES" sz="1100" dirty="0"/>
          </a:p>
        </p:txBody>
      </p:sp>
      <p:sp>
        <p:nvSpPr>
          <p:cNvPr id="73" name="72 CuadroTexto"/>
          <p:cNvSpPr txBox="1"/>
          <p:nvPr/>
        </p:nvSpPr>
        <p:spPr>
          <a:xfrm>
            <a:off x="6626057" y="3799327"/>
            <a:ext cx="738644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100" dirty="0" smtClean="0"/>
              <a:t>68</a:t>
            </a:r>
          </a:p>
          <a:p>
            <a:pPr algn="ctr"/>
            <a:r>
              <a:rPr lang="es-ES" sz="1100" dirty="0" smtClean="0"/>
              <a:t>T</a:t>
            </a:r>
            <a:r>
              <a:rPr lang="es-ES" sz="1100" smtClean="0"/>
              <a:t>est </a:t>
            </a:r>
            <a:r>
              <a:rPr lang="es-ES" sz="1100" dirty="0" smtClean="0"/>
              <a:t>(-)</a:t>
            </a:r>
            <a:endParaRPr lang="es-ES" sz="1100" dirty="0"/>
          </a:p>
        </p:txBody>
      </p:sp>
      <p:sp>
        <p:nvSpPr>
          <p:cNvPr id="48" name="47 CuadroTexto"/>
          <p:cNvSpPr txBox="1"/>
          <p:nvPr/>
        </p:nvSpPr>
        <p:spPr>
          <a:xfrm>
            <a:off x="827584" y="836712"/>
            <a:ext cx="5040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a-ES" dirty="0" smtClean="0"/>
              <a:t>b)</a:t>
            </a:r>
            <a:endParaRPr lang="ca-ES" dirty="0"/>
          </a:p>
        </p:txBody>
      </p:sp>
      <p:sp>
        <p:nvSpPr>
          <p:cNvPr id="24" name="23 Rectángulo"/>
          <p:cNvSpPr/>
          <p:nvPr/>
        </p:nvSpPr>
        <p:spPr>
          <a:xfrm>
            <a:off x="2555776" y="2636912"/>
            <a:ext cx="63831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s-ES" sz="1200" b="1" dirty="0" smtClean="0"/>
              <a:t>R-PFBC</a:t>
            </a:r>
          </a:p>
        </p:txBody>
      </p:sp>
      <p:sp>
        <p:nvSpPr>
          <p:cNvPr id="25" name="24 Rectángulo"/>
          <p:cNvSpPr/>
          <p:nvPr/>
        </p:nvSpPr>
        <p:spPr>
          <a:xfrm>
            <a:off x="5780145" y="2636912"/>
            <a:ext cx="73930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s-ES" sz="1200" b="1" dirty="0" smtClean="0"/>
              <a:t>NR-PFBC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51</TotalTime>
  <Words>94</Words>
  <Application>Microsoft Office PowerPoint</Application>
  <PresentationFormat>Presentación en pantalla (4:3)</PresentationFormat>
  <Paragraphs>53</Paragraphs>
  <Slides>2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2</vt:i4>
      </vt:variant>
    </vt:vector>
  </HeadingPairs>
  <TitlesOfParts>
    <vt:vector size="3" baseType="lpstr">
      <vt:lpstr>Tema de Office</vt:lpstr>
      <vt:lpstr>Diapositiva 1</vt:lpstr>
      <vt:lpstr>Diapositiva 2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MENGUAL, LOURDES (FCRB)</dc:creator>
  <cp:lastModifiedBy>MENGUAL, LOURDES (FCRB)</cp:lastModifiedBy>
  <cp:revision>23</cp:revision>
  <dcterms:modified xsi:type="dcterms:W3CDTF">2018-03-02T12:43:11Z</dcterms:modified>
</cp:coreProperties>
</file>